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1.xml" ContentType="application/vnd.openxmlformats-officedocument.presentationml.notesSl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8"/>
  </p:notesMasterIdLst>
  <p:sldIdLst>
    <p:sldId id="278" r:id="rId2"/>
    <p:sldId id="279" r:id="rId3"/>
    <p:sldId id="280" r:id="rId4"/>
    <p:sldId id="281" r:id="rId5"/>
    <p:sldId id="257" r:id="rId6"/>
    <p:sldId id="282" r:id="rId7"/>
  </p:sldIdLst>
  <p:sldSz cx="7559675" cy="106918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368" userDrawn="1">
          <p15:clr>
            <a:srgbClr val="A4A3A4"/>
          </p15:clr>
        </p15:guide>
        <p15:guide id="2" pos="238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B3866B7-E131-554E-A029-6FF3082FF097}" v="13" dt="2025-12-29T09:19:53.41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50"/>
    <p:restoredTop sz="94721"/>
  </p:normalViewPr>
  <p:slideViewPr>
    <p:cSldViewPr snapToGrid="0" showGuides="1">
      <p:cViewPr varScale="1">
        <p:scale>
          <a:sx n="53" d="100"/>
          <a:sy n="53" d="100"/>
        </p:scale>
        <p:origin x="2785" y="90"/>
      </p:cViewPr>
      <p:guideLst>
        <p:guide orient="horz" pos="3368"/>
        <p:guide pos="238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 Id="rId14"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知暉 渋谷" userId="4faee5f901734df7" providerId="LiveId" clId="{4A928590-1D67-5C46-88A7-CDCF80F68BE1}"/>
    <pc:docChg chg="undo redo custSel addSld delSld modSld">
      <pc:chgData name="知暉 渋谷" userId="4faee5f901734df7" providerId="LiveId" clId="{4A928590-1D67-5C46-88A7-CDCF80F68BE1}" dt="2025-12-29T09:19:54.420" v="99" actId="20577"/>
      <pc:docMkLst>
        <pc:docMk/>
      </pc:docMkLst>
      <pc:sldChg chg="del">
        <pc:chgData name="知暉 渋谷" userId="4faee5f901734df7" providerId="LiveId" clId="{4A928590-1D67-5C46-88A7-CDCF80F68BE1}" dt="2025-12-27T22:59:48.913" v="0" actId="2696"/>
        <pc:sldMkLst>
          <pc:docMk/>
          <pc:sldMk cId="3263459425" sldId="256"/>
        </pc:sldMkLst>
      </pc:sldChg>
      <pc:sldChg chg="addSp delSp modSp mod">
        <pc:chgData name="知暉 渋谷" userId="4faee5f901734df7" providerId="LiveId" clId="{4A928590-1D67-5C46-88A7-CDCF80F68BE1}" dt="2025-12-29T09:18:06.517" v="84" actId="20577"/>
        <pc:sldMkLst>
          <pc:docMk/>
          <pc:sldMk cId="1551231434" sldId="257"/>
        </pc:sldMkLst>
        <pc:spChg chg="mod">
          <ac:chgData name="知暉 渋谷" userId="4faee5f901734df7" providerId="LiveId" clId="{4A928590-1D67-5C46-88A7-CDCF80F68BE1}" dt="2025-12-29T09:17:24.434" v="73" actId="2711"/>
          <ac:spMkLst>
            <pc:docMk/>
            <pc:sldMk cId="1551231434" sldId="257"/>
            <ac:spMk id="2" creationId="{A04452A1-CBCD-F32F-9E27-FC390F7C5330}"/>
          </ac:spMkLst>
        </pc:spChg>
        <pc:spChg chg="add del mod">
          <ac:chgData name="知暉 渋谷" userId="4faee5f901734df7" providerId="LiveId" clId="{4A928590-1D67-5C46-88A7-CDCF80F68BE1}" dt="2025-12-29T09:18:06.517" v="84" actId="20577"/>
          <ac:spMkLst>
            <pc:docMk/>
            <pc:sldMk cId="1551231434" sldId="257"/>
            <ac:spMk id="3" creationId="{2B4CD572-E03E-1377-9E4B-6E925D5D87B0}"/>
          </ac:spMkLst>
        </pc:spChg>
      </pc:sldChg>
      <pc:sldChg chg="addSp delSp modSp mod">
        <pc:chgData name="知暉 渋谷" userId="4faee5f901734df7" providerId="LiveId" clId="{4A928590-1D67-5C46-88A7-CDCF80F68BE1}" dt="2025-12-29T09:18:30.984" v="92"/>
        <pc:sldMkLst>
          <pc:docMk/>
          <pc:sldMk cId="2227556227" sldId="278"/>
        </pc:sldMkLst>
        <pc:spChg chg="add mod">
          <ac:chgData name="知暉 渋谷" userId="4faee5f901734df7" providerId="LiveId" clId="{4A928590-1D67-5C46-88A7-CDCF80F68BE1}" dt="2025-12-29T09:18:30.984" v="92"/>
          <ac:spMkLst>
            <pc:docMk/>
            <pc:sldMk cId="2227556227" sldId="278"/>
            <ac:spMk id="2" creationId="{BD16DF3A-247E-C89F-78BE-4B509BF67B9B}"/>
          </ac:spMkLst>
        </pc:spChg>
        <pc:spChg chg="del">
          <ac:chgData name="知暉 渋谷" userId="4faee5f901734df7" providerId="LiveId" clId="{4A928590-1D67-5C46-88A7-CDCF80F68BE1}" dt="2025-12-29T09:18:30.437" v="91" actId="478"/>
          <ac:spMkLst>
            <pc:docMk/>
            <pc:sldMk cId="2227556227" sldId="278"/>
            <ac:spMk id="3" creationId="{F43D54A7-21E2-6F91-F977-A148A323D599}"/>
          </ac:spMkLst>
        </pc:spChg>
      </pc:sldChg>
      <pc:sldChg chg="addSp delSp modSp mod">
        <pc:chgData name="知暉 渋谷" userId="4faee5f901734df7" providerId="LiveId" clId="{4A928590-1D67-5C46-88A7-CDCF80F68BE1}" dt="2025-12-29T09:18:26.552" v="90"/>
        <pc:sldMkLst>
          <pc:docMk/>
          <pc:sldMk cId="156992178" sldId="279"/>
        </pc:sldMkLst>
        <pc:spChg chg="del">
          <ac:chgData name="知暉 渋谷" userId="4faee5f901734df7" providerId="LiveId" clId="{4A928590-1D67-5C46-88A7-CDCF80F68BE1}" dt="2025-12-29T09:18:25.821" v="89" actId="478"/>
          <ac:spMkLst>
            <pc:docMk/>
            <pc:sldMk cId="156992178" sldId="279"/>
            <ac:spMk id="3" creationId="{8A6632FC-6F22-F33B-C070-5D636DE82AD2}"/>
          </ac:spMkLst>
        </pc:spChg>
        <pc:spChg chg="add mod">
          <ac:chgData name="知暉 渋谷" userId="4faee5f901734df7" providerId="LiveId" clId="{4A928590-1D67-5C46-88A7-CDCF80F68BE1}" dt="2025-12-29T09:18:26.552" v="90"/>
          <ac:spMkLst>
            <pc:docMk/>
            <pc:sldMk cId="156992178" sldId="279"/>
            <ac:spMk id="8" creationId="{0F8B8AA1-CF76-59DF-109C-EF63A8410969}"/>
          </ac:spMkLst>
        </pc:spChg>
      </pc:sldChg>
      <pc:sldChg chg="addSp delSp modSp mod">
        <pc:chgData name="知暉 渋谷" userId="4faee5f901734df7" providerId="LiveId" clId="{4A928590-1D67-5C46-88A7-CDCF80F68BE1}" dt="2025-12-29T09:18:21.021" v="88"/>
        <pc:sldMkLst>
          <pc:docMk/>
          <pc:sldMk cId="350928422" sldId="280"/>
        </pc:sldMkLst>
        <pc:spChg chg="del mod">
          <ac:chgData name="知暉 渋谷" userId="4faee5f901734df7" providerId="LiveId" clId="{4A928590-1D67-5C46-88A7-CDCF80F68BE1}" dt="2025-12-29T09:18:20.154" v="87" actId="478"/>
          <ac:spMkLst>
            <pc:docMk/>
            <pc:sldMk cId="350928422" sldId="280"/>
            <ac:spMk id="3" creationId="{544BFF59-EE8B-C376-5799-DF0CF8C83C9A}"/>
          </ac:spMkLst>
        </pc:spChg>
        <pc:spChg chg="add mod">
          <ac:chgData name="知暉 渋谷" userId="4faee5f901734df7" providerId="LiveId" clId="{4A928590-1D67-5C46-88A7-CDCF80F68BE1}" dt="2025-12-29T09:18:21.021" v="88"/>
          <ac:spMkLst>
            <pc:docMk/>
            <pc:sldMk cId="350928422" sldId="280"/>
            <ac:spMk id="8" creationId="{B6EBA25C-3FEC-CA94-B407-71D32863B3C2}"/>
          </ac:spMkLst>
        </pc:spChg>
      </pc:sldChg>
      <pc:sldChg chg="addSp delSp modSp new mod">
        <pc:chgData name="知暉 渋谷" userId="4faee5f901734df7" providerId="LiveId" clId="{4A928590-1D67-5C46-88A7-CDCF80F68BE1}" dt="2025-12-29T09:19:54.420" v="99" actId="20577"/>
        <pc:sldMkLst>
          <pc:docMk/>
          <pc:sldMk cId="1932631172" sldId="282"/>
        </pc:sldMkLst>
        <pc:spChg chg="add mod">
          <ac:chgData name="知暉 渋谷" userId="4faee5f901734df7" providerId="LiveId" clId="{4A928590-1D67-5C46-88A7-CDCF80F68BE1}" dt="2025-12-29T09:17:31.965" v="74" actId="2711"/>
          <ac:spMkLst>
            <pc:docMk/>
            <pc:sldMk cId="1932631172" sldId="282"/>
            <ac:spMk id="5" creationId="{C516E553-3FB6-D5AE-E768-D97C0EA8175E}"/>
          </ac:spMkLst>
        </pc:spChg>
        <pc:spChg chg="add mod">
          <ac:chgData name="知暉 渋谷" userId="4faee5f901734df7" providerId="LiveId" clId="{4A928590-1D67-5C46-88A7-CDCF80F68BE1}" dt="2025-12-29T09:19:54.420" v="99" actId="20577"/>
          <ac:spMkLst>
            <pc:docMk/>
            <pc:sldMk cId="1932631172" sldId="282"/>
            <ac:spMk id="6" creationId="{DCABADD5-81A0-81A4-10D8-1AD8F8891CE7}"/>
          </ac:spMkLst>
        </pc:spChg>
        <pc:picChg chg="add mod">
          <ac:chgData name="知暉 渋谷" userId="4faee5f901734df7" providerId="LiveId" clId="{4A928590-1D67-5C46-88A7-CDCF80F68BE1}" dt="2025-12-27T23:00:44.763" v="5" actId="1076"/>
          <ac:picMkLst>
            <pc:docMk/>
            <pc:sldMk cId="1932631172" sldId="282"/>
            <ac:picMk id="4" creationId="{6754BD8D-C41A-A684-3180-BE3B198A950F}"/>
          </ac:picMkLst>
        </pc:pic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file:///\\Users\hikaruishikawa\Desktop\&#30740;&#31350;\2025\shine\phenotype\&#26524;&#31890;&#20999;&#29255;\shine&#26524;&#31890;&#20999;&#29255;&#12486;&#12441;&#12540;&#12479;&#12414;&#12392;&#12417;&#65288;251120&#36861;&#21152;&#65289;&#33521;&#35486;.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Users\hikaruishikawa\Desktop\&#30740;&#31350;\2025\shine\phenotype\&#26524;&#31890;&#20999;&#29255;\shine&#26524;&#31890;&#20999;&#29255;&#12486;&#12441;&#12540;&#12479;&#12414;&#12392;&#12417;&#65288;251120&#36861;&#21152;&#65289;&#33521;&#35486;.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Users\hikaruishikawa\Desktop\&#30740;&#31350;\2025\shine\phenotype\&#26524;&#31890;&#20999;&#29255;\shine&#26524;&#31890;&#20999;&#29255;&#12486;&#12441;&#12540;&#12479;&#12414;&#12392;&#12417;&#65288;251120&#36861;&#21152;&#65289;&#33521;&#35486;.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Users\hikaruishikawa\Desktop\&#30740;&#31350;\2025\shine\phenotype\&#26524;&#31890;&#20999;&#29255;\shine&#26524;&#31890;&#20999;&#29255;&#12486;&#12441;&#12540;&#12479;&#12414;&#12392;&#12417;&#65288;251120&#36861;&#21152;&#65289;&#33521;&#35486;.xlsx" TargetMode="External"/><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7.4947897346400477E-2"/>
          <c:y val="3.4390388188536812E-2"/>
          <c:w val="0.86725707798452267"/>
          <c:h val="0.88583566861172902"/>
        </c:manualLayout>
      </c:layout>
      <c:scatterChart>
        <c:scatterStyle val="lineMarker"/>
        <c:varyColors val="0"/>
        <c:ser>
          <c:idx val="0"/>
          <c:order val="0"/>
          <c:tx>
            <c:v>NT</c:v>
          </c:tx>
          <c:spPr>
            <a:ln w="25400" cap="rnd">
              <a:noFill/>
              <a:round/>
            </a:ln>
            <a:effectLst/>
          </c:spPr>
          <c:marker>
            <c:symbol val="circle"/>
            <c:size val="4"/>
            <c:spPr>
              <a:noFill/>
              <a:ln w="12700">
                <a:solidFill>
                  <a:schemeClr val="accent2"/>
                </a:solidFill>
              </a:ln>
              <a:effectLst/>
            </c:spPr>
          </c:marker>
          <c:xVal>
            <c:numRef>
              <c:f>ベレ散布図!$B$4:$B$403</c:f>
              <c:numCache>
                <c:formatCode>General</c:formatCode>
                <c:ptCount val="400"/>
                <c:pt idx="0">
                  <c:v>240.09</c:v>
                </c:pt>
                <c:pt idx="1">
                  <c:v>299.99</c:v>
                </c:pt>
                <c:pt idx="2">
                  <c:v>226.54</c:v>
                </c:pt>
                <c:pt idx="3">
                  <c:v>353.54</c:v>
                </c:pt>
                <c:pt idx="4">
                  <c:v>247.48</c:v>
                </c:pt>
                <c:pt idx="5">
                  <c:v>85.75</c:v>
                </c:pt>
                <c:pt idx="6">
                  <c:v>102.9</c:v>
                </c:pt>
                <c:pt idx="7">
                  <c:v>120.05</c:v>
                </c:pt>
                <c:pt idx="8">
                  <c:v>77.17</c:v>
                </c:pt>
                <c:pt idx="9">
                  <c:v>120.05</c:v>
                </c:pt>
                <c:pt idx="10">
                  <c:v>180.07</c:v>
                </c:pt>
                <c:pt idx="11">
                  <c:v>231.52</c:v>
                </c:pt>
                <c:pt idx="12">
                  <c:v>282.95999999999998</c:v>
                </c:pt>
                <c:pt idx="13">
                  <c:v>137.19999999999999</c:v>
                </c:pt>
                <c:pt idx="14">
                  <c:v>162.91999999999999</c:v>
                </c:pt>
                <c:pt idx="15">
                  <c:v>240.09</c:v>
                </c:pt>
                <c:pt idx="16">
                  <c:v>240.09</c:v>
                </c:pt>
                <c:pt idx="17">
                  <c:v>137.19999999999999</c:v>
                </c:pt>
                <c:pt idx="18">
                  <c:v>145.77000000000001</c:v>
                </c:pt>
                <c:pt idx="19">
                  <c:v>85.75</c:v>
                </c:pt>
                <c:pt idx="20">
                  <c:v>119.45</c:v>
                </c:pt>
                <c:pt idx="21">
                  <c:v>136.51</c:v>
                </c:pt>
                <c:pt idx="22">
                  <c:v>162.11000000000001</c:v>
                </c:pt>
                <c:pt idx="23">
                  <c:v>76.790000000000006</c:v>
                </c:pt>
                <c:pt idx="24">
                  <c:v>110.92</c:v>
                </c:pt>
                <c:pt idx="25">
                  <c:v>204.77</c:v>
                </c:pt>
                <c:pt idx="26">
                  <c:v>145.05000000000001</c:v>
                </c:pt>
                <c:pt idx="27">
                  <c:v>153.58000000000001</c:v>
                </c:pt>
                <c:pt idx="28">
                  <c:v>93.85</c:v>
                </c:pt>
                <c:pt idx="29">
                  <c:v>102.39</c:v>
                </c:pt>
                <c:pt idx="30">
                  <c:v>136.51</c:v>
                </c:pt>
                <c:pt idx="31">
                  <c:v>179.18</c:v>
                </c:pt>
                <c:pt idx="32">
                  <c:v>238.9</c:v>
                </c:pt>
                <c:pt idx="33">
                  <c:v>170.64</c:v>
                </c:pt>
                <c:pt idx="34">
                  <c:v>119.45</c:v>
                </c:pt>
                <c:pt idx="35">
                  <c:v>85.32</c:v>
                </c:pt>
                <c:pt idx="36">
                  <c:v>93.85</c:v>
                </c:pt>
                <c:pt idx="37">
                  <c:v>119.45</c:v>
                </c:pt>
                <c:pt idx="38">
                  <c:v>76.790000000000006</c:v>
                </c:pt>
                <c:pt idx="39">
                  <c:v>196.24</c:v>
                </c:pt>
                <c:pt idx="40">
                  <c:v>167.82046</c:v>
                </c:pt>
                <c:pt idx="41">
                  <c:v>184.60249999999999</c:v>
                </c:pt>
                <c:pt idx="42">
                  <c:v>134.25635999999997</c:v>
                </c:pt>
                <c:pt idx="43">
                  <c:v>109.08330000000001</c:v>
                </c:pt>
                <c:pt idx="44">
                  <c:v>234.94864000000001</c:v>
                </c:pt>
                <c:pt idx="45">
                  <c:v>142.64739</c:v>
                </c:pt>
                <c:pt idx="46">
                  <c:v>109.08330000000001</c:v>
                </c:pt>
                <c:pt idx="47">
                  <c:v>100.69227000000001</c:v>
                </c:pt>
                <c:pt idx="48">
                  <c:v>117.47432000000001</c:v>
                </c:pt>
                <c:pt idx="49">
                  <c:v>109.08330000000001</c:v>
                </c:pt>
                <c:pt idx="50">
                  <c:v>125.86534</c:v>
                </c:pt>
                <c:pt idx="51">
                  <c:v>100.69227000000001</c:v>
                </c:pt>
                <c:pt idx="52">
                  <c:v>151.03841</c:v>
                </c:pt>
                <c:pt idx="53">
                  <c:v>201.38454999999999</c:v>
                </c:pt>
                <c:pt idx="54">
                  <c:v>67.128179999999986</c:v>
                </c:pt>
                <c:pt idx="55">
                  <c:v>159.42943</c:v>
                </c:pt>
                <c:pt idx="56">
                  <c:v>125.86534</c:v>
                </c:pt>
                <c:pt idx="57">
                  <c:v>151.03841</c:v>
                </c:pt>
                <c:pt idx="58">
                  <c:v>125.86534</c:v>
                </c:pt>
                <c:pt idx="59">
                  <c:v>134.25635999999997</c:v>
                </c:pt>
                <c:pt idx="60">
                  <c:v>225.5</c:v>
                </c:pt>
                <c:pt idx="61">
                  <c:v>171.38</c:v>
                </c:pt>
                <c:pt idx="62">
                  <c:v>117.26</c:v>
                </c:pt>
                <c:pt idx="63">
                  <c:v>198.44</c:v>
                </c:pt>
                <c:pt idx="64">
                  <c:v>135.30000000000001</c:v>
                </c:pt>
                <c:pt idx="65">
                  <c:v>180.4</c:v>
                </c:pt>
                <c:pt idx="66">
                  <c:v>153.34</c:v>
                </c:pt>
                <c:pt idx="67">
                  <c:v>117.26</c:v>
                </c:pt>
                <c:pt idx="68">
                  <c:v>252.56</c:v>
                </c:pt>
                <c:pt idx="69">
                  <c:v>189.42</c:v>
                </c:pt>
                <c:pt idx="70">
                  <c:v>171.38</c:v>
                </c:pt>
                <c:pt idx="71">
                  <c:v>126.28</c:v>
                </c:pt>
                <c:pt idx="72">
                  <c:v>153.34</c:v>
                </c:pt>
                <c:pt idx="73">
                  <c:v>171.38</c:v>
                </c:pt>
                <c:pt idx="74">
                  <c:v>180.4</c:v>
                </c:pt>
                <c:pt idx="75">
                  <c:v>144.32</c:v>
                </c:pt>
                <c:pt idx="76">
                  <c:v>153.34</c:v>
                </c:pt>
                <c:pt idx="77">
                  <c:v>81.180000000000007</c:v>
                </c:pt>
                <c:pt idx="78">
                  <c:v>81.180000000000007</c:v>
                </c:pt>
                <c:pt idx="79">
                  <c:v>144.32</c:v>
                </c:pt>
                <c:pt idx="80">
                  <c:v>170</c:v>
                </c:pt>
                <c:pt idx="81">
                  <c:v>190</c:v>
                </c:pt>
                <c:pt idx="82">
                  <c:v>90</c:v>
                </c:pt>
                <c:pt idx="83">
                  <c:v>130</c:v>
                </c:pt>
                <c:pt idx="84">
                  <c:v>170</c:v>
                </c:pt>
                <c:pt idx="85">
                  <c:v>190</c:v>
                </c:pt>
                <c:pt idx="86">
                  <c:v>140</c:v>
                </c:pt>
                <c:pt idx="87">
                  <c:v>120</c:v>
                </c:pt>
                <c:pt idx="88">
                  <c:v>120</c:v>
                </c:pt>
                <c:pt idx="89">
                  <c:v>260</c:v>
                </c:pt>
                <c:pt idx="90">
                  <c:v>210</c:v>
                </c:pt>
                <c:pt idx="91">
                  <c:v>190</c:v>
                </c:pt>
                <c:pt idx="92">
                  <c:v>120</c:v>
                </c:pt>
                <c:pt idx="93">
                  <c:v>120</c:v>
                </c:pt>
                <c:pt idx="94">
                  <c:v>80</c:v>
                </c:pt>
                <c:pt idx="95">
                  <c:v>160</c:v>
                </c:pt>
                <c:pt idx="96">
                  <c:v>160</c:v>
                </c:pt>
                <c:pt idx="97">
                  <c:v>50</c:v>
                </c:pt>
                <c:pt idx="98">
                  <c:v>120</c:v>
                </c:pt>
                <c:pt idx="99">
                  <c:v>210</c:v>
                </c:pt>
                <c:pt idx="100">
                  <c:v>151.88999999999999</c:v>
                </c:pt>
                <c:pt idx="101">
                  <c:v>111.39</c:v>
                </c:pt>
                <c:pt idx="102">
                  <c:v>111.39</c:v>
                </c:pt>
                <c:pt idx="103">
                  <c:v>232.9</c:v>
                </c:pt>
                <c:pt idx="104">
                  <c:v>192.39</c:v>
                </c:pt>
                <c:pt idx="105">
                  <c:v>91.13</c:v>
                </c:pt>
                <c:pt idx="106">
                  <c:v>222.77</c:v>
                </c:pt>
                <c:pt idx="107">
                  <c:v>162.02000000000001</c:v>
                </c:pt>
                <c:pt idx="108">
                  <c:v>162.02000000000001</c:v>
                </c:pt>
                <c:pt idx="109">
                  <c:v>111.39</c:v>
                </c:pt>
                <c:pt idx="110">
                  <c:v>192.39</c:v>
                </c:pt>
                <c:pt idx="111">
                  <c:v>162.02000000000001</c:v>
                </c:pt>
                <c:pt idx="112">
                  <c:v>243.02</c:v>
                </c:pt>
                <c:pt idx="113">
                  <c:v>415.17</c:v>
                </c:pt>
                <c:pt idx="114">
                  <c:v>263.27999999999997</c:v>
                </c:pt>
                <c:pt idx="115">
                  <c:v>243.02</c:v>
                </c:pt>
                <c:pt idx="116">
                  <c:v>263.27999999999997</c:v>
                </c:pt>
                <c:pt idx="117">
                  <c:v>222.77</c:v>
                </c:pt>
                <c:pt idx="118">
                  <c:v>131.63999999999999</c:v>
                </c:pt>
                <c:pt idx="119">
                  <c:v>202.52</c:v>
                </c:pt>
                <c:pt idx="120">
                  <c:v>122.31</c:v>
                </c:pt>
                <c:pt idx="121">
                  <c:v>122.31</c:v>
                </c:pt>
                <c:pt idx="122">
                  <c:v>142.69</c:v>
                </c:pt>
                <c:pt idx="123">
                  <c:v>71.349999999999994</c:v>
                </c:pt>
                <c:pt idx="124">
                  <c:v>101.92</c:v>
                </c:pt>
                <c:pt idx="125">
                  <c:v>142.69</c:v>
                </c:pt>
                <c:pt idx="126">
                  <c:v>101.92</c:v>
                </c:pt>
                <c:pt idx="127">
                  <c:v>132.5</c:v>
                </c:pt>
                <c:pt idx="128">
                  <c:v>132.5</c:v>
                </c:pt>
                <c:pt idx="129">
                  <c:v>173.27</c:v>
                </c:pt>
                <c:pt idx="130">
                  <c:v>122.31</c:v>
                </c:pt>
                <c:pt idx="131">
                  <c:v>163.08000000000001</c:v>
                </c:pt>
                <c:pt idx="132">
                  <c:v>101.92</c:v>
                </c:pt>
                <c:pt idx="133">
                  <c:v>112.12</c:v>
                </c:pt>
                <c:pt idx="134">
                  <c:v>101.92</c:v>
                </c:pt>
                <c:pt idx="135">
                  <c:v>163.08000000000001</c:v>
                </c:pt>
                <c:pt idx="136">
                  <c:v>163.08000000000001</c:v>
                </c:pt>
                <c:pt idx="137">
                  <c:v>101.92</c:v>
                </c:pt>
                <c:pt idx="138">
                  <c:v>112.12</c:v>
                </c:pt>
                <c:pt idx="139">
                  <c:v>183.46</c:v>
                </c:pt>
                <c:pt idx="140">
                  <c:v>102.3</c:v>
                </c:pt>
                <c:pt idx="141">
                  <c:v>61.38</c:v>
                </c:pt>
                <c:pt idx="142">
                  <c:v>102.3</c:v>
                </c:pt>
                <c:pt idx="143">
                  <c:v>71.61</c:v>
                </c:pt>
                <c:pt idx="144">
                  <c:v>112.54</c:v>
                </c:pt>
                <c:pt idx="145">
                  <c:v>81.84</c:v>
                </c:pt>
                <c:pt idx="146">
                  <c:v>153.46</c:v>
                </c:pt>
                <c:pt idx="147">
                  <c:v>51.15</c:v>
                </c:pt>
                <c:pt idx="148">
                  <c:v>92.07</c:v>
                </c:pt>
                <c:pt idx="149">
                  <c:v>112.54</c:v>
                </c:pt>
                <c:pt idx="150">
                  <c:v>92.07</c:v>
                </c:pt>
                <c:pt idx="151">
                  <c:v>92.07</c:v>
                </c:pt>
                <c:pt idx="152">
                  <c:v>92.07</c:v>
                </c:pt>
                <c:pt idx="153">
                  <c:v>214.84</c:v>
                </c:pt>
                <c:pt idx="154">
                  <c:v>71.61</c:v>
                </c:pt>
                <c:pt idx="155">
                  <c:v>184.15</c:v>
                </c:pt>
                <c:pt idx="156">
                  <c:v>163.69</c:v>
                </c:pt>
                <c:pt idx="157">
                  <c:v>122.77</c:v>
                </c:pt>
                <c:pt idx="158">
                  <c:v>61.38</c:v>
                </c:pt>
                <c:pt idx="159">
                  <c:v>143.22999999999999</c:v>
                </c:pt>
                <c:pt idx="160">
                  <c:v>132.58000000000001</c:v>
                </c:pt>
                <c:pt idx="161">
                  <c:v>112.18</c:v>
                </c:pt>
                <c:pt idx="162">
                  <c:v>122.38</c:v>
                </c:pt>
                <c:pt idx="163">
                  <c:v>101.98</c:v>
                </c:pt>
                <c:pt idx="164">
                  <c:v>122.38</c:v>
                </c:pt>
                <c:pt idx="165">
                  <c:v>214.16</c:v>
                </c:pt>
                <c:pt idx="166">
                  <c:v>183.57</c:v>
                </c:pt>
                <c:pt idx="167">
                  <c:v>183.57</c:v>
                </c:pt>
                <c:pt idx="168">
                  <c:v>142.77000000000001</c:v>
                </c:pt>
                <c:pt idx="169">
                  <c:v>173.37</c:v>
                </c:pt>
                <c:pt idx="170">
                  <c:v>152.97</c:v>
                </c:pt>
                <c:pt idx="171">
                  <c:v>265.14999999999998</c:v>
                </c:pt>
                <c:pt idx="172">
                  <c:v>122.38</c:v>
                </c:pt>
                <c:pt idx="173">
                  <c:v>132.58000000000001</c:v>
                </c:pt>
                <c:pt idx="174">
                  <c:v>214.16</c:v>
                </c:pt>
                <c:pt idx="175">
                  <c:v>71.39</c:v>
                </c:pt>
                <c:pt idx="176">
                  <c:v>81.59</c:v>
                </c:pt>
                <c:pt idx="177">
                  <c:v>91.78</c:v>
                </c:pt>
                <c:pt idx="178">
                  <c:v>132.58000000000001</c:v>
                </c:pt>
                <c:pt idx="179">
                  <c:v>173.37</c:v>
                </c:pt>
                <c:pt idx="180">
                  <c:v>91.48</c:v>
                </c:pt>
                <c:pt idx="181">
                  <c:v>81.319999999999993</c:v>
                </c:pt>
                <c:pt idx="182">
                  <c:v>121.98</c:v>
                </c:pt>
                <c:pt idx="183">
                  <c:v>60.99</c:v>
                </c:pt>
                <c:pt idx="184">
                  <c:v>111.81</c:v>
                </c:pt>
                <c:pt idx="185">
                  <c:v>91.48</c:v>
                </c:pt>
                <c:pt idx="186">
                  <c:v>121.98</c:v>
                </c:pt>
                <c:pt idx="187">
                  <c:v>152.47</c:v>
                </c:pt>
                <c:pt idx="188">
                  <c:v>81.319999999999993</c:v>
                </c:pt>
                <c:pt idx="189">
                  <c:v>71.150000000000006</c:v>
                </c:pt>
                <c:pt idx="190">
                  <c:v>111.81</c:v>
                </c:pt>
                <c:pt idx="191">
                  <c:v>213.46</c:v>
                </c:pt>
                <c:pt idx="192">
                  <c:v>81.319999999999993</c:v>
                </c:pt>
                <c:pt idx="193">
                  <c:v>142.31</c:v>
                </c:pt>
                <c:pt idx="194">
                  <c:v>132.13999999999999</c:v>
                </c:pt>
                <c:pt idx="195">
                  <c:v>132.13999999999999</c:v>
                </c:pt>
                <c:pt idx="196">
                  <c:v>101.65</c:v>
                </c:pt>
                <c:pt idx="197">
                  <c:v>40.659999999999997</c:v>
                </c:pt>
                <c:pt idx="198">
                  <c:v>50.82</c:v>
                </c:pt>
                <c:pt idx="199">
                  <c:v>60.99</c:v>
                </c:pt>
                <c:pt idx="200">
                  <c:v>112.62</c:v>
                </c:pt>
                <c:pt idx="201">
                  <c:v>143.33000000000001</c:v>
                </c:pt>
                <c:pt idx="202">
                  <c:v>122.85</c:v>
                </c:pt>
                <c:pt idx="203">
                  <c:v>92.14</c:v>
                </c:pt>
                <c:pt idx="204">
                  <c:v>61.43</c:v>
                </c:pt>
                <c:pt idx="205">
                  <c:v>61.43</c:v>
                </c:pt>
                <c:pt idx="206">
                  <c:v>122.85</c:v>
                </c:pt>
                <c:pt idx="207">
                  <c:v>133.09</c:v>
                </c:pt>
                <c:pt idx="208">
                  <c:v>112.62</c:v>
                </c:pt>
                <c:pt idx="209">
                  <c:v>143.33000000000001</c:v>
                </c:pt>
                <c:pt idx="210">
                  <c:v>214.99</c:v>
                </c:pt>
                <c:pt idx="211">
                  <c:v>92.14</c:v>
                </c:pt>
                <c:pt idx="212">
                  <c:v>51.19</c:v>
                </c:pt>
                <c:pt idx="213">
                  <c:v>102.38</c:v>
                </c:pt>
                <c:pt idx="214">
                  <c:v>143.33000000000001</c:v>
                </c:pt>
                <c:pt idx="215">
                  <c:v>163.81</c:v>
                </c:pt>
                <c:pt idx="216">
                  <c:v>143.33000000000001</c:v>
                </c:pt>
                <c:pt idx="217">
                  <c:v>194.52</c:v>
                </c:pt>
                <c:pt idx="218">
                  <c:v>112.62</c:v>
                </c:pt>
                <c:pt idx="219">
                  <c:v>92.14</c:v>
                </c:pt>
                <c:pt idx="220">
                  <c:v>179.18</c:v>
                </c:pt>
                <c:pt idx="221">
                  <c:v>188.61</c:v>
                </c:pt>
                <c:pt idx="222">
                  <c:v>103.73</c:v>
                </c:pt>
                <c:pt idx="223">
                  <c:v>103.73</c:v>
                </c:pt>
                <c:pt idx="224">
                  <c:v>254.62</c:v>
                </c:pt>
                <c:pt idx="225">
                  <c:v>216.9</c:v>
                </c:pt>
                <c:pt idx="226">
                  <c:v>113.16</c:v>
                </c:pt>
                <c:pt idx="227">
                  <c:v>179.18</c:v>
                </c:pt>
                <c:pt idx="228">
                  <c:v>132.03</c:v>
                </c:pt>
                <c:pt idx="229">
                  <c:v>150.88999999999999</c:v>
                </c:pt>
                <c:pt idx="230">
                  <c:v>103.73</c:v>
                </c:pt>
                <c:pt idx="231">
                  <c:v>113.16</c:v>
                </c:pt>
                <c:pt idx="232">
                  <c:v>113.16</c:v>
                </c:pt>
                <c:pt idx="233">
                  <c:v>150.88999999999999</c:v>
                </c:pt>
                <c:pt idx="234">
                  <c:v>132.03</c:v>
                </c:pt>
                <c:pt idx="235">
                  <c:v>84.87</c:v>
                </c:pt>
                <c:pt idx="236">
                  <c:v>66.010000000000005</c:v>
                </c:pt>
                <c:pt idx="237">
                  <c:v>358.35</c:v>
                </c:pt>
                <c:pt idx="238">
                  <c:v>245.19</c:v>
                </c:pt>
                <c:pt idx="239">
                  <c:v>188.61</c:v>
                </c:pt>
                <c:pt idx="240">
                  <c:v>195.32</c:v>
                </c:pt>
                <c:pt idx="241">
                  <c:v>130.21</c:v>
                </c:pt>
                <c:pt idx="242">
                  <c:v>120.91</c:v>
                </c:pt>
                <c:pt idx="243">
                  <c:v>148.81</c:v>
                </c:pt>
                <c:pt idx="244">
                  <c:v>120.91</c:v>
                </c:pt>
                <c:pt idx="245">
                  <c:v>74.41</c:v>
                </c:pt>
                <c:pt idx="246">
                  <c:v>102.31</c:v>
                </c:pt>
                <c:pt idx="247">
                  <c:v>83.71</c:v>
                </c:pt>
                <c:pt idx="248">
                  <c:v>111.61</c:v>
                </c:pt>
                <c:pt idx="249">
                  <c:v>241.82</c:v>
                </c:pt>
                <c:pt idx="250">
                  <c:v>195.32</c:v>
                </c:pt>
                <c:pt idx="251">
                  <c:v>186.02</c:v>
                </c:pt>
                <c:pt idx="252">
                  <c:v>102.31</c:v>
                </c:pt>
                <c:pt idx="253">
                  <c:v>139.51</c:v>
                </c:pt>
                <c:pt idx="254">
                  <c:v>195.32</c:v>
                </c:pt>
                <c:pt idx="255">
                  <c:v>83.71</c:v>
                </c:pt>
                <c:pt idx="256">
                  <c:v>83.71</c:v>
                </c:pt>
                <c:pt idx="257">
                  <c:v>167.42</c:v>
                </c:pt>
                <c:pt idx="258">
                  <c:v>148.81</c:v>
                </c:pt>
                <c:pt idx="259">
                  <c:v>148.81</c:v>
                </c:pt>
                <c:pt idx="260">
                  <c:v>176.79</c:v>
                </c:pt>
                <c:pt idx="261">
                  <c:v>148.87</c:v>
                </c:pt>
                <c:pt idx="262">
                  <c:v>158.18</c:v>
                </c:pt>
                <c:pt idx="263">
                  <c:v>120.96</c:v>
                </c:pt>
                <c:pt idx="264">
                  <c:v>158.18</c:v>
                </c:pt>
                <c:pt idx="265">
                  <c:v>148.87</c:v>
                </c:pt>
                <c:pt idx="266">
                  <c:v>167.48</c:v>
                </c:pt>
                <c:pt idx="267">
                  <c:v>130.26</c:v>
                </c:pt>
                <c:pt idx="268">
                  <c:v>148.87</c:v>
                </c:pt>
                <c:pt idx="269">
                  <c:v>139.57</c:v>
                </c:pt>
                <c:pt idx="270">
                  <c:v>148.87</c:v>
                </c:pt>
                <c:pt idx="271">
                  <c:v>148.87</c:v>
                </c:pt>
                <c:pt idx="272">
                  <c:v>139.57</c:v>
                </c:pt>
                <c:pt idx="273">
                  <c:v>186.09</c:v>
                </c:pt>
                <c:pt idx="274">
                  <c:v>176.79</c:v>
                </c:pt>
                <c:pt idx="275">
                  <c:v>214.01</c:v>
                </c:pt>
                <c:pt idx="276">
                  <c:v>288.44</c:v>
                </c:pt>
                <c:pt idx="277">
                  <c:v>83.74</c:v>
                </c:pt>
                <c:pt idx="278">
                  <c:v>158.18</c:v>
                </c:pt>
                <c:pt idx="279">
                  <c:v>223.31</c:v>
                </c:pt>
                <c:pt idx="280">
                  <c:v>129.33000000000001</c:v>
                </c:pt>
                <c:pt idx="281">
                  <c:v>159.18</c:v>
                </c:pt>
                <c:pt idx="282">
                  <c:v>198.98</c:v>
                </c:pt>
                <c:pt idx="283">
                  <c:v>179.08</c:v>
                </c:pt>
                <c:pt idx="284">
                  <c:v>79.59</c:v>
                </c:pt>
                <c:pt idx="285">
                  <c:v>139.28</c:v>
                </c:pt>
                <c:pt idx="286">
                  <c:v>119.39</c:v>
                </c:pt>
                <c:pt idx="287">
                  <c:v>79.59</c:v>
                </c:pt>
                <c:pt idx="288">
                  <c:v>198.98</c:v>
                </c:pt>
                <c:pt idx="289">
                  <c:v>238.77</c:v>
                </c:pt>
                <c:pt idx="290">
                  <c:v>208.93</c:v>
                </c:pt>
                <c:pt idx="291">
                  <c:v>208.93</c:v>
                </c:pt>
                <c:pt idx="292">
                  <c:v>79.59</c:v>
                </c:pt>
                <c:pt idx="293">
                  <c:v>129.33000000000001</c:v>
                </c:pt>
                <c:pt idx="294">
                  <c:v>129.33000000000001</c:v>
                </c:pt>
                <c:pt idx="295">
                  <c:v>208.93</c:v>
                </c:pt>
                <c:pt idx="296">
                  <c:v>139.28</c:v>
                </c:pt>
                <c:pt idx="297">
                  <c:v>69.64</c:v>
                </c:pt>
                <c:pt idx="298">
                  <c:v>89.54</c:v>
                </c:pt>
                <c:pt idx="299">
                  <c:v>198.98</c:v>
                </c:pt>
                <c:pt idx="300">
                  <c:v>98.04</c:v>
                </c:pt>
                <c:pt idx="301">
                  <c:v>176.47</c:v>
                </c:pt>
                <c:pt idx="302">
                  <c:v>156.86000000000001</c:v>
                </c:pt>
                <c:pt idx="303">
                  <c:v>137.25</c:v>
                </c:pt>
                <c:pt idx="304">
                  <c:v>156.86000000000001</c:v>
                </c:pt>
                <c:pt idx="305">
                  <c:v>196.08</c:v>
                </c:pt>
                <c:pt idx="306">
                  <c:v>205.88</c:v>
                </c:pt>
                <c:pt idx="307">
                  <c:v>107.84</c:v>
                </c:pt>
                <c:pt idx="308">
                  <c:v>78.430000000000007</c:v>
                </c:pt>
                <c:pt idx="309">
                  <c:v>147.06</c:v>
                </c:pt>
                <c:pt idx="310">
                  <c:v>127.45</c:v>
                </c:pt>
                <c:pt idx="311">
                  <c:v>147.06</c:v>
                </c:pt>
                <c:pt idx="312">
                  <c:v>166.67</c:v>
                </c:pt>
                <c:pt idx="313">
                  <c:v>107.84</c:v>
                </c:pt>
                <c:pt idx="314">
                  <c:v>117.65</c:v>
                </c:pt>
                <c:pt idx="315">
                  <c:v>156.86000000000001</c:v>
                </c:pt>
                <c:pt idx="316">
                  <c:v>254.9</c:v>
                </c:pt>
                <c:pt idx="317">
                  <c:v>147.06</c:v>
                </c:pt>
                <c:pt idx="318">
                  <c:v>88.24</c:v>
                </c:pt>
                <c:pt idx="319">
                  <c:v>107.84</c:v>
                </c:pt>
                <c:pt idx="320">
                  <c:v>120.84</c:v>
                </c:pt>
                <c:pt idx="321">
                  <c:v>100.7</c:v>
                </c:pt>
                <c:pt idx="322">
                  <c:v>70.489999999999995</c:v>
                </c:pt>
                <c:pt idx="323">
                  <c:v>161.12</c:v>
                </c:pt>
                <c:pt idx="324">
                  <c:v>100.7</c:v>
                </c:pt>
                <c:pt idx="325">
                  <c:v>161.12</c:v>
                </c:pt>
                <c:pt idx="326">
                  <c:v>241.68</c:v>
                </c:pt>
                <c:pt idx="327">
                  <c:v>130.91</c:v>
                </c:pt>
                <c:pt idx="328">
                  <c:v>120.84</c:v>
                </c:pt>
                <c:pt idx="329">
                  <c:v>130.91</c:v>
                </c:pt>
                <c:pt idx="330">
                  <c:v>140.97999999999999</c:v>
                </c:pt>
                <c:pt idx="331">
                  <c:v>161.12</c:v>
                </c:pt>
                <c:pt idx="332">
                  <c:v>110.77</c:v>
                </c:pt>
                <c:pt idx="333">
                  <c:v>110.77</c:v>
                </c:pt>
                <c:pt idx="334">
                  <c:v>100.7</c:v>
                </c:pt>
                <c:pt idx="335">
                  <c:v>211.47</c:v>
                </c:pt>
                <c:pt idx="336">
                  <c:v>241.68</c:v>
                </c:pt>
                <c:pt idx="337">
                  <c:v>151.05000000000001</c:v>
                </c:pt>
                <c:pt idx="338">
                  <c:v>191.33</c:v>
                </c:pt>
                <c:pt idx="339">
                  <c:v>130.91</c:v>
                </c:pt>
                <c:pt idx="340">
                  <c:v>221.68</c:v>
                </c:pt>
                <c:pt idx="341">
                  <c:v>211.6</c:v>
                </c:pt>
                <c:pt idx="342">
                  <c:v>201.53</c:v>
                </c:pt>
                <c:pt idx="343">
                  <c:v>110.84</c:v>
                </c:pt>
                <c:pt idx="344">
                  <c:v>90.69</c:v>
                </c:pt>
                <c:pt idx="345">
                  <c:v>130.99</c:v>
                </c:pt>
                <c:pt idx="346">
                  <c:v>80.61</c:v>
                </c:pt>
                <c:pt idx="347">
                  <c:v>100.76</c:v>
                </c:pt>
                <c:pt idx="348">
                  <c:v>70.53</c:v>
                </c:pt>
                <c:pt idx="349">
                  <c:v>241.83</c:v>
                </c:pt>
                <c:pt idx="350">
                  <c:v>90.69</c:v>
                </c:pt>
                <c:pt idx="351">
                  <c:v>120.92</c:v>
                </c:pt>
                <c:pt idx="352">
                  <c:v>191.45</c:v>
                </c:pt>
                <c:pt idx="353">
                  <c:v>151.13999999999999</c:v>
                </c:pt>
                <c:pt idx="354">
                  <c:v>151.13999999999999</c:v>
                </c:pt>
                <c:pt idx="355">
                  <c:v>161.22</c:v>
                </c:pt>
                <c:pt idx="356">
                  <c:v>151.13999999999999</c:v>
                </c:pt>
                <c:pt idx="357">
                  <c:v>80.61</c:v>
                </c:pt>
                <c:pt idx="358">
                  <c:v>181.37</c:v>
                </c:pt>
                <c:pt idx="359">
                  <c:v>100.76</c:v>
                </c:pt>
                <c:pt idx="360">
                  <c:v>251.13</c:v>
                </c:pt>
                <c:pt idx="361">
                  <c:v>110.5</c:v>
                </c:pt>
                <c:pt idx="362">
                  <c:v>140.63</c:v>
                </c:pt>
                <c:pt idx="363">
                  <c:v>140.63</c:v>
                </c:pt>
                <c:pt idx="364">
                  <c:v>160.72</c:v>
                </c:pt>
                <c:pt idx="365">
                  <c:v>110.5</c:v>
                </c:pt>
                <c:pt idx="366">
                  <c:v>130.59</c:v>
                </c:pt>
                <c:pt idx="367">
                  <c:v>110.5</c:v>
                </c:pt>
                <c:pt idx="368">
                  <c:v>120.54</c:v>
                </c:pt>
                <c:pt idx="369">
                  <c:v>60.27</c:v>
                </c:pt>
                <c:pt idx="370">
                  <c:v>170.77</c:v>
                </c:pt>
                <c:pt idx="371">
                  <c:v>140.63</c:v>
                </c:pt>
                <c:pt idx="372">
                  <c:v>60.27</c:v>
                </c:pt>
                <c:pt idx="373">
                  <c:v>160.72</c:v>
                </c:pt>
                <c:pt idx="374">
                  <c:v>70.319999999999993</c:v>
                </c:pt>
                <c:pt idx="375">
                  <c:v>70.319999999999993</c:v>
                </c:pt>
                <c:pt idx="376">
                  <c:v>90.41</c:v>
                </c:pt>
                <c:pt idx="377">
                  <c:v>90.41</c:v>
                </c:pt>
                <c:pt idx="378">
                  <c:v>210.95</c:v>
                </c:pt>
                <c:pt idx="379">
                  <c:v>180.82</c:v>
                </c:pt>
                <c:pt idx="380">
                  <c:v>147.464</c:v>
                </c:pt>
                <c:pt idx="381">
                  <c:v>108.14000000000001</c:v>
                </c:pt>
                <c:pt idx="382">
                  <c:v>88.477999999999994</c:v>
                </c:pt>
                <c:pt idx="383">
                  <c:v>196.619</c:v>
                </c:pt>
                <c:pt idx="384">
                  <c:v>98.308999999999997</c:v>
                </c:pt>
                <c:pt idx="385">
                  <c:v>108.14000000000001</c:v>
                </c:pt>
                <c:pt idx="386">
                  <c:v>137.63299999999998</c:v>
                </c:pt>
                <c:pt idx="387">
                  <c:v>157.29500000000002</c:v>
                </c:pt>
                <c:pt idx="388">
                  <c:v>176.95699999999999</c:v>
                </c:pt>
                <c:pt idx="389">
                  <c:v>117.971</c:v>
                </c:pt>
                <c:pt idx="390">
                  <c:v>157.29500000000002</c:v>
                </c:pt>
                <c:pt idx="391">
                  <c:v>127.80199999999999</c:v>
                </c:pt>
                <c:pt idx="392">
                  <c:v>117.971</c:v>
                </c:pt>
                <c:pt idx="393">
                  <c:v>167.126</c:v>
                </c:pt>
                <c:pt idx="394">
                  <c:v>147.464</c:v>
                </c:pt>
                <c:pt idx="395">
                  <c:v>117.971</c:v>
                </c:pt>
                <c:pt idx="396">
                  <c:v>226.11100000000002</c:v>
                </c:pt>
                <c:pt idx="397">
                  <c:v>157.29500000000002</c:v>
                </c:pt>
                <c:pt idx="398">
                  <c:v>176.95699999999999</c:v>
                </c:pt>
                <c:pt idx="399">
                  <c:v>255.60399999999998</c:v>
                </c:pt>
              </c:numCache>
            </c:numRef>
          </c:xVal>
          <c:yVal>
            <c:numRef>
              <c:f>ベレ散布図!$C$4:$C$403</c:f>
              <c:numCache>
                <c:formatCode>General</c:formatCode>
                <c:ptCount val="400"/>
                <c:pt idx="0">
                  <c:v>411.59</c:v>
                </c:pt>
                <c:pt idx="1">
                  <c:v>202.37</c:v>
                </c:pt>
                <c:pt idx="2">
                  <c:v>161.1</c:v>
                </c:pt>
                <c:pt idx="3">
                  <c:v>200.73</c:v>
                </c:pt>
                <c:pt idx="4">
                  <c:v>510.03</c:v>
                </c:pt>
                <c:pt idx="5">
                  <c:v>188.64</c:v>
                </c:pt>
                <c:pt idx="6">
                  <c:v>171.49</c:v>
                </c:pt>
                <c:pt idx="7">
                  <c:v>128.62</c:v>
                </c:pt>
                <c:pt idx="8">
                  <c:v>94.32</c:v>
                </c:pt>
                <c:pt idx="9">
                  <c:v>205.79</c:v>
                </c:pt>
                <c:pt idx="10">
                  <c:v>231.52</c:v>
                </c:pt>
                <c:pt idx="11">
                  <c:v>248.67</c:v>
                </c:pt>
                <c:pt idx="12">
                  <c:v>480.18</c:v>
                </c:pt>
                <c:pt idx="13">
                  <c:v>214.37</c:v>
                </c:pt>
                <c:pt idx="14">
                  <c:v>274.39</c:v>
                </c:pt>
                <c:pt idx="15">
                  <c:v>377.29</c:v>
                </c:pt>
                <c:pt idx="16">
                  <c:v>291.08999999999997</c:v>
                </c:pt>
                <c:pt idx="17">
                  <c:v>188.64</c:v>
                </c:pt>
                <c:pt idx="18">
                  <c:v>214.37</c:v>
                </c:pt>
                <c:pt idx="19">
                  <c:v>308.69</c:v>
                </c:pt>
                <c:pt idx="20">
                  <c:v>187.71</c:v>
                </c:pt>
                <c:pt idx="21">
                  <c:v>204.77</c:v>
                </c:pt>
                <c:pt idx="22">
                  <c:v>153.58000000000001</c:v>
                </c:pt>
                <c:pt idx="23">
                  <c:v>153.58000000000001</c:v>
                </c:pt>
                <c:pt idx="24">
                  <c:v>127.98</c:v>
                </c:pt>
                <c:pt idx="25">
                  <c:v>349.82</c:v>
                </c:pt>
                <c:pt idx="26">
                  <c:v>213.3</c:v>
                </c:pt>
                <c:pt idx="27">
                  <c:v>273.02999999999997</c:v>
                </c:pt>
                <c:pt idx="28">
                  <c:v>230.37</c:v>
                </c:pt>
                <c:pt idx="29">
                  <c:v>230.37</c:v>
                </c:pt>
                <c:pt idx="30">
                  <c:v>238.9</c:v>
                </c:pt>
                <c:pt idx="31">
                  <c:v>341.29</c:v>
                </c:pt>
                <c:pt idx="32">
                  <c:v>349.82</c:v>
                </c:pt>
                <c:pt idx="33">
                  <c:v>281.56</c:v>
                </c:pt>
                <c:pt idx="34">
                  <c:v>213.3</c:v>
                </c:pt>
                <c:pt idx="35">
                  <c:v>187.71</c:v>
                </c:pt>
                <c:pt idx="36">
                  <c:v>85.32</c:v>
                </c:pt>
                <c:pt idx="37">
                  <c:v>153.58000000000001</c:v>
                </c:pt>
                <c:pt idx="38">
                  <c:v>110.92</c:v>
                </c:pt>
                <c:pt idx="39">
                  <c:v>187.71</c:v>
                </c:pt>
                <c:pt idx="40">
                  <c:v>159.42943</c:v>
                </c:pt>
                <c:pt idx="41">
                  <c:v>209.77557000000002</c:v>
                </c:pt>
                <c:pt idx="42">
                  <c:v>234.94864000000001</c:v>
                </c:pt>
                <c:pt idx="43">
                  <c:v>176.21148000000002</c:v>
                </c:pt>
                <c:pt idx="44">
                  <c:v>318.85886999999997</c:v>
                </c:pt>
                <c:pt idx="45">
                  <c:v>151.03841</c:v>
                </c:pt>
                <c:pt idx="46">
                  <c:v>117.47432000000001</c:v>
                </c:pt>
                <c:pt idx="47">
                  <c:v>167.82046</c:v>
                </c:pt>
                <c:pt idx="48">
                  <c:v>184.60249999999999</c:v>
                </c:pt>
                <c:pt idx="49">
                  <c:v>167.82046</c:v>
                </c:pt>
                <c:pt idx="50">
                  <c:v>192.99351999999999</c:v>
                </c:pt>
                <c:pt idx="51">
                  <c:v>100.69227000000001</c:v>
                </c:pt>
                <c:pt idx="52">
                  <c:v>100.69227000000001</c:v>
                </c:pt>
                <c:pt idx="53">
                  <c:v>167.82046</c:v>
                </c:pt>
                <c:pt idx="54">
                  <c:v>92.301249999999996</c:v>
                </c:pt>
                <c:pt idx="55">
                  <c:v>176.21148000000002</c:v>
                </c:pt>
                <c:pt idx="56">
                  <c:v>117.47432000000001</c:v>
                </c:pt>
                <c:pt idx="57">
                  <c:v>75.519210000000001</c:v>
                </c:pt>
                <c:pt idx="58">
                  <c:v>92.301249999999996</c:v>
                </c:pt>
                <c:pt idx="59">
                  <c:v>251.73068000000001</c:v>
                </c:pt>
                <c:pt idx="60">
                  <c:v>288.63</c:v>
                </c:pt>
                <c:pt idx="61">
                  <c:v>171.38</c:v>
                </c:pt>
                <c:pt idx="62">
                  <c:v>189.42</c:v>
                </c:pt>
                <c:pt idx="63">
                  <c:v>207.46</c:v>
                </c:pt>
                <c:pt idx="64">
                  <c:v>270.60000000000002</c:v>
                </c:pt>
                <c:pt idx="65">
                  <c:v>162.36000000000001</c:v>
                </c:pt>
                <c:pt idx="66">
                  <c:v>252.56</c:v>
                </c:pt>
                <c:pt idx="67">
                  <c:v>261.58</c:v>
                </c:pt>
                <c:pt idx="68">
                  <c:v>450.99</c:v>
                </c:pt>
                <c:pt idx="69">
                  <c:v>189.42</c:v>
                </c:pt>
                <c:pt idx="70">
                  <c:v>234.52</c:v>
                </c:pt>
                <c:pt idx="71">
                  <c:v>162.36000000000001</c:v>
                </c:pt>
                <c:pt idx="72">
                  <c:v>261.58</c:v>
                </c:pt>
                <c:pt idx="73">
                  <c:v>396.87</c:v>
                </c:pt>
                <c:pt idx="74">
                  <c:v>369.81</c:v>
                </c:pt>
                <c:pt idx="75">
                  <c:v>162.36000000000001</c:v>
                </c:pt>
                <c:pt idx="76">
                  <c:v>180.4</c:v>
                </c:pt>
                <c:pt idx="77">
                  <c:v>99.22</c:v>
                </c:pt>
                <c:pt idx="78">
                  <c:v>108.24</c:v>
                </c:pt>
                <c:pt idx="79">
                  <c:v>198.44</c:v>
                </c:pt>
                <c:pt idx="80">
                  <c:v>210</c:v>
                </c:pt>
                <c:pt idx="81">
                  <c:v>230</c:v>
                </c:pt>
                <c:pt idx="82">
                  <c:v>130</c:v>
                </c:pt>
                <c:pt idx="83">
                  <c:v>200</c:v>
                </c:pt>
                <c:pt idx="84">
                  <c:v>400</c:v>
                </c:pt>
                <c:pt idx="85">
                  <c:v>440</c:v>
                </c:pt>
                <c:pt idx="86">
                  <c:v>210</c:v>
                </c:pt>
                <c:pt idx="87">
                  <c:v>170</c:v>
                </c:pt>
                <c:pt idx="88">
                  <c:v>120</c:v>
                </c:pt>
                <c:pt idx="89">
                  <c:v>250</c:v>
                </c:pt>
                <c:pt idx="90">
                  <c:v>220</c:v>
                </c:pt>
                <c:pt idx="91">
                  <c:v>170</c:v>
                </c:pt>
                <c:pt idx="92">
                  <c:v>110</c:v>
                </c:pt>
                <c:pt idx="93">
                  <c:v>150</c:v>
                </c:pt>
                <c:pt idx="94">
                  <c:v>90</c:v>
                </c:pt>
                <c:pt idx="95">
                  <c:v>200</c:v>
                </c:pt>
                <c:pt idx="96">
                  <c:v>190</c:v>
                </c:pt>
                <c:pt idx="97">
                  <c:v>100</c:v>
                </c:pt>
                <c:pt idx="98">
                  <c:v>110</c:v>
                </c:pt>
                <c:pt idx="99">
                  <c:v>210</c:v>
                </c:pt>
                <c:pt idx="100">
                  <c:v>111.39</c:v>
                </c:pt>
                <c:pt idx="101">
                  <c:v>81.010000000000005</c:v>
                </c:pt>
                <c:pt idx="102">
                  <c:v>111.39</c:v>
                </c:pt>
                <c:pt idx="103">
                  <c:v>283.52999999999997</c:v>
                </c:pt>
                <c:pt idx="104">
                  <c:v>283.52999999999997</c:v>
                </c:pt>
                <c:pt idx="105">
                  <c:v>91.13</c:v>
                </c:pt>
                <c:pt idx="106">
                  <c:v>222.77</c:v>
                </c:pt>
                <c:pt idx="107">
                  <c:v>162.02000000000001</c:v>
                </c:pt>
                <c:pt idx="108">
                  <c:v>212.65</c:v>
                </c:pt>
                <c:pt idx="109">
                  <c:v>141.76</c:v>
                </c:pt>
                <c:pt idx="110">
                  <c:v>212.65</c:v>
                </c:pt>
                <c:pt idx="111">
                  <c:v>253.15</c:v>
                </c:pt>
                <c:pt idx="112">
                  <c:v>243.02</c:v>
                </c:pt>
                <c:pt idx="113">
                  <c:v>475.92</c:v>
                </c:pt>
                <c:pt idx="114">
                  <c:v>293.66000000000003</c:v>
                </c:pt>
                <c:pt idx="115">
                  <c:v>111.39</c:v>
                </c:pt>
                <c:pt idx="116">
                  <c:v>192.39</c:v>
                </c:pt>
                <c:pt idx="117">
                  <c:v>303.77999999999997</c:v>
                </c:pt>
                <c:pt idx="118">
                  <c:v>313.91000000000003</c:v>
                </c:pt>
                <c:pt idx="119">
                  <c:v>303.77999999999997</c:v>
                </c:pt>
                <c:pt idx="120">
                  <c:v>183.46</c:v>
                </c:pt>
                <c:pt idx="121">
                  <c:v>265</c:v>
                </c:pt>
                <c:pt idx="122">
                  <c:v>315.97000000000003</c:v>
                </c:pt>
                <c:pt idx="123">
                  <c:v>122.31</c:v>
                </c:pt>
                <c:pt idx="124">
                  <c:v>152.88999999999999</c:v>
                </c:pt>
                <c:pt idx="125">
                  <c:v>265</c:v>
                </c:pt>
                <c:pt idx="126">
                  <c:v>224.23</c:v>
                </c:pt>
                <c:pt idx="127">
                  <c:v>152.88999999999999</c:v>
                </c:pt>
                <c:pt idx="128">
                  <c:v>91.73</c:v>
                </c:pt>
                <c:pt idx="129">
                  <c:v>224.23</c:v>
                </c:pt>
                <c:pt idx="130">
                  <c:v>275.2</c:v>
                </c:pt>
                <c:pt idx="131">
                  <c:v>326.16000000000003</c:v>
                </c:pt>
                <c:pt idx="132">
                  <c:v>132.5</c:v>
                </c:pt>
                <c:pt idx="133">
                  <c:v>163.08000000000001</c:v>
                </c:pt>
                <c:pt idx="134">
                  <c:v>132.5</c:v>
                </c:pt>
                <c:pt idx="135">
                  <c:v>234.43</c:v>
                </c:pt>
                <c:pt idx="136">
                  <c:v>275.2</c:v>
                </c:pt>
                <c:pt idx="137">
                  <c:v>214.04</c:v>
                </c:pt>
                <c:pt idx="138">
                  <c:v>142.69</c:v>
                </c:pt>
                <c:pt idx="139">
                  <c:v>234.43</c:v>
                </c:pt>
                <c:pt idx="140">
                  <c:v>214.84</c:v>
                </c:pt>
                <c:pt idx="141">
                  <c:v>81.84</c:v>
                </c:pt>
                <c:pt idx="142">
                  <c:v>153.46</c:v>
                </c:pt>
                <c:pt idx="143">
                  <c:v>122.77</c:v>
                </c:pt>
                <c:pt idx="144">
                  <c:v>163.69</c:v>
                </c:pt>
                <c:pt idx="145">
                  <c:v>92.07</c:v>
                </c:pt>
                <c:pt idx="146">
                  <c:v>255.76</c:v>
                </c:pt>
                <c:pt idx="147">
                  <c:v>92.07</c:v>
                </c:pt>
                <c:pt idx="148">
                  <c:v>133</c:v>
                </c:pt>
                <c:pt idx="149">
                  <c:v>194.38</c:v>
                </c:pt>
                <c:pt idx="150">
                  <c:v>143.22999999999999</c:v>
                </c:pt>
                <c:pt idx="151">
                  <c:v>102.3</c:v>
                </c:pt>
                <c:pt idx="152">
                  <c:v>133</c:v>
                </c:pt>
                <c:pt idx="153">
                  <c:v>286.45</c:v>
                </c:pt>
                <c:pt idx="154">
                  <c:v>153.46</c:v>
                </c:pt>
                <c:pt idx="155">
                  <c:v>214.84</c:v>
                </c:pt>
                <c:pt idx="156">
                  <c:v>102.3</c:v>
                </c:pt>
                <c:pt idx="157">
                  <c:v>40.92</c:v>
                </c:pt>
                <c:pt idx="158">
                  <c:v>71.61</c:v>
                </c:pt>
                <c:pt idx="159">
                  <c:v>133</c:v>
                </c:pt>
                <c:pt idx="160">
                  <c:v>142.77000000000001</c:v>
                </c:pt>
                <c:pt idx="161">
                  <c:v>132.58000000000001</c:v>
                </c:pt>
                <c:pt idx="162">
                  <c:v>132.58000000000001</c:v>
                </c:pt>
                <c:pt idx="163">
                  <c:v>163.16999999999999</c:v>
                </c:pt>
                <c:pt idx="164">
                  <c:v>142.77000000000001</c:v>
                </c:pt>
                <c:pt idx="165">
                  <c:v>163.16999999999999</c:v>
                </c:pt>
                <c:pt idx="166">
                  <c:v>152.97</c:v>
                </c:pt>
                <c:pt idx="167">
                  <c:v>122.38</c:v>
                </c:pt>
                <c:pt idx="168">
                  <c:v>91.78</c:v>
                </c:pt>
                <c:pt idx="169">
                  <c:v>183.57</c:v>
                </c:pt>
                <c:pt idx="170">
                  <c:v>122.38</c:v>
                </c:pt>
                <c:pt idx="171">
                  <c:v>367.14</c:v>
                </c:pt>
                <c:pt idx="172">
                  <c:v>152.97</c:v>
                </c:pt>
                <c:pt idx="173">
                  <c:v>152.97</c:v>
                </c:pt>
                <c:pt idx="174">
                  <c:v>326.33999999999997</c:v>
                </c:pt>
                <c:pt idx="175">
                  <c:v>71.39</c:v>
                </c:pt>
                <c:pt idx="176">
                  <c:v>122.38</c:v>
                </c:pt>
                <c:pt idx="177">
                  <c:v>101.98</c:v>
                </c:pt>
                <c:pt idx="178">
                  <c:v>112.18</c:v>
                </c:pt>
                <c:pt idx="179">
                  <c:v>163.16999999999999</c:v>
                </c:pt>
                <c:pt idx="180">
                  <c:v>111.81</c:v>
                </c:pt>
                <c:pt idx="181">
                  <c:v>71.150000000000006</c:v>
                </c:pt>
                <c:pt idx="182">
                  <c:v>213.46</c:v>
                </c:pt>
                <c:pt idx="183">
                  <c:v>223.63</c:v>
                </c:pt>
                <c:pt idx="184">
                  <c:v>223.63</c:v>
                </c:pt>
                <c:pt idx="185">
                  <c:v>121.98</c:v>
                </c:pt>
                <c:pt idx="186">
                  <c:v>233.79</c:v>
                </c:pt>
                <c:pt idx="187">
                  <c:v>213.46</c:v>
                </c:pt>
                <c:pt idx="188">
                  <c:v>132.13999999999999</c:v>
                </c:pt>
                <c:pt idx="189">
                  <c:v>132.13999999999999</c:v>
                </c:pt>
                <c:pt idx="190">
                  <c:v>193.13</c:v>
                </c:pt>
                <c:pt idx="191">
                  <c:v>345.61</c:v>
                </c:pt>
                <c:pt idx="192">
                  <c:v>142.31</c:v>
                </c:pt>
                <c:pt idx="193">
                  <c:v>193.13</c:v>
                </c:pt>
                <c:pt idx="194">
                  <c:v>172.8</c:v>
                </c:pt>
                <c:pt idx="195">
                  <c:v>182.97</c:v>
                </c:pt>
                <c:pt idx="196">
                  <c:v>121.98</c:v>
                </c:pt>
                <c:pt idx="197">
                  <c:v>60.99</c:v>
                </c:pt>
                <c:pt idx="198">
                  <c:v>91.48</c:v>
                </c:pt>
                <c:pt idx="199">
                  <c:v>71.150000000000006</c:v>
                </c:pt>
                <c:pt idx="200">
                  <c:v>122.85</c:v>
                </c:pt>
                <c:pt idx="201">
                  <c:v>204.76</c:v>
                </c:pt>
                <c:pt idx="202">
                  <c:v>163.81</c:v>
                </c:pt>
                <c:pt idx="203">
                  <c:v>102.38</c:v>
                </c:pt>
                <c:pt idx="204">
                  <c:v>112.62</c:v>
                </c:pt>
                <c:pt idx="205">
                  <c:v>133.09</c:v>
                </c:pt>
                <c:pt idx="206">
                  <c:v>184.28</c:v>
                </c:pt>
                <c:pt idx="207">
                  <c:v>143.33000000000001</c:v>
                </c:pt>
                <c:pt idx="208">
                  <c:v>112.62</c:v>
                </c:pt>
                <c:pt idx="209">
                  <c:v>143.33000000000001</c:v>
                </c:pt>
                <c:pt idx="210">
                  <c:v>307.13</c:v>
                </c:pt>
                <c:pt idx="211">
                  <c:v>184.28</c:v>
                </c:pt>
                <c:pt idx="212">
                  <c:v>61.43</c:v>
                </c:pt>
                <c:pt idx="213">
                  <c:v>214.99</c:v>
                </c:pt>
                <c:pt idx="214">
                  <c:v>266.18</c:v>
                </c:pt>
                <c:pt idx="215">
                  <c:v>255.95</c:v>
                </c:pt>
                <c:pt idx="216">
                  <c:v>143.33000000000001</c:v>
                </c:pt>
                <c:pt idx="217">
                  <c:v>214.99</c:v>
                </c:pt>
                <c:pt idx="218">
                  <c:v>92.14</c:v>
                </c:pt>
                <c:pt idx="219">
                  <c:v>92.14</c:v>
                </c:pt>
                <c:pt idx="220">
                  <c:v>273.48</c:v>
                </c:pt>
                <c:pt idx="221">
                  <c:v>330.06</c:v>
                </c:pt>
                <c:pt idx="222">
                  <c:v>75.44</c:v>
                </c:pt>
                <c:pt idx="223">
                  <c:v>132.03</c:v>
                </c:pt>
                <c:pt idx="224">
                  <c:v>358.35</c:v>
                </c:pt>
                <c:pt idx="225">
                  <c:v>330.06</c:v>
                </c:pt>
                <c:pt idx="226">
                  <c:v>207.47</c:v>
                </c:pt>
                <c:pt idx="227">
                  <c:v>358.35</c:v>
                </c:pt>
                <c:pt idx="228">
                  <c:v>188.61</c:v>
                </c:pt>
                <c:pt idx="229">
                  <c:v>320.63</c:v>
                </c:pt>
                <c:pt idx="230">
                  <c:v>132.03</c:v>
                </c:pt>
                <c:pt idx="231">
                  <c:v>132.03</c:v>
                </c:pt>
                <c:pt idx="232">
                  <c:v>169.75</c:v>
                </c:pt>
                <c:pt idx="233">
                  <c:v>235.76</c:v>
                </c:pt>
                <c:pt idx="234">
                  <c:v>330.06</c:v>
                </c:pt>
                <c:pt idx="235">
                  <c:v>141.46</c:v>
                </c:pt>
                <c:pt idx="236">
                  <c:v>141.46</c:v>
                </c:pt>
                <c:pt idx="237">
                  <c:v>650.70000000000005</c:v>
                </c:pt>
                <c:pt idx="238">
                  <c:v>358.35</c:v>
                </c:pt>
                <c:pt idx="239">
                  <c:v>226.33</c:v>
                </c:pt>
                <c:pt idx="240">
                  <c:v>362.73</c:v>
                </c:pt>
                <c:pt idx="241">
                  <c:v>167.42</c:v>
                </c:pt>
                <c:pt idx="242">
                  <c:v>260.42</c:v>
                </c:pt>
                <c:pt idx="243">
                  <c:v>176.72</c:v>
                </c:pt>
                <c:pt idx="244">
                  <c:v>204.62</c:v>
                </c:pt>
                <c:pt idx="245">
                  <c:v>241.82</c:v>
                </c:pt>
                <c:pt idx="246">
                  <c:v>93.01</c:v>
                </c:pt>
                <c:pt idx="247">
                  <c:v>120.91</c:v>
                </c:pt>
                <c:pt idx="248">
                  <c:v>167.42</c:v>
                </c:pt>
                <c:pt idx="249">
                  <c:v>427.84</c:v>
                </c:pt>
                <c:pt idx="250">
                  <c:v>372.03</c:v>
                </c:pt>
                <c:pt idx="251">
                  <c:v>334.83</c:v>
                </c:pt>
                <c:pt idx="252">
                  <c:v>213.92</c:v>
                </c:pt>
                <c:pt idx="253">
                  <c:v>306.93</c:v>
                </c:pt>
                <c:pt idx="254">
                  <c:v>492.94</c:v>
                </c:pt>
                <c:pt idx="255">
                  <c:v>158.11000000000001</c:v>
                </c:pt>
                <c:pt idx="256">
                  <c:v>176.72</c:v>
                </c:pt>
                <c:pt idx="257">
                  <c:v>558.04999999999995</c:v>
                </c:pt>
                <c:pt idx="258">
                  <c:v>167.42</c:v>
                </c:pt>
                <c:pt idx="259">
                  <c:v>427.84</c:v>
                </c:pt>
                <c:pt idx="260">
                  <c:v>381.49</c:v>
                </c:pt>
                <c:pt idx="261">
                  <c:v>176.79</c:v>
                </c:pt>
                <c:pt idx="262">
                  <c:v>204.7</c:v>
                </c:pt>
                <c:pt idx="263">
                  <c:v>223.31</c:v>
                </c:pt>
                <c:pt idx="264">
                  <c:v>186.09</c:v>
                </c:pt>
                <c:pt idx="265">
                  <c:v>260.52999999999997</c:v>
                </c:pt>
                <c:pt idx="266">
                  <c:v>139.57</c:v>
                </c:pt>
                <c:pt idx="267">
                  <c:v>232.61</c:v>
                </c:pt>
                <c:pt idx="268">
                  <c:v>241.92</c:v>
                </c:pt>
                <c:pt idx="269">
                  <c:v>214.01</c:v>
                </c:pt>
                <c:pt idx="270">
                  <c:v>241.92</c:v>
                </c:pt>
                <c:pt idx="271">
                  <c:v>232.61</c:v>
                </c:pt>
                <c:pt idx="272">
                  <c:v>204.7</c:v>
                </c:pt>
                <c:pt idx="273">
                  <c:v>269.83</c:v>
                </c:pt>
                <c:pt idx="274">
                  <c:v>195.4</c:v>
                </c:pt>
                <c:pt idx="275">
                  <c:v>316.36</c:v>
                </c:pt>
                <c:pt idx="276">
                  <c:v>474.53</c:v>
                </c:pt>
                <c:pt idx="277">
                  <c:v>241.92</c:v>
                </c:pt>
                <c:pt idx="278">
                  <c:v>223.31</c:v>
                </c:pt>
                <c:pt idx="279">
                  <c:v>372.18</c:v>
                </c:pt>
                <c:pt idx="280">
                  <c:v>189.03</c:v>
                </c:pt>
                <c:pt idx="281">
                  <c:v>218.87</c:v>
                </c:pt>
                <c:pt idx="282">
                  <c:v>208.93</c:v>
                </c:pt>
                <c:pt idx="283">
                  <c:v>189.03</c:v>
                </c:pt>
                <c:pt idx="284">
                  <c:v>149.22999999999999</c:v>
                </c:pt>
                <c:pt idx="285">
                  <c:v>159.18</c:v>
                </c:pt>
                <c:pt idx="286">
                  <c:v>208.93</c:v>
                </c:pt>
                <c:pt idx="287">
                  <c:v>129.33000000000001</c:v>
                </c:pt>
                <c:pt idx="288">
                  <c:v>298.45999999999998</c:v>
                </c:pt>
                <c:pt idx="289">
                  <c:v>447.7</c:v>
                </c:pt>
                <c:pt idx="290">
                  <c:v>318.36</c:v>
                </c:pt>
                <c:pt idx="291">
                  <c:v>358.16</c:v>
                </c:pt>
                <c:pt idx="292">
                  <c:v>99.49</c:v>
                </c:pt>
                <c:pt idx="293">
                  <c:v>218.87</c:v>
                </c:pt>
                <c:pt idx="294">
                  <c:v>189.03</c:v>
                </c:pt>
                <c:pt idx="295">
                  <c:v>278.57</c:v>
                </c:pt>
                <c:pt idx="296">
                  <c:v>99.49</c:v>
                </c:pt>
                <c:pt idx="297">
                  <c:v>89.54</c:v>
                </c:pt>
                <c:pt idx="298">
                  <c:v>149.22999999999999</c:v>
                </c:pt>
                <c:pt idx="299">
                  <c:v>238.77</c:v>
                </c:pt>
                <c:pt idx="300">
                  <c:v>176.47</c:v>
                </c:pt>
                <c:pt idx="301">
                  <c:v>274.51</c:v>
                </c:pt>
                <c:pt idx="302">
                  <c:v>303.92</c:v>
                </c:pt>
                <c:pt idx="303">
                  <c:v>215.69</c:v>
                </c:pt>
                <c:pt idx="304">
                  <c:v>254.9</c:v>
                </c:pt>
                <c:pt idx="305">
                  <c:v>627.45000000000005</c:v>
                </c:pt>
                <c:pt idx="306">
                  <c:v>303.92</c:v>
                </c:pt>
                <c:pt idx="307">
                  <c:v>98.04</c:v>
                </c:pt>
                <c:pt idx="308">
                  <c:v>58.82</c:v>
                </c:pt>
                <c:pt idx="309">
                  <c:v>313.73</c:v>
                </c:pt>
                <c:pt idx="310">
                  <c:v>333.33</c:v>
                </c:pt>
                <c:pt idx="311">
                  <c:v>264.70999999999998</c:v>
                </c:pt>
                <c:pt idx="312">
                  <c:v>401.96</c:v>
                </c:pt>
                <c:pt idx="313">
                  <c:v>186.27</c:v>
                </c:pt>
                <c:pt idx="314">
                  <c:v>245.1</c:v>
                </c:pt>
                <c:pt idx="315">
                  <c:v>343.14</c:v>
                </c:pt>
                <c:pt idx="316">
                  <c:v>666.67</c:v>
                </c:pt>
                <c:pt idx="317">
                  <c:v>431.37</c:v>
                </c:pt>
                <c:pt idx="318">
                  <c:v>166.67</c:v>
                </c:pt>
                <c:pt idx="319">
                  <c:v>264.70999999999998</c:v>
                </c:pt>
                <c:pt idx="320">
                  <c:v>181.26</c:v>
                </c:pt>
                <c:pt idx="321">
                  <c:v>171.19</c:v>
                </c:pt>
                <c:pt idx="322">
                  <c:v>60.42</c:v>
                </c:pt>
                <c:pt idx="323">
                  <c:v>221.54</c:v>
                </c:pt>
                <c:pt idx="324">
                  <c:v>171.19</c:v>
                </c:pt>
                <c:pt idx="325">
                  <c:v>221.54</c:v>
                </c:pt>
                <c:pt idx="326">
                  <c:v>352.45</c:v>
                </c:pt>
                <c:pt idx="327">
                  <c:v>140.97999999999999</c:v>
                </c:pt>
                <c:pt idx="328">
                  <c:v>151.05000000000001</c:v>
                </c:pt>
                <c:pt idx="329">
                  <c:v>120.84</c:v>
                </c:pt>
                <c:pt idx="330">
                  <c:v>151.05000000000001</c:v>
                </c:pt>
                <c:pt idx="331">
                  <c:v>251.75</c:v>
                </c:pt>
                <c:pt idx="332">
                  <c:v>271.89</c:v>
                </c:pt>
                <c:pt idx="333">
                  <c:v>201.4</c:v>
                </c:pt>
                <c:pt idx="334">
                  <c:v>120.84</c:v>
                </c:pt>
                <c:pt idx="335">
                  <c:v>322.24</c:v>
                </c:pt>
                <c:pt idx="336">
                  <c:v>352.45</c:v>
                </c:pt>
                <c:pt idx="337">
                  <c:v>171.19</c:v>
                </c:pt>
                <c:pt idx="338">
                  <c:v>342.38</c:v>
                </c:pt>
                <c:pt idx="339">
                  <c:v>241.68</c:v>
                </c:pt>
                <c:pt idx="340">
                  <c:v>312.36</c:v>
                </c:pt>
                <c:pt idx="341">
                  <c:v>282.14</c:v>
                </c:pt>
                <c:pt idx="342">
                  <c:v>201.53</c:v>
                </c:pt>
                <c:pt idx="343">
                  <c:v>181.37</c:v>
                </c:pt>
                <c:pt idx="344">
                  <c:v>181.37</c:v>
                </c:pt>
                <c:pt idx="345">
                  <c:v>181.37</c:v>
                </c:pt>
                <c:pt idx="346">
                  <c:v>120.92</c:v>
                </c:pt>
                <c:pt idx="347">
                  <c:v>161.22</c:v>
                </c:pt>
                <c:pt idx="348">
                  <c:v>161.22</c:v>
                </c:pt>
                <c:pt idx="349">
                  <c:v>352.67</c:v>
                </c:pt>
                <c:pt idx="350">
                  <c:v>130.99</c:v>
                </c:pt>
                <c:pt idx="351">
                  <c:v>211.6</c:v>
                </c:pt>
                <c:pt idx="352">
                  <c:v>282.14</c:v>
                </c:pt>
                <c:pt idx="353">
                  <c:v>322.44</c:v>
                </c:pt>
                <c:pt idx="354">
                  <c:v>191.45</c:v>
                </c:pt>
                <c:pt idx="355">
                  <c:v>261.98</c:v>
                </c:pt>
                <c:pt idx="356">
                  <c:v>312.36</c:v>
                </c:pt>
                <c:pt idx="357">
                  <c:v>151.13999999999999</c:v>
                </c:pt>
                <c:pt idx="358">
                  <c:v>171.3</c:v>
                </c:pt>
                <c:pt idx="359">
                  <c:v>130.99</c:v>
                </c:pt>
                <c:pt idx="360">
                  <c:v>271.22000000000003</c:v>
                </c:pt>
                <c:pt idx="361">
                  <c:v>170.77</c:v>
                </c:pt>
                <c:pt idx="362">
                  <c:v>130.59</c:v>
                </c:pt>
                <c:pt idx="363">
                  <c:v>210.95</c:v>
                </c:pt>
                <c:pt idx="364">
                  <c:v>231.04</c:v>
                </c:pt>
                <c:pt idx="365">
                  <c:v>120.54</c:v>
                </c:pt>
                <c:pt idx="366">
                  <c:v>241.09</c:v>
                </c:pt>
                <c:pt idx="367">
                  <c:v>140.63</c:v>
                </c:pt>
                <c:pt idx="368">
                  <c:v>200.91</c:v>
                </c:pt>
                <c:pt idx="369">
                  <c:v>60.27</c:v>
                </c:pt>
                <c:pt idx="370">
                  <c:v>190.86</c:v>
                </c:pt>
                <c:pt idx="371">
                  <c:v>261.18</c:v>
                </c:pt>
                <c:pt idx="372">
                  <c:v>190.86</c:v>
                </c:pt>
                <c:pt idx="373">
                  <c:v>241.09</c:v>
                </c:pt>
                <c:pt idx="374">
                  <c:v>140.63</c:v>
                </c:pt>
                <c:pt idx="375">
                  <c:v>120.54</c:v>
                </c:pt>
                <c:pt idx="376">
                  <c:v>241.09</c:v>
                </c:pt>
                <c:pt idx="377">
                  <c:v>190.86</c:v>
                </c:pt>
                <c:pt idx="378">
                  <c:v>582.63</c:v>
                </c:pt>
                <c:pt idx="379">
                  <c:v>441.99</c:v>
                </c:pt>
                <c:pt idx="380">
                  <c:v>216.28000000000003</c:v>
                </c:pt>
                <c:pt idx="381">
                  <c:v>167.126</c:v>
                </c:pt>
                <c:pt idx="382">
                  <c:v>216.28000000000003</c:v>
                </c:pt>
                <c:pt idx="383">
                  <c:v>304.75900000000001</c:v>
                </c:pt>
                <c:pt idx="384">
                  <c:v>98.308999999999997</c:v>
                </c:pt>
                <c:pt idx="385">
                  <c:v>196.619</c:v>
                </c:pt>
                <c:pt idx="386">
                  <c:v>186.78800000000001</c:v>
                </c:pt>
                <c:pt idx="387">
                  <c:v>147.464</c:v>
                </c:pt>
                <c:pt idx="388">
                  <c:v>285.09699999999998</c:v>
                </c:pt>
                <c:pt idx="389">
                  <c:v>265.435</c:v>
                </c:pt>
                <c:pt idx="390">
                  <c:v>108.14000000000001</c:v>
                </c:pt>
                <c:pt idx="391">
                  <c:v>176.95699999999999</c:v>
                </c:pt>
                <c:pt idx="392">
                  <c:v>147.464</c:v>
                </c:pt>
                <c:pt idx="393">
                  <c:v>186.78800000000001</c:v>
                </c:pt>
                <c:pt idx="394">
                  <c:v>196.619</c:v>
                </c:pt>
                <c:pt idx="395">
                  <c:v>196.619</c:v>
                </c:pt>
                <c:pt idx="396">
                  <c:v>265.435</c:v>
                </c:pt>
                <c:pt idx="397">
                  <c:v>216.28000000000003</c:v>
                </c:pt>
                <c:pt idx="398">
                  <c:v>304.75900000000001</c:v>
                </c:pt>
                <c:pt idx="399">
                  <c:v>393.23699999999997</c:v>
                </c:pt>
              </c:numCache>
            </c:numRef>
          </c:yVal>
          <c:smooth val="0"/>
          <c:extLst>
            <c:ext xmlns:c16="http://schemas.microsoft.com/office/drawing/2014/chart" uri="{C3380CC4-5D6E-409C-BE32-E72D297353CC}">
              <c16:uniqueId val="{00000000-17D9-6242-9D49-DE8872981ECE}"/>
            </c:ext>
          </c:extLst>
        </c:ser>
        <c:ser>
          <c:idx val="1"/>
          <c:order val="1"/>
          <c:tx>
            <c:v>GA</c:v>
          </c:tx>
          <c:spPr>
            <a:ln w="25400" cap="rnd">
              <a:noFill/>
              <a:round/>
            </a:ln>
            <a:effectLst/>
          </c:spPr>
          <c:marker>
            <c:symbol val="triangle"/>
            <c:size val="4"/>
            <c:spPr>
              <a:noFill/>
              <a:ln w="12700">
                <a:solidFill>
                  <a:schemeClr val="tx1"/>
                </a:solidFill>
              </a:ln>
              <a:effectLst/>
            </c:spPr>
          </c:marker>
          <c:xVal>
            <c:numRef>
              <c:f>ベレ散布図!$D$4:$D$463</c:f>
              <c:numCache>
                <c:formatCode>General</c:formatCode>
                <c:ptCount val="460"/>
                <c:pt idx="0">
                  <c:v>90.81</c:v>
                </c:pt>
                <c:pt idx="1">
                  <c:v>105.95</c:v>
                </c:pt>
                <c:pt idx="2">
                  <c:v>45.41</c:v>
                </c:pt>
                <c:pt idx="3">
                  <c:v>121.08</c:v>
                </c:pt>
                <c:pt idx="4">
                  <c:v>60.54</c:v>
                </c:pt>
                <c:pt idx="5">
                  <c:v>189.19</c:v>
                </c:pt>
                <c:pt idx="6">
                  <c:v>83.24</c:v>
                </c:pt>
                <c:pt idx="7">
                  <c:v>45.41</c:v>
                </c:pt>
                <c:pt idx="8">
                  <c:v>75.680000000000007</c:v>
                </c:pt>
                <c:pt idx="9">
                  <c:v>98.38</c:v>
                </c:pt>
                <c:pt idx="10">
                  <c:v>121.08</c:v>
                </c:pt>
                <c:pt idx="11">
                  <c:v>83.24</c:v>
                </c:pt>
                <c:pt idx="12">
                  <c:v>219.46</c:v>
                </c:pt>
                <c:pt idx="13">
                  <c:v>257.3</c:v>
                </c:pt>
                <c:pt idx="14">
                  <c:v>90.81</c:v>
                </c:pt>
                <c:pt idx="15">
                  <c:v>75.680000000000007</c:v>
                </c:pt>
                <c:pt idx="16">
                  <c:v>83.24</c:v>
                </c:pt>
                <c:pt idx="17">
                  <c:v>60.54</c:v>
                </c:pt>
                <c:pt idx="18">
                  <c:v>105.95</c:v>
                </c:pt>
                <c:pt idx="19">
                  <c:v>105.95</c:v>
                </c:pt>
                <c:pt idx="20">
                  <c:v>100.38</c:v>
                </c:pt>
                <c:pt idx="21">
                  <c:v>123.54</c:v>
                </c:pt>
                <c:pt idx="22">
                  <c:v>208.48</c:v>
                </c:pt>
                <c:pt idx="23">
                  <c:v>138.99</c:v>
                </c:pt>
                <c:pt idx="24">
                  <c:v>123.54</c:v>
                </c:pt>
                <c:pt idx="25">
                  <c:v>115.82</c:v>
                </c:pt>
                <c:pt idx="26">
                  <c:v>108.1</c:v>
                </c:pt>
                <c:pt idx="27">
                  <c:v>54.05</c:v>
                </c:pt>
                <c:pt idx="28">
                  <c:v>69.489999999999995</c:v>
                </c:pt>
                <c:pt idx="29">
                  <c:v>193.04</c:v>
                </c:pt>
                <c:pt idx="30">
                  <c:v>54.05</c:v>
                </c:pt>
                <c:pt idx="31">
                  <c:v>61.77</c:v>
                </c:pt>
                <c:pt idx="32">
                  <c:v>115.82</c:v>
                </c:pt>
                <c:pt idx="33">
                  <c:v>123.54</c:v>
                </c:pt>
                <c:pt idx="34">
                  <c:v>108.1</c:v>
                </c:pt>
                <c:pt idx="35">
                  <c:v>177.59</c:v>
                </c:pt>
                <c:pt idx="36">
                  <c:v>131.27000000000001</c:v>
                </c:pt>
                <c:pt idx="37">
                  <c:v>131.27000000000001</c:v>
                </c:pt>
                <c:pt idx="38">
                  <c:v>231.65</c:v>
                </c:pt>
                <c:pt idx="39">
                  <c:v>108.1</c:v>
                </c:pt>
                <c:pt idx="40">
                  <c:v>218.69</c:v>
                </c:pt>
                <c:pt idx="41">
                  <c:v>291.58999999999997</c:v>
                </c:pt>
                <c:pt idx="42">
                  <c:v>124.97</c:v>
                </c:pt>
                <c:pt idx="43">
                  <c:v>218.69</c:v>
                </c:pt>
                <c:pt idx="44">
                  <c:v>322.83</c:v>
                </c:pt>
                <c:pt idx="45">
                  <c:v>239.52</c:v>
                </c:pt>
                <c:pt idx="46">
                  <c:v>197.87</c:v>
                </c:pt>
                <c:pt idx="47">
                  <c:v>187.45</c:v>
                </c:pt>
                <c:pt idx="48">
                  <c:v>208.28</c:v>
                </c:pt>
                <c:pt idx="49">
                  <c:v>395.73</c:v>
                </c:pt>
                <c:pt idx="50">
                  <c:v>333.25</c:v>
                </c:pt>
                <c:pt idx="51">
                  <c:v>124.97</c:v>
                </c:pt>
                <c:pt idx="52">
                  <c:v>166.62</c:v>
                </c:pt>
                <c:pt idx="53">
                  <c:v>229.11</c:v>
                </c:pt>
                <c:pt idx="54">
                  <c:v>135.38</c:v>
                </c:pt>
                <c:pt idx="55">
                  <c:v>208.28</c:v>
                </c:pt>
                <c:pt idx="56">
                  <c:v>197.87</c:v>
                </c:pt>
                <c:pt idx="57">
                  <c:v>302.01</c:v>
                </c:pt>
                <c:pt idx="58">
                  <c:v>187.45</c:v>
                </c:pt>
                <c:pt idx="59">
                  <c:v>166.62</c:v>
                </c:pt>
                <c:pt idx="60">
                  <c:v>205.65</c:v>
                </c:pt>
                <c:pt idx="61">
                  <c:v>221.46</c:v>
                </c:pt>
                <c:pt idx="62">
                  <c:v>245.19</c:v>
                </c:pt>
                <c:pt idx="63">
                  <c:v>237.28</c:v>
                </c:pt>
                <c:pt idx="64">
                  <c:v>166.1</c:v>
                </c:pt>
                <c:pt idx="65">
                  <c:v>253.1</c:v>
                </c:pt>
                <c:pt idx="66">
                  <c:v>181.92</c:v>
                </c:pt>
                <c:pt idx="67">
                  <c:v>134.46</c:v>
                </c:pt>
                <c:pt idx="68">
                  <c:v>166.1</c:v>
                </c:pt>
                <c:pt idx="69">
                  <c:v>166.1</c:v>
                </c:pt>
                <c:pt idx="70">
                  <c:v>142.37</c:v>
                </c:pt>
                <c:pt idx="71">
                  <c:v>181.92</c:v>
                </c:pt>
                <c:pt idx="72">
                  <c:v>142.37</c:v>
                </c:pt>
                <c:pt idx="73">
                  <c:v>126.55</c:v>
                </c:pt>
                <c:pt idx="74">
                  <c:v>126.55</c:v>
                </c:pt>
                <c:pt idx="75">
                  <c:v>118.64</c:v>
                </c:pt>
                <c:pt idx="76">
                  <c:v>221.46</c:v>
                </c:pt>
                <c:pt idx="77">
                  <c:v>142.37</c:v>
                </c:pt>
                <c:pt idx="78">
                  <c:v>268.92</c:v>
                </c:pt>
                <c:pt idx="79">
                  <c:v>213.56</c:v>
                </c:pt>
                <c:pt idx="80">
                  <c:v>252.88</c:v>
                </c:pt>
                <c:pt idx="81">
                  <c:v>229.17</c:v>
                </c:pt>
                <c:pt idx="82">
                  <c:v>268.68</c:v>
                </c:pt>
                <c:pt idx="83">
                  <c:v>118.54</c:v>
                </c:pt>
                <c:pt idx="84">
                  <c:v>94.83</c:v>
                </c:pt>
                <c:pt idx="85">
                  <c:v>134.34</c:v>
                </c:pt>
                <c:pt idx="86">
                  <c:v>126.44</c:v>
                </c:pt>
                <c:pt idx="87">
                  <c:v>150.15</c:v>
                </c:pt>
                <c:pt idx="88">
                  <c:v>150.15</c:v>
                </c:pt>
                <c:pt idx="89">
                  <c:v>229.17</c:v>
                </c:pt>
                <c:pt idx="90">
                  <c:v>118.54</c:v>
                </c:pt>
                <c:pt idx="91">
                  <c:v>102.73</c:v>
                </c:pt>
                <c:pt idx="92">
                  <c:v>268.68</c:v>
                </c:pt>
                <c:pt idx="93">
                  <c:v>126.44</c:v>
                </c:pt>
                <c:pt idx="94">
                  <c:v>229.17</c:v>
                </c:pt>
                <c:pt idx="95">
                  <c:v>189.66</c:v>
                </c:pt>
                <c:pt idx="96">
                  <c:v>142.24</c:v>
                </c:pt>
                <c:pt idx="97">
                  <c:v>213.37</c:v>
                </c:pt>
                <c:pt idx="98">
                  <c:v>276.58999999999997</c:v>
                </c:pt>
                <c:pt idx="99">
                  <c:v>126.44</c:v>
                </c:pt>
                <c:pt idx="100">
                  <c:v>191.96</c:v>
                </c:pt>
                <c:pt idx="101">
                  <c:v>131.97</c:v>
                </c:pt>
                <c:pt idx="102">
                  <c:v>131.97</c:v>
                </c:pt>
                <c:pt idx="103">
                  <c:v>155.97</c:v>
                </c:pt>
                <c:pt idx="104">
                  <c:v>119.97</c:v>
                </c:pt>
                <c:pt idx="105">
                  <c:v>179.96</c:v>
                </c:pt>
                <c:pt idx="106">
                  <c:v>167.96</c:v>
                </c:pt>
                <c:pt idx="107">
                  <c:v>119.97</c:v>
                </c:pt>
                <c:pt idx="108">
                  <c:v>155.97</c:v>
                </c:pt>
                <c:pt idx="109">
                  <c:v>215.95</c:v>
                </c:pt>
                <c:pt idx="110">
                  <c:v>227.95</c:v>
                </c:pt>
                <c:pt idx="111">
                  <c:v>203.95</c:v>
                </c:pt>
                <c:pt idx="112">
                  <c:v>179.96</c:v>
                </c:pt>
                <c:pt idx="113">
                  <c:v>143.97</c:v>
                </c:pt>
                <c:pt idx="114">
                  <c:v>167.96</c:v>
                </c:pt>
                <c:pt idx="115">
                  <c:v>83.98</c:v>
                </c:pt>
                <c:pt idx="116">
                  <c:v>215.95</c:v>
                </c:pt>
                <c:pt idx="117">
                  <c:v>227.95</c:v>
                </c:pt>
                <c:pt idx="118">
                  <c:v>167.96</c:v>
                </c:pt>
                <c:pt idx="119">
                  <c:v>239.95</c:v>
                </c:pt>
                <c:pt idx="120">
                  <c:v>192.31</c:v>
                </c:pt>
                <c:pt idx="121">
                  <c:v>178.57</c:v>
                </c:pt>
                <c:pt idx="122">
                  <c:v>137.36000000000001</c:v>
                </c:pt>
                <c:pt idx="123">
                  <c:v>260.99</c:v>
                </c:pt>
                <c:pt idx="124">
                  <c:v>233.51</c:v>
                </c:pt>
                <c:pt idx="125">
                  <c:v>206.04</c:v>
                </c:pt>
                <c:pt idx="126">
                  <c:v>178.57</c:v>
                </c:pt>
                <c:pt idx="127">
                  <c:v>206.04</c:v>
                </c:pt>
                <c:pt idx="128">
                  <c:v>219.78</c:v>
                </c:pt>
                <c:pt idx="129">
                  <c:v>398.35</c:v>
                </c:pt>
                <c:pt idx="130">
                  <c:v>260.99</c:v>
                </c:pt>
                <c:pt idx="131">
                  <c:v>260.99</c:v>
                </c:pt>
                <c:pt idx="132">
                  <c:v>219.78</c:v>
                </c:pt>
                <c:pt idx="133">
                  <c:v>137.36000000000001</c:v>
                </c:pt>
                <c:pt idx="134">
                  <c:v>206.04</c:v>
                </c:pt>
                <c:pt idx="135">
                  <c:v>206.04</c:v>
                </c:pt>
                <c:pt idx="136">
                  <c:v>274.72000000000003</c:v>
                </c:pt>
                <c:pt idx="137">
                  <c:v>206.04</c:v>
                </c:pt>
                <c:pt idx="138">
                  <c:v>164.83</c:v>
                </c:pt>
                <c:pt idx="139">
                  <c:v>219.78</c:v>
                </c:pt>
                <c:pt idx="140">
                  <c:v>82.15</c:v>
                </c:pt>
                <c:pt idx="141">
                  <c:v>82.15</c:v>
                </c:pt>
                <c:pt idx="142">
                  <c:v>70.41</c:v>
                </c:pt>
                <c:pt idx="143">
                  <c:v>176.04</c:v>
                </c:pt>
                <c:pt idx="144">
                  <c:v>70.41</c:v>
                </c:pt>
                <c:pt idx="145">
                  <c:v>164.3</c:v>
                </c:pt>
                <c:pt idx="146">
                  <c:v>152.56</c:v>
                </c:pt>
                <c:pt idx="147">
                  <c:v>105.62</c:v>
                </c:pt>
                <c:pt idx="148">
                  <c:v>222.98</c:v>
                </c:pt>
                <c:pt idx="149">
                  <c:v>176.04</c:v>
                </c:pt>
                <c:pt idx="150">
                  <c:v>117.36</c:v>
                </c:pt>
                <c:pt idx="151">
                  <c:v>211.24</c:v>
                </c:pt>
                <c:pt idx="152">
                  <c:v>187.77</c:v>
                </c:pt>
                <c:pt idx="153">
                  <c:v>187.77</c:v>
                </c:pt>
                <c:pt idx="154">
                  <c:v>222.98</c:v>
                </c:pt>
                <c:pt idx="155">
                  <c:v>176.04</c:v>
                </c:pt>
                <c:pt idx="156">
                  <c:v>222.98</c:v>
                </c:pt>
                <c:pt idx="157">
                  <c:v>246.45</c:v>
                </c:pt>
                <c:pt idx="158">
                  <c:v>93.89</c:v>
                </c:pt>
                <c:pt idx="159">
                  <c:v>129.09</c:v>
                </c:pt>
                <c:pt idx="160">
                  <c:v>94</c:v>
                </c:pt>
                <c:pt idx="161">
                  <c:v>94</c:v>
                </c:pt>
                <c:pt idx="162">
                  <c:v>140.99</c:v>
                </c:pt>
                <c:pt idx="163">
                  <c:v>164.49</c:v>
                </c:pt>
                <c:pt idx="164">
                  <c:v>164.49</c:v>
                </c:pt>
                <c:pt idx="165">
                  <c:v>140.99</c:v>
                </c:pt>
                <c:pt idx="166">
                  <c:v>129.24</c:v>
                </c:pt>
                <c:pt idx="167">
                  <c:v>140.99</c:v>
                </c:pt>
                <c:pt idx="168">
                  <c:v>211.49</c:v>
                </c:pt>
                <c:pt idx="169">
                  <c:v>164.49</c:v>
                </c:pt>
                <c:pt idx="170">
                  <c:v>199.74</c:v>
                </c:pt>
                <c:pt idx="171">
                  <c:v>176.24</c:v>
                </c:pt>
                <c:pt idx="172">
                  <c:v>117.49</c:v>
                </c:pt>
                <c:pt idx="173">
                  <c:v>117.49</c:v>
                </c:pt>
                <c:pt idx="174">
                  <c:v>129.24</c:v>
                </c:pt>
                <c:pt idx="175">
                  <c:v>129.24</c:v>
                </c:pt>
                <c:pt idx="176">
                  <c:v>129.24</c:v>
                </c:pt>
                <c:pt idx="177">
                  <c:v>164.49</c:v>
                </c:pt>
                <c:pt idx="178">
                  <c:v>234.99</c:v>
                </c:pt>
                <c:pt idx="179">
                  <c:v>82.25</c:v>
                </c:pt>
                <c:pt idx="180">
                  <c:v>212.58</c:v>
                </c:pt>
                <c:pt idx="181">
                  <c:v>200.77</c:v>
                </c:pt>
                <c:pt idx="182">
                  <c:v>236.2</c:v>
                </c:pt>
                <c:pt idx="183">
                  <c:v>200.77</c:v>
                </c:pt>
                <c:pt idx="184">
                  <c:v>295.25</c:v>
                </c:pt>
                <c:pt idx="185">
                  <c:v>212.58</c:v>
                </c:pt>
                <c:pt idx="186">
                  <c:v>212.58</c:v>
                </c:pt>
                <c:pt idx="187">
                  <c:v>200.77</c:v>
                </c:pt>
                <c:pt idx="188">
                  <c:v>271.63</c:v>
                </c:pt>
                <c:pt idx="189">
                  <c:v>212.58</c:v>
                </c:pt>
                <c:pt idx="190">
                  <c:v>141.72</c:v>
                </c:pt>
                <c:pt idx="191">
                  <c:v>224.39</c:v>
                </c:pt>
                <c:pt idx="192">
                  <c:v>283.44</c:v>
                </c:pt>
                <c:pt idx="193">
                  <c:v>165.34</c:v>
                </c:pt>
                <c:pt idx="194">
                  <c:v>141.72</c:v>
                </c:pt>
                <c:pt idx="195">
                  <c:v>236.2</c:v>
                </c:pt>
                <c:pt idx="196">
                  <c:v>259.82</c:v>
                </c:pt>
                <c:pt idx="197">
                  <c:v>165.34</c:v>
                </c:pt>
                <c:pt idx="198">
                  <c:v>118.1</c:v>
                </c:pt>
                <c:pt idx="199">
                  <c:v>177.15</c:v>
                </c:pt>
                <c:pt idx="200">
                  <c:v>236.03</c:v>
                </c:pt>
                <c:pt idx="201">
                  <c:v>141.62</c:v>
                </c:pt>
                <c:pt idx="202">
                  <c:v>188.82</c:v>
                </c:pt>
                <c:pt idx="203">
                  <c:v>141.62</c:v>
                </c:pt>
                <c:pt idx="204">
                  <c:v>141.62</c:v>
                </c:pt>
                <c:pt idx="205">
                  <c:v>106.21</c:v>
                </c:pt>
                <c:pt idx="206">
                  <c:v>106.21</c:v>
                </c:pt>
                <c:pt idx="207">
                  <c:v>118.02</c:v>
                </c:pt>
                <c:pt idx="208">
                  <c:v>118.02</c:v>
                </c:pt>
                <c:pt idx="209">
                  <c:v>82.61</c:v>
                </c:pt>
                <c:pt idx="210">
                  <c:v>200.63</c:v>
                </c:pt>
                <c:pt idx="211">
                  <c:v>224.23</c:v>
                </c:pt>
                <c:pt idx="212">
                  <c:v>283.24</c:v>
                </c:pt>
                <c:pt idx="213">
                  <c:v>177.02</c:v>
                </c:pt>
                <c:pt idx="214">
                  <c:v>141.62</c:v>
                </c:pt>
                <c:pt idx="215">
                  <c:v>342.24</c:v>
                </c:pt>
                <c:pt idx="216">
                  <c:v>283.24</c:v>
                </c:pt>
                <c:pt idx="217">
                  <c:v>177.02</c:v>
                </c:pt>
                <c:pt idx="218">
                  <c:v>271.44</c:v>
                </c:pt>
                <c:pt idx="219">
                  <c:v>200.63</c:v>
                </c:pt>
                <c:pt idx="220">
                  <c:v>172.79</c:v>
                </c:pt>
                <c:pt idx="221">
                  <c:v>92.16</c:v>
                </c:pt>
                <c:pt idx="222">
                  <c:v>207.35</c:v>
                </c:pt>
                <c:pt idx="223">
                  <c:v>149.75</c:v>
                </c:pt>
                <c:pt idx="224">
                  <c:v>230.39</c:v>
                </c:pt>
                <c:pt idx="225">
                  <c:v>253.43</c:v>
                </c:pt>
                <c:pt idx="226">
                  <c:v>138.22999999999999</c:v>
                </c:pt>
                <c:pt idx="227">
                  <c:v>437.74</c:v>
                </c:pt>
                <c:pt idx="228">
                  <c:v>195.83</c:v>
                </c:pt>
                <c:pt idx="229">
                  <c:v>195.83</c:v>
                </c:pt>
                <c:pt idx="230">
                  <c:v>184.31</c:v>
                </c:pt>
                <c:pt idx="231">
                  <c:v>241.91</c:v>
                </c:pt>
                <c:pt idx="232">
                  <c:v>241.91</c:v>
                </c:pt>
                <c:pt idx="233">
                  <c:v>184.31</c:v>
                </c:pt>
                <c:pt idx="234">
                  <c:v>299.5</c:v>
                </c:pt>
                <c:pt idx="235">
                  <c:v>218.87</c:v>
                </c:pt>
                <c:pt idx="236">
                  <c:v>184.31</c:v>
                </c:pt>
                <c:pt idx="237">
                  <c:v>161.27000000000001</c:v>
                </c:pt>
                <c:pt idx="238">
                  <c:v>115.19</c:v>
                </c:pt>
                <c:pt idx="239">
                  <c:v>218.87</c:v>
                </c:pt>
                <c:pt idx="240">
                  <c:v>239.03</c:v>
                </c:pt>
                <c:pt idx="241">
                  <c:v>274.89</c:v>
                </c:pt>
                <c:pt idx="242">
                  <c:v>203.18</c:v>
                </c:pt>
                <c:pt idx="243">
                  <c:v>227.08</c:v>
                </c:pt>
                <c:pt idx="244">
                  <c:v>227.08</c:v>
                </c:pt>
                <c:pt idx="245">
                  <c:v>227.08</c:v>
                </c:pt>
                <c:pt idx="246">
                  <c:v>167.32</c:v>
                </c:pt>
                <c:pt idx="247">
                  <c:v>83.66</c:v>
                </c:pt>
                <c:pt idx="248">
                  <c:v>83.66</c:v>
                </c:pt>
                <c:pt idx="249">
                  <c:v>179.27</c:v>
                </c:pt>
                <c:pt idx="250">
                  <c:v>107.56</c:v>
                </c:pt>
                <c:pt idx="251">
                  <c:v>227.08</c:v>
                </c:pt>
                <c:pt idx="252">
                  <c:v>131.47</c:v>
                </c:pt>
                <c:pt idx="253">
                  <c:v>262.94</c:v>
                </c:pt>
                <c:pt idx="254">
                  <c:v>155.37</c:v>
                </c:pt>
                <c:pt idx="255">
                  <c:v>143.41999999999999</c:v>
                </c:pt>
                <c:pt idx="256">
                  <c:v>131.47</c:v>
                </c:pt>
                <c:pt idx="257">
                  <c:v>143.41999999999999</c:v>
                </c:pt>
                <c:pt idx="258">
                  <c:v>167.32</c:v>
                </c:pt>
                <c:pt idx="259">
                  <c:v>155.37</c:v>
                </c:pt>
                <c:pt idx="260">
                  <c:v>190.57</c:v>
                </c:pt>
                <c:pt idx="261">
                  <c:v>178.66</c:v>
                </c:pt>
                <c:pt idx="262">
                  <c:v>154.84</c:v>
                </c:pt>
                <c:pt idx="263">
                  <c:v>142.93</c:v>
                </c:pt>
                <c:pt idx="264">
                  <c:v>107.2</c:v>
                </c:pt>
                <c:pt idx="265">
                  <c:v>119.11</c:v>
                </c:pt>
                <c:pt idx="266">
                  <c:v>154.84</c:v>
                </c:pt>
                <c:pt idx="267">
                  <c:v>119.11</c:v>
                </c:pt>
                <c:pt idx="268">
                  <c:v>166.75</c:v>
                </c:pt>
                <c:pt idx="269">
                  <c:v>190.57</c:v>
                </c:pt>
                <c:pt idx="270">
                  <c:v>154.84</c:v>
                </c:pt>
                <c:pt idx="271">
                  <c:v>142.93</c:v>
                </c:pt>
                <c:pt idx="272">
                  <c:v>142.93</c:v>
                </c:pt>
                <c:pt idx="273">
                  <c:v>166.75</c:v>
                </c:pt>
                <c:pt idx="274">
                  <c:v>238.21</c:v>
                </c:pt>
                <c:pt idx="275">
                  <c:v>178.66</c:v>
                </c:pt>
                <c:pt idx="276">
                  <c:v>142.93</c:v>
                </c:pt>
                <c:pt idx="277">
                  <c:v>202.48</c:v>
                </c:pt>
                <c:pt idx="278">
                  <c:v>154.84</c:v>
                </c:pt>
                <c:pt idx="279">
                  <c:v>166.75</c:v>
                </c:pt>
                <c:pt idx="280">
                  <c:v>253.52</c:v>
                </c:pt>
                <c:pt idx="281">
                  <c:v>193.16</c:v>
                </c:pt>
                <c:pt idx="282">
                  <c:v>265.58999999999997</c:v>
                </c:pt>
                <c:pt idx="283">
                  <c:v>96.58</c:v>
                </c:pt>
                <c:pt idx="284">
                  <c:v>241.45</c:v>
                </c:pt>
                <c:pt idx="285">
                  <c:v>181.09</c:v>
                </c:pt>
                <c:pt idx="286">
                  <c:v>265.58999999999997</c:v>
                </c:pt>
                <c:pt idx="287">
                  <c:v>229.37</c:v>
                </c:pt>
                <c:pt idx="288">
                  <c:v>120.72</c:v>
                </c:pt>
                <c:pt idx="289">
                  <c:v>120.72</c:v>
                </c:pt>
                <c:pt idx="290">
                  <c:v>120.72</c:v>
                </c:pt>
                <c:pt idx="291">
                  <c:v>313.88</c:v>
                </c:pt>
                <c:pt idx="292">
                  <c:v>205.23</c:v>
                </c:pt>
                <c:pt idx="293">
                  <c:v>120.72</c:v>
                </c:pt>
                <c:pt idx="294">
                  <c:v>156.94</c:v>
                </c:pt>
                <c:pt idx="295">
                  <c:v>132.80000000000001</c:v>
                </c:pt>
                <c:pt idx="296">
                  <c:v>181.09</c:v>
                </c:pt>
                <c:pt idx="297">
                  <c:v>108.65</c:v>
                </c:pt>
                <c:pt idx="298">
                  <c:v>156.94</c:v>
                </c:pt>
                <c:pt idx="299">
                  <c:v>205.23</c:v>
                </c:pt>
                <c:pt idx="300">
                  <c:v>205.53299999999999</c:v>
                </c:pt>
                <c:pt idx="301">
                  <c:v>133.596</c:v>
                </c:pt>
                <c:pt idx="302">
                  <c:v>164.42599999999999</c:v>
                </c:pt>
                <c:pt idx="303">
                  <c:v>205.53299999999999</c:v>
                </c:pt>
                <c:pt idx="304">
                  <c:v>102.76600000000001</c:v>
                </c:pt>
                <c:pt idx="305">
                  <c:v>82.212999999999994</c:v>
                </c:pt>
                <c:pt idx="306">
                  <c:v>184.98</c:v>
                </c:pt>
                <c:pt idx="307">
                  <c:v>174.703</c:v>
                </c:pt>
                <c:pt idx="308">
                  <c:v>133.596</c:v>
                </c:pt>
                <c:pt idx="309">
                  <c:v>184.98</c:v>
                </c:pt>
                <c:pt idx="310">
                  <c:v>184.98</c:v>
                </c:pt>
                <c:pt idx="311">
                  <c:v>143.87299999999999</c:v>
                </c:pt>
                <c:pt idx="312">
                  <c:v>267.19299999999998</c:v>
                </c:pt>
                <c:pt idx="313">
                  <c:v>205.53299999999999</c:v>
                </c:pt>
                <c:pt idx="314">
                  <c:v>215.81</c:v>
                </c:pt>
                <c:pt idx="315">
                  <c:v>226.08600000000001</c:v>
                </c:pt>
                <c:pt idx="316">
                  <c:v>51.383000000000003</c:v>
                </c:pt>
                <c:pt idx="317">
                  <c:v>195.256</c:v>
                </c:pt>
                <c:pt idx="318">
                  <c:v>102.76600000000001</c:v>
                </c:pt>
                <c:pt idx="319">
                  <c:v>113.04300000000001</c:v>
                </c:pt>
                <c:pt idx="320">
                  <c:v>224.47</c:v>
                </c:pt>
                <c:pt idx="321">
                  <c:v>244.87</c:v>
                </c:pt>
                <c:pt idx="322">
                  <c:v>183.65</c:v>
                </c:pt>
                <c:pt idx="323">
                  <c:v>132.63999999999999</c:v>
                </c:pt>
                <c:pt idx="324">
                  <c:v>91.83</c:v>
                </c:pt>
                <c:pt idx="325">
                  <c:v>112.23</c:v>
                </c:pt>
                <c:pt idx="326">
                  <c:v>234.67</c:v>
                </c:pt>
                <c:pt idx="327">
                  <c:v>173.45</c:v>
                </c:pt>
                <c:pt idx="328">
                  <c:v>255.08</c:v>
                </c:pt>
                <c:pt idx="329">
                  <c:v>204.06</c:v>
                </c:pt>
                <c:pt idx="330">
                  <c:v>224.47</c:v>
                </c:pt>
                <c:pt idx="331">
                  <c:v>173.45</c:v>
                </c:pt>
                <c:pt idx="332">
                  <c:v>183.65</c:v>
                </c:pt>
                <c:pt idx="333">
                  <c:v>244.87</c:v>
                </c:pt>
                <c:pt idx="334">
                  <c:v>224.47</c:v>
                </c:pt>
                <c:pt idx="335">
                  <c:v>61.22</c:v>
                </c:pt>
                <c:pt idx="336">
                  <c:v>224.47</c:v>
                </c:pt>
                <c:pt idx="337">
                  <c:v>132.63999999999999</c:v>
                </c:pt>
                <c:pt idx="338">
                  <c:v>132.63999999999999</c:v>
                </c:pt>
                <c:pt idx="339">
                  <c:v>153.05000000000001</c:v>
                </c:pt>
                <c:pt idx="340">
                  <c:v>185.28</c:v>
                </c:pt>
                <c:pt idx="341">
                  <c:v>123.52</c:v>
                </c:pt>
                <c:pt idx="342">
                  <c:v>154.4</c:v>
                </c:pt>
                <c:pt idx="343">
                  <c:v>102.93</c:v>
                </c:pt>
                <c:pt idx="344">
                  <c:v>123.52</c:v>
                </c:pt>
                <c:pt idx="345">
                  <c:v>92.64</c:v>
                </c:pt>
                <c:pt idx="346">
                  <c:v>164.69</c:v>
                </c:pt>
                <c:pt idx="347">
                  <c:v>123.52</c:v>
                </c:pt>
                <c:pt idx="348">
                  <c:v>123.52</c:v>
                </c:pt>
                <c:pt idx="349">
                  <c:v>102.93</c:v>
                </c:pt>
                <c:pt idx="350">
                  <c:v>174.98</c:v>
                </c:pt>
                <c:pt idx="351">
                  <c:v>164.69</c:v>
                </c:pt>
                <c:pt idx="352">
                  <c:v>154.4</c:v>
                </c:pt>
                <c:pt idx="353">
                  <c:v>92.64</c:v>
                </c:pt>
                <c:pt idx="354">
                  <c:v>133.81</c:v>
                </c:pt>
                <c:pt idx="355">
                  <c:v>195.57</c:v>
                </c:pt>
                <c:pt idx="356">
                  <c:v>164.69</c:v>
                </c:pt>
                <c:pt idx="357">
                  <c:v>154.4</c:v>
                </c:pt>
                <c:pt idx="358">
                  <c:v>154.4</c:v>
                </c:pt>
                <c:pt idx="359">
                  <c:v>164.69</c:v>
                </c:pt>
                <c:pt idx="360">
                  <c:v>206.55</c:v>
                </c:pt>
                <c:pt idx="361">
                  <c:v>175.57</c:v>
                </c:pt>
                <c:pt idx="362">
                  <c:v>154.91999999999999</c:v>
                </c:pt>
                <c:pt idx="363">
                  <c:v>134.26</c:v>
                </c:pt>
                <c:pt idx="364">
                  <c:v>144.59</c:v>
                </c:pt>
                <c:pt idx="365">
                  <c:v>227.21</c:v>
                </c:pt>
                <c:pt idx="366">
                  <c:v>165.24</c:v>
                </c:pt>
                <c:pt idx="367">
                  <c:v>165.24</c:v>
                </c:pt>
                <c:pt idx="368">
                  <c:v>154.91999999999999</c:v>
                </c:pt>
                <c:pt idx="369">
                  <c:v>289.18</c:v>
                </c:pt>
                <c:pt idx="370">
                  <c:v>196.23</c:v>
                </c:pt>
                <c:pt idx="371">
                  <c:v>216.88</c:v>
                </c:pt>
                <c:pt idx="372">
                  <c:v>134.26</c:v>
                </c:pt>
                <c:pt idx="373">
                  <c:v>185.9</c:v>
                </c:pt>
                <c:pt idx="374">
                  <c:v>144.59</c:v>
                </c:pt>
                <c:pt idx="375">
                  <c:v>185.9</c:v>
                </c:pt>
                <c:pt idx="376">
                  <c:v>123.93</c:v>
                </c:pt>
                <c:pt idx="377">
                  <c:v>196.23</c:v>
                </c:pt>
                <c:pt idx="378">
                  <c:v>185.9</c:v>
                </c:pt>
                <c:pt idx="379">
                  <c:v>216.88</c:v>
                </c:pt>
                <c:pt idx="380">
                  <c:v>216.1</c:v>
                </c:pt>
                <c:pt idx="381">
                  <c:v>123.49</c:v>
                </c:pt>
                <c:pt idx="382">
                  <c:v>82.33</c:v>
                </c:pt>
                <c:pt idx="383">
                  <c:v>216.1</c:v>
                </c:pt>
                <c:pt idx="384">
                  <c:v>154.36000000000001</c:v>
                </c:pt>
                <c:pt idx="385">
                  <c:v>113.2</c:v>
                </c:pt>
                <c:pt idx="386">
                  <c:v>133.78</c:v>
                </c:pt>
                <c:pt idx="387">
                  <c:v>154.36000000000001</c:v>
                </c:pt>
                <c:pt idx="388">
                  <c:v>144.07</c:v>
                </c:pt>
                <c:pt idx="389">
                  <c:v>226.39</c:v>
                </c:pt>
                <c:pt idx="390">
                  <c:v>133.78</c:v>
                </c:pt>
                <c:pt idx="391">
                  <c:v>174.94</c:v>
                </c:pt>
                <c:pt idx="392">
                  <c:v>144.07</c:v>
                </c:pt>
                <c:pt idx="393">
                  <c:v>102.91</c:v>
                </c:pt>
                <c:pt idx="394">
                  <c:v>195.52</c:v>
                </c:pt>
                <c:pt idx="395">
                  <c:v>72.03</c:v>
                </c:pt>
                <c:pt idx="396">
                  <c:v>92.62</c:v>
                </c:pt>
                <c:pt idx="397">
                  <c:v>113.2</c:v>
                </c:pt>
                <c:pt idx="398">
                  <c:v>185.23</c:v>
                </c:pt>
                <c:pt idx="399">
                  <c:v>246.98</c:v>
                </c:pt>
                <c:pt idx="400">
                  <c:v>112.15</c:v>
                </c:pt>
                <c:pt idx="401">
                  <c:v>203.9</c:v>
                </c:pt>
                <c:pt idx="402">
                  <c:v>91.76</c:v>
                </c:pt>
                <c:pt idx="403">
                  <c:v>91.76</c:v>
                </c:pt>
                <c:pt idx="404">
                  <c:v>254.88</c:v>
                </c:pt>
                <c:pt idx="405">
                  <c:v>142.72999999999999</c:v>
                </c:pt>
                <c:pt idx="406">
                  <c:v>142.72999999999999</c:v>
                </c:pt>
                <c:pt idx="407">
                  <c:v>265.08</c:v>
                </c:pt>
                <c:pt idx="408">
                  <c:v>285.47000000000003</c:v>
                </c:pt>
                <c:pt idx="409">
                  <c:v>224.29</c:v>
                </c:pt>
                <c:pt idx="410">
                  <c:v>214.1</c:v>
                </c:pt>
                <c:pt idx="411">
                  <c:v>295.66000000000003</c:v>
                </c:pt>
                <c:pt idx="412">
                  <c:v>173.32</c:v>
                </c:pt>
                <c:pt idx="413">
                  <c:v>152.93</c:v>
                </c:pt>
                <c:pt idx="414">
                  <c:v>152.93</c:v>
                </c:pt>
                <c:pt idx="415">
                  <c:v>152.93</c:v>
                </c:pt>
                <c:pt idx="416">
                  <c:v>112.15</c:v>
                </c:pt>
                <c:pt idx="417">
                  <c:v>122.34</c:v>
                </c:pt>
                <c:pt idx="418">
                  <c:v>61.17</c:v>
                </c:pt>
                <c:pt idx="419">
                  <c:v>183.51</c:v>
                </c:pt>
                <c:pt idx="420">
                  <c:v>81.93</c:v>
                </c:pt>
                <c:pt idx="421">
                  <c:v>102.41</c:v>
                </c:pt>
                <c:pt idx="422">
                  <c:v>92.17</c:v>
                </c:pt>
                <c:pt idx="423">
                  <c:v>153.61000000000001</c:v>
                </c:pt>
                <c:pt idx="424">
                  <c:v>204.81</c:v>
                </c:pt>
                <c:pt idx="425">
                  <c:v>174.09</c:v>
                </c:pt>
                <c:pt idx="426">
                  <c:v>133.13</c:v>
                </c:pt>
                <c:pt idx="427">
                  <c:v>143.37</c:v>
                </c:pt>
                <c:pt idx="428">
                  <c:v>225.29</c:v>
                </c:pt>
                <c:pt idx="429">
                  <c:v>174.09</c:v>
                </c:pt>
                <c:pt idx="430">
                  <c:v>266.26</c:v>
                </c:pt>
                <c:pt idx="431">
                  <c:v>112.65</c:v>
                </c:pt>
                <c:pt idx="432">
                  <c:v>81.93</c:v>
                </c:pt>
                <c:pt idx="433">
                  <c:v>163.85</c:v>
                </c:pt>
                <c:pt idx="434">
                  <c:v>40.96</c:v>
                </c:pt>
                <c:pt idx="435">
                  <c:v>194.57</c:v>
                </c:pt>
                <c:pt idx="436">
                  <c:v>215.05</c:v>
                </c:pt>
                <c:pt idx="437">
                  <c:v>143.37</c:v>
                </c:pt>
                <c:pt idx="438">
                  <c:v>133.13</c:v>
                </c:pt>
                <c:pt idx="439">
                  <c:v>204.81</c:v>
                </c:pt>
                <c:pt idx="440">
                  <c:v>114.65</c:v>
                </c:pt>
                <c:pt idx="441">
                  <c:v>72.959999999999994</c:v>
                </c:pt>
                <c:pt idx="442">
                  <c:v>250.14</c:v>
                </c:pt>
                <c:pt idx="443">
                  <c:v>187.6</c:v>
                </c:pt>
                <c:pt idx="444">
                  <c:v>166.76</c:v>
                </c:pt>
                <c:pt idx="445">
                  <c:v>125.07</c:v>
                </c:pt>
                <c:pt idx="446">
                  <c:v>229.29</c:v>
                </c:pt>
                <c:pt idx="447">
                  <c:v>177.18</c:v>
                </c:pt>
                <c:pt idx="448">
                  <c:v>166.76</c:v>
                </c:pt>
                <c:pt idx="449">
                  <c:v>104.22</c:v>
                </c:pt>
                <c:pt idx="450">
                  <c:v>270.98</c:v>
                </c:pt>
                <c:pt idx="451">
                  <c:v>177.18</c:v>
                </c:pt>
                <c:pt idx="452">
                  <c:v>156.34</c:v>
                </c:pt>
                <c:pt idx="453">
                  <c:v>156.34</c:v>
                </c:pt>
                <c:pt idx="454">
                  <c:v>114.65</c:v>
                </c:pt>
                <c:pt idx="455">
                  <c:v>166.76</c:v>
                </c:pt>
                <c:pt idx="456">
                  <c:v>156.34</c:v>
                </c:pt>
                <c:pt idx="457">
                  <c:v>166.76</c:v>
                </c:pt>
                <c:pt idx="458">
                  <c:v>270.98</c:v>
                </c:pt>
                <c:pt idx="459">
                  <c:v>135.49</c:v>
                </c:pt>
              </c:numCache>
            </c:numRef>
          </c:xVal>
          <c:yVal>
            <c:numRef>
              <c:f>ベレ散布図!$E$4:$E$463</c:f>
              <c:numCache>
                <c:formatCode>General</c:formatCode>
                <c:ptCount val="460"/>
                <c:pt idx="0">
                  <c:v>121.08</c:v>
                </c:pt>
                <c:pt idx="1">
                  <c:v>75.680000000000007</c:v>
                </c:pt>
                <c:pt idx="2">
                  <c:v>45.41</c:v>
                </c:pt>
                <c:pt idx="3">
                  <c:v>83.24</c:v>
                </c:pt>
                <c:pt idx="4">
                  <c:v>83.24</c:v>
                </c:pt>
                <c:pt idx="5">
                  <c:v>98.38</c:v>
                </c:pt>
                <c:pt idx="6">
                  <c:v>143.78</c:v>
                </c:pt>
                <c:pt idx="7">
                  <c:v>105.95</c:v>
                </c:pt>
                <c:pt idx="8">
                  <c:v>60.54</c:v>
                </c:pt>
                <c:pt idx="9">
                  <c:v>98.38</c:v>
                </c:pt>
                <c:pt idx="10">
                  <c:v>98.38</c:v>
                </c:pt>
                <c:pt idx="11">
                  <c:v>90.81</c:v>
                </c:pt>
                <c:pt idx="12">
                  <c:v>151.35</c:v>
                </c:pt>
                <c:pt idx="13">
                  <c:v>174.05</c:v>
                </c:pt>
                <c:pt idx="14">
                  <c:v>98.38</c:v>
                </c:pt>
                <c:pt idx="15">
                  <c:v>52.97</c:v>
                </c:pt>
                <c:pt idx="16">
                  <c:v>75.680000000000007</c:v>
                </c:pt>
                <c:pt idx="17">
                  <c:v>98.38</c:v>
                </c:pt>
                <c:pt idx="18">
                  <c:v>143.78</c:v>
                </c:pt>
                <c:pt idx="19">
                  <c:v>121.08</c:v>
                </c:pt>
                <c:pt idx="20">
                  <c:v>169.87</c:v>
                </c:pt>
                <c:pt idx="21">
                  <c:v>177.59</c:v>
                </c:pt>
                <c:pt idx="22">
                  <c:v>262.52999999999997</c:v>
                </c:pt>
                <c:pt idx="23">
                  <c:v>262.52999999999997</c:v>
                </c:pt>
                <c:pt idx="24">
                  <c:v>185.32</c:v>
                </c:pt>
                <c:pt idx="25">
                  <c:v>231.65</c:v>
                </c:pt>
                <c:pt idx="26">
                  <c:v>239.37</c:v>
                </c:pt>
                <c:pt idx="27">
                  <c:v>69.489999999999995</c:v>
                </c:pt>
                <c:pt idx="28">
                  <c:v>61.77</c:v>
                </c:pt>
                <c:pt idx="29">
                  <c:v>332.02</c:v>
                </c:pt>
                <c:pt idx="30">
                  <c:v>239.37</c:v>
                </c:pt>
                <c:pt idx="31">
                  <c:v>185.32</c:v>
                </c:pt>
                <c:pt idx="32">
                  <c:v>138.99</c:v>
                </c:pt>
                <c:pt idx="33">
                  <c:v>223.92</c:v>
                </c:pt>
                <c:pt idx="34">
                  <c:v>193.04</c:v>
                </c:pt>
                <c:pt idx="35">
                  <c:v>185.32</c:v>
                </c:pt>
                <c:pt idx="36">
                  <c:v>231.65</c:v>
                </c:pt>
                <c:pt idx="37">
                  <c:v>285.7</c:v>
                </c:pt>
                <c:pt idx="38">
                  <c:v>316.58</c:v>
                </c:pt>
                <c:pt idx="39">
                  <c:v>146.71</c:v>
                </c:pt>
                <c:pt idx="40">
                  <c:v>239.52</c:v>
                </c:pt>
                <c:pt idx="41">
                  <c:v>208.28</c:v>
                </c:pt>
                <c:pt idx="42">
                  <c:v>62.48</c:v>
                </c:pt>
                <c:pt idx="43">
                  <c:v>156.21</c:v>
                </c:pt>
                <c:pt idx="44">
                  <c:v>187.45</c:v>
                </c:pt>
                <c:pt idx="45">
                  <c:v>104.14</c:v>
                </c:pt>
                <c:pt idx="46">
                  <c:v>72.900000000000006</c:v>
                </c:pt>
                <c:pt idx="47">
                  <c:v>218.69</c:v>
                </c:pt>
                <c:pt idx="48">
                  <c:v>177.04</c:v>
                </c:pt>
                <c:pt idx="49">
                  <c:v>291.58999999999997</c:v>
                </c:pt>
                <c:pt idx="50">
                  <c:v>239.52</c:v>
                </c:pt>
                <c:pt idx="51">
                  <c:v>135.38</c:v>
                </c:pt>
                <c:pt idx="52">
                  <c:v>156.21</c:v>
                </c:pt>
                <c:pt idx="53">
                  <c:v>218.69</c:v>
                </c:pt>
                <c:pt idx="54">
                  <c:v>93.73</c:v>
                </c:pt>
                <c:pt idx="55">
                  <c:v>218.69</c:v>
                </c:pt>
                <c:pt idx="56">
                  <c:v>187.45</c:v>
                </c:pt>
                <c:pt idx="57">
                  <c:v>312.42</c:v>
                </c:pt>
                <c:pt idx="58">
                  <c:v>239.52</c:v>
                </c:pt>
                <c:pt idx="59">
                  <c:v>166.62</c:v>
                </c:pt>
                <c:pt idx="60">
                  <c:v>442.93</c:v>
                </c:pt>
                <c:pt idx="61">
                  <c:v>292.64999999999998</c:v>
                </c:pt>
                <c:pt idx="62">
                  <c:v>355.93</c:v>
                </c:pt>
                <c:pt idx="63">
                  <c:v>371.74</c:v>
                </c:pt>
                <c:pt idx="64">
                  <c:v>213.56</c:v>
                </c:pt>
                <c:pt idx="65">
                  <c:v>427.11</c:v>
                </c:pt>
                <c:pt idx="66">
                  <c:v>189.83</c:v>
                </c:pt>
                <c:pt idx="67">
                  <c:v>174.01</c:v>
                </c:pt>
                <c:pt idx="68">
                  <c:v>166.1</c:v>
                </c:pt>
                <c:pt idx="69">
                  <c:v>213.56</c:v>
                </c:pt>
                <c:pt idx="70">
                  <c:v>110.73</c:v>
                </c:pt>
                <c:pt idx="71">
                  <c:v>292.64999999999998</c:v>
                </c:pt>
                <c:pt idx="72">
                  <c:v>466.66</c:v>
                </c:pt>
                <c:pt idx="73">
                  <c:v>292.64999999999998</c:v>
                </c:pt>
                <c:pt idx="74">
                  <c:v>324.29000000000002</c:v>
                </c:pt>
                <c:pt idx="75">
                  <c:v>158.19</c:v>
                </c:pt>
                <c:pt idx="76">
                  <c:v>466.66</c:v>
                </c:pt>
                <c:pt idx="77">
                  <c:v>237.28</c:v>
                </c:pt>
                <c:pt idx="78">
                  <c:v>427.11</c:v>
                </c:pt>
                <c:pt idx="79">
                  <c:v>348.02</c:v>
                </c:pt>
                <c:pt idx="80">
                  <c:v>600.59</c:v>
                </c:pt>
                <c:pt idx="81">
                  <c:v>545.27</c:v>
                </c:pt>
                <c:pt idx="82">
                  <c:v>458.34</c:v>
                </c:pt>
                <c:pt idx="83">
                  <c:v>292.39</c:v>
                </c:pt>
                <c:pt idx="84">
                  <c:v>324</c:v>
                </c:pt>
                <c:pt idx="85">
                  <c:v>308.2</c:v>
                </c:pt>
                <c:pt idx="86">
                  <c:v>434.63</c:v>
                </c:pt>
                <c:pt idx="87">
                  <c:v>316.10000000000002</c:v>
                </c:pt>
                <c:pt idx="88">
                  <c:v>205.46</c:v>
                </c:pt>
                <c:pt idx="89">
                  <c:v>624.29</c:v>
                </c:pt>
                <c:pt idx="90">
                  <c:v>276.58999999999997</c:v>
                </c:pt>
                <c:pt idx="91">
                  <c:v>181.76</c:v>
                </c:pt>
                <c:pt idx="92">
                  <c:v>387.22</c:v>
                </c:pt>
                <c:pt idx="93">
                  <c:v>466.24</c:v>
                </c:pt>
                <c:pt idx="94">
                  <c:v>395.12</c:v>
                </c:pt>
                <c:pt idx="95">
                  <c:v>371.42</c:v>
                </c:pt>
                <c:pt idx="96">
                  <c:v>355.61</c:v>
                </c:pt>
                <c:pt idx="97">
                  <c:v>371.42</c:v>
                </c:pt>
                <c:pt idx="98">
                  <c:v>395.12</c:v>
                </c:pt>
                <c:pt idx="99">
                  <c:v>339.81</c:v>
                </c:pt>
                <c:pt idx="100">
                  <c:v>371.92</c:v>
                </c:pt>
                <c:pt idx="101">
                  <c:v>359.92</c:v>
                </c:pt>
                <c:pt idx="102">
                  <c:v>311.93</c:v>
                </c:pt>
                <c:pt idx="103">
                  <c:v>299.93</c:v>
                </c:pt>
                <c:pt idx="104">
                  <c:v>275.94</c:v>
                </c:pt>
                <c:pt idx="105">
                  <c:v>335.92</c:v>
                </c:pt>
                <c:pt idx="106">
                  <c:v>347.92</c:v>
                </c:pt>
                <c:pt idx="107">
                  <c:v>191.96</c:v>
                </c:pt>
                <c:pt idx="108">
                  <c:v>227.95</c:v>
                </c:pt>
                <c:pt idx="109">
                  <c:v>299.93</c:v>
                </c:pt>
                <c:pt idx="110">
                  <c:v>407.91</c:v>
                </c:pt>
                <c:pt idx="111">
                  <c:v>551.88</c:v>
                </c:pt>
                <c:pt idx="112">
                  <c:v>311.93</c:v>
                </c:pt>
                <c:pt idx="113">
                  <c:v>299.93</c:v>
                </c:pt>
                <c:pt idx="114">
                  <c:v>443.9</c:v>
                </c:pt>
                <c:pt idx="115">
                  <c:v>203.95</c:v>
                </c:pt>
                <c:pt idx="116">
                  <c:v>407.91</c:v>
                </c:pt>
                <c:pt idx="117">
                  <c:v>287.94</c:v>
                </c:pt>
                <c:pt idx="118">
                  <c:v>227.95</c:v>
                </c:pt>
                <c:pt idx="119">
                  <c:v>419.91</c:v>
                </c:pt>
                <c:pt idx="120">
                  <c:v>384.61</c:v>
                </c:pt>
                <c:pt idx="121">
                  <c:v>329.67</c:v>
                </c:pt>
                <c:pt idx="122">
                  <c:v>178.57</c:v>
                </c:pt>
                <c:pt idx="123">
                  <c:v>288.45999999999998</c:v>
                </c:pt>
                <c:pt idx="124">
                  <c:v>260.99</c:v>
                </c:pt>
                <c:pt idx="125">
                  <c:v>192.31</c:v>
                </c:pt>
                <c:pt idx="126">
                  <c:v>219.78</c:v>
                </c:pt>
                <c:pt idx="127">
                  <c:v>219.78</c:v>
                </c:pt>
                <c:pt idx="128">
                  <c:v>439.56</c:v>
                </c:pt>
                <c:pt idx="129">
                  <c:v>631.86</c:v>
                </c:pt>
                <c:pt idx="130">
                  <c:v>288.45999999999998</c:v>
                </c:pt>
                <c:pt idx="131">
                  <c:v>370.88</c:v>
                </c:pt>
                <c:pt idx="132">
                  <c:v>260.99</c:v>
                </c:pt>
                <c:pt idx="133">
                  <c:v>384.61</c:v>
                </c:pt>
                <c:pt idx="134">
                  <c:v>425.82</c:v>
                </c:pt>
                <c:pt idx="135">
                  <c:v>453.29</c:v>
                </c:pt>
                <c:pt idx="136">
                  <c:v>467.03</c:v>
                </c:pt>
                <c:pt idx="137">
                  <c:v>329.67</c:v>
                </c:pt>
                <c:pt idx="138">
                  <c:v>357.14</c:v>
                </c:pt>
                <c:pt idx="139">
                  <c:v>384.61</c:v>
                </c:pt>
                <c:pt idx="140">
                  <c:v>246.45</c:v>
                </c:pt>
                <c:pt idx="141">
                  <c:v>105.62</c:v>
                </c:pt>
                <c:pt idx="142">
                  <c:v>93.89</c:v>
                </c:pt>
                <c:pt idx="143">
                  <c:v>222.98</c:v>
                </c:pt>
                <c:pt idx="144">
                  <c:v>140.83000000000001</c:v>
                </c:pt>
                <c:pt idx="145">
                  <c:v>269.92</c:v>
                </c:pt>
                <c:pt idx="146">
                  <c:v>234.72</c:v>
                </c:pt>
                <c:pt idx="147">
                  <c:v>164.3</c:v>
                </c:pt>
                <c:pt idx="148">
                  <c:v>269.92</c:v>
                </c:pt>
                <c:pt idx="149">
                  <c:v>258.19</c:v>
                </c:pt>
                <c:pt idx="150">
                  <c:v>140.83000000000001</c:v>
                </c:pt>
                <c:pt idx="151">
                  <c:v>234.72</c:v>
                </c:pt>
                <c:pt idx="152">
                  <c:v>281.66000000000003</c:v>
                </c:pt>
                <c:pt idx="153">
                  <c:v>176.04</c:v>
                </c:pt>
                <c:pt idx="154">
                  <c:v>269.92</c:v>
                </c:pt>
                <c:pt idx="155">
                  <c:v>199.51</c:v>
                </c:pt>
                <c:pt idx="156">
                  <c:v>269.92</c:v>
                </c:pt>
                <c:pt idx="157">
                  <c:v>269.92</c:v>
                </c:pt>
                <c:pt idx="158">
                  <c:v>93.89</c:v>
                </c:pt>
                <c:pt idx="159">
                  <c:v>164.3</c:v>
                </c:pt>
                <c:pt idx="160">
                  <c:v>152.74</c:v>
                </c:pt>
                <c:pt idx="161">
                  <c:v>164.49</c:v>
                </c:pt>
                <c:pt idx="162">
                  <c:v>293.74</c:v>
                </c:pt>
                <c:pt idx="163">
                  <c:v>223.24</c:v>
                </c:pt>
                <c:pt idx="164">
                  <c:v>223.24</c:v>
                </c:pt>
                <c:pt idx="165">
                  <c:v>176.24</c:v>
                </c:pt>
                <c:pt idx="166">
                  <c:v>176.24</c:v>
                </c:pt>
                <c:pt idx="167">
                  <c:v>164.49</c:v>
                </c:pt>
                <c:pt idx="168">
                  <c:v>234.99</c:v>
                </c:pt>
                <c:pt idx="169">
                  <c:v>305.49</c:v>
                </c:pt>
                <c:pt idx="170">
                  <c:v>317.23</c:v>
                </c:pt>
                <c:pt idx="171">
                  <c:v>223.24</c:v>
                </c:pt>
                <c:pt idx="172">
                  <c:v>176.24</c:v>
                </c:pt>
                <c:pt idx="173">
                  <c:v>187.99</c:v>
                </c:pt>
                <c:pt idx="174">
                  <c:v>199.74</c:v>
                </c:pt>
                <c:pt idx="175">
                  <c:v>164.49</c:v>
                </c:pt>
                <c:pt idx="176">
                  <c:v>140.99</c:v>
                </c:pt>
                <c:pt idx="177">
                  <c:v>211.49</c:v>
                </c:pt>
                <c:pt idx="178">
                  <c:v>305.49</c:v>
                </c:pt>
                <c:pt idx="179">
                  <c:v>187.99</c:v>
                </c:pt>
                <c:pt idx="180">
                  <c:v>318.87</c:v>
                </c:pt>
                <c:pt idx="181">
                  <c:v>342.49</c:v>
                </c:pt>
                <c:pt idx="182">
                  <c:v>224.39</c:v>
                </c:pt>
                <c:pt idx="183">
                  <c:v>259.82</c:v>
                </c:pt>
                <c:pt idx="184">
                  <c:v>318.87</c:v>
                </c:pt>
                <c:pt idx="185">
                  <c:v>200.77</c:v>
                </c:pt>
                <c:pt idx="186">
                  <c:v>165.34</c:v>
                </c:pt>
                <c:pt idx="187">
                  <c:v>259.82</c:v>
                </c:pt>
                <c:pt idx="188">
                  <c:v>366.11</c:v>
                </c:pt>
                <c:pt idx="189">
                  <c:v>236.2</c:v>
                </c:pt>
                <c:pt idx="190">
                  <c:v>259.82</c:v>
                </c:pt>
                <c:pt idx="191">
                  <c:v>318.87</c:v>
                </c:pt>
                <c:pt idx="192">
                  <c:v>307.06</c:v>
                </c:pt>
                <c:pt idx="193">
                  <c:v>177.15</c:v>
                </c:pt>
                <c:pt idx="194">
                  <c:v>141.72</c:v>
                </c:pt>
                <c:pt idx="195">
                  <c:v>318.87</c:v>
                </c:pt>
                <c:pt idx="196">
                  <c:v>401.54</c:v>
                </c:pt>
                <c:pt idx="197">
                  <c:v>188.96</c:v>
                </c:pt>
                <c:pt idx="198">
                  <c:v>129.91</c:v>
                </c:pt>
                <c:pt idx="199">
                  <c:v>283.44</c:v>
                </c:pt>
                <c:pt idx="200">
                  <c:v>271.44</c:v>
                </c:pt>
                <c:pt idx="201">
                  <c:v>200.63</c:v>
                </c:pt>
                <c:pt idx="202">
                  <c:v>271.44</c:v>
                </c:pt>
                <c:pt idx="203">
                  <c:v>165.22</c:v>
                </c:pt>
                <c:pt idx="204">
                  <c:v>236.03</c:v>
                </c:pt>
                <c:pt idx="205">
                  <c:v>188.82</c:v>
                </c:pt>
                <c:pt idx="206">
                  <c:v>129.82</c:v>
                </c:pt>
                <c:pt idx="207">
                  <c:v>200.63</c:v>
                </c:pt>
                <c:pt idx="208">
                  <c:v>236.03</c:v>
                </c:pt>
                <c:pt idx="209">
                  <c:v>141.62</c:v>
                </c:pt>
                <c:pt idx="210">
                  <c:v>212.43</c:v>
                </c:pt>
                <c:pt idx="211">
                  <c:v>259.63</c:v>
                </c:pt>
                <c:pt idx="212">
                  <c:v>306.83999999999997</c:v>
                </c:pt>
                <c:pt idx="213">
                  <c:v>165.22</c:v>
                </c:pt>
                <c:pt idx="214">
                  <c:v>165.22</c:v>
                </c:pt>
                <c:pt idx="215">
                  <c:v>660.89</c:v>
                </c:pt>
                <c:pt idx="216">
                  <c:v>578.28</c:v>
                </c:pt>
                <c:pt idx="217">
                  <c:v>460.26</c:v>
                </c:pt>
                <c:pt idx="218">
                  <c:v>719.89</c:v>
                </c:pt>
                <c:pt idx="219">
                  <c:v>354.05</c:v>
                </c:pt>
                <c:pt idx="220">
                  <c:v>264.95</c:v>
                </c:pt>
                <c:pt idx="221">
                  <c:v>184.31</c:v>
                </c:pt>
                <c:pt idx="222">
                  <c:v>380.14</c:v>
                </c:pt>
                <c:pt idx="223">
                  <c:v>184.31</c:v>
                </c:pt>
                <c:pt idx="224">
                  <c:v>276.47000000000003</c:v>
                </c:pt>
                <c:pt idx="225">
                  <c:v>334.06</c:v>
                </c:pt>
                <c:pt idx="226">
                  <c:v>172.79</c:v>
                </c:pt>
                <c:pt idx="227">
                  <c:v>656.61</c:v>
                </c:pt>
                <c:pt idx="228">
                  <c:v>264.95</c:v>
                </c:pt>
                <c:pt idx="229">
                  <c:v>264.95</c:v>
                </c:pt>
                <c:pt idx="230">
                  <c:v>345.58</c:v>
                </c:pt>
                <c:pt idx="231">
                  <c:v>299.5</c:v>
                </c:pt>
                <c:pt idx="232">
                  <c:v>357.1</c:v>
                </c:pt>
                <c:pt idx="233">
                  <c:v>345.58</c:v>
                </c:pt>
                <c:pt idx="234">
                  <c:v>506.85</c:v>
                </c:pt>
                <c:pt idx="235">
                  <c:v>345.58</c:v>
                </c:pt>
                <c:pt idx="236">
                  <c:v>241.91</c:v>
                </c:pt>
                <c:pt idx="237">
                  <c:v>264.95</c:v>
                </c:pt>
                <c:pt idx="238">
                  <c:v>218.87</c:v>
                </c:pt>
                <c:pt idx="239">
                  <c:v>368.62</c:v>
                </c:pt>
                <c:pt idx="240">
                  <c:v>370.5</c:v>
                </c:pt>
                <c:pt idx="241">
                  <c:v>370.5</c:v>
                </c:pt>
                <c:pt idx="242">
                  <c:v>310.74</c:v>
                </c:pt>
                <c:pt idx="243">
                  <c:v>215.13</c:v>
                </c:pt>
                <c:pt idx="244">
                  <c:v>262.94</c:v>
                </c:pt>
                <c:pt idx="245">
                  <c:v>394.4</c:v>
                </c:pt>
                <c:pt idx="246">
                  <c:v>250.98</c:v>
                </c:pt>
                <c:pt idx="247">
                  <c:v>83.66</c:v>
                </c:pt>
                <c:pt idx="248">
                  <c:v>107.56</c:v>
                </c:pt>
                <c:pt idx="249">
                  <c:v>250.98</c:v>
                </c:pt>
                <c:pt idx="250">
                  <c:v>179.27</c:v>
                </c:pt>
                <c:pt idx="251">
                  <c:v>167.32</c:v>
                </c:pt>
                <c:pt idx="252">
                  <c:v>215.13</c:v>
                </c:pt>
                <c:pt idx="253">
                  <c:v>274.89</c:v>
                </c:pt>
                <c:pt idx="254">
                  <c:v>167.32</c:v>
                </c:pt>
                <c:pt idx="255">
                  <c:v>191.23</c:v>
                </c:pt>
                <c:pt idx="256">
                  <c:v>239.03</c:v>
                </c:pt>
                <c:pt idx="257">
                  <c:v>227.08</c:v>
                </c:pt>
                <c:pt idx="258">
                  <c:v>215.13</c:v>
                </c:pt>
                <c:pt idx="259">
                  <c:v>239.03</c:v>
                </c:pt>
                <c:pt idx="260">
                  <c:v>238.21</c:v>
                </c:pt>
                <c:pt idx="261">
                  <c:v>238.21</c:v>
                </c:pt>
                <c:pt idx="262">
                  <c:v>488.34</c:v>
                </c:pt>
                <c:pt idx="263">
                  <c:v>297.77</c:v>
                </c:pt>
                <c:pt idx="264">
                  <c:v>357.32</c:v>
                </c:pt>
                <c:pt idx="265">
                  <c:v>321.58999999999997</c:v>
                </c:pt>
                <c:pt idx="266">
                  <c:v>262.02999999999997</c:v>
                </c:pt>
                <c:pt idx="267">
                  <c:v>142.93</c:v>
                </c:pt>
                <c:pt idx="268">
                  <c:v>273.95</c:v>
                </c:pt>
                <c:pt idx="269">
                  <c:v>404.96</c:v>
                </c:pt>
                <c:pt idx="270">
                  <c:v>273.95</c:v>
                </c:pt>
                <c:pt idx="271">
                  <c:v>428.78</c:v>
                </c:pt>
                <c:pt idx="272">
                  <c:v>357.32</c:v>
                </c:pt>
                <c:pt idx="273">
                  <c:v>381.14</c:v>
                </c:pt>
                <c:pt idx="274">
                  <c:v>393.05</c:v>
                </c:pt>
                <c:pt idx="275">
                  <c:v>381.14</c:v>
                </c:pt>
                <c:pt idx="276">
                  <c:v>416.87</c:v>
                </c:pt>
                <c:pt idx="277">
                  <c:v>464.52</c:v>
                </c:pt>
                <c:pt idx="278">
                  <c:v>309.68</c:v>
                </c:pt>
                <c:pt idx="279">
                  <c:v>273.95</c:v>
                </c:pt>
                <c:pt idx="280">
                  <c:v>507.04</c:v>
                </c:pt>
                <c:pt idx="281">
                  <c:v>362.17</c:v>
                </c:pt>
                <c:pt idx="282">
                  <c:v>434.6</c:v>
                </c:pt>
                <c:pt idx="283">
                  <c:v>193.16</c:v>
                </c:pt>
                <c:pt idx="284">
                  <c:v>362.17</c:v>
                </c:pt>
                <c:pt idx="285">
                  <c:v>338.03</c:v>
                </c:pt>
                <c:pt idx="286">
                  <c:v>567.4</c:v>
                </c:pt>
                <c:pt idx="287">
                  <c:v>325.95</c:v>
                </c:pt>
                <c:pt idx="288">
                  <c:v>253.52</c:v>
                </c:pt>
                <c:pt idx="289">
                  <c:v>265.58999999999997</c:v>
                </c:pt>
                <c:pt idx="290">
                  <c:v>132.80000000000001</c:v>
                </c:pt>
                <c:pt idx="291">
                  <c:v>579.47</c:v>
                </c:pt>
                <c:pt idx="292">
                  <c:v>338.03</c:v>
                </c:pt>
                <c:pt idx="293">
                  <c:v>241.45</c:v>
                </c:pt>
                <c:pt idx="294">
                  <c:v>229.37</c:v>
                </c:pt>
                <c:pt idx="295">
                  <c:v>205.23</c:v>
                </c:pt>
                <c:pt idx="296">
                  <c:v>350.1</c:v>
                </c:pt>
                <c:pt idx="297">
                  <c:v>217.3</c:v>
                </c:pt>
                <c:pt idx="298">
                  <c:v>313.88</c:v>
                </c:pt>
                <c:pt idx="299">
                  <c:v>434.6</c:v>
                </c:pt>
                <c:pt idx="300">
                  <c:v>298.02300000000002</c:v>
                </c:pt>
                <c:pt idx="301">
                  <c:v>328.85300000000001</c:v>
                </c:pt>
                <c:pt idx="302">
                  <c:v>349.40600000000001</c:v>
                </c:pt>
                <c:pt idx="303">
                  <c:v>308.29899999999998</c:v>
                </c:pt>
                <c:pt idx="304">
                  <c:v>133.596</c:v>
                </c:pt>
                <c:pt idx="305">
                  <c:v>226.08600000000001</c:v>
                </c:pt>
                <c:pt idx="306">
                  <c:v>400.78899999999999</c:v>
                </c:pt>
                <c:pt idx="307">
                  <c:v>359.68299999999999</c:v>
                </c:pt>
                <c:pt idx="308">
                  <c:v>195.256</c:v>
                </c:pt>
                <c:pt idx="309">
                  <c:v>267.19299999999998</c:v>
                </c:pt>
                <c:pt idx="310">
                  <c:v>256.916</c:v>
                </c:pt>
                <c:pt idx="311">
                  <c:v>328.85300000000001</c:v>
                </c:pt>
                <c:pt idx="312">
                  <c:v>462.44899999999996</c:v>
                </c:pt>
                <c:pt idx="313">
                  <c:v>256.916</c:v>
                </c:pt>
                <c:pt idx="314">
                  <c:v>390.51300000000003</c:v>
                </c:pt>
                <c:pt idx="315">
                  <c:v>349.40600000000001</c:v>
                </c:pt>
                <c:pt idx="316">
                  <c:v>154.15</c:v>
                </c:pt>
                <c:pt idx="317">
                  <c:v>339.12900000000002</c:v>
                </c:pt>
                <c:pt idx="318">
                  <c:v>92.49</c:v>
                </c:pt>
                <c:pt idx="319">
                  <c:v>195.256</c:v>
                </c:pt>
                <c:pt idx="320">
                  <c:v>357.11</c:v>
                </c:pt>
                <c:pt idx="321">
                  <c:v>510.15</c:v>
                </c:pt>
                <c:pt idx="322">
                  <c:v>357.11</c:v>
                </c:pt>
                <c:pt idx="323">
                  <c:v>255.08</c:v>
                </c:pt>
                <c:pt idx="324">
                  <c:v>163.25</c:v>
                </c:pt>
                <c:pt idx="325">
                  <c:v>163.25</c:v>
                </c:pt>
                <c:pt idx="326">
                  <c:v>418.32</c:v>
                </c:pt>
                <c:pt idx="327">
                  <c:v>367.31</c:v>
                </c:pt>
                <c:pt idx="328">
                  <c:v>418.32</c:v>
                </c:pt>
                <c:pt idx="329">
                  <c:v>336.7</c:v>
                </c:pt>
                <c:pt idx="330">
                  <c:v>459.14</c:v>
                </c:pt>
                <c:pt idx="331">
                  <c:v>377.51</c:v>
                </c:pt>
                <c:pt idx="332">
                  <c:v>367.31</c:v>
                </c:pt>
                <c:pt idx="333">
                  <c:v>397.92</c:v>
                </c:pt>
                <c:pt idx="334">
                  <c:v>448.93</c:v>
                </c:pt>
                <c:pt idx="335">
                  <c:v>224.47</c:v>
                </c:pt>
                <c:pt idx="336">
                  <c:v>316.29000000000002</c:v>
                </c:pt>
                <c:pt idx="337">
                  <c:v>285.69</c:v>
                </c:pt>
                <c:pt idx="338">
                  <c:v>193.86</c:v>
                </c:pt>
                <c:pt idx="339">
                  <c:v>234.67</c:v>
                </c:pt>
                <c:pt idx="340">
                  <c:v>360.26</c:v>
                </c:pt>
                <c:pt idx="341">
                  <c:v>298.5</c:v>
                </c:pt>
                <c:pt idx="342">
                  <c:v>319.08999999999997</c:v>
                </c:pt>
                <c:pt idx="343">
                  <c:v>216.16</c:v>
                </c:pt>
                <c:pt idx="344">
                  <c:v>174.98</c:v>
                </c:pt>
                <c:pt idx="345">
                  <c:v>185.28</c:v>
                </c:pt>
                <c:pt idx="346">
                  <c:v>277.92</c:v>
                </c:pt>
                <c:pt idx="347">
                  <c:v>205.86</c:v>
                </c:pt>
                <c:pt idx="348">
                  <c:v>154.4</c:v>
                </c:pt>
                <c:pt idx="349">
                  <c:v>144.11000000000001</c:v>
                </c:pt>
                <c:pt idx="350">
                  <c:v>329.38</c:v>
                </c:pt>
                <c:pt idx="351">
                  <c:v>298.5</c:v>
                </c:pt>
                <c:pt idx="352">
                  <c:v>174.98</c:v>
                </c:pt>
                <c:pt idx="353">
                  <c:v>257.33</c:v>
                </c:pt>
                <c:pt idx="354">
                  <c:v>205.86</c:v>
                </c:pt>
                <c:pt idx="355">
                  <c:v>226.45</c:v>
                </c:pt>
                <c:pt idx="356">
                  <c:v>133.81</c:v>
                </c:pt>
                <c:pt idx="357">
                  <c:v>133.81</c:v>
                </c:pt>
                <c:pt idx="358">
                  <c:v>308.8</c:v>
                </c:pt>
                <c:pt idx="359">
                  <c:v>164.69</c:v>
                </c:pt>
                <c:pt idx="360">
                  <c:v>216.88</c:v>
                </c:pt>
                <c:pt idx="361">
                  <c:v>216.88</c:v>
                </c:pt>
                <c:pt idx="362">
                  <c:v>123.93</c:v>
                </c:pt>
                <c:pt idx="363">
                  <c:v>165.24</c:v>
                </c:pt>
                <c:pt idx="364">
                  <c:v>258.19</c:v>
                </c:pt>
                <c:pt idx="365">
                  <c:v>506.06</c:v>
                </c:pt>
                <c:pt idx="366">
                  <c:v>309.83</c:v>
                </c:pt>
                <c:pt idx="367">
                  <c:v>185.9</c:v>
                </c:pt>
                <c:pt idx="368">
                  <c:v>289.18</c:v>
                </c:pt>
                <c:pt idx="369">
                  <c:v>506.06</c:v>
                </c:pt>
                <c:pt idx="370">
                  <c:v>516.39</c:v>
                </c:pt>
                <c:pt idx="371">
                  <c:v>413.11</c:v>
                </c:pt>
                <c:pt idx="372">
                  <c:v>216.88</c:v>
                </c:pt>
                <c:pt idx="373">
                  <c:v>258.19</c:v>
                </c:pt>
                <c:pt idx="374">
                  <c:v>289.18</c:v>
                </c:pt>
                <c:pt idx="375">
                  <c:v>227.21</c:v>
                </c:pt>
                <c:pt idx="376">
                  <c:v>154.91999999999999</c:v>
                </c:pt>
                <c:pt idx="377">
                  <c:v>237.54</c:v>
                </c:pt>
                <c:pt idx="378">
                  <c:v>227.21</c:v>
                </c:pt>
                <c:pt idx="379">
                  <c:v>258.19</c:v>
                </c:pt>
                <c:pt idx="380">
                  <c:v>257.27</c:v>
                </c:pt>
                <c:pt idx="381">
                  <c:v>113.2</c:v>
                </c:pt>
                <c:pt idx="382">
                  <c:v>144.07</c:v>
                </c:pt>
                <c:pt idx="383">
                  <c:v>452.79</c:v>
                </c:pt>
                <c:pt idx="384">
                  <c:v>236.69</c:v>
                </c:pt>
                <c:pt idx="385">
                  <c:v>308.72000000000003</c:v>
                </c:pt>
                <c:pt idx="386">
                  <c:v>205.81</c:v>
                </c:pt>
                <c:pt idx="387">
                  <c:v>277.85000000000002</c:v>
                </c:pt>
                <c:pt idx="388">
                  <c:v>246.98</c:v>
                </c:pt>
                <c:pt idx="389">
                  <c:v>391.05</c:v>
                </c:pt>
                <c:pt idx="390">
                  <c:v>319.01</c:v>
                </c:pt>
                <c:pt idx="391">
                  <c:v>133.78</c:v>
                </c:pt>
                <c:pt idx="392">
                  <c:v>123.49</c:v>
                </c:pt>
                <c:pt idx="393">
                  <c:v>144.07</c:v>
                </c:pt>
                <c:pt idx="394">
                  <c:v>257.27</c:v>
                </c:pt>
                <c:pt idx="395">
                  <c:v>144.07</c:v>
                </c:pt>
                <c:pt idx="396">
                  <c:v>144.07</c:v>
                </c:pt>
                <c:pt idx="397">
                  <c:v>174.94</c:v>
                </c:pt>
                <c:pt idx="398">
                  <c:v>246.98</c:v>
                </c:pt>
                <c:pt idx="399">
                  <c:v>277.85000000000002</c:v>
                </c:pt>
                <c:pt idx="400">
                  <c:v>326.25</c:v>
                </c:pt>
                <c:pt idx="401">
                  <c:v>540.35</c:v>
                </c:pt>
                <c:pt idx="402">
                  <c:v>183.51</c:v>
                </c:pt>
                <c:pt idx="403">
                  <c:v>305.86</c:v>
                </c:pt>
                <c:pt idx="404">
                  <c:v>601.52</c:v>
                </c:pt>
                <c:pt idx="405">
                  <c:v>203.9</c:v>
                </c:pt>
                <c:pt idx="406">
                  <c:v>254.88</c:v>
                </c:pt>
                <c:pt idx="407">
                  <c:v>458.78</c:v>
                </c:pt>
                <c:pt idx="408">
                  <c:v>632.1</c:v>
                </c:pt>
                <c:pt idx="409">
                  <c:v>326.25</c:v>
                </c:pt>
                <c:pt idx="410">
                  <c:v>244.69</c:v>
                </c:pt>
                <c:pt idx="411">
                  <c:v>642.29999999999995</c:v>
                </c:pt>
                <c:pt idx="412">
                  <c:v>346.64</c:v>
                </c:pt>
                <c:pt idx="413">
                  <c:v>407.81</c:v>
                </c:pt>
                <c:pt idx="414">
                  <c:v>214.1</c:v>
                </c:pt>
                <c:pt idx="415">
                  <c:v>173.32</c:v>
                </c:pt>
                <c:pt idx="416">
                  <c:v>183.51</c:v>
                </c:pt>
                <c:pt idx="417">
                  <c:v>152.93</c:v>
                </c:pt>
                <c:pt idx="418">
                  <c:v>112.15</c:v>
                </c:pt>
                <c:pt idx="419">
                  <c:v>234.49</c:v>
                </c:pt>
                <c:pt idx="420">
                  <c:v>215.05</c:v>
                </c:pt>
                <c:pt idx="421">
                  <c:v>153.61000000000001</c:v>
                </c:pt>
                <c:pt idx="422">
                  <c:v>225.29</c:v>
                </c:pt>
                <c:pt idx="423">
                  <c:v>256.02</c:v>
                </c:pt>
                <c:pt idx="424">
                  <c:v>348.18</c:v>
                </c:pt>
                <c:pt idx="425">
                  <c:v>286.74</c:v>
                </c:pt>
                <c:pt idx="426">
                  <c:v>317.45999999999998</c:v>
                </c:pt>
                <c:pt idx="427">
                  <c:v>174.09</c:v>
                </c:pt>
                <c:pt idx="428">
                  <c:v>440.35</c:v>
                </c:pt>
                <c:pt idx="429">
                  <c:v>378.9</c:v>
                </c:pt>
                <c:pt idx="430">
                  <c:v>460.83</c:v>
                </c:pt>
                <c:pt idx="431">
                  <c:v>235.53</c:v>
                </c:pt>
                <c:pt idx="432">
                  <c:v>112.65</c:v>
                </c:pt>
                <c:pt idx="433">
                  <c:v>317.45999999999998</c:v>
                </c:pt>
                <c:pt idx="434">
                  <c:v>61.44</c:v>
                </c:pt>
                <c:pt idx="435">
                  <c:v>225.29</c:v>
                </c:pt>
                <c:pt idx="436">
                  <c:v>348.18</c:v>
                </c:pt>
                <c:pt idx="437">
                  <c:v>266.26</c:v>
                </c:pt>
                <c:pt idx="438">
                  <c:v>327.7</c:v>
                </c:pt>
                <c:pt idx="439">
                  <c:v>307.22000000000003</c:v>
                </c:pt>
                <c:pt idx="440">
                  <c:v>229.29</c:v>
                </c:pt>
                <c:pt idx="441">
                  <c:v>114.65</c:v>
                </c:pt>
                <c:pt idx="442">
                  <c:v>291.83</c:v>
                </c:pt>
                <c:pt idx="443">
                  <c:v>187.6</c:v>
                </c:pt>
                <c:pt idx="444">
                  <c:v>198.03</c:v>
                </c:pt>
                <c:pt idx="445">
                  <c:v>198.03</c:v>
                </c:pt>
                <c:pt idx="446">
                  <c:v>437.74</c:v>
                </c:pt>
                <c:pt idx="447">
                  <c:v>281.39999999999998</c:v>
                </c:pt>
                <c:pt idx="448">
                  <c:v>218.87</c:v>
                </c:pt>
                <c:pt idx="449">
                  <c:v>125.07</c:v>
                </c:pt>
                <c:pt idx="450">
                  <c:v>437.74</c:v>
                </c:pt>
                <c:pt idx="451">
                  <c:v>260.56</c:v>
                </c:pt>
                <c:pt idx="452">
                  <c:v>333.52</c:v>
                </c:pt>
                <c:pt idx="453">
                  <c:v>260.56</c:v>
                </c:pt>
                <c:pt idx="454">
                  <c:v>156.34</c:v>
                </c:pt>
                <c:pt idx="455">
                  <c:v>198.03</c:v>
                </c:pt>
                <c:pt idx="456">
                  <c:v>364.78</c:v>
                </c:pt>
                <c:pt idx="457">
                  <c:v>385.63</c:v>
                </c:pt>
                <c:pt idx="458">
                  <c:v>469.01</c:v>
                </c:pt>
                <c:pt idx="459">
                  <c:v>364.78</c:v>
                </c:pt>
              </c:numCache>
            </c:numRef>
          </c:yVal>
          <c:smooth val="0"/>
          <c:extLst>
            <c:ext xmlns:c16="http://schemas.microsoft.com/office/drawing/2014/chart" uri="{C3380CC4-5D6E-409C-BE32-E72D297353CC}">
              <c16:uniqueId val="{00000001-17D9-6242-9D49-DE8872981ECE}"/>
            </c:ext>
          </c:extLst>
        </c:ser>
        <c:dLbls>
          <c:showLegendKey val="0"/>
          <c:showVal val="0"/>
          <c:showCatName val="0"/>
          <c:showSerName val="0"/>
          <c:showPercent val="0"/>
          <c:showBubbleSize val="0"/>
        </c:dLbls>
        <c:axId val="1374367008"/>
        <c:axId val="1418485024"/>
      </c:scatterChart>
      <c:valAx>
        <c:axId val="1374367008"/>
        <c:scaling>
          <c:orientation val="minMax"/>
        </c:scaling>
        <c:delete val="0"/>
        <c:axPos val="b"/>
        <c:majorGridlines>
          <c:spPr>
            <a:ln w="9525" cap="flat" cmpd="sng" algn="ctr">
              <a:noFill/>
              <a:round/>
            </a:ln>
            <a:effectLst/>
          </c:spPr>
        </c:majorGridlines>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18485024"/>
        <c:crosses val="autoZero"/>
        <c:crossBetween val="midCat"/>
      </c:valAx>
      <c:valAx>
        <c:axId val="1418485024"/>
        <c:scaling>
          <c:orientation val="minMax"/>
        </c:scaling>
        <c:delete val="0"/>
        <c:axPos val="l"/>
        <c:majorGridlines>
          <c:spPr>
            <a:ln w="9525" cap="flat" cmpd="sng" algn="ctr">
              <a:noFill/>
              <a:round/>
            </a:ln>
            <a:effectLst/>
          </c:spPr>
        </c:majorGridlines>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74367008"/>
        <c:crosses val="autoZero"/>
        <c:crossBetween val="midCat"/>
      </c:valAx>
      <c:spPr>
        <a:noFill/>
        <a:ln>
          <a:solidFill>
            <a:schemeClr val="tx1"/>
          </a:solidFill>
        </a:ln>
        <a:effectLst/>
      </c:spPr>
    </c:plotArea>
    <c:legend>
      <c:legendPos val="r"/>
      <c:layout>
        <c:manualLayout>
          <c:xMode val="edge"/>
          <c:yMode val="edge"/>
          <c:x val="0.82672088732349991"/>
          <c:y val="0.81885908076286018"/>
          <c:w val="0.11231802449771593"/>
          <c:h val="8.7776986691789058E-2"/>
        </c:manualLayout>
      </c:layout>
      <c:overlay val="0"/>
      <c:spPr>
        <a:noFill/>
        <a:ln>
          <a:noFill/>
        </a:ln>
        <a:effectLst/>
      </c:spPr>
      <c:txPr>
        <a:bodyPr rot="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662608633742845"/>
          <c:y val="0.10272089402078179"/>
          <c:w val="0.82567002782195575"/>
          <c:h val="0.82432046595847486"/>
        </c:manualLayout>
      </c:layout>
      <c:scatterChart>
        <c:scatterStyle val="lineMarker"/>
        <c:varyColors val="0"/>
        <c:ser>
          <c:idx val="0"/>
          <c:order val="0"/>
          <c:tx>
            <c:v>NT</c:v>
          </c:tx>
          <c:spPr>
            <a:ln w="25400" cap="rnd">
              <a:noFill/>
              <a:round/>
            </a:ln>
            <a:effectLst/>
          </c:spPr>
          <c:marker>
            <c:symbol val="circle"/>
            <c:size val="4"/>
            <c:spPr>
              <a:noFill/>
              <a:ln w="12700">
                <a:solidFill>
                  <a:schemeClr val="accent2"/>
                </a:solidFill>
              </a:ln>
              <a:effectLst/>
            </c:spPr>
          </c:marker>
          <c:xVal>
            <c:numRef>
              <c:f>ベレ散布図!$G$4:$G$403</c:f>
              <c:numCache>
                <c:formatCode>General</c:formatCode>
                <c:ptCount val="400"/>
                <c:pt idx="0">
                  <c:v>137.19999999999999</c:v>
                </c:pt>
                <c:pt idx="1">
                  <c:v>111.47</c:v>
                </c:pt>
                <c:pt idx="2">
                  <c:v>128.62</c:v>
                </c:pt>
                <c:pt idx="3">
                  <c:v>68.599999999999994</c:v>
                </c:pt>
                <c:pt idx="4">
                  <c:v>94.32</c:v>
                </c:pt>
                <c:pt idx="5">
                  <c:v>60.02</c:v>
                </c:pt>
                <c:pt idx="6">
                  <c:v>111.47</c:v>
                </c:pt>
                <c:pt idx="7">
                  <c:v>102.9</c:v>
                </c:pt>
                <c:pt idx="8">
                  <c:v>137.19999999999999</c:v>
                </c:pt>
                <c:pt idx="9">
                  <c:v>77.17</c:v>
                </c:pt>
                <c:pt idx="10">
                  <c:v>85.75</c:v>
                </c:pt>
                <c:pt idx="11">
                  <c:v>111.47</c:v>
                </c:pt>
                <c:pt idx="12">
                  <c:v>94.32</c:v>
                </c:pt>
                <c:pt idx="13">
                  <c:v>60.02</c:v>
                </c:pt>
                <c:pt idx="14">
                  <c:v>68.599999999999994</c:v>
                </c:pt>
                <c:pt idx="15">
                  <c:v>111.47</c:v>
                </c:pt>
                <c:pt idx="16">
                  <c:v>68.599999999999994</c:v>
                </c:pt>
                <c:pt idx="17">
                  <c:v>85.75</c:v>
                </c:pt>
                <c:pt idx="18">
                  <c:v>77.17</c:v>
                </c:pt>
                <c:pt idx="19">
                  <c:v>120.05</c:v>
                </c:pt>
                <c:pt idx="20">
                  <c:v>127.98</c:v>
                </c:pt>
                <c:pt idx="21">
                  <c:v>127.98</c:v>
                </c:pt>
                <c:pt idx="22">
                  <c:v>119.45</c:v>
                </c:pt>
                <c:pt idx="23">
                  <c:v>127.98</c:v>
                </c:pt>
                <c:pt idx="24">
                  <c:v>59.73</c:v>
                </c:pt>
                <c:pt idx="25">
                  <c:v>68.260000000000005</c:v>
                </c:pt>
                <c:pt idx="26">
                  <c:v>110.92</c:v>
                </c:pt>
                <c:pt idx="27">
                  <c:v>110.92</c:v>
                </c:pt>
                <c:pt idx="28">
                  <c:v>136.51</c:v>
                </c:pt>
                <c:pt idx="29">
                  <c:v>127.98</c:v>
                </c:pt>
                <c:pt idx="30">
                  <c:v>136.51</c:v>
                </c:pt>
                <c:pt idx="31">
                  <c:v>145.05000000000001</c:v>
                </c:pt>
                <c:pt idx="32">
                  <c:v>68.260000000000005</c:v>
                </c:pt>
                <c:pt idx="33">
                  <c:v>76.790000000000006</c:v>
                </c:pt>
                <c:pt idx="34">
                  <c:v>59.73</c:v>
                </c:pt>
                <c:pt idx="35">
                  <c:v>153.58000000000001</c:v>
                </c:pt>
                <c:pt idx="36">
                  <c:v>76.790000000000006</c:v>
                </c:pt>
                <c:pt idx="37">
                  <c:v>85.32</c:v>
                </c:pt>
                <c:pt idx="38">
                  <c:v>93.85</c:v>
                </c:pt>
                <c:pt idx="39">
                  <c:v>93.85</c:v>
                </c:pt>
                <c:pt idx="40">
                  <c:v>84.75</c:v>
                </c:pt>
                <c:pt idx="41">
                  <c:v>67.8</c:v>
                </c:pt>
                <c:pt idx="42">
                  <c:v>67.8</c:v>
                </c:pt>
                <c:pt idx="43">
                  <c:v>42.37</c:v>
                </c:pt>
                <c:pt idx="44">
                  <c:v>59.32</c:v>
                </c:pt>
                <c:pt idx="45">
                  <c:v>59.32</c:v>
                </c:pt>
                <c:pt idx="46">
                  <c:v>93.22</c:v>
                </c:pt>
                <c:pt idx="47">
                  <c:v>76.27</c:v>
                </c:pt>
                <c:pt idx="48">
                  <c:v>93.22</c:v>
                </c:pt>
                <c:pt idx="49">
                  <c:v>110.17</c:v>
                </c:pt>
                <c:pt idx="50">
                  <c:v>67.8</c:v>
                </c:pt>
                <c:pt idx="51">
                  <c:v>67.8</c:v>
                </c:pt>
                <c:pt idx="52">
                  <c:v>84.75</c:v>
                </c:pt>
                <c:pt idx="53">
                  <c:v>50.85</c:v>
                </c:pt>
                <c:pt idx="54">
                  <c:v>76.27</c:v>
                </c:pt>
                <c:pt idx="55">
                  <c:v>67.8</c:v>
                </c:pt>
                <c:pt idx="56">
                  <c:v>50.85</c:v>
                </c:pt>
                <c:pt idx="57">
                  <c:v>59.32</c:v>
                </c:pt>
                <c:pt idx="58">
                  <c:v>76.27</c:v>
                </c:pt>
                <c:pt idx="59">
                  <c:v>59.32</c:v>
                </c:pt>
                <c:pt idx="60">
                  <c:v>63.14</c:v>
                </c:pt>
                <c:pt idx="61">
                  <c:v>63.14</c:v>
                </c:pt>
                <c:pt idx="62">
                  <c:v>63.14</c:v>
                </c:pt>
                <c:pt idx="63">
                  <c:v>72.16</c:v>
                </c:pt>
                <c:pt idx="64">
                  <c:v>108.24</c:v>
                </c:pt>
                <c:pt idx="65">
                  <c:v>45.1</c:v>
                </c:pt>
                <c:pt idx="66">
                  <c:v>72.16</c:v>
                </c:pt>
                <c:pt idx="67">
                  <c:v>99.22</c:v>
                </c:pt>
                <c:pt idx="68">
                  <c:v>90.2</c:v>
                </c:pt>
                <c:pt idx="69">
                  <c:v>144.32</c:v>
                </c:pt>
                <c:pt idx="70">
                  <c:v>90.2</c:v>
                </c:pt>
                <c:pt idx="71">
                  <c:v>99.22</c:v>
                </c:pt>
                <c:pt idx="72">
                  <c:v>72.16</c:v>
                </c:pt>
                <c:pt idx="73">
                  <c:v>135.30000000000001</c:v>
                </c:pt>
                <c:pt idx="74">
                  <c:v>90.2</c:v>
                </c:pt>
                <c:pt idx="75">
                  <c:v>81.180000000000007</c:v>
                </c:pt>
                <c:pt idx="76">
                  <c:v>90.2</c:v>
                </c:pt>
                <c:pt idx="77">
                  <c:v>63.14</c:v>
                </c:pt>
                <c:pt idx="78">
                  <c:v>90.2</c:v>
                </c:pt>
                <c:pt idx="79">
                  <c:v>108.24</c:v>
                </c:pt>
                <c:pt idx="80">
                  <c:v>130</c:v>
                </c:pt>
                <c:pt idx="81">
                  <c:v>190</c:v>
                </c:pt>
                <c:pt idx="82">
                  <c:v>90</c:v>
                </c:pt>
                <c:pt idx="83">
                  <c:v>100</c:v>
                </c:pt>
                <c:pt idx="84">
                  <c:v>120</c:v>
                </c:pt>
                <c:pt idx="85">
                  <c:v>90</c:v>
                </c:pt>
                <c:pt idx="86">
                  <c:v>100</c:v>
                </c:pt>
                <c:pt idx="87">
                  <c:v>90</c:v>
                </c:pt>
                <c:pt idx="88">
                  <c:v>80</c:v>
                </c:pt>
                <c:pt idx="89">
                  <c:v>60</c:v>
                </c:pt>
                <c:pt idx="90">
                  <c:v>140</c:v>
                </c:pt>
                <c:pt idx="91">
                  <c:v>80</c:v>
                </c:pt>
                <c:pt idx="92">
                  <c:v>100</c:v>
                </c:pt>
                <c:pt idx="93">
                  <c:v>70</c:v>
                </c:pt>
                <c:pt idx="94">
                  <c:v>70</c:v>
                </c:pt>
                <c:pt idx="95">
                  <c:v>120</c:v>
                </c:pt>
                <c:pt idx="96">
                  <c:v>120</c:v>
                </c:pt>
                <c:pt idx="97">
                  <c:v>100</c:v>
                </c:pt>
                <c:pt idx="98">
                  <c:v>130</c:v>
                </c:pt>
                <c:pt idx="99">
                  <c:v>130</c:v>
                </c:pt>
                <c:pt idx="100">
                  <c:v>128.26</c:v>
                </c:pt>
                <c:pt idx="101">
                  <c:v>117.57</c:v>
                </c:pt>
                <c:pt idx="102">
                  <c:v>106.88</c:v>
                </c:pt>
                <c:pt idx="103">
                  <c:v>138.94999999999999</c:v>
                </c:pt>
                <c:pt idx="104">
                  <c:v>160.32</c:v>
                </c:pt>
                <c:pt idx="105">
                  <c:v>74.819999999999993</c:v>
                </c:pt>
                <c:pt idx="106">
                  <c:v>106.88</c:v>
                </c:pt>
                <c:pt idx="107">
                  <c:v>96.19</c:v>
                </c:pt>
                <c:pt idx="108">
                  <c:v>117.57</c:v>
                </c:pt>
                <c:pt idx="109">
                  <c:v>74.819999999999993</c:v>
                </c:pt>
                <c:pt idx="110">
                  <c:v>74.819999999999993</c:v>
                </c:pt>
                <c:pt idx="111">
                  <c:v>85.51</c:v>
                </c:pt>
                <c:pt idx="112">
                  <c:v>96.19</c:v>
                </c:pt>
                <c:pt idx="113">
                  <c:v>64.13</c:v>
                </c:pt>
                <c:pt idx="114">
                  <c:v>117.57</c:v>
                </c:pt>
                <c:pt idx="115">
                  <c:v>85.51</c:v>
                </c:pt>
                <c:pt idx="116">
                  <c:v>74.819999999999993</c:v>
                </c:pt>
                <c:pt idx="117">
                  <c:v>74.819999999999993</c:v>
                </c:pt>
                <c:pt idx="118">
                  <c:v>96.19</c:v>
                </c:pt>
                <c:pt idx="119">
                  <c:v>106.88</c:v>
                </c:pt>
                <c:pt idx="120">
                  <c:v>118.61</c:v>
                </c:pt>
                <c:pt idx="121">
                  <c:v>177.92</c:v>
                </c:pt>
                <c:pt idx="122">
                  <c:v>138.38</c:v>
                </c:pt>
                <c:pt idx="123">
                  <c:v>118.61</c:v>
                </c:pt>
                <c:pt idx="124">
                  <c:v>79.08</c:v>
                </c:pt>
                <c:pt idx="125">
                  <c:v>108.73</c:v>
                </c:pt>
                <c:pt idx="126">
                  <c:v>138.38</c:v>
                </c:pt>
                <c:pt idx="127">
                  <c:v>128.5</c:v>
                </c:pt>
                <c:pt idx="128">
                  <c:v>128.5</c:v>
                </c:pt>
                <c:pt idx="129">
                  <c:v>98.84</c:v>
                </c:pt>
                <c:pt idx="130">
                  <c:v>158.15</c:v>
                </c:pt>
                <c:pt idx="131">
                  <c:v>118.61</c:v>
                </c:pt>
                <c:pt idx="132">
                  <c:v>98.84</c:v>
                </c:pt>
                <c:pt idx="133">
                  <c:v>168.03</c:v>
                </c:pt>
                <c:pt idx="134">
                  <c:v>98.84</c:v>
                </c:pt>
                <c:pt idx="135">
                  <c:v>79.08</c:v>
                </c:pt>
                <c:pt idx="136">
                  <c:v>118.61</c:v>
                </c:pt>
                <c:pt idx="137">
                  <c:v>79.08</c:v>
                </c:pt>
                <c:pt idx="138">
                  <c:v>108.73</c:v>
                </c:pt>
                <c:pt idx="139">
                  <c:v>88.96</c:v>
                </c:pt>
                <c:pt idx="140">
                  <c:v>93.1</c:v>
                </c:pt>
                <c:pt idx="141">
                  <c:v>82.76</c:v>
                </c:pt>
                <c:pt idx="142">
                  <c:v>144.83000000000001</c:v>
                </c:pt>
                <c:pt idx="143">
                  <c:v>103.45</c:v>
                </c:pt>
                <c:pt idx="144">
                  <c:v>62.07</c:v>
                </c:pt>
                <c:pt idx="145">
                  <c:v>72.41</c:v>
                </c:pt>
                <c:pt idx="146">
                  <c:v>82.76</c:v>
                </c:pt>
                <c:pt idx="147">
                  <c:v>51.72</c:v>
                </c:pt>
                <c:pt idx="148">
                  <c:v>72.41</c:v>
                </c:pt>
                <c:pt idx="149">
                  <c:v>113.79</c:v>
                </c:pt>
                <c:pt idx="150">
                  <c:v>82.76</c:v>
                </c:pt>
                <c:pt idx="151">
                  <c:v>72.41</c:v>
                </c:pt>
                <c:pt idx="152">
                  <c:v>62.07</c:v>
                </c:pt>
                <c:pt idx="153">
                  <c:v>62.07</c:v>
                </c:pt>
                <c:pt idx="154">
                  <c:v>124.14</c:v>
                </c:pt>
                <c:pt idx="155">
                  <c:v>72.41</c:v>
                </c:pt>
                <c:pt idx="156">
                  <c:v>113.79</c:v>
                </c:pt>
                <c:pt idx="157">
                  <c:v>41.38</c:v>
                </c:pt>
                <c:pt idx="158">
                  <c:v>62.07</c:v>
                </c:pt>
                <c:pt idx="159">
                  <c:v>82.76</c:v>
                </c:pt>
                <c:pt idx="160">
                  <c:v>71.39</c:v>
                </c:pt>
                <c:pt idx="161">
                  <c:v>71.39</c:v>
                </c:pt>
                <c:pt idx="162">
                  <c:v>50.99</c:v>
                </c:pt>
                <c:pt idx="163">
                  <c:v>101.98</c:v>
                </c:pt>
                <c:pt idx="164">
                  <c:v>122.38</c:v>
                </c:pt>
                <c:pt idx="165">
                  <c:v>122.38</c:v>
                </c:pt>
                <c:pt idx="166">
                  <c:v>122.38</c:v>
                </c:pt>
                <c:pt idx="167">
                  <c:v>81.59</c:v>
                </c:pt>
                <c:pt idx="168">
                  <c:v>71.39</c:v>
                </c:pt>
                <c:pt idx="169">
                  <c:v>81.59</c:v>
                </c:pt>
                <c:pt idx="170">
                  <c:v>91.78</c:v>
                </c:pt>
                <c:pt idx="171">
                  <c:v>122.38</c:v>
                </c:pt>
                <c:pt idx="172">
                  <c:v>112.18</c:v>
                </c:pt>
                <c:pt idx="173">
                  <c:v>122.38</c:v>
                </c:pt>
                <c:pt idx="174">
                  <c:v>142.77000000000001</c:v>
                </c:pt>
                <c:pt idx="175">
                  <c:v>112.18</c:v>
                </c:pt>
                <c:pt idx="176">
                  <c:v>81.59</c:v>
                </c:pt>
                <c:pt idx="177">
                  <c:v>122.38</c:v>
                </c:pt>
                <c:pt idx="178">
                  <c:v>122.38</c:v>
                </c:pt>
                <c:pt idx="179">
                  <c:v>152.97</c:v>
                </c:pt>
                <c:pt idx="180">
                  <c:v>203.3</c:v>
                </c:pt>
                <c:pt idx="181">
                  <c:v>101.65</c:v>
                </c:pt>
                <c:pt idx="182">
                  <c:v>81.319999999999993</c:v>
                </c:pt>
                <c:pt idx="183">
                  <c:v>81.319999999999993</c:v>
                </c:pt>
                <c:pt idx="184">
                  <c:v>162.63999999999999</c:v>
                </c:pt>
                <c:pt idx="185">
                  <c:v>111.81</c:v>
                </c:pt>
                <c:pt idx="186">
                  <c:v>162.63999999999999</c:v>
                </c:pt>
                <c:pt idx="187">
                  <c:v>142.31</c:v>
                </c:pt>
                <c:pt idx="188">
                  <c:v>50.82</c:v>
                </c:pt>
                <c:pt idx="189">
                  <c:v>71.150000000000006</c:v>
                </c:pt>
                <c:pt idx="190">
                  <c:v>81.319999999999993</c:v>
                </c:pt>
                <c:pt idx="191">
                  <c:v>50.82</c:v>
                </c:pt>
                <c:pt idx="192">
                  <c:v>50.82</c:v>
                </c:pt>
                <c:pt idx="193">
                  <c:v>101.65</c:v>
                </c:pt>
                <c:pt idx="194">
                  <c:v>101.65</c:v>
                </c:pt>
                <c:pt idx="195">
                  <c:v>71.150000000000006</c:v>
                </c:pt>
                <c:pt idx="196">
                  <c:v>71.150000000000006</c:v>
                </c:pt>
                <c:pt idx="197">
                  <c:v>81.319999999999993</c:v>
                </c:pt>
                <c:pt idx="198">
                  <c:v>111.81</c:v>
                </c:pt>
                <c:pt idx="199">
                  <c:v>71.150000000000006</c:v>
                </c:pt>
                <c:pt idx="200">
                  <c:v>77.34</c:v>
                </c:pt>
                <c:pt idx="201">
                  <c:v>135.35</c:v>
                </c:pt>
                <c:pt idx="202">
                  <c:v>67.67</c:v>
                </c:pt>
                <c:pt idx="203">
                  <c:v>96.68</c:v>
                </c:pt>
                <c:pt idx="204">
                  <c:v>87.01</c:v>
                </c:pt>
                <c:pt idx="205">
                  <c:v>67.67</c:v>
                </c:pt>
                <c:pt idx="206">
                  <c:v>96.68</c:v>
                </c:pt>
                <c:pt idx="207">
                  <c:v>87.01</c:v>
                </c:pt>
                <c:pt idx="208">
                  <c:v>67.67</c:v>
                </c:pt>
                <c:pt idx="209">
                  <c:v>87.01</c:v>
                </c:pt>
                <c:pt idx="210">
                  <c:v>67.67</c:v>
                </c:pt>
                <c:pt idx="211">
                  <c:v>96.68</c:v>
                </c:pt>
                <c:pt idx="212">
                  <c:v>116.01</c:v>
                </c:pt>
                <c:pt idx="213">
                  <c:v>87.01</c:v>
                </c:pt>
                <c:pt idx="214">
                  <c:v>106.34</c:v>
                </c:pt>
                <c:pt idx="215">
                  <c:v>38.67</c:v>
                </c:pt>
                <c:pt idx="216">
                  <c:v>96.68</c:v>
                </c:pt>
                <c:pt idx="217">
                  <c:v>87.01</c:v>
                </c:pt>
                <c:pt idx="218">
                  <c:v>87.01</c:v>
                </c:pt>
                <c:pt idx="219">
                  <c:v>67.67</c:v>
                </c:pt>
                <c:pt idx="220">
                  <c:v>122.59</c:v>
                </c:pt>
                <c:pt idx="221">
                  <c:v>56.58</c:v>
                </c:pt>
                <c:pt idx="222">
                  <c:v>75.44</c:v>
                </c:pt>
                <c:pt idx="223">
                  <c:v>56.58</c:v>
                </c:pt>
                <c:pt idx="224">
                  <c:v>103.73</c:v>
                </c:pt>
                <c:pt idx="225">
                  <c:v>84.87</c:v>
                </c:pt>
                <c:pt idx="226">
                  <c:v>75.44</c:v>
                </c:pt>
                <c:pt idx="227">
                  <c:v>84.87</c:v>
                </c:pt>
                <c:pt idx="228">
                  <c:v>113.16</c:v>
                </c:pt>
                <c:pt idx="229">
                  <c:v>141.46</c:v>
                </c:pt>
                <c:pt idx="230">
                  <c:v>75.44</c:v>
                </c:pt>
                <c:pt idx="231">
                  <c:v>94.3</c:v>
                </c:pt>
                <c:pt idx="232">
                  <c:v>75.44</c:v>
                </c:pt>
                <c:pt idx="233">
                  <c:v>75.44</c:v>
                </c:pt>
                <c:pt idx="234">
                  <c:v>122.59</c:v>
                </c:pt>
                <c:pt idx="235">
                  <c:v>103.73</c:v>
                </c:pt>
                <c:pt idx="236">
                  <c:v>103.73</c:v>
                </c:pt>
                <c:pt idx="237">
                  <c:v>113.16</c:v>
                </c:pt>
                <c:pt idx="238">
                  <c:v>75.44</c:v>
                </c:pt>
                <c:pt idx="239">
                  <c:v>94.3</c:v>
                </c:pt>
                <c:pt idx="240">
                  <c:v>93.45</c:v>
                </c:pt>
                <c:pt idx="241">
                  <c:v>84.1</c:v>
                </c:pt>
                <c:pt idx="242">
                  <c:v>93.45</c:v>
                </c:pt>
                <c:pt idx="243">
                  <c:v>140.16999999999999</c:v>
                </c:pt>
                <c:pt idx="244">
                  <c:v>149.52000000000001</c:v>
                </c:pt>
                <c:pt idx="245">
                  <c:v>168.21</c:v>
                </c:pt>
                <c:pt idx="246">
                  <c:v>130.83000000000001</c:v>
                </c:pt>
                <c:pt idx="247">
                  <c:v>149.52000000000001</c:v>
                </c:pt>
                <c:pt idx="248">
                  <c:v>140.16999999999999</c:v>
                </c:pt>
                <c:pt idx="249">
                  <c:v>84.1</c:v>
                </c:pt>
                <c:pt idx="250">
                  <c:v>112.14</c:v>
                </c:pt>
                <c:pt idx="251">
                  <c:v>140.16999999999999</c:v>
                </c:pt>
                <c:pt idx="252">
                  <c:v>168.21</c:v>
                </c:pt>
                <c:pt idx="253">
                  <c:v>102.79</c:v>
                </c:pt>
                <c:pt idx="254">
                  <c:v>112.14</c:v>
                </c:pt>
                <c:pt idx="255">
                  <c:v>168.21</c:v>
                </c:pt>
                <c:pt idx="256">
                  <c:v>140.16999999999999</c:v>
                </c:pt>
                <c:pt idx="257">
                  <c:v>130.83000000000001</c:v>
                </c:pt>
                <c:pt idx="258">
                  <c:v>177.55</c:v>
                </c:pt>
                <c:pt idx="259">
                  <c:v>121.48</c:v>
                </c:pt>
                <c:pt idx="260">
                  <c:v>64.52</c:v>
                </c:pt>
                <c:pt idx="261">
                  <c:v>101.38</c:v>
                </c:pt>
                <c:pt idx="262">
                  <c:v>73.73</c:v>
                </c:pt>
                <c:pt idx="263">
                  <c:v>73.73</c:v>
                </c:pt>
                <c:pt idx="264">
                  <c:v>138.25</c:v>
                </c:pt>
                <c:pt idx="265">
                  <c:v>101.38</c:v>
                </c:pt>
                <c:pt idx="266">
                  <c:v>110.6</c:v>
                </c:pt>
                <c:pt idx="267">
                  <c:v>82.95</c:v>
                </c:pt>
                <c:pt idx="268">
                  <c:v>138.25</c:v>
                </c:pt>
                <c:pt idx="269">
                  <c:v>101.38</c:v>
                </c:pt>
                <c:pt idx="270">
                  <c:v>110.6</c:v>
                </c:pt>
                <c:pt idx="271">
                  <c:v>64.52</c:v>
                </c:pt>
                <c:pt idx="272">
                  <c:v>73.73</c:v>
                </c:pt>
                <c:pt idx="273">
                  <c:v>138.25</c:v>
                </c:pt>
                <c:pt idx="274">
                  <c:v>138.25</c:v>
                </c:pt>
                <c:pt idx="275">
                  <c:v>92.17</c:v>
                </c:pt>
                <c:pt idx="276">
                  <c:v>129.03</c:v>
                </c:pt>
                <c:pt idx="277">
                  <c:v>110.6</c:v>
                </c:pt>
                <c:pt idx="278">
                  <c:v>82.95</c:v>
                </c:pt>
                <c:pt idx="279">
                  <c:v>110.6</c:v>
                </c:pt>
                <c:pt idx="280">
                  <c:v>99.49</c:v>
                </c:pt>
                <c:pt idx="281">
                  <c:v>99.49</c:v>
                </c:pt>
                <c:pt idx="282">
                  <c:v>89.54</c:v>
                </c:pt>
                <c:pt idx="283">
                  <c:v>99.49</c:v>
                </c:pt>
                <c:pt idx="284">
                  <c:v>129.33000000000001</c:v>
                </c:pt>
                <c:pt idx="285">
                  <c:v>129.33000000000001</c:v>
                </c:pt>
                <c:pt idx="286">
                  <c:v>99.49</c:v>
                </c:pt>
                <c:pt idx="287">
                  <c:v>99.49</c:v>
                </c:pt>
                <c:pt idx="288">
                  <c:v>69.64</c:v>
                </c:pt>
                <c:pt idx="289">
                  <c:v>69.64</c:v>
                </c:pt>
                <c:pt idx="290">
                  <c:v>59.69</c:v>
                </c:pt>
                <c:pt idx="291">
                  <c:v>59.69</c:v>
                </c:pt>
                <c:pt idx="292">
                  <c:v>129.33000000000001</c:v>
                </c:pt>
                <c:pt idx="293">
                  <c:v>149.22999999999999</c:v>
                </c:pt>
                <c:pt idx="294">
                  <c:v>139.28</c:v>
                </c:pt>
                <c:pt idx="295">
                  <c:v>119.39</c:v>
                </c:pt>
                <c:pt idx="296">
                  <c:v>69.64</c:v>
                </c:pt>
                <c:pt idx="297">
                  <c:v>69.64</c:v>
                </c:pt>
                <c:pt idx="298">
                  <c:v>69.64</c:v>
                </c:pt>
                <c:pt idx="299">
                  <c:v>129.33000000000001</c:v>
                </c:pt>
                <c:pt idx="300">
                  <c:v>117.65</c:v>
                </c:pt>
                <c:pt idx="301">
                  <c:v>117.65</c:v>
                </c:pt>
                <c:pt idx="302">
                  <c:v>78.430000000000007</c:v>
                </c:pt>
                <c:pt idx="303">
                  <c:v>88.24</c:v>
                </c:pt>
                <c:pt idx="304">
                  <c:v>127.45</c:v>
                </c:pt>
                <c:pt idx="305">
                  <c:v>107.84</c:v>
                </c:pt>
                <c:pt idx="306">
                  <c:v>117.65</c:v>
                </c:pt>
                <c:pt idx="307">
                  <c:v>127.45</c:v>
                </c:pt>
                <c:pt idx="308">
                  <c:v>98.04</c:v>
                </c:pt>
                <c:pt idx="309">
                  <c:v>107.84</c:v>
                </c:pt>
                <c:pt idx="310">
                  <c:v>88.24</c:v>
                </c:pt>
                <c:pt idx="311">
                  <c:v>117.65</c:v>
                </c:pt>
                <c:pt idx="312">
                  <c:v>117.65</c:v>
                </c:pt>
                <c:pt idx="313">
                  <c:v>137.25</c:v>
                </c:pt>
                <c:pt idx="314">
                  <c:v>117.65</c:v>
                </c:pt>
                <c:pt idx="315">
                  <c:v>117.65</c:v>
                </c:pt>
                <c:pt idx="316">
                  <c:v>88.24</c:v>
                </c:pt>
                <c:pt idx="317">
                  <c:v>88.24</c:v>
                </c:pt>
                <c:pt idx="318">
                  <c:v>156.86000000000001</c:v>
                </c:pt>
                <c:pt idx="319">
                  <c:v>117.65</c:v>
                </c:pt>
                <c:pt idx="320">
                  <c:v>100.7</c:v>
                </c:pt>
                <c:pt idx="321">
                  <c:v>100.7</c:v>
                </c:pt>
                <c:pt idx="322">
                  <c:v>151.05000000000001</c:v>
                </c:pt>
                <c:pt idx="323">
                  <c:v>110.77</c:v>
                </c:pt>
                <c:pt idx="324">
                  <c:v>80.56</c:v>
                </c:pt>
                <c:pt idx="325">
                  <c:v>100.7</c:v>
                </c:pt>
                <c:pt idx="326">
                  <c:v>120.84</c:v>
                </c:pt>
                <c:pt idx="327">
                  <c:v>90.63</c:v>
                </c:pt>
                <c:pt idx="328">
                  <c:v>130.91</c:v>
                </c:pt>
                <c:pt idx="329">
                  <c:v>100.7</c:v>
                </c:pt>
                <c:pt idx="330">
                  <c:v>120.84</c:v>
                </c:pt>
                <c:pt idx="331">
                  <c:v>110.77</c:v>
                </c:pt>
                <c:pt idx="332">
                  <c:v>80.56</c:v>
                </c:pt>
                <c:pt idx="333">
                  <c:v>80.56</c:v>
                </c:pt>
                <c:pt idx="334">
                  <c:v>100.7</c:v>
                </c:pt>
                <c:pt idx="335">
                  <c:v>100.7</c:v>
                </c:pt>
                <c:pt idx="336">
                  <c:v>70.489999999999995</c:v>
                </c:pt>
                <c:pt idx="337">
                  <c:v>140.97999999999999</c:v>
                </c:pt>
                <c:pt idx="338">
                  <c:v>140.97999999999999</c:v>
                </c:pt>
                <c:pt idx="339">
                  <c:v>120.84</c:v>
                </c:pt>
                <c:pt idx="340">
                  <c:v>100.76</c:v>
                </c:pt>
                <c:pt idx="341">
                  <c:v>120.92</c:v>
                </c:pt>
                <c:pt idx="342">
                  <c:v>120.92</c:v>
                </c:pt>
                <c:pt idx="343">
                  <c:v>130.99</c:v>
                </c:pt>
                <c:pt idx="344">
                  <c:v>141.07</c:v>
                </c:pt>
                <c:pt idx="345">
                  <c:v>181.37</c:v>
                </c:pt>
                <c:pt idx="346">
                  <c:v>120.92</c:v>
                </c:pt>
                <c:pt idx="347">
                  <c:v>120.92</c:v>
                </c:pt>
                <c:pt idx="348">
                  <c:v>100.76</c:v>
                </c:pt>
                <c:pt idx="349">
                  <c:v>100.76</c:v>
                </c:pt>
                <c:pt idx="350">
                  <c:v>80.61</c:v>
                </c:pt>
                <c:pt idx="351">
                  <c:v>90.69</c:v>
                </c:pt>
                <c:pt idx="352">
                  <c:v>90.69</c:v>
                </c:pt>
                <c:pt idx="353">
                  <c:v>110.84</c:v>
                </c:pt>
                <c:pt idx="354">
                  <c:v>110.84</c:v>
                </c:pt>
                <c:pt idx="355">
                  <c:v>60.46</c:v>
                </c:pt>
                <c:pt idx="356">
                  <c:v>100.76</c:v>
                </c:pt>
                <c:pt idx="357">
                  <c:v>100.76</c:v>
                </c:pt>
                <c:pt idx="358">
                  <c:v>100.76</c:v>
                </c:pt>
                <c:pt idx="359">
                  <c:v>110.84</c:v>
                </c:pt>
                <c:pt idx="360">
                  <c:v>110.5</c:v>
                </c:pt>
                <c:pt idx="361">
                  <c:v>100.45</c:v>
                </c:pt>
                <c:pt idx="362">
                  <c:v>150.68</c:v>
                </c:pt>
                <c:pt idx="363">
                  <c:v>100.45</c:v>
                </c:pt>
                <c:pt idx="364">
                  <c:v>90.41</c:v>
                </c:pt>
                <c:pt idx="365">
                  <c:v>80.36</c:v>
                </c:pt>
                <c:pt idx="366">
                  <c:v>90.41</c:v>
                </c:pt>
                <c:pt idx="367">
                  <c:v>110.5</c:v>
                </c:pt>
                <c:pt idx="368">
                  <c:v>120.54</c:v>
                </c:pt>
                <c:pt idx="369">
                  <c:v>100.45</c:v>
                </c:pt>
                <c:pt idx="370">
                  <c:v>150.68</c:v>
                </c:pt>
                <c:pt idx="371">
                  <c:v>120.54</c:v>
                </c:pt>
                <c:pt idx="372">
                  <c:v>80.36</c:v>
                </c:pt>
                <c:pt idx="373">
                  <c:v>110.5</c:v>
                </c:pt>
                <c:pt idx="374">
                  <c:v>100.45</c:v>
                </c:pt>
                <c:pt idx="375">
                  <c:v>110.5</c:v>
                </c:pt>
                <c:pt idx="376">
                  <c:v>100.45</c:v>
                </c:pt>
                <c:pt idx="377">
                  <c:v>80.36</c:v>
                </c:pt>
                <c:pt idx="378">
                  <c:v>90.41</c:v>
                </c:pt>
                <c:pt idx="379">
                  <c:v>70.319999999999993</c:v>
                </c:pt>
                <c:pt idx="380">
                  <c:v>139.76</c:v>
                </c:pt>
                <c:pt idx="381">
                  <c:v>109.81</c:v>
                </c:pt>
                <c:pt idx="382">
                  <c:v>129.77000000000001</c:v>
                </c:pt>
                <c:pt idx="383">
                  <c:v>69.88</c:v>
                </c:pt>
                <c:pt idx="384">
                  <c:v>79.86</c:v>
                </c:pt>
                <c:pt idx="385">
                  <c:v>89.84</c:v>
                </c:pt>
                <c:pt idx="386">
                  <c:v>149.74</c:v>
                </c:pt>
                <c:pt idx="387">
                  <c:v>109.81</c:v>
                </c:pt>
                <c:pt idx="388">
                  <c:v>149.74</c:v>
                </c:pt>
                <c:pt idx="389">
                  <c:v>139.76</c:v>
                </c:pt>
                <c:pt idx="390">
                  <c:v>119.79</c:v>
                </c:pt>
                <c:pt idx="391">
                  <c:v>89.84</c:v>
                </c:pt>
                <c:pt idx="392">
                  <c:v>109.81</c:v>
                </c:pt>
                <c:pt idx="393">
                  <c:v>79.86</c:v>
                </c:pt>
                <c:pt idx="394">
                  <c:v>89.84</c:v>
                </c:pt>
                <c:pt idx="395">
                  <c:v>99.83</c:v>
                </c:pt>
                <c:pt idx="396">
                  <c:v>69.88</c:v>
                </c:pt>
                <c:pt idx="397">
                  <c:v>189.67</c:v>
                </c:pt>
                <c:pt idx="398">
                  <c:v>189.67</c:v>
                </c:pt>
                <c:pt idx="399">
                  <c:v>129.77000000000001</c:v>
                </c:pt>
              </c:numCache>
            </c:numRef>
          </c:xVal>
          <c:yVal>
            <c:numRef>
              <c:f>ベレ散布図!$H$4:$H$403</c:f>
              <c:numCache>
                <c:formatCode>General</c:formatCode>
                <c:ptCount val="400"/>
                <c:pt idx="0">
                  <c:v>68.599999999999994</c:v>
                </c:pt>
                <c:pt idx="1">
                  <c:v>77.17</c:v>
                </c:pt>
                <c:pt idx="2">
                  <c:v>77.17</c:v>
                </c:pt>
                <c:pt idx="3">
                  <c:v>51.45</c:v>
                </c:pt>
                <c:pt idx="4">
                  <c:v>1.0289999999999999</c:v>
                </c:pt>
                <c:pt idx="5">
                  <c:v>51.45</c:v>
                </c:pt>
                <c:pt idx="6">
                  <c:v>60.02</c:v>
                </c:pt>
                <c:pt idx="7">
                  <c:v>60.02</c:v>
                </c:pt>
                <c:pt idx="8">
                  <c:v>102.9</c:v>
                </c:pt>
                <c:pt idx="9">
                  <c:v>68.599999999999994</c:v>
                </c:pt>
                <c:pt idx="10">
                  <c:v>51.45</c:v>
                </c:pt>
                <c:pt idx="11">
                  <c:v>85.75</c:v>
                </c:pt>
                <c:pt idx="12">
                  <c:v>102.9</c:v>
                </c:pt>
                <c:pt idx="13">
                  <c:v>77.17</c:v>
                </c:pt>
                <c:pt idx="14">
                  <c:v>102.9</c:v>
                </c:pt>
                <c:pt idx="15">
                  <c:v>77.17</c:v>
                </c:pt>
                <c:pt idx="16">
                  <c:v>77.17</c:v>
                </c:pt>
                <c:pt idx="17">
                  <c:v>85.75</c:v>
                </c:pt>
                <c:pt idx="18">
                  <c:v>68.599999999999994</c:v>
                </c:pt>
                <c:pt idx="19">
                  <c:v>68.599999999999994</c:v>
                </c:pt>
                <c:pt idx="20">
                  <c:v>102.39</c:v>
                </c:pt>
                <c:pt idx="21">
                  <c:v>110.92</c:v>
                </c:pt>
                <c:pt idx="22">
                  <c:v>102.39</c:v>
                </c:pt>
                <c:pt idx="23">
                  <c:v>136.51</c:v>
                </c:pt>
                <c:pt idx="24">
                  <c:v>102.39</c:v>
                </c:pt>
                <c:pt idx="25">
                  <c:v>93.85</c:v>
                </c:pt>
                <c:pt idx="26">
                  <c:v>68.260000000000005</c:v>
                </c:pt>
                <c:pt idx="27">
                  <c:v>68.260000000000005</c:v>
                </c:pt>
                <c:pt idx="28">
                  <c:v>162.11000000000001</c:v>
                </c:pt>
                <c:pt idx="29">
                  <c:v>110.92</c:v>
                </c:pt>
                <c:pt idx="30">
                  <c:v>102.39</c:v>
                </c:pt>
                <c:pt idx="31">
                  <c:v>93.85</c:v>
                </c:pt>
                <c:pt idx="32">
                  <c:v>42.66</c:v>
                </c:pt>
                <c:pt idx="33">
                  <c:v>51.19</c:v>
                </c:pt>
                <c:pt idx="34">
                  <c:v>85.32</c:v>
                </c:pt>
                <c:pt idx="35">
                  <c:v>196.24</c:v>
                </c:pt>
                <c:pt idx="36">
                  <c:v>85.32</c:v>
                </c:pt>
                <c:pt idx="37">
                  <c:v>102.39</c:v>
                </c:pt>
                <c:pt idx="38">
                  <c:v>127.98</c:v>
                </c:pt>
                <c:pt idx="39">
                  <c:v>119.45</c:v>
                </c:pt>
                <c:pt idx="40">
                  <c:v>59.32</c:v>
                </c:pt>
                <c:pt idx="41">
                  <c:v>127.12</c:v>
                </c:pt>
                <c:pt idx="42">
                  <c:v>101.69</c:v>
                </c:pt>
                <c:pt idx="43">
                  <c:v>67.8</c:v>
                </c:pt>
                <c:pt idx="44">
                  <c:v>76.27</c:v>
                </c:pt>
                <c:pt idx="45">
                  <c:v>59.32</c:v>
                </c:pt>
                <c:pt idx="46">
                  <c:v>84.75</c:v>
                </c:pt>
                <c:pt idx="47">
                  <c:v>59.32</c:v>
                </c:pt>
                <c:pt idx="48">
                  <c:v>42.37</c:v>
                </c:pt>
                <c:pt idx="49">
                  <c:v>25.42</c:v>
                </c:pt>
                <c:pt idx="50">
                  <c:v>59.32</c:v>
                </c:pt>
                <c:pt idx="51">
                  <c:v>76.27</c:v>
                </c:pt>
                <c:pt idx="52">
                  <c:v>59.32</c:v>
                </c:pt>
                <c:pt idx="53">
                  <c:v>59.32</c:v>
                </c:pt>
                <c:pt idx="54">
                  <c:v>33.9</c:v>
                </c:pt>
                <c:pt idx="55">
                  <c:v>76.27</c:v>
                </c:pt>
                <c:pt idx="56">
                  <c:v>67.8</c:v>
                </c:pt>
                <c:pt idx="57">
                  <c:v>42.37</c:v>
                </c:pt>
                <c:pt idx="58">
                  <c:v>67.8</c:v>
                </c:pt>
                <c:pt idx="59">
                  <c:v>50.85</c:v>
                </c:pt>
                <c:pt idx="60">
                  <c:v>81.180000000000007</c:v>
                </c:pt>
                <c:pt idx="61">
                  <c:v>81.180000000000007</c:v>
                </c:pt>
                <c:pt idx="62">
                  <c:v>99.22</c:v>
                </c:pt>
                <c:pt idx="63">
                  <c:v>90.2</c:v>
                </c:pt>
                <c:pt idx="64">
                  <c:v>108.24</c:v>
                </c:pt>
                <c:pt idx="65">
                  <c:v>54.12</c:v>
                </c:pt>
                <c:pt idx="66">
                  <c:v>117.26</c:v>
                </c:pt>
                <c:pt idx="67">
                  <c:v>90.2</c:v>
                </c:pt>
                <c:pt idx="68">
                  <c:v>90.2</c:v>
                </c:pt>
                <c:pt idx="69">
                  <c:v>162.36000000000001</c:v>
                </c:pt>
                <c:pt idx="70">
                  <c:v>81.180000000000007</c:v>
                </c:pt>
                <c:pt idx="71">
                  <c:v>72.16</c:v>
                </c:pt>
                <c:pt idx="72">
                  <c:v>54.12</c:v>
                </c:pt>
                <c:pt idx="73">
                  <c:v>153.34</c:v>
                </c:pt>
                <c:pt idx="74">
                  <c:v>72.16</c:v>
                </c:pt>
                <c:pt idx="75">
                  <c:v>117.26</c:v>
                </c:pt>
                <c:pt idx="76">
                  <c:v>144.32</c:v>
                </c:pt>
                <c:pt idx="77">
                  <c:v>135.30000000000001</c:v>
                </c:pt>
                <c:pt idx="78">
                  <c:v>153.34</c:v>
                </c:pt>
                <c:pt idx="79">
                  <c:v>153.34</c:v>
                </c:pt>
                <c:pt idx="80">
                  <c:v>170</c:v>
                </c:pt>
                <c:pt idx="81">
                  <c:v>170</c:v>
                </c:pt>
                <c:pt idx="82">
                  <c:v>60</c:v>
                </c:pt>
                <c:pt idx="83">
                  <c:v>100</c:v>
                </c:pt>
                <c:pt idx="84">
                  <c:v>100</c:v>
                </c:pt>
                <c:pt idx="85">
                  <c:v>100</c:v>
                </c:pt>
                <c:pt idx="86">
                  <c:v>80</c:v>
                </c:pt>
                <c:pt idx="87">
                  <c:v>90</c:v>
                </c:pt>
                <c:pt idx="88">
                  <c:v>120</c:v>
                </c:pt>
                <c:pt idx="89">
                  <c:v>60</c:v>
                </c:pt>
                <c:pt idx="90">
                  <c:v>240</c:v>
                </c:pt>
                <c:pt idx="91">
                  <c:v>60</c:v>
                </c:pt>
                <c:pt idx="92">
                  <c:v>120</c:v>
                </c:pt>
                <c:pt idx="93">
                  <c:v>80</c:v>
                </c:pt>
                <c:pt idx="94">
                  <c:v>70</c:v>
                </c:pt>
                <c:pt idx="95">
                  <c:v>110</c:v>
                </c:pt>
                <c:pt idx="96">
                  <c:v>80</c:v>
                </c:pt>
                <c:pt idx="97">
                  <c:v>100</c:v>
                </c:pt>
                <c:pt idx="98">
                  <c:v>100</c:v>
                </c:pt>
                <c:pt idx="99">
                  <c:v>90</c:v>
                </c:pt>
                <c:pt idx="100">
                  <c:v>64.13</c:v>
                </c:pt>
                <c:pt idx="101">
                  <c:v>85.51</c:v>
                </c:pt>
                <c:pt idx="102">
                  <c:v>74.819999999999993</c:v>
                </c:pt>
                <c:pt idx="103">
                  <c:v>64.13</c:v>
                </c:pt>
                <c:pt idx="104">
                  <c:v>106.88</c:v>
                </c:pt>
                <c:pt idx="105">
                  <c:v>42.75</c:v>
                </c:pt>
                <c:pt idx="106">
                  <c:v>85.51</c:v>
                </c:pt>
                <c:pt idx="107">
                  <c:v>128.26</c:v>
                </c:pt>
                <c:pt idx="108">
                  <c:v>74.819999999999993</c:v>
                </c:pt>
                <c:pt idx="109">
                  <c:v>117.57</c:v>
                </c:pt>
                <c:pt idx="110">
                  <c:v>96.19</c:v>
                </c:pt>
                <c:pt idx="111">
                  <c:v>74.819999999999993</c:v>
                </c:pt>
                <c:pt idx="112">
                  <c:v>42.75</c:v>
                </c:pt>
                <c:pt idx="113">
                  <c:v>53.44</c:v>
                </c:pt>
                <c:pt idx="114">
                  <c:v>117.57</c:v>
                </c:pt>
                <c:pt idx="115">
                  <c:v>85.51</c:v>
                </c:pt>
                <c:pt idx="116">
                  <c:v>85.51</c:v>
                </c:pt>
                <c:pt idx="117">
                  <c:v>53.44</c:v>
                </c:pt>
                <c:pt idx="118">
                  <c:v>74.819999999999993</c:v>
                </c:pt>
                <c:pt idx="119">
                  <c:v>117.57</c:v>
                </c:pt>
                <c:pt idx="120">
                  <c:v>118.61</c:v>
                </c:pt>
                <c:pt idx="121">
                  <c:v>118.61</c:v>
                </c:pt>
                <c:pt idx="122">
                  <c:v>128.5</c:v>
                </c:pt>
                <c:pt idx="123">
                  <c:v>108.73</c:v>
                </c:pt>
                <c:pt idx="124">
                  <c:v>88.96</c:v>
                </c:pt>
                <c:pt idx="125">
                  <c:v>79.08</c:v>
                </c:pt>
                <c:pt idx="126">
                  <c:v>88.96</c:v>
                </c:pt>
                <c:pt idx="127">
                  <c:v>118.61</c:v>
                </c:pt>
                <c:pt idx="128">
                  <c:v>108.73</c:v>
                </c:pt>
                <c:pt idx="129">
                  <c:v>98.84</c:v>
                </c:pt>
                <c:pt idx="130">
                  <c:v>79.08</c:v>
                </c:pt>
                <c:pt idx="131">
                  <c:v>177.92</c:v>
                </c:pt>
                <c:pt idx="132">
                  <c:v>128.5</c:v>
                </c:pt>
                <c:pt idx="133">
                  <c:v>128.5</c:v>
                </c:pt>
                <c:pt idx="134">
                  <c:v>98.84</c:v>
                </c:pt>
                <c:pt idx="135">
                  <c:v>98.84</c:v>
                </c:pt>
                <c:pt idx="136">
                  <c:v>88.96</c:v>
                </c:pt>
                <c:pt idx="137">
                  <c:v>79.08</c:v>
                </c:pt>
                <c:pt idx="138">
                  <c:v>98.84</c:v>
                </c:pt>
                <c:pt idx="139">
                  <c:v>118.61</c:v>
                </c:pt>
                <c:pt idx="140">
                  <c:v>103.45</c:v>
                </c:pt>
                <c:pt idx="141">
                  <c:v>103.45</c:v>
                </c:pt>
                <c:pt idx="142">
                  <c:v>124.14</c:v>
                </c:pt>
                <c:pt idx="143">
                  <c:v>51.72</c:v>
                </c:pt>
                <c:pt idx="144">
                  <c:v>41.38</c:v>
                </c:pt>
                <c:pt idx="145">
                  <c:v>62.07</c:v>
                </c:pt>
                <c:pt idx="146">
                  <c:v>51.72</c:v>
                </c:pt>
                <c:pt idx="147">
                  <c:v>82.76</c:v>
                </c:pt>
                <c:pt idx="148">
                  <c:v>82.76</c:v>
                </c:pt>
                <c:pt idx="149">
                  <c:v>93.1</c:v>
                </c:pt>
                <c:pt idx="150">
                  <c:v>72.41</c:v>
                </c:pt>
                <c:pt idx="151">
                  <c:v>82.76</c:v>
                </c:pt>
                <c:pt idx="152">
                  <c:v>72.41</c:v>
                </c:pt>
                <c:pt idx="153">
                  <c:v>72.41</c:v>
                </c:pt>
                <c:pt idx="154">
                  <c:v>113.79</c:v>
                </c:pt>
                <c:pt idx="155">
                  <c:v>93.1</c:v>
                </c:pt>
                <c:pt idx="156">
                  <c:v>124.14</c:v>
                </c:pt>
                <c:pt idx="157">
                  <c:v>51.72</c:v>
                </c:pt>
                <c:pt idx="158">
                  <c:v>82.76</c:v>
                </c:pt>
                <c:pt idx="159">
                  <c:v>103.45</c:v>
                </c:pt>
                <c:pt idx="160">
                  <c:v>91.78</c:v>
                </c:pt>
                <c:pt idx="161">
                  <c:v>71.39</c:v>
                </c:pt>
                <c:pt idx="162">
                  <c:v>101.98</c:v>
                </c:pt>
                <c:pt idx="163">
                  <c:v>132.58000000000001</c:v>
                </c:pt>
                <c:pt idx="164">
                  <c:v>152.97</c:v>
                </c:pt>
                <c:pt idx="165">
                  <c:v>112.18</c:v>
                </c:pt>
                <c:pt idx="166">
                  <c:v>91.78</c:v>
                </c:pt>
                <c:pt idx="167">
                  <c:v>193.77</c:v>
                </c:pt>
                <c:pt idx="168">
                  <c:v>112.18</c:v>
                </c:pt>
                <c:pt idx="169">
                  <c:v>101.98</c:v>
                </c:pt>
                <c:pt idx="170">
                  <c:v>81.59</c:v>
                </c:pt>
                <c:pt idx="171">
                  <c:v>40.79</c:v>
                </c:pt>
                <c:pt idx="172">
                  <c:v>61.19</c:v>
                </c:pt>
                <c:pt idx="173">
                  <c:v>101.98</c:v>
                </c:pt>
                <c:pt idx="174">
                  <c:v>91.78</c:v>
                </c:pt>
                <c:pt idx="175">
                  <c:v>81.59</c:v>
                </c:pt>
                <c:pt idx="176">
                  <c:v>152.97</c:v>
                </c:pt>
                <c:pt idx="177">
                  <c:v>101.98</c:v>
                </c:pt>
                <c:pt idx="178">
                  <c:v>101.98</c:v>
                </c:pt>
                <c:pt idx="179">
                  <c:v>163.16999999999999</c:v>
                </c:pt>
                <c:pt idx="180">
                  <c:v>162.63999999999999</c:v>
                </c:pt>
                <c:pt idx="181">
                  <c:v>111.81</c:v>
                </c:pt>
                <c:pt idx="182">
                  <c:v>101.65</c:v>
                </c:pt>
                <c:pt idx="183">
                  <c:v>121.98</c:v>
                </c:pt>
                <c:pt idx="184">
                  <c:v>142.31</c:v>
                </c:pt>
                <c:pt idx="185">
                  <c:v>152.47</c:v>
                </c:pt>
                <c:pt idx="186">
                  <c:v>101.65</c:v>
                </c:pt>
                <c:pt idx="187">
                  <c:v>203.3</c:v>
                </c:pt>
                <c:pt idx="188">
                  <c:v>60.99</c:v>
                </c:pt>
                <c:pt idx="189">
                  <c:v>101.65</c:v>
                </c:pt>
                <c:pt idx="190">
                  <c:v>111.81</c:v>
                </c:pt>
                <c:pt idx="191">
                  <c:v>91.48</c:v>
                </c:pt>
                <c:pt idx="192">
                  <c:v>60.99</c:v>
                </c:pt>
                <c:pt idx="193">
                  <c:v>60.99</c:v>
                </c:pt>
                <c:pt idx="194">
                  <c:v>81.319999999999993</c:v>
                </c:pt>
                <c:pt idx="195">
                  <c:v>30.49</c:v>
                </c:pt>
                <c:pt idx="196">
                  <c:v>30.49</c:v>
                </c:pt>
                <c:pt idx="197">
                  <c:v>132.13999999999999</c:v>
                </c:pt>
                <c:pt idx="198">
                  <c:v>91.48</c:v>
                </c:pt>
                <c:pt idx="199">
                  <c:v>50.82</c:v>
                </c:pt>
                <c:pt idx="200">
                  <c:v>145.02000000000001</c:v>
                </c:pt>
                <c:pt idx="201">
                  <c:v>125.68</c:v>
                </c:pt>
                <c:pt idx="202">
                  <c:v>87.01</c:v>
                </c:pt>
                <c:pt idx="203">
                  <c:v>77.34</c:v>
                </c:pt>
                <c:pt idx="204">
                  <c:v>116.01</c:v>
                </c:pt>
                <c:pt idx="205">
                  <c:v>38.67</c:v>
                </c:pt>
                <c:pt idx="206">
                  <c:v>77.34</c:v>
                </c:pt>
                <c:pt idx="207">
                  <c:v>67.67</c:v>
                </c:pt>
                <c:pt idx="208">
                  <c:v>58.01</c:v>
                </c:pt>
                <c:pt idx="209">
                  <c:v>77.34</c:v>
                </c:pt>
                <c:pt idx="210">
                  <c:v>67.67</c:v>
                </c:pt>
                <c:pt idx="211">
                  <c:v>87.01</c:v>
                </c:pt>
                <c:pt idx="212">
                  <c:v>77.34</c:v>
                </c:pt>
                <c:pt idx="213">
                  <c:v>87.01</c:v>
                </c:pt>
                <c:pt idx="214">
                  <c:v>96.68</c:v>
                </c:pt>
                <c:pt idx="215">
                  <c:v>48.34</c:v>
                </c:pt>
                <c:pt idx="216">
                  <c:v>87.01</c:v>
                </c:pt>
                <c:pt idx="217">
                  <c:v>106.34</c:v>
                </c:pt>
                <c:pt idx="218">
                  <c:v>77.34</c:v>
                </c:pt>
                <c:pt idx="219">
                  <c:v>96.68</c:v>
                </c:pt>
                <c:pt idx="220">
                  <c:v>75.44</c:v>
                </c:pt>
                <c:pt idx="221">
                  <c:v>37.72</c:v>
                </c:pt>
                <c:pt idx="222">
                  <c:v>47.15</c:v>
                </c:pt>
                <c:pt idx="223">
                  <c:v>75.44</c:v>
                </c:pt>
                <c:pt idx="224">
                  <c:v>75.44</c:v>
                </c:pt>
                <c:pt idx="225">
                  <c:v>94.3</c:v>
                </c:pt>
                <c:pt idx="226">
                  <c:v>94.3</c:v>
                </c:pt>
                <c:pt idx="227">
                  <c:v>66.010000000000005</c:v>
                </c:pt>
                <c:pt idx="228">
                  <c:v>113.16</c:v>
                </c:pt>
                <c:pt idx="229">
                  <c:v>122.59</c:v>
                </c:pt>
                <c:pt idx="230">
                  <c:v>66.010000000000005</c:v>
                </c:pt>
                <c:pt idx="231">
                  <c:v>66.010000000000005</c:v>
                </c:pt>
                <c:pt idx="232">
                  <c:v>56.58</c:v>
                </c:pt>
                <c:pt idx="233">
                  <c:v>66.010000000000005</c:v>
                </c:pt>
                <c:pt idx="234">
                  <c:v>122.59</c:v>
                </c:pt>
                <c:pt idx="235">
                  <c:v>113.16</c:v>
                </c:pt>
                <c:pt idx="236">
                  <c:v>132.03</c:v>
                </c:pt>
                <c:pt idx="237">
                  <c:v>103.73</c:v>
                </c:pt>
                <c:pt idx="238">
                  <c:v>47.15</c:v>
                </c:pt>
                <c:pt idx="239">
                  <c:v>94.3</c:v>
                </c:pt>
                <c:pt idx="240">
                  <c:v>308.38</c:v>
                </c:pt>
                <c:pt idx="241">
                  <c:v>280.35000000000002</c:v>
                </c:pt>
                <c:pt idx="242">
                  <c:v>168.21</c:v>
                </c:pt>
                <c:pt idx="243">
                  <c:v>168.21</c:v>
                </c:pt>
                <c:pt idx="244">
                  <c:v>84.1</c:v>
                </c:pt>
                <c:pt idx="245">
                  <c:v>121.48</c:v>
                </c:pt>
                <c:pt idx="246">
                  <c:v>112.14</c:v>
                </c:pt>
                <c:pt idx="247">
                  <c:v>121.48</c:v>
                </c:pt>
                <c:pt idx="248">
                  <c:v>186.9</c:v>
                </c:pt>
                <c:pt idx="249">
                  <c:v>84.1</c:v>
                </c:pt>
                <c:pt idx="250">
                  <c:v>102.79</c:v>
                </c:pt>
                <c:pt idx="251">
                  <c:v>289.69</c:v>
                </c:pt>
                <c:pt idx="252">
                  <c:v>317.73</c:v>
                </c:pt>
                <c:pt idx="253">
                  <c:v>168.21</c:v>
                </c:pt>
                <c:pt idx="254">
                  <c:v>158.86000000000001</c:v>
                </c:pt>
                <c:pt idx="255">
                  <c:v>299.04000000000002</c:v>
                </c:pt>
                <c:pt idx="256">
                  <c:v>345.76</c:v>
                </c:pt>
                <c:pt idx="257">
                  <c:v>261.66000000000003</c:v>
                </c:pt>
                <c:pt idx="258">
                  <c:v>289.69</c:v>
                </c:pt>
                <c:pt idx="259">
                  <c:v>130.83000000000001</c:v>
                </c:pt>
                <c:pt idx="260">
                  <c:v>211.98</c:v>
                </c:pt>
                <c:pt idx="261">
                  <c:v>258.06</c:v>
                </c:pt>
                <c:pt idx="262">
                  <c:v>156.68</c:v>
                </c:pt>
                <c:pt idx="263">
                  <c:v>165.9</c:v>
                </c:pt>
                <c:pt idx="264">
                  <c:v>184.33</c:v>
                </c:pt>
                <c:pt idx="265">
                  <c:v>119.81</c:v>
                </c:pt>
                <c:pt idx="266">
                  <c:v>147.46</c:v>
                </c:pt>
                <c:pt idx="267">
                  <c:v>129.03</c:v>
                </c:pt>
                <c:pt idx="268">
                  <c:v>304.14</c:v>
                </c:pt>
                <c:pt idx="269">
                  <c:v>175.11</c:v>
                </c:pt>
                <c:pt idx="270">
                  <c:v>147.46</c:v>
                </c:pt>
                <c:pt idx="271">
                  <c:v>184.33</c:v>
                </c:pt>
                <c:pt idx="272">
                  <c:v>248.85</c:v>
                </c:pt>
                <c:pt idx="273">
                  <c:v>304.14</c:v>
                </c:pt>
                <c:pt idx="274">
                  <c:v>221.2</c:v>
                </c:pt>
                <c:pt idx="275">
                  <c:v>202.76</c:v>
                </c:pt>
                <c:pt idx="276">
                  <c:v>267.27999999999997</c:v>
                </c:pt>
                <c:pt idx="277">
                  <c:v>322.58</c:v>
                </c:pt>
                <c:pt idx="278">
                  <c:v>184.33</c:v>
                </c:pt>
                <c:pt idx="279">
                  <c:v>193.55</c:v>
                </c:pt>
                <c:pt idx="280">
                  <c:v>99.49</c:v>
                </c:pt>
                <c:pt idx="281">
                  <c:v>109.44</c:v>
                </c:pt>
                <c:pt idx="282">
                  <c:v>119.39</c:v>
                </c:pt>
                <c:pt idx="283">
                  <c:v>109.44</c:v>
                </c:pt>
                <c:pt idx="284">
                  <c:v>258.67</c:v>
                </c:pt>
                <c:pt idx="285">
                  <c:v>179.08</c:v>
                </c:pt>
                <c:pt idx="286">
                  <c:v>169.13</c:v>
                </c:pt>
                <c:pt idx="287">
                  <c:v>139.28</c:v>
                </c:pt>
                <c:pt idx="288">
                  <c:v>119.39</c:v>
                </c:pt>
                <c:pt idx="289">
                  <c:v>99.49</c:v>
                </c:pt>
                <c:pt idx="290">
                  <c:v>89.54</c:v>
                </c:pt>
                <c:pt idx="291">
                  <c:v>89.54</c:v>
                </c:pt>
                <c:pt idx="292">
                  <c:v>218.87</c:v>
                </c:pt>
                <c:pt idx="293">
                  <c:v>208.93</c:v>
                </c:pt>
                <c:pt idx="294">
                  <c:v>198.98</c:v>
                </c:pt>
                <c:pt idx="295">
                  <c:v>129.33000000000001</c:v>
                </c:pt>
                <c:pt idx="296">
                  <c:v>79.59</c:v>
                </c:pt>
                <c:pt idx="297">
                  <c:v>79.59</c:v>
                </c:pt>
                <c:pt idx="298">
                  <c:v>89.54</c:v>
                </c:pt>
                <c:pt idx="299">
                  <c:v>139.28</c:v>
                </c:pt>
                <c:pt idx="300">
                  <c:v>98.04</c:v>
                </c:pt>
                <c:pt idx="301">
                  <c:v>254.9</c:v>
                </c:pt>
                <c:pt idx="302">
                  <c:v>117.65</c:v>
                </c:pt>
                <c:pt idx="303">
                  <c:v>137.25</c:v>
                </c:pt>
                <c:pt idx="304">
                  <c:v>166.67</c:v>
                </c:pt>
                <c:pt idx="305">
                  <c:v>215.69</c:v>
                </c:pt>
                <c:pt idx="306">
                  <c:v>235.29</c:v>
                </c:pt>
                <c:pt idx="307">
                  <c:v>245.1</c:v>
                </c:pt>
                <c:pt idx="308">
                  <c:v>107.84</c:v>
                </c:pt>
                <c:pt idx="309">
                  <c:v>137.25</c:v>
                </c:pt>
                <c:pt idx="310">
                  <c:v>147.06</c:v>
                </c:pt>
                <c:pt idx="311">
                  <c:v>137.25</c:v>
                </c:pt>
                <c:pt idx="312">
                  <c:v>147.06</c:v>
                </c:pt>
                <c:pt idx="313">
                  <c:v>215.69</c:v>
                </c:pt>
                <c:pt idx="314">
                  <c:v>245.1</c:v>
                </c:pt>
                <c:pt idx="315">
                  <c:v>176.47</c:v>
                </c:pt>
                <c:pt idx="316">
                  <c:v>176.47</c:v>
                </c:pt>
                <c:pt idx="317">
                  <c:v>147.06</c:v>
                </c:pt>
                <c:pt idx="318">
                  <c:v>186.27</c:v>
                </c:pt>
                <c:pt idx="319">
                  <c:v>117.65</c:v>
                </c:pt>
                <c:pt idx="320">
                  <c:v>70.489999999999995</c:v>
                </c:pt>
                <c:pt idx="321">
                  <c:v>80.56</c:v>
                </c:pt>
                <c:pt idx="322">
                  <c:v>100.7</c:v>
                </c:pt>
                <c:pt idx="323">
                  <c:v>161.12</c:v>
                </c:pt>
                <c:pt idx="324">
                  <c:v>90.63</c:v>
                </c:pt>
                <c:pt idx="325">
                  <c:v>110.77</c:v>
                </c:pt>
                <c:pt idx="326">
                  <c:v>151.05000000000001</c:v>
                </c:pt>
                <c:pt idx="327">
                  <c:v>140.97999999999999</c:v>
                </c:pt>
                <c:pt idx="328">
                  <c:v>70.489999999999995</c:v>
                </c:pt>
                <c:pt idx="329">
                  <c:v>100.7</c:v>
                </c:pt>
                <c:pt idx="330">
                  <c:v>181.26</c:v>
                </c:pt>
                <c:pt idx="331">
                  <c:v>60.42</c:v>
                </c:pt>
                <c:pt idx="332">
                  <c:v>70.489999999999995</c:v>
                </c:pt>
                <c:pt idx="333">
                  <c:v>50.35</c:v>
                </c:pt>
                <c:pt idx="334">
                  <c:v>161.12</c:v>
                </c:pt>
                <c:pt idx="335">
                  <c:v>110.77</c:v>
                </c:pt>
                <c:pt idx="336">
                  <c:v>60.42</c:v>
                </c:pt>
                <c:pt idx="337">
                  <c:v>100.7</c:v>
                </c:pt>
                <c:pt idx="338">
                  <c:v>130.91</c:v>
                </c:pt>
                <c:pt idx="339">
                  <c:v>120.84</c:v>
                </c:pt>
                <c:pt idx="340">
                  <c:v>151.13999999999999</c:v>
                </c:pt>
                <c:pt idx="341">
                  <c:v>110.84</c:v>
                </c:pt>
                <c:pt idx="342">
                  <c:v>141.07</c:v>
                </c:pt>
                <c:pt idx="343">
                  <c:v>181.37</c:v>
                </c:pt>
                <c:pt idx="344">
                  <c:v>201.53</c:v>
                </c:pt>
                <c:pt idx="345">
                  <c:v>161.22</c:v>
                </c:pt>
                <c:pt idx="346">
                  <c:v>141.07</c:v>
                </c:pt>
                <c:pt idx="347">
                  <c:v>181.37</c:v>
                </c:pt>
                <c:pt idx="348">
                  <c:v>130.99</c:v>
                </c:pt>
                <c:pt idx="349">
                  <c:v>171.3</c:v>
                </c:pt>
                <c:pt idx="350">
                  <c:v>141.07</c:v>
                </c:pt>
                <c:pt idx="351">
                  <c:v>161.22</c:v>
                </c:pt>
                <c:pt idx="352">
                  <c:v>171.3</c:v>
                </c:pt>
                <c:pt idx="353">
                  <c:v>141.07</c:v>
                </c:pt>
                <c:pt idx="354">
                  <c:v>141.07</c:v>
                </c:pt>
                <c:pt idx="355">
                  <c:v>50.38</c:v>
                </c:pt>
                <c:pt idx="356">
                  <c:v>80.61</c:v>
                </c:pt>
                <c:pt idx="357">
                  <c:v>80.61</c:v>
                </c:pt>
                <c:pt idx="358">
                  <c:v>181.37</c:v>
                </c:pt>
                <c:pt idx="359">
                  <c:v>161.22</c:v>
                </c:pt>
                <c:pt idx="360">
                  <c:v>140.63</c:v>
                </c:pt>
                <c:pt idx="361">
                  <c:v>271.22000000000003</c:v>
                </c:pt>
                <c:pt idx="362">
                  <c:v>241.09</c:v>
                </c:pt>
                <c:pt idx="363">
                  <c:v>241.09</c:v>
                </c:pt>
                <c:pt idx="364">
                  <c:v>170.77</c:v>
                </c:pt>
                <c:pt idx="365">
                  <c:v>140.63</c:v>
                </c:pt>
                <c:pt idx="366">
                  <c:v>170.77</c:v>
                </c:pt>
                <c:pt idx="367">
                  <c:v>231.04</c:v>
                </c:pt>
                <c:pt idx="368">
                  <c:v>231.04</c:v>
                </c:pt>
                <c:pt idx="369">
                  <c:v>180.82</c:v>
                </c:pt>
                <c:pt idx="370">
                  <c:v>321.45</c:v>
                </c:pt>
                <c:pt idx="371">
                  <c:v>130.59</c:v>
                </c:pt>
                <c:pt idx="372">
                  <c:v>110.5</c:v>
                </c:pt>
                <c:pt idx="373">
                  <c:v>190.86</c:v>
                </c:pt>
                <c:pt idx="374">
                  <c:v>140.63</c:v>
                </c:pt>
                <c:pt idx="375">
                  <c:v>160.72</c:v>
                </c:pt>
                <c:pt idx="376">
                  <c:v>160.72</c:v>
                </c:pt>
                <c:pt idx="377">
                  <c:v>130.59</c:v>
                </c:pt>
                <c:pt idx="378">
                  <c:v>180.82</c:v>
                </c:pt>
                <c:pt idx="379">
                  <c:v>170.77</c:v>
                </c:pt>
                <c:pt idx="380">
                  <c:v>139.76</c:v>
                </c:pt>
                <c:pt idx="381">
                  <c:v>129.77000000000001</c:v>
                </c:pt>
                <c:pt idx="382">
                  <c:v>179.69</c:v>
                </c:pt>
                <c:pt idx="383">
                  <c:v>69.88</c:v>
                </c:pt>
                <c:pt idx="384">
                  <c:v>109.81</c:v>
                </c:pt>
                <c:pt idx="385">
                  <c:v>109.81</c:v>
                </c:pt>
                <c:pt idx="386">
                  <c:v>179.69</c:v>
                </c:pt>
                <c:pt idx="387">
                  <c:v>159.72</c:v>
                </c:pt>
                <c:pt idx="388">
                  <c:v>159.72</c:v>
                </c:pt>
                <c:pt idx="389">
                  <c:v>119.79</c:v>
                </c:pt>
                <c:pt idx="390">
                  <c:v>159.72</c:v>
                </c:pt>
                <c:pt idx="391">
                  <c:v>99.83</c:v>
                </c:pt>
                <c:pt idx="392">
                  <c:v>129.77000000000001</c:v>
                </c:pt>
                <c:pt idx="393">
                  <c:v>79.86</c:v>
                </c:pt>
                <c:pt idx="394">
                  <c:v>239.58</c:v>
                </c:pt>
                <c:pt idx="395">
                  <c:v>239.58</c:v>
                </c:pt>
                <c:pt idx="396">
                  <c:v>109.81</c:v>
                </c:pt>
                <c:pt idx="397">
                  <c:v>119.79</c:v>
                </c:pt>
                <c:pt idx="398">
                  <c:v>129.77000000000001</c:v>
                </c:pt>
                <c:pt idx="399">
                  <c:v>229.6</c:v>
                </c:pt>
              </c:numCache>
            </c:numRef>
          </c:yVal>
          <c:smooth val="0"/>
          <c:extLst>
            <c:ext xmlns:c16="http://schemas.microsoft.com/office/drawing/2014/chart" uri="{C3380CC4-5D6E-409C-BE32-E72D297353CC}">
              <c16:uniqueId val="{00000000-D75F-5348-A0BD-C6667D02E1F1}"/>
            </c:ext>
          </c:extLst>
        </c:ser>
        <c:ser>
          <c:idx val="1"/>
          <c:order val="1"/>
          <c:tx>
            <c:v>GA</c:v>
          </c:tx>
          <c:spPr>
            <a:ln w="25400" cap="rnd">
              <a:noFill/>
              <a:round/>
            </a:ln>
            <a:effectLst/>
          </c:spPr>
          <c:marker>
            <c:symbol val="triangle"/>
            <c:size val="4"/>
            <c:spPr>
              <a:noFill/>
              <a:ln w="12700">
                <a:solidFill>
                  <a:schemeClr val="tx1"/>
                </a:solidFill>
              </a:ln>
              <a:effectLst/>
            </c:spPr>
          </c:marker>
          <c:xVal>
            <c:numRef>
              <c:f>ベレ散布図!$I$4:$I$463</c:f>
              <c:numCache>
                <c:formatCode>General</c:formatCode>
                <c:ptCount val="460"/>
                <c:pt idx="0">
                  <c:v>136.22</c:v>
                </c:pt>
                <c:pt idx="1">
                  <c:v>121.08</c:v>
                </c:pt>
                <c:pt idx="2">
                  <c:v>83.24</c:v>
                </c:pt>
                <c:pt idx="3">
                  <c:v>98.38</c:v>
                </c:pt>
                <c:pt idx="4">
                  <c:v>83.24</c:v>
                </c:pt>
                <c:pt idx="5">
                  <c:v>174.05</c:v>
                </c:pt>
                <c:pt idx="6">
                  <c:v>98.38</c:v>
                </c:pt>
                <c:pt idx="7">
                  <c:v>128.65</c:v>
                </c:pt>
                <c:pt idx="8">
                  <c:v>158.91999999999999</c:v>
                </c:pt>
                <c:pt idx="9">
                  <c:v>83.24</c:v>
                </c:pt>
                <c:pt idx="10">
                  <c:v>90.81</c:v>
                </c:pt>
                <c:pt idx="11">
                  <c:v>113.51</c:v>
                </c:pt>
                <c:pt idx="12">
                  <c:v>90.81</c:v>
                </c:pt>
                <c:pt idx="13">
                  <c:v>105.95</c:v>
                </c:pt>
                <c:pt idx="14">
                  <c:v>113.51</c:v>
                </c:pt>
                <c:pt idx="15">
                  <c:v>60.54</c:v>
                </c:pt>
                <c:pt idx="16">
                  <c:v>113.51</c:v>
                </c:pt>
                <c:pt idx="17">
                  <c:v>83.24</c:v>
                </c:pt>
                <c:pt idx="18">
                  <c:v>151.35</c:v>
                </c:pt>
                <c:pt idx="19">
                  <c:v>196.76</c:v>
                </c:pt>
                <c:pt idx="20">
                  <c:v>69.489999999999995</c:v>
                </c:pt>
                <c:pt idx="21">
                  <c:v>61.77</c:v>
                </c:pt>
                <c:pt idx="22">
                  <c:v>46.33</c:v>
                </c:pt>
                <c:pt idx="23">
                  <c:v>61.77</c:v>
                </c:pt>
                <c:pt idx="24">
                  <c:v>61.77</c:v>
                </c:pt>
                <c:pt idx="25">
                  <c:v>108.1</c:v>
                </c:pt>
                <c:pt idx="26">
                  <c:v>92.66</c:v>
                </c:pt>
                <c:pt idx="27">
                  <c:v>115.82</c:v>
                </c:pt>
                <c:pt idx="28">
                  <c:v>54.05</c:v>
                </c:pt>
                <c:pt idx="29">
                  <c:v>84.94</c:v>
                </c:pt>
                <c:pt idx="30">
                  <c:v>77.22</c:v>
                </c:pt>
                <c:pt idx="31">
                  <c:v>131.27000000000001</c:v>
                </c:pt>
                <c:pt idx="32">
                  <c:v>77.22</c:v>
                </c:pt>
                <c:pt idx="33">
                  <c:v>92.66</c:v>
                </c:pt>
                <c:pt idx="34">
                  <c:v>69.489999999999995</c:v>
                </c:pt>
                <c:pt idx="35">
                  <c:v>77.22</c:v>
                </c:pt>
                <c:pt idx="36">
                  <c:v>54.05</c:v>
                </c:pt>
                <c:pt idx="37">
                  <c:v>77.22</c:v>
                </c:pt>
                <c:pt idx="38">
                  <c:v>61.77</c:v>
                </c:pt>
                <c:pt idx="39">
                  <c:v>77.22</c:v>
                </c:pt>
                <c:pt idx="40">
                  <c:v>107.19400000000002</c:v>
                </c:pt>
                <c:pt idx="41">
                  <c:v>96.475000000000009</c:v>
                </c:pt>
                <c:pt idx="42">
                  <c:v>85.754999999999995</c:v>
                </c:pt>
                <c:pt idx="43">
                  <c:v>171.511</c:v>
                </c:pt>
                <c:pt idx="44">
                  <c:v>64.316999999999993</c:v>
                </c:pt>
                <c:pt idx="45">
                  <c:v>107.19400000000002</c:v>
                </c:pt>
                <c:pt idx="46">
                  <c:v>85.754999999999995</c:v>
                </c:pt>
                <c:pt idx="47">
                  <c:v>96.475000000000009</c:v>
                </c:pt>
                <c:pt idx="48">
                  <c:v>117.91400000000002</c:v>
                </c:pt>
                <c:pt idx="49">
                  <c:v>117.91400000000002</c:v>
                </c:pt>
                <c:pt idx="50">
                  <c:v>64.316999999999993</c:v>
                </c:pt>
                <c:pt idx="51">
                  <c:v>96.475000000000009</c:v>
                </c:pt>
                <c:pt idx="52">
                  <c:v>107.19400000000002</c:v>
                </c:pt>
                <c:pt idx="53">
                  <c:v>107.19400000000002</c:v>
                </c:pt>
                <c:pt idx="54">
                  <c:v>85.754999999999995</c:v>
                </c:pt>
                <c:pt idx="55">
                  <c:v>96.475000000000009</c:v>
                </c:pt>
                <c:pt idx="56">
                  <c:v>53.597000000000008</c:v>
                </c:pt>
                <c:pt idx="57">
                  <c:v>85.754999999999995</c:v>
                </c:pt>
                <c:pt idx="58">
                  <c:v>85.754999999999995</c:v>
                </c:pt>
                <c:pt idx="59">
                  <c:v>53.597000000000008</c:v>
                </c:pt>
                <c:pt idx="60">
                  <c:v>197.74</c:v>
                </c:pt>
                <c:pt idx="61">
                  <c:v>63.28</c:v>
                </c:pt>
                <c:pt idx="62">
                  <c:v>142.37</c:v>
                </c:pt>
                <c:pt idx="63">
                  <c:v>197.74</c:v>
                </c:pt>
                <c:pt idx="64">
                  <c:v>205.65</c:v>
                </c:pt>
                <c:pt idx="65">
                  <c:v>284.74</c:v>
                </c:pt>
                <c:pt idx="66">
                  <c:v>94.91</c:v>
                </c:pt>
                <c:pt idx="67">
                  <c:v>94.91</c:v>
                </c:pt>
                <c:pt idx="68">
                  <c:v>142.37</c:v>
                </c:pt>
                <c:pt idx="69">
                  <c:v>118.64</c:v>
                </c:pt>
                <c:pt idx="70">
                  <c:v>126.55</c:v>
                </c:pt>
                <c:pt idx="71">
                  <c:v>87</c:v>
                </c:pt>
                <c:pt idx="72">
                  <c:v>87</c:v>
                </c:pt>
                <c:pt idx="73">
                  <c:v>158.19</c:v>
                </c:pt>
                <c:pt idx="74">
                  <c:v>126.55</c:v>
                </c:pt>
                <c:pt idx="75">
                  <c:v>166.1</c:v>
                </c:pt>
                <c:pt idx="76">
                  <c:v>110.73</c:v>
                </c:pt>
                <c:pt idx="77">
                  <c:v>126.55</c:v>
                </c:pt>
                <c:pt idx="78">
                  <c:v>150.28</c:v>
                </c:pt>
                <c:pt idx="79">
                  <c:v>253.1</c:v>
                </c:pt>
                <c:pt idx="80">
                  <c:v>110.63</c:v>
                </c:pt>
                <c:pt idx="81">
                  <c:v>126.44</c:v>
                </c:pt>
                <c:pt idx="82">
                  <c:v>150.15</c:v>
                </c:pt>
                <c:pt idx="83">
                  <c:v>189.66</c:v>
                </c:pt>
                <c:pt idx="84">
                  <c:v>102.73</c:v>
                </c:pt>
                <c:pt idx="85">
                  <c:v>63.22</c:v>
                </c:pt>
                <c:pt idx="86">
                  <c:v>173.85</c:v>
                </c:pt>
                <c:pt idx="87">
                  <c:v>71.12</c:v>
                </c:pt>
                <c:pt idx="88">
                  <c:v>150.15</c:v>
                </c:pt>
                <c:pt idx="89">
                  <c:v>126.44</c:v>
                </c:pt>
                <c:pt idx="90">
                  <c:v>134.34</c:v>
                </c:pt>
                <c:pt idx="91">
                  <c:v>94.83</c:v>
                </c:pt>
                <c:pt idx="92">
                  <c:v>126.44</c:v>
                </c:pt>
                <c:pt idx="93">
                  <c:v>110.63</c:v>
                </c:pt>
                <c:pt idx="94">
                  <c:v>118.54</c:v>
                </c:pt>
                <c:pt idx="95">
                  <c:v>86.93</c:v>
                </c:pt>
                <c:pt idx="96">
                  <c:v>158.05000000000001</c:v>
                </c:pt>
                <c:pt idx="97">
                  <c:v>55.32</c:v>
                </c:pt>
                <c:pt idx="98">
                  <c:v>47.41</c:v>
                </c:pt>
                <c:pt idx="99">
                  <c:v>94.83</c:v>
                </c:pt>
                <c:pt idx="100">
                  <c:v>131.97</c:v>
                </c:pt>
                <c:pt idx="101">
                  <c:v>107.98</c:v>
                </c:pt>
                <c:pt idx="102">
                  <c:v>155.97</c:v>
                </c:pt>
                <c:pt idx="103">
                  <c:v>143.97</c:v>
                </c:pt>
                <c:pt idx="104">
                  <c:v>131.97</c:v>
                </c:pt>
                <c:pt idx="105">
                  <c:v>107.98</c:v>
                </c:pt>
                <c:pt idx="106">
                  <c:v>131.97</c:v>
                </c:pt>
                <c:pt idx="107">
                  <c:v>83.98</c:v>
                </c:pt>
                <c:pt idx="108">
                  <c:v>119.97</c:v>
                </c:pt>
                <c:pt idx="109">
                  <c:v>119.97</c:v>
                </c:pt>
                <c:pt idx="110">
                  <c:v>71.98</c:v>
                </c:pt>
                <c:pt idx="111">
                  <c:v>215.95</c:v>
                </c:pt>
                <c:pt idx="112">
                  <c:v>107.98</c:v>
                </c:pt>
                <c:pt idx="113">
                  <c:v>119.97</c:v>
                </c:pt>
                <c:pt idx="114">
                  <c:v>107.98</c:v>
                </c:pt>
                <c:pt idx="115">
                  <c:v>107.98</c:v>
                </c:pt>
                <c:pt idx="116">
                  <c:v>107.98</c:v>
                </c:pt>
                <c:pt idx="117">
                  <c:v>119.97</c:v>
                </c:pt>
                <c:pt idx="118">
                  <c:v>95.98</c:v>
                </c:pt>
                <c:pt idx="119">
                  <c:v>143.97</c:v>
                </c:pt>
                <c:pt idx="120">
                  <c:v>137.36000000000001</c:v>
                </c:pt>
                <c:pt idx="121">
                  <c:v>137.36000000000001</c:v>
                </c:pt>
                <c:pt idx="122">
                  <c:v>137.36000000000001</c:v>
                </c:pt>
                <c:pt idx="123">
                  <c:v>151.1</c:v>
                </c:pt>
                <c:pt idx="124">
                  <c:v>109.89</c:v>
                </c:pt>
                <c:pt idx="125">
                  <c:v>109.89</c:v>
                </c:pt>
                <c:pt idx="126">
                  <c:v>109.89</c:v>
                </c:pt>
                <c:pt idx="127">
                  <c:v>164.83</c:v>
                </c:pt>
                <c:pt idx="128">
                  <c:v>96.15</c:v>
                </c:pt>
                <c:pt idx="129">
                  <c:v>123.63</c:v>
                </c:pt>
                <c:pt idx="130">
                  <c:v>82.42</c:v>
                </c:pt>
                <c:pt idx="131">
                  <c:v>137.36000000000001</c:v>
                </c:pt>
                <c:pt idx="132">
                  <c:v>178.57</c:v>
                </c:pt>
                <c:pt idx="133">
                  <c:v>123.63</c:v>
                </c:pt>
                <c:pt idx="134">
                  <c:v>123.63</c:v>
                </c:pt>
                <c:pt idx="135">
                  <c:v>109.89</c:v>
                </c:pt>
                <c:pt idx="136">
                  <c:v>109.89</c:v>
                </c:pt>
                <c:pt idx="137">
                  <c:v>123.63</c:v>
                </c:pt>
                <c:pt idx="138">
                  <c:v>164.83</c:v>
                </c:pt>
                <c:pt idx="139">
                  <c:v>137.36000000000001</c:v>
                </c:pt>
                <c:pt idx="140">
                  <c:v>119.89</c:v>
                </c:pt>
                <c:pt idx="141">
                  <c:v>107.9</c:v>
                </c:pt>
                <c:pt idx="142">
                  <c:v>95.91</c:v>
                </c:pt>
                <c:pt idx="143">
                  <c:v>131.88</c:v>
                </c:pt>
                <c:pt idx="144">
                  <c:v>95.91</c:v>
                </c:pt>
                <c:pt idx="145">
                  <c:v>155.86000000000001</c:v>
                </c:pt>
                <c:pt idx="146">
                  <c:v>155.86000000000001</c:v>
                </c:pt>
                <c:pt idx="147">
                  <c:v>107.9</c:v>
                </c:pt>
                <c:pt idx="148">
                  <c:v>83.92</c:v>
                </c:pt>
                <c:pt idx="149">
                  <c:v>107.9</c:v>
                </c:pt>
                <c:pt idx="150">
                  <c:v>143.87</c:v>
                </c:pt>
                <c:pt idx="151">
                  <c:v>203.81</c:v>
                </c:pt>
                <c:pt idx="152">
                  <c:v>191.82</c:v>
                </c:pt>
                <c:pt idx="153">
                  <c:v>167.84</c:v>
                </c:pt>
                <c:pt idx="154">
                  <c:v>143.87</c:v>
                </c:pt>
                <c:pt idx="155">
                  <c:v>143.87</c:v>
                </c:pt>
                <c:pt idx="156">
                  <c:v>143.87</c:v>
                </c:pt>
                <c:pt idx="157">
                  <c:v>155.86000000000001</c:v>
                </c:pt>
                <c:pt idx="158">
                  <c:v>131.88</c:v>
                </c:pt>
                <c:pt idx="159">
                  <c:v>191.82</c:v>
                </c:pt>
                <c:pt idx="160">
                  <c:v>140.99</c:v>
                </c:pt>
                <c:pt idx="161">
                  <c:v>94</c:v>
                </c:pt>
                <c:pt idx="162">
                  <c:v>117.49</c:v>
                </c:pt>
                <c:pt idx="163">
                  <c:v>129.24</c:v>
                </c:pt>
                <c:pt idx="164">
                  <c:v>58.75</c:v>
                </c:pt>
                <c:pt idx="165">
                  <c:v>117.49</c:v>
                </c:pt>
                <c:pt idx="166">
                  <c:v>105.74</c:v>
                </c:pt>
                <c:pt idx="167">
                  <c:v>94</c:v>
                </c:pt>
                <c:pt idx="168">
                  <c:v>94</c:v>
                </c:pt>
                <c:pt idx="169">
                  <c:v>140.99</c:v>
                </c:pt>
                <c:pt idx="170">
                  <c:v>129.24</c:v>
                </c:pt>
                <c:pt idx="171">
                  <c:v>140.99</c:v>
                </c:pt>
                <c:pt idx="172">
                  <c:v>94</c:v>
                </c:pt>
                <c:pt idx="173">
                  <c:v>140.99</c:v>
                </c:pt>
                <c:pt idx="174">
                  <c:v>152.74</c:v>
                </c:pt>
                <c:pt idx="175">
                  <c:v>105.74</c:v>
                </c:pt>
                <c:pt idx="176">
                  <c:v>140.99</c:v>
                </c:pt>
                <c:pt idx="177">
                  <c:v>105.74</c:v>
                </c:pt>
                <c:pt idx="178">
                  <c:v>129.24</c:v>
                </c:pt>
                <c:pt idx="179">
                  <c:v>129.24</c:v>
                </c:pt>
                <c:pt idx="180">
                  <c:v>70.86</c:v>
                </c:pt>
                <c:pt idx="181">
                  <c:v>59.05</c:v>
                </c:pt>
                <c:pt idx="182">
                  <c:v>82.67</c:v>
                </c:pt>
                <c:pt idx="183">
                  <c:v>82.67</c:v>
                </c:pt>
                <c:pt idx="184">
                  <c:v>106.29</c:v>
                </c:pt>
                <c:pt idx="185">
                  <c:v>94.48</c:v>
                </c:pt>
                <c:pt idx="186">
                  <c:v>94.48</c:v>
                </c:pt>
                <c:pt idx="187">
                  <c:v>118.1</c:v>
                </c:pt>
                <c:pt idx="188">
                  <c:v>94.48</c:v>
                </c:pt>
                <c:pt idx="189">
                  <c:v>82.67</c:v>
                </c:pt>
                <c:pt idx="190">
                  <c:v>94.48</c:v>
                </c:pt>
                <c:pt idx="191">
                  <c:v>141.72</c:v>
                </c:pt>
                <c:pt idx="192">
                  <c:v>82.67</c:v>
                </c:pt>
                <c:pt idx="193">
                  <c:v>129.91</c:v>
                </c:pt>
                <c:pt idx="194">
                  <c:v>129.91</c:v>
                </c:pt>
                <c:pt idx="195">
                  <c:v>82.67</c:v>
                </c:pt>
                <c:pt idx="196">
                  <c:v>177.15</c:v>
                </c:pt>
                <c:pt idx="197">
                  <c:v>118.1</c:v>
                </c:pt>
                <c:pt idx="198">
                  <c:v>212.58</c:v>
                </c:pt>
                <c:pt idx="199">
                  <c:v>153.53</c:v>
                </c:pt>
                <c:pt idx="200">
                  <c:v>106.21</c:v>
                </c:pt>
                <c:pt idx="201">
                  <c:v>106.21</c:v>
                </c:pt>
                <c:pt idx="202">
                  <c:v>141.62</c:v>
                </c:pt>
                <c:pt idx="203">
                  <c:v>94.41</c:v>
                </c:pt>
                <c:pt idx="204">
                  <c:v>94.41</c:v>
                </c:pt>
                <c:pt idx="205">
                  <c:v>118.02</c:v>
                </c:pt>
                <c:pt idx="206">
                  <c:v>70.81</c:v>
                </c:pt>
                <c:pt idx="207">
                  <c:v>118.02</c:v>
                </c:pt>
                <c:pt idx="208">
                  <c:v>106.21</c:v>
                </c:pt>
                <c:pt idx="209">
                  <c:v>94.41</c:v>
                </c:pt>
                <c:pt idx="210">
                  <c:v>153.41999999999999</c:v>
                </c:pt>
                <c:pt idx="211">
                  <c:v>82.61</c:v>
                </c:pt>
                <c:pt idx="212">
                  <c:v>141.62</c:v>
                </c:pt>
                <c:pt idx="213">
                  <c:v>129.82</c:v>
                </c:pt>
                <c:pt idx="214">
                  <c:v>94.41</c:v>
                </c:pt>
                <c:pt idx="215">
                  <c:v>177.02</c:v>
                </c:pt>
                <c:pt idx="216">
                  <c:v>141.62</c:v>
                </c:pt>
                <c:pt idx="217">
                  <c:v>165.22</c:v>
                </c:pt>
                <c:pt idx="218">
                  <c:v>94.41</c:v>
                </c:pt>
                <c:pt idx="219">
                  <c:v>129.82</c:v>
                </c:pt>
                <c:pt idx="220">
                  <c:v>184.31</c:v>
                </c:pt>
                <c:pt idx="221">
                  <c:v>126.71</c:v>
                </c:pt>
                <c:pt idx="222">
                  <c:v>115.19</c:v>
                </c:pt>
                <c:pt idx="223">
                  <c:v>195.83</c:v>
                </c:pt>
                <c:pt idx="224">
                  <c:v>138.22999999999999</c:v>
                </c:pt>
                <c:pt idx="225">
                  <c:v>92.16</c:v>
                </c:pt>
                <c:pt idx="226">
                  <c:v>103.67</c:v>
                </c:pt>
                <c:pt idx="227">
                  <c:v>115.19</c:v>
                </c:pt>
                <c:pt idx="228">
                  <c:v>80.64</c:v>
                </c:pt>
                <c:pt idx="229">
                  <c:v>138.22999999999999</c:v>
                </c:pt>
                <c:pt idx="230">
                  <c:v>126.71</c:v>
                </c:pt>
                <c:pt idx="231">
                  <c:v>115.19</c:v>
                </c:pt>
                <c:pt idx="232">
                  <c:v>126.71</c:v>
                </c:pt>
                <c:pt idx="233">
                  <c:v>184.31</c:v>
                </c:pt>
                <c:pt idx="234">
                  <c:v>149.75</c:v>
                </c:pt>
                <c:pt idx="235">
                  <c:v>115.19</c:v>
                </c:pt>
                <c:pt idx="236">
                  <c:v>103.67</c:v>
                </c:pt>
                <c:pt idx="237">
                  <c:v>103.67</c:v>
                </c:pt>
                <c:pt idx="238">
                  <c:v>80.64</c:v>
                </c:pt>
                <c:pt idx="239">
                  <c:v>172.79</c:v>
                </c:pt>
                <c:pt idx="240">
                  <c:v>47.81</c:v>
                </c:pt>
                <c:pt idx="241">
                  <c:v>95.61</c:v>
                </c:pt>
                <c:pt idx="242">
                  <c:v>143.41999999999999</c:v>
                </c:pt>
                <c:pt idx="243">
                  <c:v>107.56</c:v>
                </c:pt>
                <c:pt idx="244">
                  <c:v>167.32</c:v>
                </c:pt>
                <c:pt idx="245">
                  <c:v>119.52</c:v>
                </c:pt>
                <c:pt idx="246">
                  <c:v>71.709999999999994</c:v>
                </c:pt>
                <c:pt idx="247">
                  <c:v>95.61</c:v>
                </c:pt>
                <c:pt idx="248">
                  <c:v>107.56</c:v>
                </c:pt>
                <c:pt idx="249">
                  <c:v>155.37</c:v>
                </c:pt>
                <c:pt idx="250">
                  <c:v>143.41999999999999</c:v>
                </c:pt>
                <c:pt idx="251">
                  <c:v>179.27</c:v>
                </c:pt>
                <c:pt idx="252">
                  <c:v>227.08</c:v>
                </c:pt>
                <c:pt idx="253">
                  <c:v>131.47</c:v>
                </c:pt>
                <c:pt idx="254">
                  <c:v>143.41999999999999</c:v>
                </c:pt>
                <c:pt idx="255">
                  <c:v>95.61</c:v>
                </c:pt>
                <c:pt idx="256">
                  <c:v>203.18</c:v>
                </c:pt>
                <c:pt idx="257">
                  <c:v>143.41999999999999</c:v>
                </c:pt>
                <c:pt idx="258">
                  <c:v>83.66</c:v>
                </c:pt>
                <c:pt idx="259">
                  <c:v>131.47</c:v>
                </c:pt>
                <c:pt idx="260">
                  <c:v>152.52000000000001</c:v>
                </c:pt>
                <c:pt idx="261">
                  <c:v>117.33</c:v>
                </c:pt>
                <c:pt idx="262">
                  <c:v>140.79</c:v>
                </c:pt>
                <c:pt idx="263">
                  <c:v>93.86</c:v>
                </c:pt>
                <c:pt idx="264">
                  <c:v>117.33</c:v>
                </c:pt>
                <c:pt idx="265">
                  <c:v>82.13</c:v>
                </c:pt>
                <c:pt idx="266">
                  <c:v>129.06</c:v>
                </c:pt>
                <c:pt idx="267">
                  <c:v>211.19</c:v>
                </c:pt>
                <c:pt idx="268">
                  <c:v>140.79</c:v>
                </c:pt>
                <c:pt idx="269">
                  <c:v>140.79</c:v>
                </c:pt>
                <c:pt idx="270">
                  <c:v>93.86</c:v>
                </c:pt>
                <c:pt idx="271">
                  <c:v>129.06</c:v>
                </c:pt>
                <c:pt idx="272">
                  <c:v>129.06</c:v>
                </c:pt>
                <c:pt idx="273">
                  <c:v>82.13</c:v>
                </c:pt>
                <c:pt idx="274">
                  <c:v>93.86</c:v>
                </c:pt>
                <c:pt idx="275">
                  <c:v>152.52000000000001</c:v>
                </c:pt>
                <c:pt idx="276">
                  <c:v>164.26</c:v>
                </c:pt>
                <c:pt idx="277">
                  <c:v>164.26</c:v>
                </c:pt>
                <c:pt idx="278">
                  <c:v>117.33</c:v>
                </c:pt>
                <c:pt idx="279">
                  <c:v>117.33</c:v>
                </c:pt>
                <c:pt idx="280">
                  <c:v>84.51</c:v>
                </c:pt>
                <c:pt idx="281">
                  <c:v>96.58</c:v>
                </c:pt>
                <c:pt idx="282">
                  <c:v>60.36</c:v>
                </c:pt>
                <c:pt idx="283">
                  <c:v>120.72</c:v>
                </c:pt>
                <c:pt idx="284">
                  <c:v>144.87</c:v>
                </c:pt>
                <c:pt idx="285">
                  <c:v>108.65</c:v>
                </c:pt>
                <c:pt idx="286">
                  <c:v>96.58</c:v>
                </c:pt>
                <c:pt idx="287">
                  <c:v>120.72</c:v>
                </c:pt>
                <c:pt idx="288">
                  <c:v>108.65</c:v>
                </c:pt>
                <c:pt idx="289">
                  <c:v>120.72</c:v>
                </c:pt>
                <c:pt idx="290">
                  <c:v>108.65</c:v>
                </c:pt>
                <c:pt idx="291">
                  <c:v>108.65</c:v>
                </c:pt>
                <c:pt idx="292">
                  <c:v>96.58</c:v>
                </c:pt>
                <c:pt idx="293">
                  <c:v>108.65</c:v>
                </c:pt>
                <c:pt idx="294">
                  <c:v>120.72</c:v>
                </c:pt>
                <c:pt idx="295">
                  <c:v>96.58</c:v>
                </c:pt>
                <c:pt idx="296">
                  <c:v>96.58</c:v>
                </c:pt>
                <c:pt idx="297">
                  <c:v>144.87</c:v>
                </c:pt>
                <c:pt idx="298">
                  <c:v>108.65</c:v>
                </c:pt>
                <c:pt idx="299">
                  <c:v>96.58</c:v>
                </c:pt>
                <c:pt idx="300">
                  <c:v>113.04300000000001</c:v>
                </c:pt>
                <c:pt idx="301">
                  <c:v>102.76600000000001</c:v>
                </c:pt>
                <c:pt idx="302">
                  <c:v>154.15</c:v>
                </c:pt>
                <c:pt idx="303">
                  <c:v>133.596</c:v>
                </c:pt>
                <c:pt idx="304">
                  <c:v>164.42599999999999</c:v>
                </c:pt>
                <c:pt idx="305">
                  <c:v>123.32000000000001</c:v>
                </c:pt>
                <c:pt idx="306">
                  <c:v>133.596</c:v>
                </c:pt>
                <c:pt idx="307">
                  <c:v>154.15</c:v>
                </c:pt>
                <c:pt idx="308">
                  <c:v>184.98</c:v>
                </c:pt>
                <c:pt idx="309">
                  <c:v>133.596</c:v>
                </c:pt>
                <c:pt idx="310">
                  <c:v>113.04300000000001</c:v>
                </c:pt>
                <c:pt idx="311">
                  <c:v>123.32000000000001</c:v>
                </c:pt>
                <c:pt idx="312">
                  <c:v>123.32000000000001</c:v>
                </c:pt>
                <c:pt idx="313">
                  <c:v>154.15</c:v>
                </c:pt>
                <c:pt idx="314">
                  <c:v>113.04300000000001</c:v>
                </c:pt>
                <c:pt idx="315">
                  <c:v>154.15</c:v>
                </c:pt>
                <c:pt idx="316">
                  <c:v>143.87299999999999</c:v>
                </c:pt>
                <c:pt idx="317">
                  <c:v>102.76600000000001</c:v>
                </c:pt>
                <c:pt idx="318">
                  <c:v>102.76600000000001</c:v>
                </c:pt>
                <c:pt idx="319">
                  <c:v>102.76600000000001</c:v>
                </c:pt>
                <c:pt idx="320">
                  <c:v>71.42</c:v>
                </c:pt>
                <c:pt idx="321">
                  <c:v>91.83</c:v>
                </c:pt>
                <c:pt idx="322">
                  <c:v>102.03</c:v>
                </c:pt>
                <c:pt idx="323">
                  <c:v>142.84</c:v>
                </c:pt>
                <c:pt idx="324">
                  <c:v>112.23</c:v>
                </c:pt>
                <c:pt idx="325">
                  <c:v>102.03</c:v>
                </c:pt>
                <c:pt idx="326">
                  <c:v>112.23</c:v>
                </c:pt>
                <c:pt idx="327">
                  <c:v>142.84</c:v>
                </c:pt>
                <c:pt idx="328">
                  <c:v>122.44</c:v>
                </c:pt>
                <c:pt idx="329">
                  <c:v>61.22</c:v>
                </c:pt>
                <c:pt idx="330">
                  <c:v>102.03</c:v>
                </c:pt>
                <c:pt idx="331">
                  <c:v>132.63999999999999</c:v>
                </c:pt>
                <c:pt idx="332">
                  <c:v>153.05000000000001</c:v>
                </c:pt>
                <c:pt idx="333">
                  <c:v>102.03</c:v>
                </c:pt>
                <c:pt idx="334">
                  <c:v>112.23</c:v>
                </c:pt>
                <c:pt idx="335">
                  <c:v>132.63999999999999</c:v>
                </c:pt>
                <c:pt idx="336">
                  <c:v>91.83</c:v>
                </c:pt>
                <c:pt idx="337">
                  <c:v>163.25</c:v>
                </c:pt>
                <c:pt idx="338">
                  <c:v>153.05000000000001</c:v>
                </c:pt>
                <c:pt idx="339">
                  <c:v>112.23</c:v>
                </c:pt>
                <c:pt idx="340">
                  <c:v>123.52</c:v>
                </c:pt>
                <c:pt idx="341">
                  <c:v>123.52</c:v>
                </c:pt>
                <c:pt idx="342">
                  <c:v>154.4</c:v>
                </c:pt>
                <c:pt idx="343">
                  <c:v>133.81</c:v>
                </c:pt>
                <c:pt idx="344">
                  <c:v>133.81</c:v>
                </c:pt>
                <c:pt idx="345">
                  <c:v>123.52</c:v>
                </c:pt>
                <c:pt idx="346">
                  <c:v>164.69</c:v>
                </c:pt>
                <c:pt idx="347">
                  <c:v>123.52</c:v>
                </c:pt>
                <c:pt idx="348">
                  <c:v>113.23</c:v>
                </c:pt>
                <c:pt idx="349">
                  <c:v>113.23</c:v>
                </c:pt>
                <c:pt idx="350">
                  <c:v>61.76</c:v>
                </c:pt>
                <c:pt idx="351">
                  <c:v>72.05</c:v>
                </c:pt>
                <c:pt idx="352">
                  <c:v>154.4</c:v>
                </c:pt>
                <c:pt idx="353">
                  <c:v>113.23</c:v>
                </c:pt>
                <c:pt idx="354">
                  <c:v>102.93</c:v>
                </c:pt>
                <c:pt idx="355">
                  <c:v>133.81</c:v>
                </c:pt>
                <c:pt idx="356">
                  <c:v>154.4</c:v>
                </c:pt>
                <c:pt idx="357">
                  <c:v>92.64</c:v>
                </c:pt>
                <c:pt idx="358">
                  <c:v>133.81</c:v>
                </c:pt>
                <c:pt idx="359">
                  <c:v>123.52</c:v>
                </c:pt>
                <c:pt idx="360">
                  <c:v>95.02</c:v>
                </c:pt>
                <c:pt idx="361">
                  <c:v>84.47</c:v>
                </c:pt>
                <c:pt idx="362">
                  <c:v>84.47</c:v>
                </c:pt>
                <c:pt idx="363">
                  <c:v>116.14</c:v>
                </c:pt>
                <c:pt idx="364">
                  <c:v>137.26</c:v>
                </c:pt>
                <c:pt idx="365">
                  <c:v>105.58</c:v>
                </c:pt>
                <c:pt idx="366">
                  <c:v>84.47</c:v>
                </c:pt>
                <c:pt idx="367">
                  <c:v>52.79</c:v>
                </c:pt>
                <c:pt idx="368">
                  <c:v>95.02</c:v>
                </c:pt>
                <c:pt idx="369">
                  <c:v>84.47</c:v>
                </c:pt>
                <c:pt idx="370">
                  <c:v>73.91</c:v>
                </c:pt>
                <c:pt idx="371">
                  <c:v>63.35</c:v>
                </c:pt>
                <c:pt idx="372">
                  <c:v>105.58</c:v>
                </c:pt>
                <c:pt idx="373">
                  <c:v>116.14</c:v>
                </c:pt>
                <c:pt idx="374">
                  <c:v>52.79</c:v>
                </c:pt>
                <c:pt idx="375">
                  <c:v>116.14</c:v>
                </c:pt>
                <c:pt idx="376">
                  <c:v>31.67</c:v>
                </c:pt>
                <c:pt idx="377">
                  <c:v>73.91</c:v>
                </c:pt>
                <c:pt idx="378">
                  <c:v>105.58</c:v>
                </c:pt>
                <c:pt idx="379">
                  <c:v>95.02</c:v>
                </c:pt>
                <c:pt idx="380">
                  <c:v>173.27</c:v>
                </c:pt>
                <c:pt idx="381">
                  <c:v>142.69999999999999</c:v>
                </c:pt>
                <c:pt idx="382">
                  <c:v>152.88999999999999</c:v>
                </c:pt>
                <c:pt idx="383">
                  <c:v>173.27</c:v>
                </c:pt>
                <c:pt idx="384">
                  <c:v>81.540000000000006</c:v>
                </c:pt>
                <c:pt idx="385">
                  <c:v>295.58999999999997</c:v>
                </c:pt>
                <c:pt idx="386">
                  <c:v>112.12</c:v>
                </c:pt>
                <c:pt idx="387">
                  <c:v>244.62</c:v>
                </c:pt>
                <c:pt idx="388">
                  <c:v>142.69999999999999</c:v>
                </c:pt>
                <c:pt idx="389">
                  <c:v>101.93</c:v>
                </c:pt>
                <c:pt idx="390">
                  <c:v>224.24</c:v>
                </c:pt>
                <c:pt idx="391">
                  <c:v>91.73</c:v>
                </c:pt>
                <c:pt idx="392">
                  <c:v>203.85</c:v>
                </c:pt>
                <c:pt idx="393">
                  <c:v>193.66</c:v>
                </c:pt>
                <c:pt idx="394">
                  <c:v>142.69999999999999</c:v>
                </c:pt>
                <c:pt idx="395">
                  <c:v>91.73</c:v>
                </c:pt>
                <c:pt idx="396">
                  <c:v>203.85</c:v>
                </c:pt>
                <c:pt idx="397">
                  <c:v>152.88999999999999</c:v>
                </c:pt>
                <c:pt idx="398">
                  <c:v>285.39</c:v>
                </c:pt>
                <c:pt idx="399">
                  <c:v>244.62</c:v>
                </c:pt>
                <c:pt idx="400">
                  <c:v>101.95</c:v>
                </c:pt>
                <c:pt idx="401">
                  <c:v>61.17</c:v>
                </c:pt>
                <c:pt idx="402">
                  <c:v>122.34</c:v>
                </c:pt>
                <c:pt idx="403">
                  <c:v>142.72999999999999</c:v>
                </c:pt>
                <c:pt idx="404">
                  <c:v>81.56</c:v>
                </c:pt>
                <c:pt idx="405">
                  <c:v>112.15</c:v>
                </c:pt>
                <c:pt idx="406">
                  <c:v>173.32</c:v>
                </c:pt>
                <c:pt idx="407">
                  <c:v>61.17</c:v>
                </c:pt>
                <c:pt idx="408">
                  <c:v>91.76</c:v>
                </c:pt>
                <c:pt idx="409">
                  <c:v>193.71</c:v>
                </c:pt>
                <c:pt idx="410">
                  <c:v>101.95</c:v>
                </c:pt>
                <c:pt idx="411">
                  <c:v>91.76</c:v>
                </c:pt>
                <c:pt idx="412">
                  <c:v>122.34</c:v>
                </c:pt>
                <c:pt idx="413">
                  <c:v>122.34</c:v>
                </c:pt>
                <c:pt idx="414">
                  <c:v>81.56</c:v>
                </c:pt>
                <c:pt idx="415">
                  <c:v>224.29</c:v>
                </c:pt>
                <c:pt idx="416">
                  <c:v>183.51</c:v>
                </c:pt>
                <c:pt idx="417">
                  <c:v>101.95</c:v>
                </c:pt>
                <c:pt idx="418">
                  <c:v>112.15</c:v>
                </c:pt>
                <c:pt idx="419">
                  <c:v>142.72999999999999</c:v>
                </c:pt>
                <c:pt idx="420">
                  <c:v>143.37</c:v>
                </c:pt>
                <c:pt idx="421">
                  <c:v>153.61000000000001</c:v>
                </c:pt>
                <c:pt idx="422">
                  <c:v>163.85</c:v>
                </c:pt>
                <c:pt idx="423">
                  <c:v>133.13</c:v>
                </c:pt>
                <c:pt idx="424">
                  <c:v>61.44</c:v>
                </c:pt>
                <c:pt idx="425">
                  <c:v>81.93</c:v>
                </c:pt>
                <c:pt idx="426">
                  <c:v>143.37</c:v>
                </c:pt>
                <c:pt idx="427">
                  <c:v>184.33</c:v>
                </c:pt>
                <c:pt idx="428">
                  <c:v>112.65</c:v>
                </c:pt>
                <c:pt idx="429">
                  <c:v>61.44</c:v>
                </c:pt>
                <c:pt idx="430">
                  <c:v>71.680000000000007</c:v>
                </c:pt>
                <c:pt idx="431">
                  <c:v>112.65</c:v>
                </c:pt>
                <c:pt idx="432">
                  <c:v>92.17</c:v>
                </c:pt>
                <c:pt idx="433">
                  <c:v>112.65</c:v>
                </c:pt>
                <c:pt idx="434">
                  <c:v>122.89</c:v>
                </c:pt>
                <c:pt idx="435">
                  <c:v>133.13</c:v>
                </c:pt>
                <c:pt idx="436">
                  <c:v>71.680000000000007</c:v>
                </c:pt>
                <c:pt idx="437">
                  <c:v>102.41</c:v>
                </c:pt>
                <c:pt idx="438">
                  <c:v>92.17</c:v>
                </c:pt>
                <c:pt idx="439">
                  <c:v>71.680000000000007</c:v>
                </c:pt>
                <c:pt idx="440">
                  <c:v>187.6</c:v>
                </c:pt>
                <c:pt idx="441">
                  <c:v>93.8</c:v>
                </c:pt>
                <c:pt idx="442">
                  <c:v>104.22</c:v>
                </c:pt>
                <c:pt idx="443">
                  <c:v>166.76</c:v>
                </c:pt>
                <c:pt idx="444">
                  <c:v>72.959999999999994</c:v>
                </c:pt>
                <c:pt idx="445">
                  <c:v>72.959999999999994</c:v>
                </c:pt>
                <c:pt idx="446">
                  <c:v>114.65</c:v>
                </c:pt>
                <c:pt idx="447">
                  <c:v>104.22</c:v>
                </c:pt>
                <c:pt idx="448">
                  <c:v>62.53</c:v>
                </c:pt>
                <c:pt idx="449">
                  <c:v>62.53</c:v>
                </c:pt>
                <c:pt idx="450">
                  <c:v>62.53</c:v>
                </c:pt>
                <c:pt idx="451">
                  <c:v>41.69</c:v>
                </c:pt>
                <c:pt idx="452">
                  <c:v>93.8</c:v>
                </c:pt>
                <c:pt idx="453">
                  <c:v>72.959999999999994</c:v>
                </c:pt>
                <c:pt idx="454">
                  <c:v>72.959999999999994</c:v>
                </c:pt>
                <c:pt idx="455">
                  <c:v>93.8</c:v>
                </c:pt>
                <c:pt idx="456">
                  <c:v>104.22</c:v>
                </c:pt>
                <c:pt idx="457">
                  <c:v>62.53</c:v>
                </c:pt>
                <c:pt idx="458">
                  <c:v>72.959999999999994</c:v>
                </c:pt>
                <c:pt idx="459">
                  <c:v>83.38</c:v>
                </c:pt>
              </c:numCache>
            </c:numRef>
          </c:xVal>
          <c:yVal>
            <c:numRef>
              <c:f>ベレ散布図!$J$4:$J$463</c:f>
              <c:numCache>
                <c:formatCode>General</c:formatCode>
                <c:ptCount val="460"/>
                <c:pt idx="0">
                  <c:v>68.11</c:v>
                </c:pt>
                <c:pt idx="1">
                  <c:v>68.11</c:v>
                </c:pt>
                <c:pt idx="2">
                  <c:v>45.41</c:v>
                </c:pt>
                <c:pt idx="3">
                  <c:v>75.680000000000007</c:v>
                </c:pt>
                <c:pt idx="4">
                  <c:v>68.11</c:v>
                </c:pt>
                <c:pt idx="5">
                  <c:v>75.680000000000007</c:v>
                </c:pt>
                <c:pt idx="6">
                  <c:v>90.81</c:v>
                </c:pt>
                <c:pt idx="7">
                  <c:v>211.89</c:v>
                </c:pt>
                <c:pt idx="8">
                  <c:v>174.05</c:v>
                </c:pt>
                <c:pt idx="9">
                  <c:v>136.22</c:v>
                </c:pt>
                <c:pt idx="10">
                  <c:v>211.89</c:v>
                </c:pt>
                <c:pt idx="11">
                  <c:v>83.24</c:v>
                </c:pt>
                <c:pt idx="12">
                  <c:v>90.81</c:v>
                </c:pt>
                <c:pt idx="13">
                  <c:v>121.08</c:v>
                </c:pt>
                <c:pt idx="14">
                  <c:v>105.95</c:v>
                </c:pt>
                <c:pt idx="15">
                  <c:v>68.11</c:v>
                </c:pt>
                <c:pt idx="16">
                  <c:v>113.51</c:v>
                </c:pt>
                <c:pt idx="17">
                  <c:v>174.05</c:v>
                </c:pt>
                <c:pt idx="18">
                  <c:v>98.38</c:v>
                </c:pt>
                <c:pt idx="19">
                  <c:v>113.51</c:v>
                </c:pt>
                <c:pt idx="20">
                  <c:v>131.27000000000001</c:v>
                </c:pt>
                <c:pt idx="21">
                  <c:v>77.22</c:v>
                </c:pt>
                <c:pt idx="22">
                  <c:v>100.38</c:v>
                </c:pt>
                <c:pt idx="23">
                  <c:v>61.77</c:v>
                </c:pt>
                <c:pt idx="24">
                  <c:v>123.54</c:v>
                </c:pt>
                <c:pt idx="25">
                  <c:v>100.38</c:v>
                </c:pt>
                <c:pt idx="26">
                  <c:v>69.489999999999995</c:v>
                </c:pt>
                <c:pt idx="27">
                  <c:v>193.04</c:v>
                </c:pt>
                <c:pt idx="28">
                  <c:v>115.82</c:v>
                </c:pt>
                <c:pt idx="29">
                  <c:v>154.43</c:v>
                </c:pt>
                <c:pt idx="30">
                  <c:v>77.22</c:v>
                </c:pt>
                <c:pt idx="31">
                  <c:v>154.43</c:v>
                </c:pt>
                <c:pt idx="32">
                  <c:v>108.1</c:v>
                </c:pt>
                <c:pt idx="33">
                  <c:v>123.54</c:v>
                </c:pt>
                <c:pt idx="34">
                  <c:v>131.27000000000001</c:v>
                </c:pt>
                <c:pt idx="35">
                  <c:v>193.04</c:v>
                </c:pt>
                <c:pt idx="36">
                  <c:v>108.1</c:v>
                </c:pt>
                <c:pt idx="37">
                  <c:v>138.99</c:v>
                </c:pt>
                <c:pt idx="38">
                  <c:v>169.87</c:v>
                </c:pt>
                <c:pt idx="39">
                  <c:v>131.27000000000001</c:v>
                </c:pt>
                <c:pt idx="40">
                  <c:v>85.754999999999995</c:v>
                </c:pt>
                <c:pt idx="41">
                  <c:v>42.878</c:v>
                </c:pt>
                <c:pt idx="42">
                  <c:v>107.19400000000002</c:v>
                </c:pt>
                <c:pt idx="43">
                  <c:v>171.511</c:v>
                </c:pt>
                <c:pt idx="44">
                  <c:v>64.316999999999993</c:v>
                </c:pt>
                <c:pt idx="45">
                  <c:v>53.597000000000008</c:v>
                </c:pt>
                <c:pt idx="46">
                  <c:v>107.19400000000002</c:v>
                </c:pt>
                <c:pt idx="47">
                  <c:v>139.352</c:v>
                </c:pt>
                <c:pt idx="48">
                  <c:v>85.754999999999995</c:v>
                </c:pt>
                <c:pt idx="49">
                  <c:v>128.63300000000001</c:v>
                </c:pt>
                <c:pt idx="50">
                  <c:v>96.475000000000009</c:v>
                </c:pt>
                <c:pt idx="51">
                  <c:v>96.475000000000009</c:v>
                </c:pt>
                <c:pt idx="52">
                  <c:v>107.19400000000002</c:v>
                </c:pt>
                <c:pt idx="53">
                  <c:v>96.475000000000009</c:v>
                </c:pt>
                <c:pt idx="54">
                  <c:v>139.352</c:v>
                </c:pt>
                <c:pt idx="55">
                  <c:v>192.95000000000002</c:v>
                </c:pt>
                <c:pt idx="56">
                  <c:v>75.036000000000001</c:v>
                </c:pt>
                <c:pt idx="57">
                  <c:v>96.475000000000009</c:v>
                </c:pt>
                <c:pt idx="58">
                  <c:v>53.597000000000008</c:v>
                </c:pt>
                <c:pt idx="59">
                  <c:v>53.597000000000008</c:v>
                </c:pt>
                <c:pt idx="60">
                  <c:v>134.46</c:v>
                </c:pt>
                <c:pt idx="61">
                  <c:v>79.09</c:v>
                </c:pt>
                <c:pt idx="62">
                  <c:v>87</c:v>
                </c:pt>
                <c:pt idx="63">
                  <c:v>134.46</c:v>
                </c:pt>
                <c:pt idx="64">
                  <c:v>110.73</c:v>
                </c:pt>
                <c:pt idx="65">
                  <c:v>197.74</c:v>
                </c:pt>
                <c:pt idx="66">
                  <c:v>87</c:v>
                </c:pt>
                <c:pt idx="67">
                  <c:v>79.09</c:v>
                </c:pt>
                <c:pt idx="68">
                  <c:v>134.46</c:v>
                </c:pt>
                <c:pt idx="69">
                  <c:v>126.55</c:v>
                </c:pt>
                <c:pt idx="70">
                  <c:v>87</c:v>
                </c:pt>
                <c:pt idx="71">
                  <c:v>47.46</c:v>
                </c:pt>
                <c:pt idx="72">
                  <c:v>102.82</c:v>
                </c:pt>
                <c:pt idx="73">
                  <c:v>150.28</c:v>
                </c:pt>
                <c:pt idx="74">
                  <c:v>94.91</c:v>
                </c:pt>
                <c:pt idx="75">
                  <c:v>150.28</c:v>
                </c:pt>
                <c:pt idx="76">
                  <c:v>126.55</c:v>
                </c:pt>
                <c:pt idx="77">
                  <c:v>102.82</c:v>
                </c:pt>
                <c:pt idx="78">
                  <c:v>79.09</c:v>
                </c:pt>
                <c:pt idx="79">
                  <c:v>150.28</c:v>
                </c:pt>
                <c:pt idx="80">
                  <c:v>118.54</c:v>
                </c:pt>
                <c:pt idx="81">
                  <c:v>158.05000000000001</c:v>
                </c:pt>
                <c:pt idx="82">
                  <c:v>173.85</c:v>
                </c:pt>
                <c:pt idx="83">
                  <c:v>197.56</c:v>
                </c:pt>
                <c:pt idx="84">
                  <c:v>110.63</c:v>
                </c:pt>
                <c:pt idx="85">
                  <c:v>118.54</c:v>
                </c:pt>
                <c:pt idx="86">
                  <c:v>181.76</c:v>
                </c:pt>
                <c:pt idx="87">
                  <c:v>189.66</c:v>
                </c:pt>
                <c:pt idx="88">
                  <c:v>229.17</c:v>
                </c:pt>
                <c:pt idx="89">
                  <c:v>197.56</c:v>
                </c:pt>
                <c:pt idx="90">
                  <c:v>165.95</c:v>
                </c:pt>
                <c:pt idx="91">
                  <c:v>118.54</c:v>
                </c:pt>
                <c:pt idx="92">
                  <c:v>94.83</c:v>
                </c:pt>
                <c:pt idx="93">
                  <c:v>142.24</c:v>
                </c:pt>
                <c:pt idx="94">
                  <c:v>268.68</c:v>
                </c:pt>
                <c:pt idx="95">
                  <c:v>142.24</c:v>
                </c:pt>
                <c:pt idx="96">
                  <c:v>158.05000000000001</c:v>
                </c:pt>
                <c:pt idx="97">
                  <c:v>181.76</c:v>
                </c:pt>
                <c:pt idx="98">
                  <c:v>165.95</c:v>
                </c:pt>
                <c:pt idx="99">
                  <c:v>197.56</c:v>
                </c:pt>
                <c:pt idx="100">
                  <c:v>119.97</c:v>
                </c:pt>
                <c:pt idx="101">
                  <c:v>131.97</c:v>
                </c:pt>
                <c:pt idx="102">
                  <c:v>131.97</c:v>
                </c:pt>
                <c:pt idx="103">
                  <c:v>155.97</c:v>
                </c:pt>
                <c:pt idx="104">
                  <c:v>203.95</c:v>
                </c:pt>
                <c:pt idx="105">
                  <c:v>143.97</c:v>
                </c:pt>
                <c:pt idx="106">
                  <c:v>215.95</c:v>
                </c:pt>
                <c:pt idx="107">
                  <c:v>83.98</c:v>
                </c:pt>
                <c:pt idx="108">
                  <c:v>215.95</c:v>
                </c:pt>
                <c:pt idx="109">
                  <c:v>143.97</c:v>
                </c:pt>
                <c:pt idx="110">
                  <c:v>131.97</c:v>
                </c:pt>
                <c:pt idx="111">
                  <c:v>239.95</c:v>
                </c:pt>
                <c:pt idx="112">
                  <c:v>155.97</c:v>
                </c:pt>
                <c:pt idx="113">
                  <c:v>107.98</c:v>
                </c:pt>
                <c:pt idx="114">
                  <c:v>95.98</c:v>
                </c:pt>
                <c:pt idx="115">
                  <c:v>155.97</c:v>
                </c:pt>
                <c:pt idx="116">
                  <c:v>119.97</c:v>
                </c:pt>
                <c:pt idx="117">
                  <c:v>107.98</c:v>
                </c:pt>
                <c:pt idx="118">
                  <c:v>131.97</c:v>
                </c:pt>
                <c:pt idx="119">
                  <c:v>203.95</c:v>
                </c:pt>
                <c:pt idx="120">
                  <c:v>247.25</c:v>
                </c:pt>
                <c:pt idx="121">
                  <c:v>233.51</c:v>
                </c:pt>
                <c:pt idx="122">
                  <c:v>247.25</c:v>
                </c:pt>
                <c:pt idx="123">
                  <c:v>219.78</c:v>
                </c:pt>
                <c:pt idx="124">
                  <c:v>343.4</c:v>
                </c:pt>
                <c:pt idx="125">
                  <c:v>288.45999999999998</c:v>
                </c:pt>
                <c:pt idx="126">
                  <c:v>123.63</c:v>
                </c:pt>
                <c:pt idx="127">
                  <c:v>315.93</c:v>
                </c:pt>
                <c:pt idx="128">
                  <c:v>233.51</c:v>
                </c:pt>
                <c:pt idx="129">
                  <c:v>178.57</c:v>
                </c:pt>
                <c:pt idx="130">
                  <c:v>137.36000000000001</c:v>
                </c:pt>
                <c:pt idx="131">
                  <c:v>274.72000000000003</c:v>
                </c:pt>
                <c:pt idx="132">
                  <c:v>370.88</c:v>
                </c:pt>
                <c:pt idx="133">
                  <c:v>206.04</c:v>
                </c:pt>
                <c:pt idx="134">
                  <c:v>233.51</c:v>
                </c:pt>
                <c:pt idx="135">
                  <c:v>109.89</c:v>
                </c:pt>
                <c:pt idx="136">
                  <c:v>178.57</c:v>
                </c:pt>
                <c:pt idx="137">
                  <c:v>178.57</c:v>
                </c:pt>
                <c:pt idx="138">
                  <c:v>206.04</c:v>
                </c:pt>
                <c:pt idx="139">
                  <c:v>192.31</c:v>
                </c:pt>
                <c:pt idx="140">
                  <c:v>95.91</c:v>
                </c:pt>
                <c:pt idx="141">
                  <c:v>107.9</c:v>
                </c:pt>
                <c:pt idx="142">
                  <c:v>119.89</c:v>
                </c:pt>
                <c:pt idx="143">
                  <c:v>143.87</c:v>
                </c:pt>
                <c:pt idx="144">
                  <c:v>143.87</c:v>
                </c:pt>
                <c:pt idx="145">
                  <c:v>227.79</c:v>
                </c:pt>
                <c:pt idx="146">
                  <c:v>155.86000000000001</c:v>
                </c:pt>
                <c:pt idx="147">
                  <c:v>143.87</c:v>
                </c:pt>
                <c:pt idx="148">
                  <c:v>131.88</c:v>
                </c:pt>
                <c:pt idx="149">
                  <c:v>83.92</c:v>
                </c:pt>
                <c:pt idx="150">
                  <c:v>155.86000000000001</c:v>
                </c:pt>
                <c:pt idx="151">
                  <c:v>143.87</c:v>
                </c:pt>
                <c:pt idx="152">
                  <c:v>179.83</c:v>
                </c:pt>
                <c:pt idx="153">
                  <c:v>71.930000000000007</c:v>
                </c:pt>
                <c:pt idx="154">
                  <c:v>71.930000000000007</c:v>
                </c:pt>
                <c:pt idx="155">
                  <c:v>179.83</c:v>
                </c:pt>
                <c:pt idx="156">
                  <c:v>83.92</c:v>
                </c:pt>
                <c:pt idx="157">
                  <c:v>107.9</c:v>
                </c:pt>
                <c:pt idx="158">
                  <c:v>179.83</c:v>
                </c:pt>
                <c:pt idx="159">
                  <c:v>203.81</c:v>
                </c:pt>
                <c:pt idx="160">
                  <c:v>129.24</c:v>
                </c:pt>
                <c:pt idx="161">
                  <c:v>152.74</c:v>
                </c:pt>
                <c:pt idx="162">
                  <c:v>176.24</c:v>
                </c:pt>
                <c:pt idx="163">
                  <c:v>187.99</c:v>
                </c:pt>
                <c:pt idx="164">
                  <c:v>129.24</c:v>
                </c:pt>
                <c:pt idx="165">
                  <c:v>152.74</c:v>
                </c:pt>
                <c:pt idx="166">
                  <c:v>82.25</c:v>
                </c:pt>
                <c:pt idx="167">
                  <c:v>140.99</c:v>
                </c:pt>
                <c:pt idx="168">
                  <c:v>105.74</c:v>
                </c:pt>
                <c:pt idx="169">
                  <c:v>140.99</c:v>
                </c:pt>
                <c:pt idx="170">
                  <c:v>152.74</c:v>
                </c:pt>
                <c:pt idx="171">
                  <c:v>187.99</c:v>
                </c:pt>
                <c:pt idx="172">
                  <c:v>199.74</c:v>
                </c:pt>
                <c:pt idx="173">
                  <c:v>199.74</c:v>
                </c:pt>
                <c:pt idx="174">
                  <c:v>164.49</c:v>
                </c:pt>
                <c:pt idx="175">
                  <c:v>176.24</c:v>
                </c:pt>
                <c:pt idx="176">
                  <c:v>164.49</c:v>
                </c:pt>
                <c:pt idx="177">
                  <c:v>94</c:v>
                </c:pt>
                <c:pt idx="178">
                  <c:v>164.49</c:v>
                </c:pt>
                <c:pt idx="179">
                  <c:v>187.99</c:v>
                </c:pt>
                <c:pt idx="180">
                  <c:v>188.96</c:v>
                </c:pt>
                <c:pt idx="181">
                  <c:v>141.72</c:v>
                </c:pt>
                <c:pt idx="182">
                  <c:v>188.96</c:v>
                </c:pt>
                <c:pt idx="183">
                  <c:v>259.82</c:v>
                </c:pt>
                <c:pt idx="184">
                  <c:v>271.63</c:v>
                </c:pt>
                <c:pt idx="185">
                  <c:v>200.77</c:v>
                </c:pt>
                <c:pt idx="186">
                  <c:v>236.2</c:v>
                </c:pt>
                <c:pt idx="187">
                  <c:v>248.01</c:v>
                </c:pt>
                <c:pt idx="188">
                  <c:v>188.96</c:v>
                </c:pt>
                <c:pt idx="189">
                  <c:v>177.15</c:v>
                </c:pt>
                <c:pt idx="190">
                  <c:v>200.77</c:v>
                </c:pt>
                <c:pt idx="191">
                  <c:v>259.82</c:v>
                </c:pt>
                <c:pt idx="192">
                  <c:v>118.1</c:v>
                </c:pt>
                <c:pt idx="193">
                  <c:v>224.39</c:v>
                </c:pt>
                <c:pt idx="194">
                  <c:v>118.1</c:v>
                </c:pt>
                <c:pt idx="195">
                  <c:v>165.34</c:v>
                </c:pt>
                <c:pt idx="196">
                  <c:v>271.63</c:v>
                </c:pt>
                <c:pt idx="197">
                  <c:v>165.34</c:v>
                </c:pt>
                <c:pt idx="198">
                  <c:v>248.01</c:v>
                </c:pt>
                <c:pt idx="199">
                  <c:v>200.77</c:v>
                </c:pt>
                <c:pt idx="200">
                  <c:v>141.62</c:v>
                </c:pt>
                <c:pt idx="201">
                  <c:v>212.43</c:v>
                </c:pt>
                <c:pt idx="202">
                  <c:v>177.02</c:v>
                </c:pt>
                <c:pt idx="203">
                  <c:v>153.41999999999999</c:v>
                </c:pt>
                <c:pt idx="204">
                  <c:v>106.21</c:v>
                </c:pt>
                <c:pt idx="205">
                  <c:v>129.82</c:v>
                </c:pt>
                <c:pt idx="206">
                  <c:v>118.02</c:v>
                </c:pt>
                <c:pt idx="207">
                  <c:v>129.82</c:v>
                </c:pt>
                <c:pt idx="208">
                  <c:v>188.82</c:v>
                </c:pt>
                <c:pt idx="209">
                  <c:v>106.21</c:v>
                </c:pt>
                <c:pt idx="210">
                  <c:v>188.82</c:v>
                </c:pt>
                <c:pt idx="211">
                  <c:v>200.63</c:v>
                </c:pt>
                <c:pt idx="212">
                  <c:v>283.24</c:v>
                </c:pt>
                <c:pt idx="213">
                  <c:v>177.02</c:v>
                </c:pt>
                <c:pt idx="214">
                  <c:v>165.22</c:v>
                </c:pt>
                <c:pt idx="215">
                  <c:v>259.63</c:v>
                </c:pt>
                <c:pt idx="216">
                  <c:v>212.43</c:v>
                </c:pt>
                <c:pt idx="217">
                  <c:v>200.63</c:v>
                </c:pt>
                <c:pt idx="218">
                  <c:v>129.82</c:v>
                </c:pt>
                <c:pt idx="219">
                  <c:v>200.63</c:v>
                </c:pt>
                <c:pt idx="220">
                  <c:v>161.27000000000001</c:v>
                </c:pt>
                <c:pt idx="221">
                  <c:v>92.16</c:v>
                </c:pt>
                <c:pt idx="222">
                  <c:v>115.19</c:v>
                </c:pt>
                <c:pt idx="223">
                  <c:v>230.39</c:v>
                </c:pt>
                <c:pt idx="224">
                  <c:v>126.71</c:v>
                </c:pt>
                <c:pt idx="225">
                  <c:v>138.22999999999999</c:v>
                </c:pt>
                <c:pt idx="226">
                  <c:v>184.31</c:v>
                </c:pt>
                <c:pt idx="227">
                  <c:v>241.91</c:v>
                </c:pt>
                <c:pt idx="228">
                  <c:v>92.16</c:v>
                </c:pt>
                <c:pt idx="229">
                  <c:v>149.75</c:v>
                </c:pt>
                <c:pt idx="230">
                  <c:v>276.47000000000003</c:v>
                </c:pt>
                <c:pt idx="231">
                  <c:v>207.35</c:v>
                </c:pt>
                <c:pt idx="232">
                  <c:v>241.91</c:v>
                </c:pt>
                <c:pt idx="233">
                  <c:v>195.83</c:v>
                </c:pt>
                <c:pt idx="234">
                  <c:v>230.39</c:v>
                </c:pt>
                <c:pt idx="235">
                  <c:v>92.16</c:v>
                </c:pt>
                <c:pt idx="236">
                  <c:v>126.71</c:v>
                </c:pt>
                <c:pt idx="237">
                  <c:v>115.19</c:v>
                </c:pt>
                <c:pt idx="238">
                  <c:v>184.31</c:v>
                </c:pt>
                <c:pt idx="239">
                  <c:v>207.35</c:v>
                </c:pt>
                <c:pt idx="240">
                  <c:v>107.56</c:v>
                </c:pt>
                <c:pt idx="241">
                  <c:v>143.41999999999999</c:v>
                </c:pt>
                <c:pt idx="242">
                  <c:v>155.37</c:v>
                </c:pt>
                <c:pt idx="243">
                  <c:v>71.709999999999994</c:v>
                </c:pt>
                <c:pt idx="244">
                  <c:v>107.56</c:v>
                </c:pt>
                <c:pt idx="245">
                  <c:v>155.37</c:v>
                </c:pt>
                <c:pt idx="246">
                  <c:v>143.41999999999999</c:v>
                </c:pt>
                <c:pt idx="247">
                  <c:v>215.13</c:v>
                </c:pt>
                <c:pt idx="248">
                  <c:v>203.18</c:v>
                </c:pt>
                <c:pt idx="249">
                  <c:v>167.32</c:v>
                </c:pt>
                <c:pt idx="250">
                  <c:v>167.32</c:v>
                </c:pt>
                <c:pt idx="251">
                  <c:v>143.41999999999999</c:v>
                </c:pt>
                <c:pt idx="252">
                  <c:v>107.56</c:v>
                </c:pt>
                <c:pt idx="253">
                  <c:v>119.52</c:v>
                </c:pt>
                <c:pt idx="254">
                  <c:v>131.47</c:v>
                </c:pt>
                <c:pt idx="255">
                  <c:v>131.47</c:v>
                </c:pt>
                <c:pt idx="256">
                  <c:v>227.08</c:v>
                </c:pt>
                <c:pt idx="257">
                  <c:v>179.27</c:v>
                </c:pt>
                <c:pt idx="258">
                  <c:v>107.56</c:v>
                </c:pt>
                <c:pt idx="259">
                  <c:v>107.56</c:v>
                </c:pt>
                <c:pt idx="260">
                  <c:v>129.06</c:v>
                </c:pt>
                <c:pt idx="261">
                  <c:v>82.13</c:v>
                </c:pt>
                <c:pt idx="262">
                  <c:v>105.59</c:v>
                </c:pt>
                <c:pt idx="263">
                  <c:v>70.400000000000006</c:v>
                </c:pt>
                <c:pt idx="264">
                  <c:v>105.59</c:v>
                </c:pt>
                <c:pt idx="265">
                  <c:v>129.06</c:v>
                </c:pt>
                <c:pt idx="266">
                  <c:v>93.86</c:v>
                </c:pt>
                <c:pt idx="267">
                  <c:v>175.99</c:v>
                </c:pt>
                <c:pt idx="268">
                  <c:v>140.79</c:v>
                </c:pt>
                <c:pt idx="269">
                  <c:v>105.59</c:v>
                </c:pt>
                <c:pt idx="270">
                  <c:v>93.86</c:v>
                </c:pt>
                <c:pt idx="271">
                  <c:v>93.86</c:v>
                </c:pt>
                <c:pt idx="272">
                  <c:v>117.33</c:v>
                </c:pt>
                <c:pt idx="273">
                  <c:v>82.13</c:v>
                </c:pt>
                <c:pt idx="274">
                  <c:v>129.06</c:v>
                </c:pt>
                <c:pt idx="275">
                  <c:v>105.59</c:v>
                </c:pt>
                <c:pt idx="276">
                  <c:v>117.33</c:v>
                </c:pt>
                <c:pt idx="277">
                  <c:v>117.33</c:v>
                </c:pt>
                <c:pt idx="278">
                  <c:v>117.33</c:v>
                </c:pt>
                <c:pt idx="279">
                  <c:v>105.59</c:v>
                </c:pt>
                <c:pt idx="280">
                  <c:v>144.87</c:v>
                </c:pt>
                <c:pt idx="281">
                  <c:v>132.80000000000001</c:v>
                </c:pt>
                <c:pt idx="282">
                  <c:v>193.16</c:v>
                </c:pt>
                <c:pt idx="283">
                  <c:v>181.09</c:v>
                </c:pt>
                <c:pt idx="284">
                  <c:v>120.72</c:v>
                </c:pt>
                <c:pt idx="285">
                  <c:v>144.87</c:v>
                </c:pt>
                <c:pt idx="286">
                  <c:v>241.45</c:v>
                </c:pt>
                <c:pt idx="287">
                  <c:v>289.74</c:v>
                </c:pt>
                <c:pt idx="288">
                  <c:v>84.51</c:v>
                </c:pt>
                <c:pt idx="289">
                  <c:v>241.45</c:v>
                </c:pt>
                <c:pt idx="290">
                  <c:v>132.80000000000001</c:v>
                </c:pt>
                <c:pt idx="291">
                  <c:v>108.65</c:v>
                </c:pt>
                <c:pt idx="292">
                  <c:v>96.58</c:v>
                </c:pt>
                <c:pt idx="293">
                  <c:v>132.80000000000001</c:v>
                </c:pt>
                <c:pt idx="294">
                  <c:v>181.09</c:v>
                </c:pt>
                <c:pt idx="295">
                  <c:v>108.65</c:v>
                </c:pt>
                <c:pt idx="296">
                  <c:v>181.09</c:v>
                </c:pt>
                <c:pt idx="297">
                  <c:v>181.09</c:v>
                </c:pt>
                <c:pt idx="298">
                  <c:v>181.09</c:v>
                </c:pt>
                <c:pt idx="299">
                  <c:v>205.23</c:v>
                </c:pt>
                <c:pt idx="300">
                  <c:v>113.04300000000001</c:v>
                </c:pt>
                <c:pt idx="301">
                  <c:v>113.04300000000001</c:v>
                </c:pt>
                <c:pt idx="302">
                  <c:v>113.04300000000001</c:v>
                </c:pt>
                <c:pt idx="303">
                  <c:v>113.04300000000001</c:v>
                </c:pt>
                <c:pt idx="304">
                  <c:v>102.76600000000001</c:v>
                </c:pt>
                <c:pt idx="305">
                  <c:v>102.76600000000001</c:v>
                </c:pt>
                <c:pt idx="306">
                  <c:v>113.04300000000001</c:v>
                </c:pt>
                <c:pt idx="307">
                  <c:v>195.256</c:v>
                </c:pt>
                <c:pt idx="308">
                  <c:v>154.15</c:v>
                </c:pt>
                <c:pt idx="309">
                  <c:v>205.53299999999999</c:v>
                </c:pt>
                <c:pt idx="310">
                  <c:v>184.98</c:v>
                </c:pt>
                <c:pt idx="311">
                  <c:v>154.15</c:v>
                </c:pt>
                <c:pt idx="312">
                  <c:v>215.81</c:v>
                </c:pt>
                <c:pt idx="313">
                  <c:v>205.53299999999999</c:v>
                </c:pt>
                <c:pt idx="314">
                  <c:v>164.42599999999999</c:v>
                </c:pt>
                <c:pt idx="315">
                  <c:v>102.76600000000001</c:v>
                </c:pt>
                <c:pt idx="316">
                  <c:v>226.08600000000001</c:v>
                </c:pt>
                <c:pt idx="317">
                  <c:v>143.87299999999999</c:v>
                </c:pt>
                <c:pt idx="318">
                  <c:v>123.32000000000001</c:v>
                </c:pt>
                <c:pt idx="319">
                  <c:v>113.04300000000001</c:v>
                </c:pt>
                <c:pt idx="320">
                  <c:v>234.67</c:v>
                </c:pt>
                <c:pt idx="321">
                  <c:v>244.87</c:v>
                </c:pt>
                <c:pt idx="322">
                  <c:v>234.67</c:v>
                </c:pt>
                <c:pt idx="323">
                  <c:v>214.26</c:v>
                </c:pt>
                <c:pt idx="324">
                  <c:v>153.05000000000001</c:v>
                </c:pt>
                <c:pt idx="325">
                  <c:v>81.62</c:v>
                </c:pt>
                <c:pt idx="326">
                  <c:v>102.03</c:v>
                </c:pt>
                <c:pt idx="327">
                  <c:v>142.84</c:v>
                </c:pt>
                <c:pt idx="328">
                  <c:v>142.84</c:v>
                </c:pt>
                <c:pt idx="329">
                  <c:v>61.22</c:v>
                </c:pt>
                <c:pt idx="330">
                  <c:v>112.23</c:v>
                </c:pt>
                <c:pt idx="331">
                  <c:v>102.03</c:v>
                </c:pt>
                <c:pt idx="332">
                  <c:v>153.05000000000001</c:v>
                </c:pt>
                <c:pt idx="333">
                  <c:v>142.84</c:v>
                </c:pt>
                <c:pt idx="334">
                  <c:v>122.44</c:v>
                </c:pt>
                <c:pt idx="335">
                  <c:v>204.06</c:v>
                </c:pt>
                <c:pt idx="336">
                  <c:v>102.03</c:v>
                </c:pt>
                <c:pt idx="337">
                  <c:v>183.65</c:v>
                </c:pt>
                <c:pt idx="338">
                  <c:v>224.47</c:v>
                </c:pt>
                <c:pt idx="339">
                  <c:v>265.27999999999997</c:v>
                </c:pt>
                <c:pt idx="340">
                  <c:v>195.57</c:v>
                </c:pt>
                <c:pt idx="341">
                  <c:v>185.28</c:v>
                </c:pt>
                <c:pt idx="342">
                  <c:v>174.98</c:v>
                </c:pt>
                <c:pt idx="343">
                  <c:v>133.81</c:v>
                </c:pt>
                <c:pt idx="344">
                  <c:v>144.11000000000001</c:v>
                </c:pt>
                <c:pt idx="345">
                  <c:v>113.23</c:v>
                </c:pt>
                <c:pt idx="346">
                  <c:v>216.16</c:v>
                </c:pt>
                <c:pt idx="347">
                  <c:v>133.81</c:v>
                </c:pt>
                <c:pt idx="348">
                  <c:v>123.52</c:v>
                </c:pt>
                <c:pt idx="349">
                  <c:v>113.23</c:v>
                </c:pt>
                <c:pt idx="350">
                  <c:v>92.64</c:v>
                </c:pt>
                <c:pt idx="351">
                  <c:v>154.4</c:v>
                </c:pt>
                <c:pt idx="352">
                  <c:v>226.45</c:v>
                </c:pt>
                <c:pt idx="353">
                  <c:v>154.4</c:v>
                </c:pt>
                <c:pt idx="354">
                  <c:v>102.93</c:v>
                </c:pt>
                <c:pt idx="355">
                  <c:v>154.4</c:v>
                </c:pt>
                <c:pt idx="356">
                  <c:v>154.4</c:v>
                </c:pt>
                <c:pt idx="357">
                  <c:v>113.23</c:v>
                </c:pt>
                <c:pt idx="358">
                  <c:v>154.4</c:v>
                </c:pt>
                <c:pt idx="359">
                  <c:v>144.11000000000001</c:v>
                </c:pt>
                <c:pt idx="360">
                  <c:v>221.72</c:v>
                </c:pt>
                <c:pt idx="361">
                  <c:v>253.4</c:v>
                </c:pt>
                <c:pt idx="362">
                  <c:v>200.61</c:v>
                </c:pt>
                <c:pt idx="363">
                  <c:v>221.72</c:v>
                </c:pt>
                <c:pt idx="364">
                  <c:v>168.93</c:v>
                </c:pt>
                <c:pt idx="365">
                  <c:v>126.7</c:v>
                </c:pt>
                <c:pt idx="366">
                  <c:v>116.14</c:v>
                </c:pt>
                <c:pt idx="367">
                  <c:v>126.7</c:v>
                </c:pt>
                <c:pt idx="368">
                  <c:v>200.61</c:v>
                </c:pt>
                <c:pt idx="369">
                  <c:v>105.58</c:v>
                </c:pt>
                <c:pt idx="370">
                  <c:v>137.26</c:v>
                </c:pt>
                <c:pt idx="371">
                  <c:v>52.79</c:v>
                </c:pt>
                <c:pt idx="372">
                  <c:v>232.28</c:v>
                </c:pt>
                <c:pt idx="373">
                  <c:v>190.05</c:v>
                </c:pt>
                <c:pt idx="374">
                  <c:v>63.35</c:v>
                </c:pt>
                <c:pt idx="375">
                  <c:v>200.61</c:v>
                </c:pt>
                <c:pt idx="376">
                  <c:v>147.82</c:v>
                </c:pt>
                <c:pt idx="377">
                  <c:v>168.93</c:v>
                </c:pt>
                <c:pt idx="378">
                  <c:v>211.16</c:v>
                </c:pt>
                <c:pt idx="379">
                  <c:v>253.4</c:v>
                </c:pt>
                <c:pt idx="380">
                  <c:v>61.16</c:v>
                </c:pt>
                <c:pt idx="381">
                  <c:v>81.540000000000006</c:v>
                </c:pt>
                <c:pt idx="382">
                  <c:v>112.12</c:v>
                </c:pt>
                <c:pt idx="383">
                  <c:v>71.349999999999994</c:v>
                </c:pt>
                <c:pt idx="384">
                  <c:v>91.73</c:v>
                </c:pt>
                <c:pt idx="385">
                  <c:v>101.93</c:v>
                </c:pt>
                <c:pt idx="386">
                  <c:v>112.12</c:v>
                </c:pt>
                <c:pt idx="387">
                  <c:v>142.69999999999999</c:v>
                </c:pt>
                <c:pt idx="388">
                  <c:v>81.540000000000006</c:v>
                </c:pt>
                <c:pt idx="389">
                  <c:v>61.16</c:v>
                </c:pt>
                <c:pt idx="390">
                  <c:v>163.08000000000001</c:v>
                </c:pt>
                <c:pt idx="391">
                  <c:v>91.73</c:v>
                </c:pt>
                <c:pt idx="392">
                  <c:v>61.16</c:v>
                </c:pt>
                <c:pt idx="393">
                  <c:v>61.16</c:v>
                </c:pt>
                <c:pt idx="394">
                  <c:v>81.540000000000006</c:v>
                </c:pt>
                <c:pt idx="395">
                  <c:v>71.349999999999994</c:v>
                </c:pt>
                <c:pt idx="396">
                  <c:v>71.349999999999994</c:v>
                </c:pt>
                <c:pt idx="397">
                  <c:v>81.540000000000006</c:v>
                </c:pt>
                <c:pt idx="398">
                  <c:v>152.88999999999999</c:v>
                </c:pt>
                <c:pt idx="399">
                  <c:v>112.12</c:v>
                </c:pt>
                <c:pt idx="400">
                  <c:v>112.15</c:v>
                </c:pt>
                <c:pt idx="401">
                  <c:v>142.72999999999999</c:v>
                </c:pt>
                <c:pt idx="402">
                  <c:v>71.37</c:v>
                </c:pt>
                <c:pt idx="403">
                  <c:v>112.15</c:v>
                </c:pt>
                <c:pt idx="404">
                  <c:v>61.17</c:v>
                </c:pt>
                <c:pt idx="405">
                  <c:v>132.54</c:v>
                </c:pt>
                <c:pt idx="406">
                  <c:v>326.25</c:v>
                </c:pt>
                <c:pt idx="407">
                  <c:v>214.1</c:v>
                </c:pt>
                <c:pt idx="408">
                  <c:v>234.49</c:v>
                </c:pt>
                <c:pt idx="409">
                  <c:v>418</c:v>
                </c:pt>
                <c:pt idx="410">
                  <c:v>224.29</c:v>
                </c:pt>
                <c:pt idx="411">
                  <c:v>91.76</c:v>
                </c:pt>
                <c:pt idx="412">
                  <c:v>132.54</c:v>
                </c:pt>
                <c:pt idx="413">
                  <c:v>183.51</c:v>
                </c:pt>
                <c:pt idx="414">
                  <c:v>183.51</c:v>
                </c:pt>
                <c:pt idx="415">
                  <c:v>387.42</c:v>
                </c:pt>
                <c:pt idx="416">
                  <c:v>173.32</c:v>
                </c:pt>
                <c:pt idx="417">
                  <c:v>336.44</c:v>
                </c:pt>
                <c:pt idx="418">
                  <c:v>173.32</c:v>
                </c:pt>
                <c:pt idx="419">
                  <c:v>163.12</c:v>
                </c:pt>
                <c:pt idx="420">
                  <c:v>163.85</c:v>
                </c:pt>
                <c:pt idx="421">
                  <c:v>112.65</c:v>
                </c:pt>
                <c:pt idx="422">
                  <c:v>92.17</c:v>
                </c:pt>
                <c:pt idx="423">
                  <c:v>102.41</c:v>
                </c:pt>
                <c:pt idx="424">
                  <c:v>81.93</c:v>
                </c:pt>
                <c:pt idx="425">
                  <c:v>61.44</c:v>
                </c:pt>
                <c:pt idx="426">
                  <c:v>163.85</c:v>
                </c:pt>
                <c:pt idx="427">
                  <c:v>122.89</c:v>
                </c:pt>
                <c:pt idx="428">
                  <c:v>102.41</c:v>
                </c:pt>
                <c:pt idx="429">
                  <c:v>51.2</c:v>
                </c:pt>
                <c:pt idx="430">
                  <c:v>71.680000000000007</c:v>
                </c:pt>
                <c:pt idx="431">
                  <c:v>112.65</c:v>
                </c:pt>
                <c:pt idx="432">
                  <c:v>102.41</c:v>
                </c:pt>
                <c:pt idx="433">
                  <c:v>194.57</c:v>
                </c:pt>
                <c:pt idx="434">
                  <c:v>133.13</c:v>
                </c:pt>
                <c:pt idx="435">
                  <c:v>184.33</c:v>
                </c:pt>
                <c:pt idx="436">
                  <c:v>71.680000000000007</c:v>
                </c:pt>
                <c:pt idx="437">
                  <c:v>71.680000000000007</c:v>
                </c:pt>
                <c:pt idx="438">
                  <c:v>81.93</c:v>
                </c:pt>
                <c:pt idx="439">
                  <c:v>112.65</c:v>
                </c:pt>
                <c:pt idx="440">
                  <c:v>218.87</c:v>
                </c:pt>
                <c:pt idx="441">
                  <c:v>114.65</c:v>
                </c:pt>
                <c:pt idx="442">
                  <c:v>104.22</c:v>
                </c:pt>
                <c:pt idx="443">
                  <c:v>145.91</c:v>
                </c:pt>
                <c:pt idx="444">
                  <c:v>218.87</c:v>
                </c:pt>
                <c:pt idx="445">
                  <c:v>145.91</c:v>
                </c:pt>
                <c:pt idx="446">
                  <c:v>208.45</c:v>
                </c:pt>
                <c:pt idx="447">
                  <c:v>208.45</c:v>
                </c:pt>
                <c:pt idx="448">
                  <c:v>104.22</c:v>
                </c:pt>
                <c:pt idx="449">
                  <c:v>93.8</c:v>
                </c:pt>
                <c:pt idx="450">
                  <c:v>83.38</c:v>
                </c:pt>
                <c:pt idx="451">
                  <c:v>52.11</c:v>
                </c:pt>
                <c:pt idx="452">
                  <c:v>187.6</c:v>
                </c:pt>
                <c:pt idx="453">
                  <c:v>114.65</c:v>
                </c:pt>
                <c:pt idx="454">
                  <c:v>104.22</c:v>
                </c:pt>
                <c:pt idx="455">
                  <c:v>125.07</c:v>
                </c:pt>
                <c:pt idx="456">
                  <c:v>208.45</c:v>
                </c:pt>
                <c:pt idx="457">
                  <c:v>198.03</c:v>
                </c:pt>
                <c:pt idx="458">
                  <c:v>166.76</c:v>
                </c:pt>
                <c:pt idx="459">
                  <c:v>135.49</c:v>
                </c:pt>
              </c:numCache>
            </c:numRef>
          </c:yVal>
          <c:smooth val="0"/>
          <c:extLst>
            <c:ext xmlns:c16="http://schemas.microsoft.com/office/drawing/2014/chart" uri="{C3380CC4-5D6E-409C-BE32-E72D297353CC}">
              <c16:uniqueId val="{00000001-D75F-5348-A0BD-C6667D02E1F1}"/>
            </c:ext>
          </c:extLst>
        </c:ser>
        <c:dLbls>
          <c:showLegendKey val="0"/>
          <c:showVal val="0"/>
          <c:showCatName val="0"/>
          <c:showSerName val="0"/>
          <c:showPercent val="0"/>
          <c:showBubbleSize val="0"/>
        </c:dLbls>
        <c:axId val="1374367008"/>
        <c:axId val="1418485024"/>
      </c:scatterChart>
      <c:valAx>
        <c:axId val="1374367008"/>
        <c:scaling>
          <c:orientation val="minMax"/>
        </c:scaling>
        <c:delete val="0"/>
        <c:axPos val="b"/>
        <c:majorGridlines>
          <c:spPr>
            <a:ln w="9525" cap="flat" cmpd="sng" algn="ctr">
              <a:noFill/>
              <a:round/>
            </a:ln>
            <a:effectLst/>
          </c:spPr>
        </c:majorGridlines>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18485024"/>
        <c:crosses val="autoZero"/>
        <c:crossBetween val="midCat"/>
        <c:majorUnit val="100"/>
      </c:valAx>
      <c:valAx>
        <c:axId val="1418485024"/>
        <c:scaling>
          <c:orientation val="minMax"/>
          <c:max val="500"/>
        </c:scaling>
        <c:delete val="0"/>
        <c:axPos val="l"/>
        <c:majorGridlines>
          <c:spPr>
            <a:ln w="9525" cap="flat" cmpd="sng" algn="ctr">
              <a:noFill/>
              <a:round/>
            </a:ln>
            <a:effectLst/>
          </c:spPr>
        </c:majorGridlines>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74367008"/>
        <c:crosses val="autoZero"/>
        <c:crossBetween val="midCat"/>
        <c:majorUnit val="100"/>
      </c:valAx>
      <c:spPr>
        <a:noFill/>
        <a:ln>
          <a:solidFill>
            <a:schemeClr val="tx1"/>
          </a:solidFill>
        </a:ln>
        <a:effectLst/>
      </c:spPr>
    </c:plotArea>
    <c:legend>
      <c:legendPos val="r"/>
      <c:layout>
        <c:manualLayout>
          <c:xMode val="edge"/>
          <c:yMode val="edge"/>
          <c:x val="0.83738024192456906"/>
          <c:y val="0.83937848770605161"/>
          <c:w val="0.12462330228779314"/>
          <c:h val="8.6202966748654256E-2"/>
        </c:manualLayout>
      </c:layout>
      <c:overlay val="0"/>
      <c:spPr>
        <a:noFill/>
        <a:ln>
          <a:noFill/>
        </a:ln>
        <a:effectLst/>
      </c:spPr>
      <c:txPr>
        <a:bodyPr rot="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9.5318427695885263E-2"/>
          <c:y val="3.644142909065403E-2"/>
          <c:w val="0.86216384106156707"/>
          <c:h val="0.88153699467754021"/>
        </c:manualLayout>
      </c:layout>
      <c:scatterChart>
        <c:scatterStyle val="lineMarker"/>
        <c:varyColors val="0"/>
        <c:ser>
          <c:idx val="0"/>
          <c:order val="0"/>
          <c:tx>
            <c:v>NT</c:v>
          </c:tx>
          <c:spPr>
            <a:ln w="25400" cap="rnd">
              <a:noFill/>
              <a:round/>
            </a:ln>
            <a:effectLst/>
          </c:spPr>
          <c:marker>
            <c:symbol val="circle"/>
            <c:size val="4"/>
            <c:spPr>
              <a:noFill/>
              <a:ln w="12700">
                <a:solidFill>
                  <a:schemeClr val="accent2"/>
                </a:solidFill>
              </a:ln>
              <a:effectLst/>
            </c:spPr>
          </c:marker>
          <c:xVal>
            <c:numRef>
              <c:f>成熟期散布図!$C$4:$C$363</c:f>
              <c:numCache>
                <c:formatCode>General</c:formatCode>
                <c:ptCount val="360"/>
                <c:pt idx="0">
                  <c:v>278.29000000000002</c:v>
                </c:pt>
                <c:pt idx="1">
                  <c:v>198.78</c:v>
                </c:pt>
                <c:pt idx="2">
                  <c:v>212.03</c:v>
                </c:pt>
                <c:pt idx="3">
                  <c:v>106.02</c:v>
                </c:pt>
                <c:pt idx="4">
                  <c:v>92.76</c:v>
                </c:pt>
                <c:pt idx="5">
                  <c:v>172.28</c:v>
                </c:pt>
                <c:pt idx="6">
                  <c:v>92.76</c:v>
                </c:pt>
                <c:pt idx="7">
                  <c:v>119.27</c:v>
                </c:pt>
                <c:pt idx="8">
                  <c:v>159.02000000000001</c:v>
                </c:pt>
                <c:pt idx="9">
                  <c:v>159.02000000000001</c:v>
                </c:pt>
                <c:pt idx="10">
                  <c:v>159.02000000000001</c:v>
                </c:pt>
                <c:pt idx="11">
                  <c:v>145.77000000000001</c:v>
                </c:pt>
                <c:pt idx="12">
                  <c:v>238.54</c:v>
                </c:pt>
                <c:pt idx="13">
                  <c:v>145.77000000000001</c:v>
                </c:pt>
                <c:pt idx="14">
                  <c:v>198.78</c:v>
                </c:pt>
                <c:pt idx="15">
                  <c:v>145.77000000000001</c:v>
                </c:pt>
                <c:pt idx="16">
                  <c:v>145.77000000000001</c:v>
                </c:pt>
                <c:pt idx="17">
                  <c:v>132.52000000000001</c:v>
                </c:pt>
                <c:pt idx="18">
                  <c:v>159.02000000000001</c:v>
                </c:pt>
                <c:pt idx="19">
                  <c:v>159.02000000000001</c:v>
                </c:pt>
                <c:pt idx="20">
                  <c:v>249</c:v>
                </c:pt>
                <c:pt idx="21">
                  <c:v>249</c:v>
                </c:pt>
                <c:pt idx="22">
                  <c:v>158.46</c:v>
                </c:pt>
                <c:pt idx="23">
                  <c:v>192.41</c:v>
                </c:pt>
                <c:pt idx="24">
                  <c:v>158.46</c:v>
                </c:pt>
                <c:pt idx="25">
                  <c:v>101.86</c:v>
                </c:pt>
                <c:pt idx="26">
                  <c:v>147.13999999999999</c:v>
                </c:pt>
                <c:pt idx="27">
                  <c:v>135.82</c:v>
                </c:pt>
                <c:pt idx="28">
                  <c:v>67.91</c:v>
                </c:pt>
                <c:pt idx="29">
                  <c:v>67.91</c:v>
                </c:pt>
                <c:pt idx="30">
                  <c:v>67.91</c:v>
                </c:pt>
                <c:pt idx="31">
                  <c:v>192.41</c:v>
                </c:pt>
                <c:pt idx="32">
                  <c:v>305.58999999999997</c:v>
                </c:pt>
                <c:pt idx="33">
                  <c:v>135.82</c:v>
                </c:pt>
                <c:pt idx="34">
                  <c:v>181.09</c:v>
                </c:pt>
                <c:pt idx="35">
                  <c:v>113.18</c:v>
                </c:pt>
                <c:pt idx="36">
                  <c:v>181.09</c:v>
                </c:pt>
                <c:pt idx="37">
                  <c:v>237.68</c:v>
                </c:pt>
                <c:pt idx="38">
                  <c:v>215.05</c:v>
                </c:pt>
                <c:pt idx="39">
                  <c:v>124.5</c:v>
                </c:pt>
                <c:pt idx="40">
                  <c:v>111.75</c:v>
                </c:pt>
                <c:pt idx="41">
                  <c:v>89.4</c:v>
                </c:pt>
                <c:pt idx="42">
                  <c:v>156.44999999999999</c:v>
                </c:pt>
                <c:pt idx="43">
                  <c:v>223.5</c:v>
                </c:pt>
                <c:pt idx="44">
                  <c:v>78.22</c:v>
                </c:pt>
                <c:pt idx="45">
                  <c:v>134.1</c:v>
                </c:pt>
                <c:pt idx="46">
                  <c:v>223.5</c:v>
                </c:pt>
                <c:pt idx="47">
                  <c:v>167.62</c:v>
                </c:pt>
                <c:pt idx="48">
                  <c:v>223.5</c:v>
                </c:pt>
                <c:pt idx="49">
                  <c:v>178.8</c:v>
                </c:pt>
                <c:pt idx="50">
                  <c:v>178.8</c:v>
                </c:pt>
                <c:pt idx="51">
                  <c:v>189.97</c:v>
                </c:pt>
                <c:pt idx="52">
                  <c:v>111.75</c:v>
                </c:pt>
                <c:pt idx="53">
                  <c:v>145.27000000000001</c:v>
                </c:pt>
                <c:pt idx="54">
                  <c:v>189.97</c:v>
                </c:pt>
                <c:pt idx="55">
                  <c:v>122.92</c:v>
                </c:pt>
                <c:pt idx="56">
                  <c:v>78.22</c:v>
                </c:pt>
                <c:pt idx="57">
                  <c:v>111.75</c:v>
                </c:pt>
                <c:pt idx="58">
                  <c:v>122.92</c:v>
                </c:pt>
                <c:pt idx="59">
                  <c:v>201.15</c:v>
                </c:pt>
                <c:pt idx="60">
                  <c:v>289.66000000000003</c:v>
                </c:pt>
                <c:pt idx="61">
                  <c:v>198.19</c:v>
                </c:pt>
                <c:pt idx="62">
                  <c:v>121.96</c:v>
                </c:pt>
                <c:pt idx="63">
                  <c:v>274.41000000000003</c:v>
                </c:pt>
                <c:pt idx="64">
                  <c:v>152.44999999999999</c:v>
                </c:pt>
                <c:pt idx="65">
                  <c:v>137.21</c:v>
                </c:pt>
                <c:pt idx="66">
                  <c:v>137.21</c:v>
                </c:pt>
                <c:pt idx="67">
                  <c:v>137.21</c:v>
                </c:pt>
                <c:pt idx="68">
                  <c:v>198.19</c:v>
                </c:pt>
                <c:pt idx="69">
                  <c:v>228.68</c:v>
                </c:pt>
                <c:pt idx="70">
                  <c:v>289.66000000000003</c:v>
                </c:pt>
                <c:pt idx="71">
                  <c:v>91.47</c:v>
                </c:pt>
                <c:pt idx="72">
                  <c:v>213.43</c:v>
                </c:pt>
                <c:pt idx="73">
                  <c:v>182.94</c:v>
                </c:pt>
                <c:pt idx="74">
                  <c:v>213.43</c:v>
                </c:pt>
                <c:pt idx="75">
                  <c:v>243.92</c:v>
                </c:pt>
                <c:pt idx="76">
                  <c:v>320.14999999999998</c:v>
                </c:pt>
                <c:pt idx="77">
                  <c:v>274.41000000000003</c:v>
                </c:pt>
                <c:pt idx="78">
                  <c:v>167.7</c:v>
                </c:pt>
                <c:pt idx="79">
                  <c:v>182.94</c:v>
                </c:pt>
                <c:pt idx="80">
                  <c:v>150.01</c:v>
                </c:pt>
                <c:pt idx="81">
                  <c:v>190.92</c:v>
                </c:pt>
                <c:pt idx="82">
                  <c:v>109.1</c:v>
                </c:pt>
                <c:pt idx="83">
                  <c:v>95.46</c:v>
                </c:pt>
                <c:pt idx="84">
                  <c:v>150.01</c:v>
                </c:pt>
                <c:pt idx="85">
                  <c:v>150.01</c:v>
                </c:pt>
                <c:pt idx="86">
                  <c:v>190.92</c:v>
                </c:pt>
                <c:pt idx="87">
                  <c:v>136.37</c:v>
                </c:pt>
                <c:pt idx="88">
                  <c:v>340.93</c:v>
                </c:pt>
                <c:pt idx="89">
                  <c:v>231.83</c:v>
                </c:pt>
                <c:pt idx="90">
                  <c:v>231.83</c:v>
                </c:pt>
                <c:pt idx="91">
                  <c:v>204.56</c:v>
                </c:pt>
                <c:pt idx="92">
                  <c:v>122.73</c:v>
                </c:pt>
                <c:pt idx="93">
                  <c:v>109.1</c:v>
                </c:pt>
                <c:pt idx="94">
                  <c:v>81.819999999999993</c:v>
                </c:pt>
                <c:pt idx="95">
                  <c:v>136.37</c:v>
                </c:pt>
                <c:pt idx="96">
                  <c:v>150.01</c:v>
                </c:pt>
                <c:pt idx="97">
                  <c:v>381.84</c:v>
                </c:pt>
                <c:pt idx="98">
                  <c:v>300.01</c:v>
                </c:pt>
                <c:pt idx="99">
                  <c:v>259.10000000000002</c:v>
                </c:pt>
                <c:pt idx="100">
                  <c:v>243.45</c:v>
                </c:pt>
                <c:pt idx="101">
                  <c:v>229.92</c:v>
                </c:pt>
                <c:pt idx="102">
                  <c:v>256.97000000000003</c:v>
                </c:pt>
                <c:pt idx="103">
                  <c:v>338.12</c:v>
                </c:pt>
                <c:pt idx="104">
                  <c:v>175.82</c:v>
                </c:pt>
                <c:pt idx="105">
                  <c:v>202.87</c:v>
                </c:pt>
                <c:pt idx="106">
                  <c:v>121.72</c:v>
                </c:pt>
                <c:pt idx="107">
                  <c:v>148.77000000000001</c:v>
                </c:pt>
                <c:pt idx="108">
                  <c:v>148.77000000000001</c:v>
                </c:pt>
                <c:pt idx="109">
                  <c:v>216.4</c:v>
                </c:pt>
                <c:pt idx="110">
                  <c:v>189.35</c:v>
                </c:pt>
                <c:pt idx="111">
                  <c:v>202.87</c:v>
                </c:pt>
                <c:pt idx="112">
                  <c:v>148.77000000000001</c:v>
                </c:pt>
                <c:pt idx="113">
                  <c:v>175.82</c:v>
                </c:pt>
                <c:pt idx="114">
                  <c:v>175.82</c:v>
                </c:pt>
                <c:pt idx="115">
                  <c:v>148.77000000000001</c:v>
                </c:pt>
                <c:pt idx="116">
                  <c:v>175.82</c:v>
                </c:pt>
                <c:pt idx="117">
                  <c:v>189.35</c:v>
                </c:pt>
                <c:pt idx="118">
                  <c:v>175.82</c:v>
                </c:pt>
                <c:pt idx="119">
                  <c:v>270.5</c:v>
                </c:pt>
                <c:pt idx="120">
                  <c:v>172.28</c:v>
                </c:pt>
                <c:pt idx="121">
                  <c:v>159.02000000000001</c:v>
                </c:pt>
                <c:pt idx="122">
                  <c:v>198.78</c:v>
                </c:pt>
                <c:pt idx="123">
                  <c:v>185.53</c:v>
                </c:pt>
                <c:pt idx="124">
                  <c:v>278.29000000000002</c:v>
                </c:pt>
                <c:pt idx="125">
                  <c:v>198.78</c:v>
                </c:pt>
                <c:pt idx="126">
                  <c:v>159.02000000000001</c:v>
                </c:pt>
                <c:pt idx="127">
                  <c:v>132.52000000000001</c:v>
                </c:pt>
                <c:pt idx="128">
                  <c:v>66.260000000000005</c:v>
                </c:pt>
                <c:pt idx="129">
                  <c:v>53.01</c:v>
                </c:pt>
                <c:pt idx="130">
                  <c:v>106.02</c:v>
                </c:pt>
                <c:pt idx="131">
                  <c:v>185.53</c:v>
                </c:pt>
                <c:pt idx="132">
                  <c:v>79.510000000000005</c:v>
                </c:pt>
                <c:pt idx="133">
                  <c:v>132.52000000000001</c:v>
                </c:pt>
                <c:pt idx="134">
                  <c:v>132.52000000000001</c:v>
                </c:pt>
                <c:pt idx="135">
                  <c:v>278.29000000000002</c:v>
                </c:pt>
                <c:pt idx="136">
                  <c:v>212.03</c:v>
                </c:pt>
                <c:pt idx="137">
                  <c:v>172.28</c:v>
                </c:pt>
                <c:pt idx="138">
                  <c:v>212.03</c:v>
                </c:pt>
                <c:pt idx="139">
                  <c:v>238.54</c:v>
                </c:pt>
                <c:pt idx="140">
                  <c:v>132.78</c:v>
                </c:pt>
                <c:pt idx="141">
                  <c:v>212.44</c:v>
                </c:pt>
                <c:pt idx="142">
                  <c:v>132.78</c:v>
                </c:pt>
                <c:pt idx="143">
                  <c:v>225.72</c:v>
                </c:pt>
                <c:pt idx="144">
                  <c:v>252.27</c:v>
                </c:pt>
                <c:pt idx="145">
                  <c:v>212.44</c:v>
                </c:pt>
                <c:pt idx="146">
                  <c:v>106.22</c:v>
                </c:pt>
                <c:pt idx="147">
                  <c:v>119.5</c:v>
                </c:pt>
                <c:pt idx="148">
                  <c:v>199.16</c:v>
                </c:pt>
                <c:pt idx="149">
                  <c:v>225.72</c:v>
                </c:pt>
                <c:pt idx="150">
                  <c:v>119.5</c:v>
                </c:pt>
                <c:pt idx="151">
                  <c:v>172.61</c:v>
                </c:pt>
                <c:pt idx="152">
                  <c:v>66.39</c:v>
                </c:pt>
                <c:pt idx="153">
                  <c:v>119.5</c:v>
                </c:pt>
                <c:pt idx="154">
                  <c:v>305.38</c:v>
                </c:pt>
                <c:pt idx="155">
                  <c:v>385.05</c:v>
                </c:pt>
                <c:pt idx="156">
                  <c:v>185.89</c:v>
                </c:pt>
                <c:pt idx="157">
                  <c:v>185.89</c:v>
                </c:pt>
                <c:pt idx="158">
                  <c:v>79.67</c:v>
                </c:pt>
                <c:pt idx="159">
                  <c:v>119.5</c:v>
                </c:pt>
                <c:pt idx="160">
                  <c:v>230.21</c:v>
                </c:pt>
                <c:pt idx="161">
                  <c:v>270.83999999999997</c:v>
                </c:pt>
                <c:pt idx="162">
                  <c:v>162.5</c:v>
                </c:pt>
                <c:pt idx="163">
                  <c:v>189.59</c:v>
                </c:pt>
                <c:pt idx="164">
                  <c:v>81.25</c:v>
                </c:pt>
                <c:pt idx="165">
                  <c:v>135.41999999999999</c:v>
                </c:pt>
                <c:pt idx="166">
                  <c:v>81.25</c:v>
                </c:pt>
                <c:pt idx="167">
                  <c:v>162.5</c:v>
                </c:pt>
                <c:pt idx="168">
                  <c:v>67.709999999999994</c:v>
                </c:pt>
                <c:pt idx="169">
                  <c:v>121.88</c:v>
                </c:pt>
                <c:pt idx="170">
                  <c:v>162.5</c:v>
                </c:pt>
                <c:pt idx="171">
                  <c:v>94.79</c:v>
                </c:pt>
                <c:pt idx="172">
                  <c:v>176.05</c:v>
                </c:pt>
                <c:pt idx="173">
                  <c:v>67.709999999999994</c:v>
                </c:pt>
                <c:pt idx="174">
                  <c:v>135.41999999999999</c:v>
                </c:pt>
                <c:pt idx="175">
                  <c:v>230.21</c:v>
                </c:pt>
                <c:pt idx="176">
                  <c:v>135.41999999999999</c:v>
                </c:pt>
                <c:pt idx="177">
                  <c:v>230.21</c:v>
                </c:pt>
                <c:pt idx="178">
                  <c:v>203.13</c:v>
                </c:pt>
                <c:pt idx="179">
                  <c:v>216.67</c:v>
                </c:pt>
                <c:pt idx="180">
                  <c:v>136.97</c:v>
                </c:pt>
                <c:pt idx="181">
                  <c:v>150.66999999999999</c:v>
                </c:pt>
                <c:pt idx="182">
                  <c:v>123.28</c:v>
                </c:pt>
                <c:pt idx="183">
                  <c:v>95.88</c:v>
                </c:pt>
                <c:pt idx="184">
                  <c:v>150.66999999999999</c:v>
                </c:pt>
                <c:pt idx="185">
                  <c:v>191.76</c:v>
                </c:pt>
                <c:pt idx="186">
                  <c:v>109.58</c:v>
                </c:pt>
                <c:pt idx="187">
                  <c:v>95.88</c:v>
                </c:pt>
                <c:pt idx="188">
                  <c:v>246.55</c:v>
                </c:pt>
                <c:pt idx="189">
                  <c:v>315.04000000000002</c:v>
                </c:pt>
                <c:pt idx="190">
                  <c:v>136.97</c:v>
                </c:pt>
                <c:pt idx="191">
                  <c:v>164.37</c:v>
                </c:pt>
                <c:pt idx="192">
                  <c:v>123.28</c:v>
                </c:pt>
                <c:pt idx="193">
                  <c:v>164.37</c:v>
                </c:pt>
                <c:pt idx="194">
                  <c:v>123.28</c:v>
                </c:pt>
                <c:pt idx="195">
                  <c:v>109.58</c:v>
                </c:pt>
                <c:pt idx="196">
                  <c:v>328.74</c:v>
                </c:pt>
                <c:pt idx="197">
                  <c:v>95.88</c:v>
                </c:pt>
                <c:pt idx="198">
                  <c:v>164.37</c:v>
                </c:pt>
                <c:pt idx="199">
                  <c:v>136.97</c:v>
                </c:pt>
                <c:pt idx="200">
                  <c:v>171.38</c:v>
                </c:pt>
                <c:pt idx="201">
                  <c:v>65.92</c:v>
                </c:pt>
                <c:pt idx="202">
                  <c:v>290.02999999999997</c:v>
                </c:pt>
                <c:pt idx="203">
                  <c:v>355.94</c:v>
                </c:pt>
                <c:pt idx="204">
                  <c:v>131.83000000000001</c:v>
                </c:pt>
                <c:pt idx="205">
                  <c:v>92.28</c:v>
                </c:pt>
                <c:pt idx="206">
                  <c:v>250.48</c:v>
                </c:pt>
                <c:pt idx="207">
                  <c:v>237.3</c:v>
                </c:pt>
                <c:pt idx="208">
                  <c:v>92.28</c:v>
                </c:pt>
                <c:pt idx="209">
                  <c:v>276.83999999999997</c:v>
                </c:pt>
                <c:pt idx="210">
                  <c:v>197.75</c:v>
                </c:pt>
                <c:pt idx="211">
                  <c:v>171.38</c:v>
                </c:pt>
                <c:pt idx="212">
                  <c:v>52.73</c:v>
                </c:pt>
                <c:pt idx="213">
                  <c:v>118.65</c:v>
                </c:pt>
                <c:pt idx="214">
                  <c:v>171.38</c:v>
                </c:pt>
                <c:pt idx="215">
                  <c:v>184.56</c:v>
                </c:pt>
                <c:pt idx="216">
                  <c:v>224.11</c:v>
                </c:pt>
                <c:pt idx="217">
                  <c:v>171.38</c:v>
                </c:pt>
                <c:pt idx="218">
                  <c:v>145.01</c:v>
                </c:pt>
                <c:pt idx="219">
                  <c:v>92.28</c:v>
                </c:pt>
                <c:pt idx="220">
                  <c:v>187.36</c:v>
                </c:pt>
                <c:pt idx="221">
                  <c:v>200.74</c:v>
                </c:pt>
                <c:pt idx="222">
                  <c:v>160.59</c:v>
                </c:pt>
                <c:pt idx="223">
                  <c:v>187.36</c:v>
                </c:pt>
                <c:pt idx="224">
                  <c:v>133.83000000000001</c:v>
                </c:pt>
                <c:pt idx="225">
                  <c:v>160.59</c:v>
                </c:pt>
                <c:pt idx="226">
                  <c:v>133.83000000000001</c:v>
                </c:pt>
                <c:pt idx="227">
                  <c:v>147.21</c:v>
                </c:pt>
                <c:pt idx="228">
                  <c:v>173.98</c:v>
                </c:pt>
                <c:pt idx="229">
                  <c:v>160.59</c:v>
                </c:pt>
                <c:pt idx="230">
                  <c:v>227.51</c:v>
                </c:pt>
                <c:pt idx="231">
                  <c:v>133.83000000000001</c:v>
                </c:pt>
                <c:pt idx="232">
                  <c:v>187.36</c:v>
                </c:pt>
                <c:pt idx="233">
                  <c:v>200.74</c:v>
                </c:pt>
                <c:pt idx="234">
                  <c:v>200.74</c:v>
                </c:pt>
                <c:pt idx="235">
                  <c:v>267.66000000000003</c:v>
                </c:pt>
                <c:pt idx="236">
                  <c:v>173.98</c:v>
                </c:pt>
                <c:pt idx="237">
                  <c:v>93.68</c:v>
                </c:pt>
                <c:pt idx="238">
                  <c:v>200.74</c:v>
                </c:pt>
                <c:pt idx="239">
                  <c:v>267.66000000000003</c:v>
                </c:pt>
                <c:pt idx="240">
                  <c:v>162.94999999999999</c:v>
                </c:pt>
                <c:pt idx="241">
                  <c:v>149.38</c:v>
                </c:pt>
                <c:pt idx="242">
                  <c:v>135.80000000000001</c:v>
                </c:pt>
                <c:pt idx="243">
                  <c:v>135.80000000000001</c:v>
                </c:pt>
                <c:pt idx="244">
                  <c:v>108.64</c:v>
                </c:pt>
                <c:pt idx="245">
                  <c:v>230.85</c:v>
                </c:pt>
                <c:pt idx="246">
                  <c:v>108.64</c:v>
                </c:pt>
                <c:pt idx="247">
                  <c:v>122.22</c:v>
                </c:pt>
                <c:pt idx="248">
                  <c:v>203.69</c:v>
                </c:pt>
                <c:pt idx="249">
                  <c:v>162.94999999999999</c:v>
                </c:pt>
                <c:pt idx="250">
                  <c:v>149.38</c:v>
                </c:pt>
                <c:pt idx="251">
                  <c:v>230.85</c:v>
                </c:pt>
                <c:pt idx="252">
                  <c:v>298.75</c:v>
                </c:pt>
                <c:pt idx="253">
                  <c:v>162.94999999999999</c:v>
                </c:pt>
                <c:pt idx="254">
                  <c:v>108.64</c:v>
                </c:pt>
                <c:pt idx="255">
                  <c:v>312.33</c:v>
                </c:pt>
                <c:pt idx="256">
                  <c:v>176.53</c:v>
                </c:pt>
                <c:pt idx="257">
                  <c:v>135.80000000000001</c:v>
                </c:pt>
                <c:pt idx="258">
                  <c:v>162.94999999999999</c:v>
                </c:pt>
                <c:pt idx="259">
                  <c:v>312.33</c:v>
                </c:pt>
                <c:pt idx="260">
                  <c:v>86.94</c:v>
                </c:pt>
                <c:pt idx="261">
                  <c:v>159.38999999999999</c:v>
                </c:pt>
                <c:pt idx="262">
                  <c:v>188.37</c:v>
                </c:pt>
                <c:pt idx="263">
                  <c:v>144.9</c:v>
                </c:pt>
                <c:pt idx="264">
                  <c:v>246.33</c:v>
                </c:pt>
                <c:pt idx="265">
                  <c:v>173.88</c:v>
                </c:pt>
                <c:pt idx="266">
                  <c:v>86.94</c:v>
                </c:pt>
                <c:pt idx="267">
                  <c:v>173.88</c:v>
                </c:pt>
                <c:pt idx="268">
                  <c:v>101.43</c:v>
                </c:pt>
                <c:pt idx="269">
                  <c:v>130.41</c:v>
                </c:pt>
                <c:pt idx="270">
                  <c:v>159.38999999999999</c:v>
                </c:pt>
                <c:pt idx="271">
                  <c:v>202.86</c:v>
                </c:pt>
                <c:pt idx="272">
                  <c:v>217.35</c:v>
                </c:pt>
                <c:pt idx="273">
                  <c:v>202.86</c:v>
                </c:pt>
                <c:pt idx="274">
                  <c:v>231.84</c:v>
                </c:pt>
                <c:pt idx="275">
                  <c:v>159.38999999999999</c:v>
                </c:pt>
                <c:pt idx="276">
                  <c:v>115.92</c:v>
                </c:pt>
                <c:pt idx="277">
                  <c:v>246.33</c:v>
                </c:pt>
                <c:pt idx="278">
                  <c:v>188.37</c:v>
                </c:pt>
                <c:pt idx="279">
                  <c:v>260.82</c:v>
                </c:pt>
                <c:pt idx="280">
                  <c:v>175.07</c:v>
                </c:pt>
                <c:pt idx="281">
                  <c:v>175.07</c:v>
                </c:pt>
                <c:pt idx="282">
                  <c:v>102.13</c:v>
                </c:pt>
                <c:pt idx="283">
                  <c:v>248.02</c:v>
                </c:pt>
                <c:pt idx="284">
                  <c:v>175.07</c:v>
                </c:pt>
                <c:pt idx="285">
                  <c:v>204.25</c:v>
                </c:pt>
                <c:pt idx="286">
                  <c:v>160.47999999999999</c:v>
                </c:pt>
                <c:pt idx="287">
                  <c:v>131.30000000000001</c:v>
                </c:pt>
                <c:pt idx="288">
                  <c:v>189.66</c:v>
                </c:pt>
                <c:pt idx="289">
                  <c:v>116.72</c:v>
                </c:pt>
                <c:pt idx="290">
                  <c:v>116.72</c:v>
                </c:pt>
                <c:pt idx="291">
                  <c:v>116.72</c:v>
                </c:pt>
                <c:pt idx="292">
                  <c:v>116.72</c:v>
                </c:pt>
                <c:pt idx="293">
                  <c:v>175.07</c:v>
                </c:pt>
                <c:pt idx="294">
                  <c:v>160.47999999999999</c:v>
                </c:pt>
                <c:pt idx="295">
                  <c:v>218.84</c:v>
                </c:pt>
                <c:pt idx="296">
                  <c:v>189.66</c:v>
                </c:pt>
                <c:pt idx="297">
                  <c:v>175.07</c:v>
                </c:pt>
                <c:pt idx="298">
                  <c:v>218.84</c:v>
                </c:pt>
                <c:pt idx="299">
                  <c:v>189.66</c:v>
                </c:pt>
                <c:pt idx="300">
                  <c:v>176.01</c:v>
                </c:pt>
                <c:pt idx="301">
                  <c:v>70.400000000000006</c:v>
                </c:pt>
                <c:pt idx="302">
                  <c:v>246.41</c:v>
                </c:pt>
                <c:pt idx="303">
                  <c:v>246.41</c:v>
                </c:pt>
                <c:pt idx="304">
                  <c:v>193.61</c:v>
                </c:pt>
                <c:pt idx="305">
                  <c:v>140.80000000000001</c:v>
                </c:pt>
                <c:pt idx="306">
                  <c:v>140.80000000000001</c:v>
                </c:pt>
                <c:pt idx="307">
                  <c:v>246.41</c:v>
                </c:pt>
                <c:pt idx="308">
                  <c:v>35.200000000000003</c:v>
                </c:pt>
                <c:pt idx="309">
                  <c:v>105.6</c:v>
                </c:pt>
                <c:pt idx="310">
                  <c:v>193.61</c:v>
                </c:pt>
                <c:pt idx="311">
                  <c:v>228.81</c:v>
                </c:pt>
                <c:pt idx="312">
                  <c:v>158.41</c:v>
                </c:pt>
                <c:pt idx="313">
                  <c:v>88</c:v>
                </c:pt>
                <c:pt idx="314">
                  <c:v>158.41</c:v>
                </c:pt>
                <c:pt idx="315">
                  <c:v>158.41</c:v>
                </c:pt>
                <c:pt idx="316">
                  <c:v>211.21</c:v>
                </c:pt>
                <c:pt idx="317">
                  <c:v>211.21</c:v>
                </c:pt>
                <c:pt idx="318">
                  <c:v>176.01</c:v>
                </c:pt>
                <c:pt idx="319">
                  <c:v>158.41</c:v>
                </c:pt>
                <c:pt idx="320">
                  <c:v>173.91</c:v>
                </c:pt>
                <c:pt idx="321">
                  <c:v>189.72</c:v>
                </c:pt>
                <c:pt idx="322">
                  <c:v>300.38</c:v>
                </c:pt>
                <c:pt idx="323">
                  <c:v>332</c:v>
                </c:pt>
                <c:pt idx="324">
                  <c:v>142.29</c:v>
                </c:pt>
                <c:pt idx="325">
                  <c:v>158.1</c:v>
                </c:pt>
                <c:pt idx="326">
                  <c:v>237.15</c:v>
                </c:pt>
                <c:pt idx="327">
                  <c:v>126.48</c:v>
                </c:pt>
                <c:pt idx="328">
                  <c:v>142.29</c:v>
                </c:pt>
                <c:pt idx="329">
                  <c:v>142.29</c:v>
                </c:pt>
                <c:pt idx="330">
                  <c:v>173.91</c:v>
                </c:pt>
                <c:pt idx="331">
                  <c:v>173.91</c:v>
                </c:pt>
                <c:pt idx="332">
                  <c:v>173.91</c:v>
                </c:pt>
                <c:pt idx="333">
                  <c:v>126.48</c:v>
                </c:pt>
                <c:pt idx="334">
                  <c:v>142.29</c:v>
                </c:pt>
                <c:pt idx="335">
                  <c:v>252.96</c:v>
                </c:pt>
                <c:pt idx="336">
                  <c:v>300.38</c:v>
                </c:pt>
                <c:pt idx="337">
                  <c:v>142.29</c:v>
                </c:pt>
                <c:pt idx="338">
                  <c:v>94.86</c:v>
                </c:pt>
                <c:pt idx="339">
                  <c:v>316.19</c:v>
                </c:pt>
                <c:pt idx="340">
                  <c:v>386.82</c:v>
                </c:pt>
                <c:pt idx="341">
                  <c:v>458.46</c:v>
                </c:pt>
                <c:pt idx="342">
                  <c:v>472.78</c:v>
                </c:pt>
                <c:pt idx="343">
                  <c:v>329.51</c:v>
                </c:pt>
                <c:pt idx="344">
                  <c:v>429.8</c:v>
                </c:pt>
                <c:pt idx="345">
                  <c:v>358.17</c:v>
                </c:pt>
                <c:pt idx="346">
                  <c:v>200.57</c:v>
                </c:pt>
                <c:pt idx="347">
                  <c:v>243.55</c:v>
                </c:pt>
                <c:pt idx="348">
                  <c:v>143.27000000000001</c:v>
                </c:pt>
                <c:pt idx="349">
                  <c:v>472.78</c:v>
                </c:pt>
                <c:pt idx="350">
                  <c:v>415.48</c:v>
                </c:pt>
                <c:pt idx="351">
                  <c:v>429.8</c:v>
                </c:pt>
                <c:pt idx="352">
                  <c:v>444.13</c:v>
                </c:pt>
                <c:pt idx="353">
                  <c:v>487.11</c:v>
                </c:pt>
                <c:pt idx="354">
                  <c:v>243.55</c:v>
                </c:pt>
                <c:pt idx="355">
                  <c:v>257.88</c:v>
                </c:pt>
                <c:pt idx="356">
                  <c:v>229.23</c:v>
                </c:pt>
                <c:pt idx="357">
                  <c:v>243.55</c:v>
                </c:pt>
                <c:pt idx="358">
                  <c:v>329.51</c:v>
                </c:pt>
                <c:pt idx="359">
                  <c:v>114.61</c:v>
                </c:pt>
              </c:numCache>
            </c:numRef>
          </c:xVal>
          <c:yVal>
            <c:numRef>
              <c:f>成熟期散布図!$D$4:$D$363</c:f>
              <c:numCache>
                <c:formatCode>General</c:formatCode>
                <c:ptCount val="360"/>
                <c:pt idx="0">
                  <c:v>795.12</c:v>
                </c:pt>
                <c:pt idx="1">
                  <c:v>477.07</c:v>
                </c:pt>
                <c:pt idx="2">
                  <c:v>278.29000000000002</c:v>
                </c:pt>
                <c:pt idx="3">
                  <c:v>304.8</c:v>
                </c:pt>
                <c:pt idx="4">
                  <c:v>304.8</c:v>
                </c:pt>
                <c:pt idx="5">
                  <c:v>583.09</c:v>
                </c:pt>
                <c:pt idx="6">
                  <c:v>278.29000000000002</c:v>
                </c:pt>
                <c:pt idx="7">
                  <c:v>265.04000000000002</c:v>
                </c:pt>
                <c:pt idx="8">
                  <c:v>185.53</c:v>
                </c:pt>
                <c:pt idx="9">
                  <c:v>185.53</c:v>
                </c:pt>
                <c:pt idx="10">
                  <c:v>371.06</c:v>
                </c:pt>
                <c:pt idx="11">
                  <c:v>477.07</c:v>
                </c:pt>
                <c:pt idx="12">
                  <c:v>596.34</c:v>
                </c:pt>
                <c:pt idx="13">
                  <c:v>450.57</c:v>
                </c:pt>
                <c:pt idx="14">
                  <c:v>344.55</c:v>
                </c:pt>
                <c:pt idx="15">
                  <c:v>424.07</c:v>
                </c:pt>
                <c:pt idx="16">
                  <c:v>410.81</c:v>
                </c:pt>
                <c:pt idx="17">
                  <c:v>318.05</c:v>
                </c:pt>
                <c:pt idx="18">
                  <c:v>238.54</c:v>
                </c:pt>
                <c:pt idx="19">
                  <c:v>238.54</c:v>
                </c:pt>
                <c:pt idx="20">
                  <c:v>373.5</c:v>
                </c:pt>
                <c:pt idx="21">
                  <c:v>475.37</c:v>
                </c:pt>
                <c:pt idx="22">
                  <c:v>192.41</c:v>
                </c:pt>
                <c:pt idx="23">
                  <c:v>396.14</c:v>
                </c:pt>
                <c:pt idx="24">
                  <c:v>203.73</c:v>
                </c:pt>
                <c:pt idx="25">
                  <c:v>169.77</c:v>
                </c:pt>
                <c:pt idx="26">
                  <c:v>215.05</c:v>
                </c:pt>
                <c:pt idx="27">
                  <c:v>237.68</c:v>
                </c:pt>
                <c:pt idx="28">
                  <c:v>113.18</c:v>
                </c:pt>
                <c:pt idx="29">
                  <c:v>67.91</c:v>
                </c:pt>
                <c:pt idx="30">
                  <c:v>113.18</c:v>
                </c:pt>
                <c:pt idx="31">
                  <c:v>192.41</c:v>
                </c:pt>
                <c:pt idx="32">
                  <c:v>350.87</c:v>
                </c:pt>
                <c:pt idx="33">
                  <c:v>271.64</c:v>
                </c:pt>
                <c:pt idx="34">
                  <c:v>282.95999999999998</c:v>
                </c:pt>
                <c:pt idx="35">
                  <c:v>90.55</c:v>
                </c:pt>
                <c:pt idx="36">
                  <c:v>135.82</c:v>
                </c:pt>
                <c:pt idx="37">
                  <c:v>316.91000000000003</c:v>
                </c:pt>
                <c:pt idx="38">
                  <c:v>192.41</c:v>
                </c:pt>
                <c:pt idx="39">
                  <c:v>181.09</c:v>
                </c:pt>
                <c:pt idx="40">
                  <c:v>134.1</c:v>
                </c:pt>
                <c:pt idx="41">
                  <c:v>201.15</c:v>
                </c:pt>
                <c:pt idx="42">
                  <c:v>145.27000000000001</c:v>
                </c:pt>
                <c:pt idx="43">
                  <c:v>212.32</c:v>
                </c:pt>
                <c:pt idx="44">
                  <c:v>100.57</c:v>
                </c:pt>
                <c:pt idx="45">
                  <c:v>178.8</c:v>
                </c:pt>
                <c:pt idx="46">
                  <c:v>301.72000000000003</c:v>
                </c:pt>
                <c:pt idx="47">
                  <c:v>134.1</c:v>
                </c:pt>
                <c:pt idx="48">
                  <c:v>167.62</c:v>
                </c:pt>
                <c:pt idx="49">
                  <c:v>134.1</c:v>
                </c:pt>
                <c:pt idx="50">
                  <c:v>245.85</c:v>
                </c:pt>
                <c:pt idx="51">
                  <c:v>279.37</c:v>
                </c:pt>
                <c:pt idx="52">
                  <c:v>100.57</c:v>
                </c:pt>
                <c:pt idx="53">
                  <c:v>268.19</c:v>
                </c:pt>
                <c:pt idx="54">
                  <c:v>223.5</c:v>
                </c:pt>
                <c:pt idx="55">
                  <c:v>134.1</c:v>
                </c:pt>
                <c:pt idx="56">
                  <c:v>89.4</c:v>
                </c:pt>
                <c:pt idx="57">
                  <c:v>145.27000000000001</c:v>
                </c:pt>
                <c:pt idx="58">
                  <c:v>145.27000000000001</c:v>
                </c:pt>
                <c:pt idx="59">
                  <c:v>245.85</c:v>
                </c:pt>
                <c:pt idx="60">
                  <c:v>716.52</c:v>
                </c:pt>
                <c:pt idx="61">
                  <c:v>289.66000000000003</c:v>
                </c:pt>
                <c:pt idx="62">
                  <c:v>289.66000000000003</c:v>
                </c:pt>
                <c:pt idx="63">
                  <c:v>609.79999999999995</c:v>
                </c:pt>
                <c:pt idx="64">
                  <c:v>289.66000000000003</c:v>
                </c:pt>
                <c:pt idx="65">
                  <c:v>182.94</c:v>
                </c:pt>
                <c:pt idx="66">
                  <c:v>228.68</c:v>
                </c:pt>
                <c:pt idx="67">
                  <c:v>259.17</c:v>
                </c:pt>
                <c:pt idx="68">
                  <c:v>289.66000000000003</c:v>
                </c:pt>
                <c:pt idx="69">
                  <c:v>457.35</c:v>
                </c:pt>
                <c:pt idx="70">
                  <c:v>487.84</c:v>
                </c:pt>
                <c:pt idx="71">
                  <c:v>91.47</c:v>
                </c:pt>
                <c:pt idx="72">
                  <c:v>304.89999999999998</c:v>
                </c:pt>
                <c:pt idx="73">
                  <c:v>228.68</c:v>
                </c:pt>
                <c:pt idx="74">
                  <c:v>243.92</c:v>
                </c:pt>
                <c:pt idx="75">
                  <c:v>213.43</c:v>
                </c:pt>
                <c:pt idx="76">
                  <c:v>365.88</c:v>
                </c:pt>
                <c:pt idx="77">
                  <c:v>487.84</c:v>
                </c:pt>
                <c:pt idx="78">
                  <c:v>198.19</c:v>
                </c:pt>
                <c:pt idx="79">
                  <c:v>228.68</c:v>
                </c:pt>
                <c:pt idx="80">
                  <c:v>313.64999999999998</c:v>
                </c:pt>
                <c:pt idx="81">
                  <c:v>627.29999999999995</c:v>
                </c:pt>
                <c:pt idx="82">
                  <c:v>245.47</c:v>
                </c:pt>
                <c:pt idx="83">
                  <c:v>286.38</c:v>
                </c:pt>
                <c:pt idx="84">
                  <c:v>259.10000000000002</c:v>
                </c:pt>
                <c:pt idx="85">
                  <c:v>204.56</c:v>
                </c:pt>
                <c:pt idx="86">
                  <c:v>313.64999999999998</c:v>
                </c:pt>
                <c:pt idx="87">
                  <c:v>190.92</c:v>
                </c:pt>
                <c:pt idx="88">
                  <c:v>518.21</c:v>
                </c:pt>
                <c:pt idx="89">
                  <c:v>231.83</c:v>
                </c:pt>
                <c:pt idx="90">
                  <c:v>259.10000000000002</c:v>
                </c:pt>
                <c:pt idx="91">
                  <c:v>286.38</c:v>
                </c:pt>
                <c:pt idx="92">
                  <c:v>136.37</c:v>
                </c:pt>
                <c:pt idx="93">
                  <c:v>109.1</c:v>
                </c:pt>
                <c:pt idx="94">
                  <c:v>109.1</c:v>
                </c:pt>
                <c:pt idx="95">
                  <c:v>163.63999999999999</c:v>
                </c:pt>
                <c:pt idx="96">
                  <c:v>204.56</c:v>
                </c:pt>
                <c:pt idx="97">
                  <c:v>368.2</c:v>
                </c:pt>
                <c:pt idx="98">
                  <c:v>259.10000000000002</c:v>
                </c:pt>
                <c:pt idx="99">
                  <c:v>368.2</c:v>
                </c:pt>
                <c:pt idx="100">
                  <c:v>392.22</c:v>
                </c:pt>
                <c:pt idx="101">
                  <c:v>243.45</c:v>
                </c:pt>
                <c:pt idx="102">
                  <c:v>324.60000000000002</c:v>
                </c:pt>
                <c:pt idx="103">
                  <c:v>473.37</c:v>
                </c:pt>
                <c:pt idx="104">
                  <c:v>202.87</c:v>
                </c:pt>
                <c:pt idx="105">
                  <c:v>270.5</c:v>
                </c:pt>
                <c:pt idx="106">
                  <c:v>175.82</c:v>
                </c:pt>
                <c:pt idx="107">
                  <c:v>148.77000000000001</c:v>
                </c:pt>
                <c:pt idx="108">
                  <c:v>121.72</c:v>
                </c:pt>
                <c:pt idx="109">
                  <c:v>392.22</c:v>
                </c:pt>
                <c:pt idx="110">
                  <c:v>311.07</c:v>
                </c:pt>
                <c:pt idx="111">
                  <c:v>338.12</c:v>
                </c:pt>
                <c:pt idx="112">
                  <c:v>270.5</c:v>
                </c:pt>
                <c:pt idx="113">
                  <c:v>405.75</c:v>
                </c:pt>
                <c:pt idx="114">
                  <c:v>175.82</c:v>
                </c:pt>
                <c:pt idx="115">
                  <c:v>324.60000000000002</c:v>
                </c:pt>
                <c:pt idx="116">
                  <c:v>311.07</c:v>
                </c:pt>
                <c:pt idx="117">
                  <c:v>338.12</c:v>
                </c:pt>
                <c:pt idx="118">
                  <c:v>297.55</c:v>
                </c:pt>
                <c:pt idx="119">
                  <c:v>649.20000000000005</c:v>
                </c:pt>
                <c:pt idx="120">
                  <c:v>424.07</c:v>
                </c:pt>
                <c:pt idx="121">
                  <c:v>172.28</c:v>
                </c:pt>
                <c:pt idx="122">
                  <c:v>251.79</c:v>
                </c:pt>
                <c:pt idx="123">
                  <c:v>304.8</c:v>
                </c:pt>
                <c:pt idx="124">
                  <c:v>503.58</c:v>
                </c:pt>
                <c:pt idx="125">
                  <c:v>384.31</c:v>
                </c:pt>
                <c:pt idx="126">
                  <c:v>265.04000000000002</c:v>
                </c:pt>
                <c:pt idx="127">
                  <c:v>304.8</c:v>
                </c:pt>
                <c:pt idx="128">
                  <c:v>159.02000000000001</c:v>
                </c:pt>
                <c:pt idx="129">
                  <c:v>145.77000000000001</c:v>
                </c:pt>
                <c:pt idx="130">
                  <c:v>159.02000000000001</c:v>
                </c:pt>
                <c:pt idx="131">
                  <c:v>583.09</c:v>
                </c:pt>
                <c:pt idx="132">
                  <c:v>212.03</c:v>
                </c:pt>
                <c:pt idx="133">
                  <c:v>371.06</c:v>
                </c:pt>
                <c:pt idx="134">
                  <c:v>424.07</c:v>
                </c:pt>
                <c:pt idx="135">
                  <c:v>768.62</c:v>
                </c:pt>
                <c:pt idx="136">
                  <c:v>556.59</c:v>
                </c:pt>
                <c:pt idx="137">
                  <c:v>490.33</c:v>
                </c:pt>
                <c:pt idx="138">
                  <c:v>490.33</c:v>
                </c:pt>
                <c:pt idx="139">
                  <c:v>477.07</c:v>
                </c:pt>
                <c:pt idx="140">
                  <c:v>239</c:v>
                </c:pt>
                <c:pt idx="141">
                  <c:v>331.94</c:v>
                </c:pt>
                <c:pt idx="142">
                  <c:v>225.72</c:v>
                </c:pt>
                <c:pt idx="143">
                  <c:v>185.89</c:v>
                </c:pt>
                <c:pt idx="144">
                  <c:v>305.38</c:v>
                </c:pt>
                <c:pt idx="145">
                  <c:v>172.61</c:v>
                </c:pt>
                <c:pt idx="146">
                  <c:v>225.72</c:v>
                </c:pt>
                <c:pt idx="147">
                  <c:v>119.5</c:v>
                </c:pt>
                <c:pt idx="148">
                  <c:v>185.89</c:v>
                </c:pt>
                <c:pt idx="149">
                  <c:v>584.21</c:v>
                </c:pt>
                <c:pt idx="150">
                  <c:v>331.94</c:v>
                </c:pt>
                <c:pt idx="151">
                  <c:v>278.83</c:v>
                </c:pt>
                <c:pt idx="152">
                  <c:v>159.33000000000001</c:v>
                </c:pt>
                <c:pt idx="153">
                  <c:v>252.27</c:v>
                </c:pt>
                <c:pt idx="154">
                  <c:v>663.88</c:v>
                </c:pt>
                <c:pt idx="155">
                  <c:v>756.82</c:v>
                </c:pt>
                <c:pt idx="156">
                  <c:v>385.05</c:v>
                </c:pt>
                <c:pt idx="157">
                  <c:v>491.27</c:v>
                </c:pt>
                <c:pt idx="158">
                  <c:v>106.22</c:v>
                </c:pt>
                <c:pt idx="159">
                  <c:v>199.16</c:v>
                </c:pt>
                <c:pt idx="160">
                  <c:v>460.43</c:v>
                </c:pt>
                <c:pt idx="161">
                  <c:v>460.43</c:v>
                </c:pt>
                <c:pt idx="162">
                  <c:v>338.55</c:v>
                </c:pt>
                <c:pt idx="163">
                  <c:v>338.55</c:v>
                </c:pt>
                <c:pt idx="164">
                  <c:v>311.47000000000003</c:v>
                </c:pt>
                <c:pt idx="165">
                  <c:v>379.18</c:v>
                </c:pt>
                <c:pt idx="166">
                  <c:v>94.79</c:v>
                </c:pt>
                <c:pt idx="167">
                  <c:v>392.72</c:v>
                </c:pt>
                <c:pt idx="168">
                  <c:v>203.13</c:v>
                </c:pt>
                <c:pt idx="169">
                  <c:v>216.67</c:v>
                </c:pt>
                <c:pt idx="170">
                  <c:v>352.09</c:v>
                </c:pt>
                <c:pt idx="171">
                  <c:v>162.5</c:v>
                </c:pt>
                <c:pt idx="172">
                  <c:v>203.13</c:v>
                </c:pt>
                <c:pt idx="173">
                  <c:v>162.5</c:v>
                </c:pt>
                <c:pt idx="174">
                  <c:v>121.88</c:v>
                </c:pt>
                <c:pt idx="175">
                  <c:v>257.3</c:v>
                </c:pt>
                <c:pt idx="176">
                  <c:v>176.05</c:v>
                </c:pt>
                <c:pt idx="177">
                  <c:v>311.47000000000003</c:v>
                </c:pt>
                <c:pt idx="178">
                  <c:v>433.34</c:v>
                </c:pt>
                <c:pt idx="179">
                  <c:v>392.72</c:v>
                </c:pt>
                <c:pt idx="180">
                  <c:v>287.64999999999998</c:v>
                </c:pt>
                <c:pt idx="181">
                  <c:v>410.92</c:v>
                </c:pt>
                <c:pt idx="182">
                  <c:v>191.76</c:v>
                </c:pt>
                <c:pt idx="183">
                  <c:v>191.76</c:v>
                </c:pt>
                <c:pt idx="184">
                  <c:v>328.74</c:v>
                </c:pt>
                <c:pt idx="185">
                  <c:v>356.13</c:v>
                </c:pt>
                <c:pt idx="186">
                  <c:v>150.66999999999999</c:v>
                </c:pt>
                <c:pt idx="187">
                  <c:v>315.04000000000002</c:v>
                </c:pt>
                <c:pt idx="188">
                  <c:v>479.41</c:v>
                </c:pt>
                <c:pt idx="189">
                  <c:v>424.62</c:v>
                </c:pt>
                <c:pt idx="190">
                  <c:v>150.66999999999999</c:v>
                </c:pt>
                <c:pt idx="191">
                  <c:v>219.16</c:v>
                </c:pt>
                <c:pt idx="192">
                  <c:v>410.92</c:v>
                </c:pt>
                <c:pt idx="193">
                  <c:v>301.33999999999997</c:v>
                </c:pt>
                <c:pt idx="194">
                  <c:v>301.33999999999997</c:v>
                </c:pt>
                <c:pt idx="195">
                  <c:v>301.33999999999997</c:v>
                </c:pt>
                <c:pt idx="196">
                  <c:v>575.29</c:v>
                </c:pt>
                <c:pt idx="197">
                  <c:v>232.86</c:v>
                </c:pt>
                <c:pt idx="198">
                  <c:v>273.95</c:v>
                </c:pt>
                <c:pt idx="199">
                  <c:v>301.33999999999997</c:v>
                </c:pt>
                <c:pt idx="200">
                  <c:v>290.02999999999997</c:v>
                </c:pt>
                <c:pt idx="201">
                  <c:v>197.75</c:v>
                </c:pt>
                <c:pt idx="202">
                  <c:v>342.76</c:v>
                </c:pt>
                <c:pt idx="203">
                  <c:v>421.86</c:v>
                </c:pt>
                <c:pt idx="204">
                  <c:v>342.76</c:v>
                </c:pt>
                <c:pt idx="205">
                  <c:v>224.11</c:v>
                </c:pt>
                <c:pt idx="206">
                  <c:v>276.83999999999997</c:v>
                </c:pt>
                <c:pt idx="207">
                  <c:v>303.20999999999998</c:v>
                </c:pt>
                <c:pt idx="208">
                  <c:v>158.19999999999999</c:v>
                </c:pt>
                <c:pt idx="209">
                  <c:v>448.22</c:v>
                </c:pt>
                <c:pt idx="210">
                  <c:v>263.66000000000003</c:v>
                </c:pt>
                <c:pt idx="211">
                  <c:v>237.3</c:v>
                </c:pt>
                <c:pt idx="212">
                  <c:v>105.46</c:v>
                </c:pt>
                <c:pt idx="213">
                  <c:v>92.28</c:v>
                </c:pt>
                <c:pt idx="214">
                  <c:v>210.93</c:v>
                </c:pt>
                <c:pt idx="215">
                  <c:v>171.38</c:v>
                </c:pt>
                <c:pt idx="216">
                  <c:v>197.75</c:v>
                </c:pt>
                <c:pt idx="217">
                  <c:v>184.56</c:v>
                </c:pt>
                <c:pt idx="218">
                  <c:v>210.93</c:v>
                </c:pt>
                <c:pt idx="219">
                  <c:v>290.02999999999997</c:v>
                </c:pt>
                <c:pt idx="220">
                  <c:v>267.66000000000003</c:v>
                </c:pt>
                <c:pt idx="221">
                  <c:v>388.1</c:v>
                </c:pt>
                <c:pt idx="222">
                  <c:v>388.1</c:v>
                </c:pt>
                <c:pt idx="223">
                  <c:v>281.04000000000002</c:v>
                </c:pt>
                <c:pt idx="224">
                  <c:v>187.36</c:v>
                </c:pt>
                <c:pt idx="225">
                  <c:v>107.06</c:v>
                </c:pt>
                <c:pt idx="226">
                  <c:v>187.36</c:v>
                </c:pt>
                <c:pt idx="227">
                  <c:v>93.68</c:v>
                </c:pt>
                <c:pt idx="228">
                  <c:v>307.8</c:v>
                </c:pt>
                <c:pt idx="229">
                  <c:v>294.42</c:v>
                </c:pt>
                <c:pt idx="230">
                  <c:v>347.95</c:v>
                </c:pt>
                <c:pt idx="231">
                  <c:v>147.21</c:v>
                </c:pt>
                <c:pt idx="232">
                  <c:v>187.36</c:v>
                </c:pt>
                <c:pt idx="233">
                  <c:v>240.89</c:v>
                </c:pt>
                <c:pt idx="234">
                  <c:v>214.12</c:v>
                </c:pt>
                <c:pt idx="235">
                  <c:v>227.51</c:v>
                </c:pt>
                <c:pt idx="236">
                  <c:v>187.36</c:v>
                </c:pt>
                <c:pt idx="237">
                  <c:v>173.98</c:v>
                </c:pt>
                <c:pt idx="238">
                  <c:v>214.12</c:v>
                </c:pt>
                <c:pt idx="239">
                  <c:v>481.78</c:v>
                </c:pt>
                <c:pt idx="240">
                  <c:v>230.85</c:v>
                </c:pt>
                <c:pt idx="241">
                  <c:v>217.27</c:v>
                </c:pt>
                <c:pt idx="242">
                  <c:v>217.27</c:v>
                </c:pt>
                <c:pt idx="243">
                  <c:v>271.58999999999997</c:v>
                </c:pt>
                <c:pt idx="244">
                  <c:v>217.27</c:v>
                </c:pt>
                <c:pt idx="245">
                  <c:v>407.39</c:v>
                </c:pt>
                <c:pt idx="246">
                  <c:v>162.94999999999999</c:v>
                </c:pt>
                <c:pt idx="247">
                  <c:v>162.94999999999999</c:v>
                </c:pt>
                <c:pt idx="248">
                  <c:v>325.91000000000003</c:v>
                </c:pt>
                <c:pt idx="249">
                  <c:v>258.01</c:v>
                </c:pt>
                <c:pt idx="250">
                  <c:v>122.22</c:v>
                </c:pt>
                <c:pt idx="251">
                  <c:v>393.81</c:v>
                </c:pt>
                <c:pt idx="252">
                  <c:v>271.58999999999997</c:v>
                </c:pt>
                <c:pt idx="253">
                  <c:v>176.53</c:v>
                </c:pt>
                <c:pt idx="254">
                  <c:v>149.38</c:v>
                </c:pt>
                <c:pt idx="255">
                  <c:v>285.17</c:v>
                </c:pt>
                <c:pt idx="256">
                  <c:v>244.43</c:v>
                </c:pt>
                <c:pt idx="257">
                  <c:v>230.85</c:v>
                </c:pt>
                <c:pt idx="258">
                  <c:v>203.69</c:v>
                </c:pt>
                <c:pt idx="259">
                  <c:v>434.55</c:v>
                </c:pt>
                <c:pt idx="260">
                  <c:v>260.82</c:v>
                </c:pt>
                <c:pt idx="261">
                  <c:v>217.35</c:v>
                </c:pt>
                <c:pt idx="262">
                  <c:v>275.31</c:v>
                </c:pt>
                <c:pt idx="263">
                  <c:v>173.88</c:v>
                </c:pt>
                <c:pt idx="264">
                  <c:v>391.22</c:v>
                </c:pt>
                <c:pt idx="265">
                  <c:v>202.86</c:v>
                </c:pt>
                <c:pt idx="266">
                  <c:v>144.9</c:v>
                </c:pt>
                <c:pt idx="267">
                  <c:v>347.75</c:v>
                </c:pt>
                <c:pt idx="268">
                  <c:v>217.35</c:v>
                </c:pt>
                <c:pt idx="269">
                  <c:v>231.84</c:v>
                </c:pt>
                <c:pt idx="270">
                  <c:v>304.29000000000002</c:v>
                </c:pt>
                <c:pt idx="271">
                  <c:v>376.73</c:v>
                </c:pt>
                <c:pt idx="272">
                  <c:v>231.84</c:v>
                </c:pt>
                <c:pt idx="273">
                  <c:v>188.37</c:v>
                </c:pt>
                <c:pt idx="274">
                  <c:v>376.73</c:v>
                </c:pt>
                <c:pt idx="275">
                  <c:v>217.35</c:v>
                </c:pt>
                <c:pt idx="276">
                  <c:v>304.29000000000002</c:v>
                </c:pt>
                <c:pt idx="277">
                  <c:v>391.22</c:v>
                </c:pt>
                <c:pt idx="278">
                  <c:v>362.24</c:v>
                </c:pt>
                <c:pt idx="279">
                  <c:v>333.27</c:v>
                </c:pt>
                <c:pt idx="280">
                  <c:v>233.43</c:v>
                </c:pt>
                <c:pt idx="281">
                  <c:v>189.66</c:v>
                </c:pt>
                <c:pt idx="282">
                  <c:v>102.13</c:v>
                </c:pt>
                <c:pt idx="283">
                  <c:v>262.61</c:v>
                </c:pt>
                <c:pt idx="284">
                  <c:v>277.2</c:v>
                </c:pt>
                <c:pt idx="285">
                  <c:v>262.61</c:v>
                </c:pt>
                <c:pt idx="286">
                  <c:v>204.25</c:v>
                </c:pt>
                <c:pt idx="287">
                  <c:v>131.30000000000001</c:v>
                </c:pt>
                <c:pt idx="288">
                  <c:v>291.79000000000002</c:v>
                </c:pt>
                <c:pt idx="289">
                  <c:v>160.47999999999999</c:v>
                </c:pt>
                <c:pt idx="290">
                  <c:v>102.13</c:v>
                </c:pt>
                <c:pt idx="291">
                  <c:v>87.54</c:v>
                </c:pt>
                <c:pt idx="292">
                  <c:v>72.95</c:v>
                </c:pt>
                <c:pt idx="293">
                  <c:v>204.25</c:v>
                </c:pt>
                <c:pt idx="294">
                  <c:v>262.61</c:v>
                </c:pt>
                <c:pt idx="295">
                  <c:v>233.43</c:v>
                </c:pt>
                <c:pt idx="296">
                  <c:v>218.84</c:v>
                </c:pt>
                <c:pt idx="297">
                  <c:v>277.2</c:v>
                </c:pt>
                <c:pt idx="298">
                  <c:v>262.61</c:v>
                </c:pt>
                <c:pt idx="299">
                  <c:v>175.07</c:v>
                </c:pt>
                <c:pt idx="300">
                  <c:v>176.01</c:v>
                </c:pt>
                <c:pt idx="301">
                  <c:v>193.61</c:v>
                </c:pt>
                <c:pt idx="302">
                  <c:v>299.20999999999998</c:v>
                </c:pt>
                <c:pt idx="303">
                  <c:v>176.01</c:v>
                </c:pt>
                <c:pt idx="304">
                  <c:v>246.41</c:v>
                </c:pt>
                <c:pt idx="305">
                  <c:v>193.61</c:v>
                </c:pt>
                <c:pt idx="306">
                  <c:v>176.01</c:v>
                </c:pt>
                <c:pt idx="307">
                  <c:v>352.01</c:v>
                </c:pt>
                <c:pt idx="308">
                  <c:v>70.400000000000006</c:v>
                </c:pt>
                <c:pt idx="309">
                  <c:v>176.01</c:v>
                </c:pt>
                <c:pt idx="310">
                  <c:v>176.01</c:v>
                </c:pt>
                <c:pt idx="311">
                  <c:v>281.61</c:v>
                </c:pt>
                <c:pt idx="312">
                  <c:v>264.01</c:v>
                </c:pt>
                <c:pt idx="313">
                  <c:v>105.6</c:v>
                </c:pt>
                <c:pt idx="314">
                  <c:v>211.21</c:v>
                </c:pt>
                <c:pt idx="315">
                  <c:v>246.41</c:v>
                </c:pt>
                <c:pt idx="316">
                  <c:v>228.81</c:v>
                </c:pt>
                <c:pt idx="317">
                  <c:v>228.81</c:v>
                </c:pt>
                <c:pt idx="318">
                  <c:v>352.01</c:v>
                </c:pt>
                <c:pt idx="319">
                  <c:v>246.41</c:v>
                </c:pt>
                <c:pt idx="320">
                  <c:v>332</c:v>
                </c:pt>
                <c:pt idx="321">
                  <c:v>395.24</c:v>
                </c:pt>
                <c:pt idx="322">
                  <c:v>379.43</c:v>
                </c:pt>
                <c:pt idx="323">
                  <c:v>442.67</c:v>
                </c:pt>
                <c:pt idx="324">
                  <c:v>237.15</c:v>
                </c:pt>
                <c:pt idx="325">
                  <c:v>205.53</c:v>
                </c:pt>
                <c:pt idx="326">
                  <c:v>505.91</c:v>
                </c:pt>
                <c:pt idx="327">
                  <c:v>316.19</c:v>
                </c:pt>
                <c:pt idx="328">
                  <c:v>237.15</c:v>
                </c:pt>
                <c:pt idx="329">
                  <c:v>189.72</c:v>
                </c:pt>
                <c:pt idx="330">
                  <c:v>189.72</c:v>
                </c:pt>
                <c:pt idx="331">
                  <c:v>268.77</c:v>
                </c:pt>
                <c:pt idx="332">
                  <c:v>442.67</c:v>
                </c:pt>
                <c:pt idx="333">
                  <c:v>363.62</c:v>
                </c:pt>
                <c:pt idx="334">
                  <c:v>316.19</c:v>
                </c:pt>
                <c:pt idx="335">
                  <c:v>458.48</c:v>
                </c:pt>
                <c:pt idx="336">
                  <c:v>363.62</c:v>
                </c:pt>
                <c:pt idx="337">
                  <c:v>458.48</c:v>
                </c:pt>
                <c:pt idx="338">
                  <c:v>268.77</c:v>
                </c:pt>
                <c:pt idx="339">
                  <c:v>679.82</c:v>
                </c:pt>
                <c:pt idx="340">
                  <c:v>143.27000000000001</c:v>
                </c:pt>
                <c:pt idx="341">
                  <c:v>229.23</c:v>
                </c:pt>
                <c:pt idx="342">
                  <c:v>186.25</c:v>
                </c:pt>
                <c:pt idx="343">
                  <c:v>143.27000000000001</c:v>
                </c:pt>
                <c:pt idx="344">
                  <c:v>186.25</c:v>
                </c:pt>
                <c:pt idx="345">
                  <c:v>143.27000000000001</c:v>
                </c:pt>
                <c:pt idx="346">
                  <c:v>85.96</c:v>
                </c:pt>
                <c:pt idx="347">
                  <c:v>157.59</c:v>
                </c:pt>
                <c:pt idx="348">
                  <c:v>114.61</c:v>
                </c:pt>
                <c:pt idx="349">
                  <c:v>372.5</c:v>
                </c:pt>
                <c:pt idx="350">
                  <c:v>257.88</c:v>
                </c:pt>
                <c:pt idx="351">
                  <c:v>214.9</c:v>
                </c:pt>
                <c:pt idx="352">
                  <c:v>315.19</c:v>
                </c:pt>
                <c:pt idx="353">
                  <c:v>243.55</c:v>
                </c:pt>
                <c:pt idx="354">
                  <c:v>214.9</c:v>
                </c:pt>
                <c:pt idx="355">
                  <c:v>257.88</c:v>
                </c:pt>
                <c:pt idx="356">
                  <c:v>200.57</c:v>
                </c:pt>
                <c:pt idx="357">
                  <c:v>171.92</c:v>
                </c:pt>
                <c:pt idx="358">
                  <c:v>214.9</c:v>
                </c:pt>
                <c:pt idx="359">
                  <c:v>128.94</c:v>
                </c:pt>
              </c:numCache>
            </c:numRef>
          </c:yVal>
          <c:smooth val="0"/>
          <c:extLst>
            <c:ext xmlns:c16="http://schemas.microsoft.com/office/drawing/2014/chart" uri="{C3380CC4-5D6E-409C-BE32-E72D297353CC}">
              <c16:uniqueId val="{00000000-C6F8-5649-B730-ECE2735D6C1C}"/>
            </c:ext>
          </c:extLst>
        </c:ser>
        <c:ser>
          <c:idx val="1"/>
          <c:order val="1"/>
          <c:tx>
            <c:v>GA</c:v>
          </c:tx>
          <c:spPr>
            <a:ln w="25400" cap="rnd">
              <a:noFill/>
              <a:round/>
            </a:ln>
            <a:effectLst/>
          </c:spPr>
          <c:marker>
            <c:symbol val="triangle"/>
            <c:size val="4"/>
            <c:spPr>
              <a:noFill/>
              <a:ln w="12700">
                <a:solidFill>
                  <a:schemeClr val="tx1"/>
                </a:solidFill>
              </a:ln>
              <a:effectLst/>
            </c:spPr>
          </c:marker>
          <c:xVal>
            <c:numRef>
              <c:f>成熟期散布図!$E$4:$E$363</c:f>
              <c:numCache>
                <c:formatCode>General</c:formatCode>
                <c:ptCount val="360"/>
                <c:pt idx="0">
                  <c:v>141.62</c:v>
                </c:pt>
                <c:pt idx="1">
                  <c:v>88.51</c:v>
                </c:pt>
                <c:pt idx="2">
                  <c:v>141.62</c:v>
                </c:pt>
                <c:pt idx="3">
                  <c:v>141.62</c:v>
                </c:pt>
                <c:pt idx="4">
                  <c:v>70.81</c:v>
                </c:pt>
                <c:pt idx="5">
                  <c:v>123.92</c:v>
                </c:pt>
                <c:pt idx="6">
                  <c:v>141.62</c:v>
                </c:pt>
                <c:pt idx="7">
                  <c:v>123.92</c:v>
                </c:pt>
                <c:pt idx="8">
                  <c:v>194.73</c:v>
                </c:pt>
                <c:pt idx="9">
                  <c:v>177.03</c:v>
                </c:pt>
                <c:pt idx="10">
                  <c:v>177.03</c:v>
                </c:pt>
                <c:pt idx="11">
                  <c:v>177.03</c:v>
                </c:pt>
                <c:pt idx="12">
                  <c:v>141.62</c:v>
                </c:pt>
                <c:pt idx="13">
                  <c:v>159.32</c:v>
                </c:pt>
                <c:pt idx="14">
                  <c:v>212.43</c:v>
                </c:pt>
                <c:pt idx="15">
                  <c:v>212.43</c:v>
                </c:pt>
                <c:pt idx="16">
                  <c:v>159.32</c:v>
                </c:pt>
                <c:pt idx="17">
                  <c:v>159.32</c:v>
                </c:pt>
                <c:pt idx="18">
                  <c:v>106.22</c:v>
                </c:pt>
                <c:pt idx="19">
                  <c:v>194.73</c:v>
                </c:pt>
                <c:pt idx="20">
                  <c:v>130</c:v>
                </c:pt>
                <c:pt idx="21">
                  <c:v>130</c:v>
                </c:pt>
                <c:pt idx="22">
                  <c:v>90</c:v>
                </c:pt>
                <c:pt idx="23">
                  <c:v>200</c:v>
                </c:pt>
                <c:pt idx="24">
                  <c:v>110</c:v>
                </c:pt>
                <c:pt idx="25">
                  <c:v>110</c:v>
                </c:pt>
                <c:pt idx="26">
                  <c:v>180</c:v>
                </c:pt>
                <c:pt idx="27">
                  <c:v>140</c:v>
                </c:pt>
                <c:pt idx="28">
                  <c:v>160</c:v>
                </c:pt>
                <c:pt idx="29">
                  <c:v>160</c:v>
                </c:pt>
                <c:pt idx="30">
                  <c:v>130</c:v>
                </c:pt>
                <c:pt idx="31">
                  <c:v>180</c:v>
                </c:pt>
                <c:pt idx="32">
                  <c:v>250</c:v>
                </c:pt>
                <c:pt idx="33">
                  <c:v>200</c:v>
                </c:pt>
                <c:pt idx="34">
                  <c:v>250</c:v>
                </c:pt>
                <c:pt idx="35">
                  <c:v>160</c:v>
                </c:pt>
                <c:pt idx="36">
                  <c:v>180</c:v>
                </c:pt>
                <c:pt idx="37">
                  <c:v>180</c:v>
                </c:pt>
                <c:pt idx="38">
                  <c:v>160</c:v>
                </c:pt>
                <c:pt idx="39">
                  <c:v>140</c:v>
                </c:pt>
                <c:pt idx="40">
                  <c:v>327</c:v>
                </c:pt>
                <c:pt idx="41">
                  <c:v>182</c:v>
                </c:pt>
                <c:pt idx="42">
                  <c:v>164</c:v>
                </c:pt>
                <c:pt idx="43">
                  <c:v>200</c:v>
                </c:pt>
                <c:pt idx="44">
                  <c:v>236</c:v>
                </c:pt>
                <c:pt idx="45">
                  <c:v>236</c:v>
                </c:pt>
                <c:pt idx="46">
                  <c:v>291</c:v>
                </c:pt>
                <c:pt idx="47">
                  <c:v>291</c:v>
                </c:pt>
                <c:pt idx="48">
                  <c:v>382</c:v>
                </c:pt>
                <c:pt idx="49">
                  <c:v>182</c:v>
                </c:pt>
                <c:pt idx="50">
                  <c:v>182</c:v>
                </c:pt>
                <c:pt idx="51">
                  <c:v>109.00000000000001</c:v>
                </c:pt>
                <c:pt idx="52">
                  <c:v>254</c:v>
                </c:pt>
                <c:pt idx="53">
                  <c:v>182</c:v>
                </c:pt>
                <c:pt idx="54">
                  <c:v>145</c:v>
                </c:pt>
                <c:pt idx="55">
                  <c:v>327</c:v>
                </c:pt>
                <c:pt idx="56">
                  <c:v>436.00000000000006</c:v>
                </c:pt>
                <c:pt idx="57">
                  <c:v>218.00000000000003</c:v>
                </c:pt>
                <c:pt idx="58">
                  <c:v>164</c:v>
                </c:pt>
                <c:pt idx="59">
                  <c:v>200</c:v>
                </c:pt>
                <c:pt idx="60">
                  <c:v>410</c:v>
                </c:pt>
                <c:pt idx="61">
                  <c:v>490</c:v>
                </c:pt>
                <c:pt idx="62">
                  <c:v>180</c:v>
                </c:pt>
                <c:pt idx="63">
                  <c:v>310</c:v>
                </c:pt>
                <c:pt idx="64">
                  <c:v>440</c:v>
                </c:pt>
                <c:pt idx="65">
                  <c:v>200</c:v>
                </c:pt>
                <c:pt idx="66">
                  <c:v>260</c:v>
                </c:pt>
                <c:pt idx="67">
                  <c:v>260</c:v>
                </c:pt>
                <c:pt idx="68">
                  <c:v>200</c:v>
                </c:pt>
                <c:pt idx="69">
                  <c:v>280</c:v>
                </c:pt>
                <c:pt idx="70">
                  <c:v>330</c:v>
                </c:pt>
                <c:pt idx="71">
                  <c:v>100</c:v>
                </c:pt>
                <c:pt idx="72">
                  <c:v>150</c:v>
                </c:pt>
                <c:pt idx="73">
                  <c:v>240</c:v>
                </c:pt>
                <c:pt idx="74">
                  <c:v>390</c:v>
                </c:pt>
                <c:pt idx="75">
                  <c:v>340</c:v>
                </c:pt>
                <c:pt idx="76">
                  <c:v>240</c:v>
                </c:pt>
                <c:pt idx="77">
                  <c:v>200</c:v>
                </c:pt>
                <c:pt idx="78">
                  <c:v>240</c:v>
                </c:pt>
                <c:pt idx="79">
                  <c:v>180</c:v>
                </c:pt>
                <c:pt idx="80">
                  <c:v>190</c:v>
                </c:pt>
                <c:pt idx="81">
                  <c:v>190</c:v>
                </c:pt>
                <c:pt idx="82">
                  <c:v>190</c:v>
                </c:pt>
                <c:pt idx="83">
                  <c:v>210</c:v>
                </c:pt>
                <c:pt idx="84">
                  <c:v>190</c:v>
                </c:pt>
                <c:pt idx="85">
                  <c:v>130</c:v>
                </c:pt>
                <c:pt idx="86">
                  <c:v>90</c:v>
                </c:pt>
                <c:pt idx="87">
                  <c:v>150</c:v>
                </c:pt>
                <c:pt idx="88">
                  <c:v>210</c:v>
                </c:pt>
                <c:pt idx="89">
                  <c:v>160</c:v>
                </c:pt>
                <c:pt idx="90">
                  <c:v>90</c:v>
                </c:pt>
                <c:pt idx="91">
                  <c:v>130</c:v>
                </c:pt>
                <c:pt idx="92">
                  <c:v>180</c:v>
                </c:pt>
                <c:pt idx="93">
                  <c:v>220</c:v>
                </c:pt>
                <c:pt idx="94">
                  <c:v>150</c:v>
                </c:pt>
                <c:pt idx="95">
                  <c:v>160</c:v>
                </c:pt>
                <c:pt idx="96">
                  <c:v>180</c:v>
                </c:pt>
                <c:pt idx="97">
                  <c:v>250</c:v>
                </c:pt>
                <c:pt idx="98">
                  <c:v>190</c:v>
                </c:pt>
                <c:pt idx="99">
                  <c:v>180</c:v>
                </c:pt>
                <c:pt idx="100">
                  <c:v>178.72</c:v>
                </c:pt>
                <c:pt idx="101">
                  <c:v>214.46</c:v>
                </c:pt>
                <c:pt idx="102">
                  <c:v>178.72</c:v>
                </c:pt>
                <c:pt idx="103">
                  <c:v>160.84</c:v>
                </c:pt>
                <c:pt idx="104">
                  <c:v>250.2</c:v>
                </c:pt>
                <c:pt idx="105">
                  <c:v>214.46</c:v>
                </c:pt>
                <c:pt idx="106">
                  <c:v>160.84</c:v>
                </c:pt>
                <c:pt idx="107">
                  <c:v>214.46</c:v>
                </c:pt>
                <c:pt idx="108">
                  <c:v>250.2</c:v>
                </c:pt>
                <c:pt idx="109">
                  <c:v>268.07</c:v>
                </c:pt>
                <c:pt idx="110">
                  <c:v>214.46</c:v>
                </c:pt>
                <c:pt idx="111">
                  <c:v>339.56</c:v>
                </c:pt>
                <c:pt idx="112">
                  <c:v>160.84</c:v>
                </c:pt>
                <c:pt idx="113">
                  <c:v>214.46</c:v>
                </c:pt>
                <c:pt idx="114">
                  <c:v>142.97</c:v>
                </c:pt>
                <c:pt idx="115">
                  <c:v>178.72</c:v>
                </c:pt>
                <c:pt idx="116">
                  <c:v>160.84</c:v>
                </c:pt>
                <c:pt idx="117">
                  <c:v>142.97</c:v>
                </c:pt>
                <c:pt idx="118">
                  <c:v>160.84</c:v>
                </c:pt>
                <c:pt idx="119">
                  <c:v>142.97</c:v>
                </c:pt>
                <c:pt idx="120">
                  <c:v>252.43</c:v>
                </c:pt>
                <c:pt idx="121">
                  <c:v>162.27000000000001</c:v>
                </c:pt>
                <c:pt idx="122">
                  <c:v>126.21</c:v>
                </c:pt>
                <c:pt idx="123">
                  <c:v>180.3</c:v>
                </c:pt>
                <c:pt idx="124">
                  <c:v>216.37</c:v>
                </c:pt>
                <c:pt idx="125">
                  <c:v>162.27000000000001</c:v>
                </c:pt>
                <c:pt idx="126">
                  <c:v>144.24</c:v>
                </c:pt>
                <c:pt idx="127">
                  <c:v>180.3</c:v>
                </c:pt>
                <c:pt idx="128">
                  <c:v>216.37</c:v>
                </c:pt>
                <c:pt idx="129">
                  <c:v>162.27000000000001</c:v>
                </c:pt>
                <c:pt idx="130">
                  <c:v>108.18</c:v>
                </c:pt>
                <c:pt idx="131">
                  <c:v>90.15</c:v>
                </c:pt>
                <c:pt idx="132">
                  <c:v>108.18</c:v>
                </c:pt>
                <c:pt idx="133">
                  <c:v>162.27000000000001</c:v>
                </c:pt>
                <c:pt idx="134">
                  <c:v>162.27000000000001</c:v>
                </c:pt>
                <c:pt idx="135">
                  <c:v>234.4</c:v>
                </c:pt>
                <c:pt idx="136">
                  <c:v>180.3</c:v>
                </c:pt>
                <c:pt idx="137">
                  <c:v>126.21</c:v>
                </c:pt>
                <c:pt idx="138">
                  <c:v>234.4</c:v>
                </c:pt>
                <c:pt idx="139">
                  <c:v>180.3</c:v>
                </c:pt>
                <c:pt idx="140">
                  <c:v>108.87295</c:v>
                </c:pt>
                <c:pt idx="141">
                  <c:v>181.45491000000001</c:v>
                </c:pt>
                <c:pt idx="142">
                  <c:v>127.01844</c:v>
                </c:pt>
                <c:pt idx="143">
                  <c:v>145.16392999999999</c:v>
                </c:pt>
                <c:pt idx="144">
                  <c:v>217.74589</c:v>
                </c:pt>
                <c:pt idx="145">
                  <c:v>254.03686999999999</c:v>
                </c:pt>
                <c:pt idx="146">
                  <c:v>217.74589</c:v>
                </c:pt>
                <c:pt idx="147">
                  <c:v>217.74589</c:v>
                </c:pt>
                <c:pt idx="148">
                  <c:v>127.01844</c:v>
                </c:pt>
                <c:pt idx="149">
                  <c:v>108.87295</c:v>
                </c:pt>
                <c:pt idx="150">
                  <c:v>127.01844</c:v>
                </c:pt>
                <c:pt idx="151">
                  <c:v>199.60040000000001</c:v>
                </c:pt>
                <c:pt idx="152">
                  <c:v>235.89138</c:v>
                </c:pt>
                <c:pt idx="153">
                  <c:v>199.60040000000001</c:v>
                </c:pt>
                <c:pt idx="154">
                  <c:v>127.01844</c:v>
                </c:pt>
                <c:pt idx="155">
                  <c:v>108.87295</c:v>
                </c:pt>
                <c:pt idx="156">
                  <c:v>145.16392999999999</c:v>
                </c:pt>
                <c:pt idx="157">
                  <c:v>163.30942000000002</c:v>
                </c:pt>
                <c:pt idx="158">
                  <c:v>181.45491000000001</c:v>
                </c:pt>
                <c:pt idx="159">
                  <c:v>181.45491000000001</c:v>
                </c:pt>
                <c:pt idx="160">
                  <c:v>237.74</c:v>
                </c:pt>
                <c:pt idx="161">
                  <c:v>128.01</c:v>
                </c:pt>
                <c:pt idx="162">
                  <c:v>182.88</c:v>
                </c:pt>
                <c:pt idx="163">
                  <c:v>128.01</c:v>
                </c:pt>
                <c:pt idx="164">
                  <c:v>164.59</c:v>
                </c:pt>
                <c:pt idx="165">
                  <c:v>201.16</c:v>
                </c:pt>
                <c:pt idx="166">
                  <c:v>164.59</c:v>
                </c:pt>
                <c:pt idx="167">
                  <c:v>219.45</c:v>
                </c:pt>
                <c:pt idx="168">
                  <c:v>256.02999999999997</c:v>
                </c:pt>
                <c:pt idx="169">
                  <c:v>292.60000000000002</c:v>
                </c:pt>
                <c:pt idx="170">
                  <c:v>237.74</c:v>
                </c:pt>
                <c:pt idx="171">
                  <c:v>182.88</c:v>
                </c:pt>
                <c:pt idx="172">
                  <c:v>182.88</c:v>
                </c:pt>
                <c:pt idx="173">
                  <c:v>109.73</c:v>
                </c:pt>
                <c:pt idx="174">
                  <c:v>109.73</c:v>
                </c:pt>
                <c:pt idx="175">
                  <c:v>109.73</c:v>
                </c:pt>
                <c:pt idx="176">
                  <c:v>219.45</c:v>
                </c:pt>
                <c:pt idx="177">
                  <c:v>164.59</c:v>
                </c:pt>
                <c:pt idx="178">
                  <c:v>91.44</c:v>
                </c:pt>
                <c:pt idx="179">
                  <c:v>201.16</c:v>
                </c:pt>
                <c:pt idx="180">
                  <c:v>200.47</c:v>
                </c:pt>
                <c:pt idx="181">
                  <c:v>127.57</c:v>
                </c:pt>
                <c:pt idx="182">
                  <c:v>273.37</c:v>
                </c:pt>
                <c:pt idx="183">
                  <c:v>91.12</c:v>
                </c:pt>
                <c:pt idx="184">
                  <c:v>291.60000000000002</c:v>
                </c:pt>
                <c:pt idx="185">
                  <c:v>145.80000000000001</c:v>
                </c:pt>
                <c:pt idx="186">
                  <c:v>145.80000000000001</c:v>
                </c:pt>
                <c:pt idx="187">
                  <c:v>127.57</c:v>
                </c:pt>
                <c:pt idx="188">
                  <c:v>182.25</c:v>
                </c:pt>
                <c:pt idx="189">
                  <c:v>109.35</c:v>
                </c:pt>
                <c:pt idx="190">
                  <c:v>200.47</c:v>
                </c:pt>
                <c:pt idx="191">
                  <c:v>145.80000000000001</c:v>
                </c:pt>
                <c:pt idx="192">
                  <c:v>127.57</c:v>
                </c:pt>
                <c:pt idx="193">
                  <c:v>182.25</c:v>
                </c:pt>
                <c:pt idx="194">
                  <c:v>145.80000000000001</c:v>
                </c:pt>
                <c:pt idx="195">
                  <c:v>109.35</c:v>
                </c:pt>
                <c:pt idx="196">
                  <c:v>218.7</c:v>
                </c:pt>
                <c:pt idx="197">
                  <c:v>200.47</c:v>
                </c:pt>
                <c:pt idx="198">
                  <c:v>218.7</c:v>
                </c:pt>
                <c:pt idx="199">
                  <c:v>127.57</c:v>
                </c:pt>
                <c:pt idx="200">
                  <c:v>182.09100000000001</c:v>
                </c:pt>
                <c:pt idx="201">
                  <c:v>182.09100000000001</c:v>
                </c:pt>
                <c:pt idx="202">
                  <c:v>182.09100000000001</c:v>
                </c:pt>
                <c:pt idx="203">
                  <c:v>182.09100000000001</c:v>
                </c:pt>
                <c:pt idx="204">
                  <c:v>182.09100000000001</c:v>
                </c:pt>
                <c:pt idx="205">
                  <c:v>236.71799999999999</c:v>
                </c:pt>
                <c:pt idx="206">
                  <c:v>182.09100000000001</c:v>
                </c:pt>
                <c:pt idx="207">
                  <c:v>182.09100000000001</c:v>
                </c:pt>
                <c:pt idx="208">
                  <c:v>182.09100000000001</c:v>
                </c:pt>
                <c:pt idx="209">
                  <c:v>218.50900000000001</c:v>
                </c:pt>
                <c:pt idx="210">
                  <c:v>109.255</c:v>
                </c:pt>
                <c:pt idx="211">
                  <c:v>200.3</c:v>
                </c:pt>
                <c:pt idx="212">
                  <c:v>254.92699999999999</c:v>
                </c:pt>
                <c:pt idx="213">
                  <c:v>291.34499999999997</c:v>
                </c:pt>
                <c:pt idx="214">
                  <c:v>254.92699999999999</c:v>
                </c:pt>
                <c:pt idx="215">
                  <c:v>218.50900000000001</c:v>
                </c:pt>
                <c:pt idx="216">
                  <c:v>200.3</c:v>
                </c:pt>
                <c:pt idx="217">
                  <c:v>163.88200000000001</c:v>
                </c:pt>
                <c:pt idx="218">
                  <c:v>91.045000000000002</c:v>
                </c:pt>
                <c:pt idx="219">
                  <c:v>200.3</c:v>
                </c:pt>
                <c:pt idx="220">
                  <c:v>215.73</c:v>
                </c:pt>
                <c:pt idx="221">
                  <c:v>143.82</c:v>
                </c:pt>
                <c:pt idx="222">
                  <c:v>179.78</c:v>
                </c:pt>
                <c:pt idx="223">
                  <c:v>197.76</c:v>
                </c:pt>
                <c:pt idx="224">
                  <c:v>143.82</c:v>
                </c:pt>
                <c:pt idx="225">
                  <c:v>197.76</c:v>
                </c:pt>
                <c:pt idx="226">
                  <c:v>179.78</c:v>
                </c:pt>
                <c:pt idx="227">
                  <c:v>161.80000000000001</c:v>
                </c:pt>
                <c:pt idx="228">
                  <c:v>143.82</c:v>
                </c:pt>
                <c:pt idx="229">
                  <c:v>107.87</c:v>
                </c:pt>
                <c:pt idx="230">
                  <c:v>161.80000000000001</c:v>
                </c:pt>
                <c:pt idx="231">
                  <c:v>125.84</c:v>
                </c:pt>
                <c:pt idx="232">
                  <c:v>197.76</c:v>
                </c:pt>
                <c:pt idx="233">
                  <c:v>161.80000000000001</c:v>
                </c:pt>
                <c:pt idx="234">
                  <c:v>197.76</c:v>
                </c:pt>
                <c:pt idx="235">
                  <c:v>251.69</c:v>
                </c:pt>
                <c:pt idx="236">
                  <c:v>233.71</c:v>
                </c:pt>
                <c:pt idx="237">
                  <c:v>233.71</c:v>
                </c:pt>
                <c:pt idx="238">
                  <c:v>179.78</c:v>
                </c:pt>
                <c:pt idx="239">
                  <c:v>269.67</c:v>
                </c:pt>
                <c:pt idx="240">
                  <c:v>230</c:v>
                </c:pt>
                <c:pt idx="241">
                  <c:v>140</c:v>
                </c:pt>
                <c:pt idx="242">
                  <c:v>110</c:v>
                </c:pt>
                <c:pt idx="243">
                  <c:v>210</c:v>
                </c:pt>
                <c:pt idx="244">
                  <c:v>180</c:v>
                </c:pt>
                <c:pt idx="245">
                  <c:v>180</c:v>
                </c:pt>
                <c:pt idx="246">
                  <c:v>290</c:v>
                </c:pt>
                <c:pt idx="247">
                  <c:v>240</c:v>
                </c:pt>
                <c:pt idx="248">
                  <c:v>260</c:v>
                </c:pt>
                <c:pt idx="249">
                  <c:v>260</c:v>
                </c:pt>
                <c:pt idx="250">
                  <c:v>260</c:v>
                </c:pt>
                <c:pt idx="251">
                  <c:v>200</c:v>
                </c:pt>
                <c:pt idx="252">
                  <c:v>240</c:v>
                </c:pt>
                <c:pt idx="253">
                  <c:v>240</c:v>
                </c:pt>
                <c:pt idx="254">
                  <c:v>230</c:v>
                </c:pt>
                <c:pt idx="255">
                  <c:v>260</c:v>
                </c:pt>
                <c:pt idx="256">
                  <c:v>270</c:v>
                </c:pt>
                <c:pt idx="257">
                  <c:v>240</c:v>
                </c:pt>
                <c:pt idx="258">
                  <c:v>110</c:v>
                </c:pt>
                <c:pt idx="259">
                  <c:v>230</c:v>
                </c:pt>
                <c:pt idx="260">
                  <c:v>210</c:v>
                </c:pt>
                <c:pt idx="261">
                  <c:v>190</c:v>
                </c:pt>
                <c:pt idx="262">
                  <c:v>240</c:v>
                </c:pt>
                <c:pt idx="263">
                  <c:v>240</c:v>
                </c:pt>
                <c:pt idx="264">
                  <c:v>220</c:v>
                </c:pt>
                <c:pt idx="265">
                  <c:v>220</c:v>
                </c:pt>
                <c:pt idx="266">
                  <c:v>190</c:v>
                </c:pt>
                <c:pt idx="267">
                  <c:v>250</c:v>
                </c:pt>
                <c:pt idx="268">
                  <c:v>170</c:v>
                </c:pt>
                <c:pt idx="269">
                  <c:v>240</c:v>
                </c:pt>
                <c:pt idx="270">
                  <c:v>170</c:v>
                </c:pt>
                <c:pt idx="271">
                  <c:v>160</c:v>
                </c:pt>
                <c:pt idx="272">
                  <c:v>190</c:v>
                </c:pt>
                <c:pt idx="273">
                  <c:v>320</c:v>
                </c:pt>
                <c:pt idx="274">
                  <c:v>270</c:v>
                </c:pt>
                <c:pt idx="275">
                  <c:v>270</c:v>
                </c:pt>
                <c:pt idx="276">
                  <c:v>170</c:v>
                </c:pt>
                <c:pt idx="277">
                  <c:v>160</c:v>
                </c:pt>
                <c:pt idx="278">
                  <c:v>170</c:v>
                </c:pt>
                <c:pt idx="279">
                  <c:v>170</c:v>
                </c:pt>
                <c:pt idx="280">
                  <c:v>206.99999999999997</c:v>
                </c:pt>
                <c:pt idx="281">
                  <c:v>262</c:v>
                </c:pt>
                <c:pt idx="282">
                  <c:v>165</c:v>
                </c:pt>
                <c:pt idx="283">
                  <c:v>206.99999999999997</c:v>
                </c:pt>
                <c:pt idx="284">
                  <c:v>276</c:v>
                </c:pt>
                <c:pt idx="285">
                  <c:v>234</c:v>
                </c:pt>
                <c:pt idx="286">
                  <c:v>152</c:v>
                </c:pt>
                <c:pt idx="287">
                  <c:v>124</c:v>
                </c:pt>
                <c:pt idx="288">
                  <c:v>97</c:v>
                </c:pt>
                <c:pt idx="289">
                  <c:v>248</c:v>
                </c:pt>
                <c:pt idx="290">
                  <c:v>179</c:v>
                </c:pt>
                <c:pt idx="291">
                  <c:v>179</c:v>
                </c:pt>
                <c:pt idx="292">
                  <c:v>152</c:v>
                </c:pt>
                <c:pt idx="293">
                  <c:v>152</c:v>
                </c:pt>
                <c:pt idx="294">
                  <c:v>290</c:v>
                </c:pt>
                <c:pt idx="295">
                  <c:v>179</c:v>
                </c:pt>
                <c:pt idx="296">
                  <c:v>179</c:v>
                </c:pt>
                <c:pt idx="297">
                  <c:v>152</c:v>
                </c:pt>
                <c:pt idx="298">
                  <c:v>138</c:v>
                </c:pt>
                <c:pt idx="299">
                  <c:v>152</c:v>
                </c:pt>
                <c:pt idx="300">
                  <c:v>217.29</c:v>
                </c:pt>
                <c:pt idx="301">
                  <c:v>235.4</c:v>
                </c:pt>
                <c:pt idx="302">
                  <c:v>162.97</c:v>
                </c:pt>
                <c:pt idx="303">
                  <c:v>162.97</c:v>
                </c:pt>
                <c:pt idx="304">
                  <c:v>199.18</c:v>
                </c:pt>
                <c:pt idx="305">
                  <c:v>235.4</c:v>
                </c:pt>
                <c:pt idx="306">
                  <c:v>126.75</c:v>
                </c:pt>
                <c:pt idx="307">
                  <c:v>126.75</c:v>
                </c:pt>
                <c:pt idx="308">
                  <c:v>108.64</c:v>
                </c:pt>
                <c:pt idx="309">
                  <c:v>253.5</c:v>
                </c:pt>
                <c:pt idx="310">
                  <c:v>271.61</c:v>
                </c:pt>
                <c:pt idx="311">
                  <c:v>271.61</c:v>
                </c:pt>
                <c:pt idx="312">
                  <c:v>325.93</c:v>
                </c:pt>
                <c:pt idx="313">
                  <c:v>325.93</c:v>
                </c:pt>
                <c:pt idx="314">
                  <c:v>253.5</c:v>
                </c:pt>
                <c:pt idx="315">
                  <c:v>199.18</c:v>
                </c:pt>
                <c:pt idx="316">
                  <c:v>162.97</c:v>
                </c:pt>
                <c:pt idx="317">
                  <c:v>271.61</c:v>
                </c:pt>
                <c:pt idx="318">
                  <c:v>162.97</c:v>
                </c:pt>
                <c:pt idx="319">
                  <c:v>307.83</c:v>
                </c:pt>
                <c:pt idx="320">
                  <c:v>124.59</c:v>
                </c:pt>
                <c:pt idx="321">
                  <c:v>302.57</c:v>
                </c:pt>
                <c:pt idx="322">
                  <c:v>213.58</c:v>
                </c:pt>
                <c:pt idx="323">
                  <c:v>355.96</c:v>
                </c:pt>
                <c:pt idx="324">
                  <c:v>231.38</c:v>
                </c:pt>
                <c:pt idx="325">
                  <c:v>266.97000000000003</c:v>
                </c:pt>
                <c:pt idx="326">
                  <c:v>142.38999999999999</c:v>
                </c:pt>
                <c:pt idx="327">
                  <c:v>249.18</c:v>
                </c:pt>
                <c:pt idx="328">
                  <c:v>266.97000000000003</c:v>
                </c:pt>
                <c:pt idx="329">
                  <c:v>195.78</c:v>
                </c:pt>
                <c:pt idx="330">
                  <c:v>302.57</c:v>
                </c:pt>
                <c:pt idx="331">
                  <c:v>302.57</c:v>
                </c:pt>
                <c:pt idx="332">
                  <c:v>231.38</c:v>
                </c:pt>
                <c:pt idx="333">
                  <c:v>320.37</c:v>
                </c:pt>
                <c:pt idx="334">
                  <c:v>284.77</c:v>
                </c:pt>
                <c:pt idx="335">
                  <c:v>302.57</c:v>
                </c:pt>
                <c:pt idx="336">
                  <c:v>302.57</c:v>
                </c:pt>
                <c:pt idx="337">
                  <c:v>213.58</c:v>
                </c:pt>
                <c:pt idx="338">
                  <c:v>266.97000000000003</c:v>
                </c:pt>
                <c:pt idx="339">
                  <c:v>373.76</c:v>
                </c:pt>
                <c:pt idx="340">
                  <c:v>235.25</c:v>
                </c:pt>
                <c:pt idx="341">
                  <c:v>180.96</c:v>
                </c:pt>
                <c:pt idx="342">
                  <c:v>162.86000000000001</c:v>
                </c:pt>
                <c:pt idx="343">
                  <c:v>180.96</c:v>
                </c:pt>
                <c:pt idx="344">
                  <c:v>325.73</c:v>
                </c:pt>
                <c:pt idx="345">
                  <c:v>289.52999999999997</c:v>
                </c:pt>
                <c:pt idx="346">
                  <c:v>235.25</c:v>
                </c:pt>
                <c:pt idx="347">
                  <c:v>289.52999999999997</c:v>
                </c:pt>
                <c:pt idx="348">
                  <c:v>289.52999999999997</c:v>
                </c:pt>
                <c:pt idx="349">
                  <c:v>235.25</c:v>
                </c:pt>
                <c:pt idx="350">
                  <c:v>162.86000000000001</c:v>
                </c:pt>
                <c:pt idx="351">
                  <c:v>217.15</c:v>
                </c:pt>
                <c:pt idx="352">
                  <c:v>235.25</c:v>
                </c:pt>
                <c:pt idx="353">
                  <c:v>253.34</c:v>
                </c:pt>
                <c:pt idx="354">
                  <c:v>180.96</c:v>
                </c:pt>
                <c:pt idx="355">
                  <c:v>289.52999999999997</c:v>
                </c:pt>
                <c:pt idx="356">
                  <c:v>180.96</c:v>
                </c:pt>
                <c:pt idx="357">
                  <c:v>126.67</c:v>
                </c:pt>
                <c:pt idx="358">
                  <c:v>162.86000000000001</c:v>
                </c:pt>
                <c:pt idx="359">
                  <c:v>144.77000000000001</c:v>
                </c:pt>
              </c:numCache>
            </c:numRef>
          </c:xVal>
          <c:yVal>
            <c:numRef>
              <c:f>成熟期散布図!$F$4:$F$363</c:f>
              <c:numCache>
                <c:formatCode>General</c:formatCode>
                <c:ptCount val="360"/>
                <c:pt idx="0">
                  <c:v>318.64999999999998</c:v>
                </c:pt>
                <c:pt idx="1">
                  <c:v>177.03</c:v>
                </c:pt>
                <c:pt idx="2">
                  <c:v>247.84</c:v>
                </c:pt>
                <c:pt idx="3">
                  <c:v>194.73</c:v>
                </c:pt>
                <c:pt idx="4">
                  <c:v>106.22</c:v>
                </c:pt>
                <c:pt idx="5">
                  <c:v>194.73</c:v>
                </c:pt>
                <c:pt idx="6">
                  <c:v>230.14</c:v>
                </c:pt>
                <c:pt idx="7">
                  <c:v>159.32</c:v>
                </c:pt>
                <c:pt idx="8">
                  <c:v>336.35</c:v>
                </c:pt>
                <c:pt idx="9">
                  <c:v>336.35</c:v>
                </c:pt>
                <c:pt idx="10">
                  <c:v>300.95</c:v>
                </c:pt>
                <c:pt idx="11">
                  <c:v>283.24</c:v>
                </c:pt>
                <c:pt idx="12">
                  <c:v>247.84</c:v>
                </c:pt>
                <c:pt idx="13">
                  <c:v>177.03</c:v>
                </c:pt>
                <c:pt idx="14">
                  <c:v>247.84</c:v>
                </c:pt>
                <c:pt idx="15">
                  <c:v>460.27</c:v>
                </c:pt>
                <c:pt idx="16">
                  <c:v>177.03</c:v>
                </c:pt>
                <c:pt idx="17">
                  <c:v>141.62</c:v>
                </c:pt>
                <c:pt idx="18">
                  <c:v>123.92</c:v>
                </c:pt>
                <c:pt idx="19">
                  <c:v>177.03</c:v>
                </c:pt>
                <c:pt idx="20">
                  <c:v>450</c:v>
                </c:pt>
                <c:pt idx="21">
                  <c:v>420</c:v>
                </c:pt>
                <c:pt idx="22">
                  <c:v>310</c:v>
                </c:pt>
                <c:pt idx="23">
                  <c:v>870</c:v>
                </c:pt>
                <c:pt idx="24">
                  <c:v>400</c:v>
                </c:pt>
                <c:pt idx="25">
                  <c:v>420</c:v>
                </c:pt>
                <c:pt idx="26">
                  <c:v>720</c:v>
                </c:pt>
                <c:pt idx="27">
                  <c:v>490</c:v>
                </c:pt>
                <c:pt idx="28">
                  <c:v>430</c:v>
                </c:pt>
                <c:pt idx="29">
                  <c:v>560</c:v>
                </c:pt>
                <c:pt idx="30">
                  <c:v>420</c:v>
                </c:pt>
                <c:pt idx="31">
                  <c:v>710</c:v>
                </c:pt>
                <c:pt idx="32">
                  <c:v>430</c:v>
                </c:pt>
                <c:pt idx="33">
                  <c:v>540</c:v>
                </c:pt>
                <c:pt idx="34">
                  <c:v>600</c:v>
                </c:pt>
                <c:pt idx="35">
                  <c:v>400</c:v>
                </c:pt>
                <c:pt idx="36">
                  <c:v>430</c:v>
                </c:pt>
                <c:pt idx="37">
                  <c:v>670</c:v>
                </c:pt>
                <c:pt idx="38">
                  <c:v>340</c:v>
                </c:pt>
                <c:pt idx="39">
                  <c:v>490</c:v>
                </c:pt>
                <c:pt idx="40">
                  <c:v>727</c:v>
                </c:pt>
                <c:pt idx="41">
                  <c:v>472</c:v>
                </c:pt>
                <c:pt idx="42">
                  <c:v>400</c:v>
                </c:pt>
                <c:pt idx="43">
                  <c:v>382</c:v>
                </c:pt>
                <c:pt idx="44">
                  <c:v>491</c:v>
                </c:pt>
                <c:pt idx="45">
                  <c:v>436.00000000000006</c:v>
                </c:pt>
                <c:pt idx="46">
                  <c:v>581</c:v>
                </c:pt>
                <c:pt idx="47">
                  <c:v>491</c:v>
                </c:pt>
                <c:pt idx="48">
                  <c:v>636</c:v>
                </c:pt>
                <c:pt idx="49">
                  <c:v>291</c:v>
                </c:pt>
                <c:pt idx="50">
                  <c:v>291</c:v>
                </c:pt>
                <c:pt idx="51">
                  <c:v>400</c:v>
                </c:pt>
                <c:pt idx="52">
                  <c:v>509</c:v>
                </c:pt>
                <c:pt idx="53">
                  <c:v>382</c:v>
                </c:pt>
                <c:pt idx="54">
                  <c:v>327</c:v>
                </c:pt>
                <c:pt idx="55">
                  <c:v>345</c:v>
                </c:pt>
                <c:pt idx="56">
                  <c:v>836</c:v>
                </c:pt>
                <c:pt idx="57">
                  <c:v>400</c:v>
                </c:pt>
                <c:pt idx="58">
                  <c:v>400</c:v>
                </c:pt>
                <c:pt idx="59">
                  <c:v>472</c:v>
                </c:pt>
                <c:pt idx="60">
                  <c:v>900</c:v>
                </c:pt>
                <c:pt idx="61">
                  <c:v>780</c:v>
                </c:pt>
                <c:pt idx="62">
                  <c:v>420</c:v>
                </c:pt>
                <c:pt idx="63">
                  <c:v>540</c:v>
                </c:pt>
                <c:pt idx="64">
                  <c:v>930</c:v>
                </c:pt>
                <c:pt idx="65">
                  <c:v>210</c:v>
                </c:pt>
                <c:pt idx="66">
                  <c:v>260</c:v>
                </c:pt>
                <c:pt idx="67">
                  <c:v>460</c:v>
                </c:pt>
                <c:pt idx="68">
                  <c:v>290</c:v>
                </c:pt>
                <c:pt idx="69">
                  <c:v>880</c:v>
                </c:pt>
                <c:pt idx="70">
                  <c:v>700</c:v>
                </c:pt>
                <c:pt idx="71">
                  <c:v>260</c:v>
                </c:pt>
                <c:pt idx="72">
                  <c:v>240</c:v>
                </c:pt>
                <c:pt idx="73">
                  <c:v>520</c:v>
                </c:pt>
                <c:pt idx="74">
                  <c:v>700</c:v>
                </c:pt>
                <c:pt idx="75">
                  <c:v>620</c:v>
                </c:pt>
                <c:pt idx="76">
                  <c:v>230</c:v>
                </c:pt>
                <c:pt idx="77">
                  <c:v>910</c:v>
                </c:pt>
                <c:pt idx="78">
                  <c:v>550</c:v>
                </c:pt>
                <c:pt idx="79">
                  <c:v>440</c:v>
                </c:pt>
                <c:pt idx="80">
                  <c:v>510</c:v>
                </c:pt>
                <c:pt idx="81">
                  <c:v>340</c:v>
                </c:pt>
                <c:pt idx="82">
                  <c:v>610</c:v>
                </c:pt>
                <c:pt idx="83">
                  <c:v>430</c:v>
                </c:pt>
                <c:pt idx="84">
                  <c:v>300</c:v>
                </c:pt>
                <c:pt idx="85">
                  <c:v>330</c:v>
                </c:pt>
                <c:pt idx="86">
                  <c:v>270</c:v>
                </c:pt>
                <c:pt idx="87">
                  <c:v>420</c:v>
                </c:pt>
                <c:pt idx="88">
                  <c:v>540</c:v>
                </c:pt>
                <c:pt idx="89">
                  <c:v>550</c:v>
                </c:pt>
                <c:pt idx="90">
                  <c:v>240</c:v>
                </c:pt>
                <c:pt idx="91">
                  <c:v>310</c:v>
                </c:pt>
                <c:pt idx="92">
                  <c:v>600</c:v>
                </c:pt>
                <c:pt idx="93">
                  <c:v>390</c:v>
                </c:pt>
                <c:pt idx="94">
                  <c:v>580</c:v>
                </c:pt>
                <c:pt idx="95">
                  <c:v>400</c:v>
                </c:pt>
                <c:pt idx="96">
                  <c:v>270</c:v>
                </c:pt>
                <c:pt idx="97">
                  <c:v>450</c:v>
                </c:pt>
                <c:pt idx="98">
                  <c:v>340</c:v>
                </c:pt>
                <c:pt idx="99">
                  <c:v>400</c:v>
                </c:pt>
                <c:pt idx="100">
                  <c:v>321.69</c:v>
                </c:pt>
                <c:pt idx="101">
                  <c:v>393.17</c:v>
                </c:pt>
                <c:pt idx="102">
                  <c:v>321.69</c:v>
                </c:pt>
                <c:pt idx="103">
                  <c:v>321.69</c:v>
                </c:pt>
                <c:pt idx="104">
                  <c:v>554.02</c:v>
                </c:pt>
                <c:pt idx="105">
                  <c:v>482.53</c:v>
                </c:pt>
                <c:pt idx="106">
                  <c:v>303.82</c:v>
                </c:pt>
                <c:pt idx="107">
                  <c:v>464.66</c:v>
                </c:pt>
                <c:pt idx="108">
                  <c:v>464.66</c:v>
                </c:pt>
                <c:pt idx="109">
                  <c:v>303.82</c:v>
                </c:pt>
                <c:pt idx="110">
                  <c:v>285.94</c:v>
                </c:pt>
                <c:pt idx="111">
                  <c:v>589.76</c:v>
                </c:pt>
                <c:pt idx="112">
                  <c:v>303.82</c:v>
                </c:pt>
                <c:pt idx="113">
                  <c:v>482.53</c:v>
                </c:pt>
                <c:pt idx="114">
                  <c:v>357.43</c:v>
                </c:pt>
                <c:pt idx="115">
                  <c:v>285.94</c:v>
                </c:pt>
                <c:pt idx="116">
                  <c:v>268.07</c:v>
                </c:pt>
                <c:pt idx="117">
                  <c:v>321.69</c:v>
                </c:pt>
                <c:pt idx="118">
                  <c:v>357.43</c:v>
                </c:pt>
                <c:pt idx="119">
                  <c:v>375.3</c:v>
                </c:pt>
                <c:pt idx="120">
                  <c:v>360.61</c:v>
                </c:pt>
                <c:pt idx="121">
                  <c:v>360.61</c:v>
                </c:pt>
                <c:pt idx="122">
                  <c:v>180.3</c:v>
                </c:pt>
                <c:pt idx="123">
                  <c:v>432.73</c:v>
                </c:pt>
                <c:pt idx="124">
                  <c:v>342.58</c:v>
                </c:pt>
                <c:pt idx="125">
                  <c:v>432.73</c:v>
                </c:pt>
                <c:pt idx="126">
                  <c:v>234.4</c:v>
                </c:pt>
                <c:pt idx="127">
                  <c:v>324.55</c:v>
                </c:pt>
                <c:pt idx="128">
                  <c:v>432.73</c:v>
                </c:pt>
                <c:pt idx="129">
                  <c:v>198.34</c:v>
                </c:pt>
                <c:pt idx="130">
                  <c:v>180.3</c:v>
                </c:pt>
                <c:pt idx="131">
                  <c:v>180.3</c:v>
                </c:pt>
                <c:pt idx="132">
                  <c:v>288.49</c:v>
                </c:pt>
                <c:pt idx="133">
                  <c:v>540.91</c:v>
                </c:pt>
                <c:pt idx="134">
                  <c:v>252.43</c:v>
                </c:pt>
                <c:pt idx="135">
                  <c:v>360.61</c:v>
                </c:pt>
                <c:pt idx="136">
                  <c:v>270.45999999999998</c:v>
                </c:pt>
                <c:pt idx="137">
                  <c:v>306.52</c:v>
                </c:pt>
                <c:pt idx="138">
                  <c:v>504.85</c:v>
                </c:pt>
                <c:pt idx="139">
                  <c:v>450.76</c:v>
                </c:pt>
                <c:pt idx="140">
                  <c:v>616.94668999999999</c:v>
                </c:pt>
                <c:pt idx="141">
                  <c:v>834.69257999999991</c:v>
                </c:pt>
                <c:pt idx="142">
                  <c:v>290.32784999999996</c:v>
                </c:pt>
                <c:pt idx="143">
                  <c:v>344.76433000000003</c:v>
                </c:pt>
                <c:pt idx="144">
                  <c:v>489.92824999999999</c:v>
                </c:pt>
                <c:pt idx="145">
                  <c:v>344.76433000000003</c:v>
                </c:pt>
                <c:pt idx="146">
                  <c:v>544.36473000000001</c:v>
                </c:pt>
                <c:pt idx="147">
                  <c:v>471.78276</c:v>
                </c:pt>
                <c:pt idx="148">
                  <c:v>254.03686999999999</c:v>
                </c:pt>
                <c:pt idx="149">
                  <c:v>217.74589</c:v>
                </c:pt>
                <c:pt idx="150">
                  <c:v>344.76433000000003</c:v>
                </c:pt>
                <c:pt idx="151">
                  <c:v>381.05531000000002</c:v>
                </c:pt>
                <c:pt idx="152">
                  <c:v>417.34628999999995</c:v>
                </c:pt>
                <c:pt idx="153">
                  <c:v>580.65571</c:v>
                </c:pt>
                <c:pt idx="154">
                  <c:v>344.76433000000003</c:v>
                </c:pt>
                <c:pt idx="155">
                  <c:v>272.18235999999996</c:v>
                </c:pt>
                <c:pt idx="156">
                  <c:v>526.21924000000001</c:v>
                </c:pt>
                <c:pt idx="157">
                  <c:v>381.05531000000002</c:v>
                </c:pt>
                <c:pt idx="158">
                  <c:v>344.76433000000003</c:v>
                </c:pt>
                <c:pt idx="159">
                  <c:v>598.80119999999999</c:v>
                </c:pt>
                <c:pt idx="160">
                  <c:v>512.04999999999995</c:v>
                </c:pt>
                <c:pt idx="161">
                  <c:v>384.04</c:v>
                </c:pt>
                <c:pt idx="162">
                  <c:v>493.76</c:v>
                </c:pt>
                <c:pt idx="163">
                  <c:v>256.02999999999997</c:v>
                </c:pt>
                <c:pt idx="164">
                  <c:v>219.45</c:v>
                </c:pt>
                <c:pt idx="165">
                  <c:v>329.18</c:v>
                </c:pt>
                <c:pt idx="166">
                  <c:v>438.9</c:v>
                </c:pt>
                <c:pt idx="167">
                  <c:v>493.76</c:v>
                </c:pt>
                <c:pt idx="168">
                  <c:v>530.34</c:v>
                </c:pt>
                <c:pt idx="169">
                  <c:v>493.76</c:v>
                </c:pt>
                <c:pt idx="170">
                  <c:v>420.61</c:v>
                </c:pt>
                <c:pt idx="171">
                  <c:v>329.18</c:v>
                </c:pt>
                <c:pt idx="172">
                  <c:v>457.19</c:v>
                </c:pt>
                <c:pt idx="173">
                  <c:v>420.61</c:v>
                </c:pt>
                <c:pt idx="174">
                  <c:v>329.18</c:v>
                </c:pt>
                <c:pt idx="175">
                  <c:v>237.74</c:v>
                </c:pt>
                <c:pt idx="176">
                  <c:v>621.78</c:v>
                </c:pt>
                <c:pt idx="177">
                  <c:v>731.5</c:v>
                </c:pt>
                <c:pt idx="178">
                  <c:v>640.07000000000005</c:v>
                </c:pt>
                <c:pt idx="179">
                  <c:v>512.04999999999995</c:v>
                </c:pt>
                <c:pt idx="180">
                  <c:v>710.77</c:v>
                </c:pt>
                <c:pt idx="181">
                  <c:v>145.80000000000001</c:v>
                </c:pt>
                <c:pt idx="182">
                  <c:v>674.32</c:v>
                </c:pt>
                <c:pt idx="183">
                  <c:v>182.25</c:v>
                </c:pt>
                <c:pt idx="184">
                  <c:v>783.67</c:v>
                </c:pt>
                <c:pt idx="185">
                  <c:v>492.07</c:v>
                </c:pt>
                <c:pt idx="186">
                  <c:v>765.44</c:v>
                </c:pt>
                <c:pt idx="187">
                  <c:v>382.72</c:v>
                </c:pt>
                <c:pt idx="188">
                  <c:v>400.95</c:v>
                </c:pt>
                <c:pt idx="189">
                  <c:v>200.47</c:v>
                </c:pt>
                <c:pt idx="190">
                  <c:v>492.07</c:v>
                </c:pt>
                <c:pt idx="191">
                  <c:v>328.05</c:v>
                </c:pt>
                <c:pt idx="192">
                  <c:v>218.7</c:v>
                </c:pt>
                <c:pt idx="193">
                  <c:v>528.52</c:v>
                </c:pt>
                <c:pt idx="194">
                  <c:v>419.17</c:v>
                </c:pt>
                <c:pt idx="195">
                  <c:v>328.05</c:v>
                </c:pt>
                <c:pt idx="196">
                  <c:v>656.1</c:v>
                </c:pt>
                <c:pt idx="197">
                  <c:v>510.3</c:v>
                </c:pt>
                <c:pt idx="198">
                  <c:v>437.4</c:v>
                </c:pt>
                <c:pt idx="199">
                  <c:v>236.92</c:v>
                </c:pt>
                <c:pt idx="200">
                  <c:v>437.01800000000003</c:v>
                </c:pt>
                <c:pt idx="201">
                  <c:v>364.18200000000002</c:v>
                </c:pt>
                <c:pt idx="202">
                  <c:v>418.80900000000003</c:v>
                </c:pt>
                <c:pt idx="203">
                  <c:v>600.9</c:v>
                </c:pt>
                <c:pt idx="204">
                  <c:v>491.64499999999998</c:v>
                </c:pt>
                <c:pt idx="205">
                  <c:v>364.18200000000002</c:v>
                </c:pt>
                <c:pt idx="206">
                  <c:v>345.97300000000001</c:v>
                </c:pt>
                <c:pt idx="207">
                  <c:v>218.50900000000001</c:v>
                </c:pt>
                <c:pt idx="208">
                  <c:v>400.6</c:v>
                </c:pt>
                <c:pt idx="209">
                  <c:v>418.80900000000003</c:v>
                </c:pt>
                <c:pt idx="210">
                  <c:v>254.92699999999999</c:v>
                </c:pt>
                <c:pt idx="211">
                  <c:v>418.80900000000003</c:v>
                </c:pt>
                <c:pt idx="212">
                  <c:v>327.76400000000001</c:v>
                </c:pt>
                <c:pt idx="213">
                  <c:v>600.9</c:v>
                </c:pt>
                <c:pt idx="214">
                  <c:v>528.06400000000008</c:v>
                </c:pt>
                <c:pt idx="215">
                  <c:v>528.06400000000008</c:v>
                </c:pt>
                <c:pt idx="216">
                  <c:v>400.6</c:v>
                </c:pt>
                <c:pt idx="217">
                  <c:v>382.39099999999996</c:v>
                </c:pt>
                <c:pt idx="218">
                  <c:v>236.71799999999999</c:v>
                </c:pt>
                <c:pt idx="219">
                  <c:v>655.52700000000004</c:v>
                </c:pt>
                <c:pt idx="220">
                  <c:v>377.53</c:v>
                </c:pt>
                <c:pt idx="221">
                  <c:v>251.69</c:v>
                </c:pt>
                <c:pt idx="222">
                  <c:v>485.4</c:v>
                </c:pt>
                <c:pt idx="223">
                  <c:v>359.56</c:v>
                </c:pt>
                <c:pt idx="224">
                  <c:v>305.62</c:v>
                </c:pt>
                <c:pt idx="225">
                  <c:v>413.49</c:v>
                </c:pt>
                <c:pt idx="226">
                  <c:v>431.47</c:v>
                </c:pt>
                <c:pt idx="227">
                  <c:v>269.67</c:v>
                </c:pt>
                <c:pt idx="228">
                  <c:v>503.38</c:v>
                </c:pt>
                <c:pt idx="229">
                  <c:v>341.58</c:v>
                </c:pt>
                <c:pt idx="230">
                  <c:v>629.22</c:v>
                </c:pt>
                <c:pt idx="231">
                  <c:v>521.36</c:v>
                </c:pt>
                <c:pt idx="232">
                  <c:v>305.62</c:v>
                </c:pt>
                <c:pt idx="233">
                  <c:v>593.27</c:v>
                </c:pt>
                <c:pt idx="234">
                  <c:v>575.29</c:v>
                </c:pt>
                <c:pt idx="235">
                  <c:v>611.24</c:v>
                </c:pt>
                <c:pt idx="236">
                  <c:v>377.53</c:v>
                </c:pt>
                <c:pt idx="237">
                  <c:v>809</c:v>
                </c:pt>
                <c:pt idx="238">
                  <c:v>377.53</c:v>
                </c:pt>
                <c:pt idx="239">
                  <c:v>341.58</c:v>
                </c:pt>
                <c:pt idx="240">
                  <c:v>630</c:v>
                </c:pt>
                <c:pt idx="241">
                  <c:v>230</c:v>
                </c:pt>
                <c:pt idx="242">
                  <c:v>210</c:v>
                </c:pt>
                <c:pt idx="243">
                  <c:v>680</c:v>
                </c:pt>
                <c:pt idx="244">
                  <c:v>470</c:v>
                </c:pt>
                <c:pt idx="245">
                  <c:v>510</c:v>
                </c:pt>
                <c:pt idx="246">
                  <c:v>590</c:v>
                </c:pt>
                <c:pt idx="247">
                  <c:v>800</c:v>
                </c:pt>
                <c:pt idx="248">
                  <c:v>570</c:v>
                </c:pt>
                <c:pt idx="249">
                  <c:v>770</c:v>
                </c:pt>
                <c:pt idx="250">
                  <c:v>600</c:v>
                </c:pt>
                <c:pt idx="251">
                  <c:v>420</c:v>
                </c:pt>
                <c:pt idx="252">
                  <c:v>330</c:v>
                </c:pt>
                <c:pt idx="253">
                  <c:v>570</c:v>
                </c:pt>
                <c:pt idx="254">
                  <c:v>960</c:v>
                </c:pt>
                <c:pt idx="255">
                  <c:v>590</c:v>
                </c:pt>
                <c:pt idx="256">
                  <c:v>530</c:v>
                </c:pt>
                <c:pt idx="257">
                  <c:v>750</c:v>
                </c:pt>
                <c:pt idx="258">
                  <c:v>290</c:v>
                </c:pt>
                <c:pt idx="259">
                  <c:v>440</c:v>
                </c:pt>
                <c:pt idx="260">
                  <c:v>460</c:v>
                </c:pt>
                <c:pt idx="261">
                  <c:v>510</c:v>
                </c:pt>
                <c:pt idx="262">
                  <c:v>330</c:v>
                </c:pt>
                <c:pt idx="263">
                  <c:v>590</c:v>
                </c:pt>
                <c:pt idx="264">
                  <c:v>440</c:v>
                </c:pt>
                <c:pt idx="265">
                  <c:v>250</c:v>
                </c:pt>
                <c:pt idx="266">
                  <c:v>710</c:v>
                </c:pt>
                <c:pt idx="267">
                  <c:v>850</c:v>
                </c:pt>
                <c:pt idx="268">
                  <c:v>270</c:v>
                </c:pt>
                <c:pt idx="269">
                  <c:v>660</c:v>
                </c:pt>
                <c:pt idx="270">
                  <c:v>380</c:v>
                </c:pt>
                <c:pt idx="271">
                  <c:v>210</c:v>
                </c:pt>
                <c:pt idx="272">
                  <c:v>170</c:v>
                </c:pt>
                <c:pt idx="273">
                  <c:v>540</c:v>
                </c:pt>
                <c:pt idx="274">
                  <c:v>630</c:v>
                </c:pt>
                <c:pt idx="275">
                  <c:v>620</c:v>
                </c:pt>
                <c:pt idx="276">
                  <c:v>510</c:v>
                </c:pt>
                <c:pt idx="277">
                  <c:v>630</c:v>
                </c:pt>
                <c:pt idx="278">
                  <c:v>550</c:v>
                </c:pt>
                <c:pt idx="279">
                  <c:v>430</c:v>
                </c:pt>
                <c:pt idx="280">
                  <c:v>509.99999999999994</c:v>
                </c:pt>
                <c:pt idx="281">
                  <c:v>936.99999999999989</c:v>
                </c:pt>
                <c:pt idx="282">
                  <c:v>593</c:v>
                </c:pt>
                <c:pt idx="283">
                  <c:v>469.00000000000006</c:v>
                </c:pt>
                <c:pt idx="284">
                  <c:v>648</c:v>
                </c:pt>
                <c:pt idx="285">
                  <c:v>800</c:v>
                </c:pt>
                <c:pt idx="286">
                  <c:v>607</c:v>
                </c:pt>
                <c:pt idx="287">
                  <c:v>331</c:v>
                </c:pt>
                <c:pt idx="288">
                  <c:v>317</c:v>
                </c:pt>
                <c:pt idx="289">
                  <c:v>538</c:v>
                </c:pt>
                <c:pt idx="290">
                  <c:v>509.99999999999994</c:v>
                </c:pt>
                <c:pt idx="291">
                  <c:v>455</c:v>
                </c:pt>
                <c:pt idx="292">
                  <c:v>276</c:v>
                </c:pt>
                <c:pt idx="293">
                  <c:v>455</c:v>
                </c:pt>
                <c:pt idx="294">
                  <c:v>772</c:v>
                </c:pt>
                <c:pt idx="295">
                  <c:v>634</c:v>
                </c:pt>
                <c:pt idx="296">
                  <c:v>400</c:v>
                </c:pt>
                <c:pt idx="297">
                  <c:v>426.99999999999994</c:v>
                </c:pt>
                <c:pt idx="298">
                  <c:v>358</c:v>
                </c:pt>
                <c:pt idx="299">
                  <c:v>317</c:v>
                </c:pt>
                <c:pt idx="300">
                  <c:v>525.11</c:v>
                </c:pt>
                <c:pt idx="301">
                  <c:v>488.9</c:v>
                </c:pt>
                <c:pt idx="302">
                  <c:v>307.83</c:v>
                </c:pt>
                <c:pt idx="303">
                  <c:v>380.26</c:v>
                </c:pt>
                <c:pt idx="304">
                  <c:v>253.5</c:v>
                </c:pt>
                <c:pt idx="305">
                  <c:v>398.36</c:v>
                </c:pt>
                <c:pt idx="306">
                  <c:v>325.93</c:v>
                </c:pt>
                <c:pt idx="307">
                  <c:v>307.83</c:v>
                </c:pt>
                <c:pt idx="308">
                  <c:v>144.86000000000001</c:v>
                </c:pt>
                <c:pt idx="309">
                  <c:v>344.04</c:v>
                </c:pt>
                <c:pt idx="310">
                  <c:v>597.54</c:v>
                </c:pt>
                <c:pt idx="311">
                  <c:v>452.68</c:v>
                </c:pt>
                <c:pt idx="312">
                  <c:v>597.54</c:v>
                </c:pt>
                <c:pt idx="313">
                  <c:v>615.65</c:v>
                </c:pt>
                <c:pt idx="314">
                  <c:v>380.26</c:v>
                </c:pt>
                <c:pt idx="315">
                  <c:v>344.04</c:v>
                </c:pt>
                <c:pt idx="316">
                  <c:v>162.97</c:v>
                </c:pt>
                <c:pt idx="317">
                  <c:v>380.26</c:v>
                </c:pt>
                <c:pt idx="318">
                  <c:v>307.83</c:v>
                </c:pt>
                <c:pt idx="319">
                  <c:v>561.33000000000004</c:v>
                </c:pt>
                <c:pt idx="320">
                  <c:v>231.38</c:v>
                </c:pt>
                <c:pt idx="321">
                  <c:v>391.56</c:v>
                </c:pt>
                <c:pt idx="322">
                  <c:v>213.58</c:v>
                </c:pt>
                <c:pt idx="323">
                  <c:v>320.37</c:v>
                </c:pt>
                <c:pt idx="324">
                  <c:v>249.18</c:v>
                </c:pt>
                <c:pt idx="325">
                  <c:v>355.96</c:v>
                </c:pt>
                <c:pt idx="326">
                  <c:v>284.77</c:v>
                </c:pt>
                <c:pt idx="327">
                  <c:v>480.55</c:v>
                </c:pt>
                <c:pt idx="328">
                  <c:v>284.77</c:v>
                </c:pt>
                <c:pt idx="329">
                  <c:v>195.78</c:v>
                </c:pt>
                <c:pt idx="330">
                  <c:v>427.16</c:v>
                </c:pt>
                <c:pt idx="331">
                  <c:v>355.96</c:v>
                </c:pt>
                <c:pt idx="332">
                  <c:v>160.18</c:v>
                </c:pt>
                <c:pt idx="333">
                  <c:v>355.96</c:v>
                </c:pt>
                <c:pt idx="334">
                  <c:v>391.56</c:v>
                </c:pt>
                <c:pt idx="335">
                  <c:v>338.17</c:v>
                </c:pt>
                <c:pt idx="336">
                  <c:v>480.55</c:v>
                </c:pt>
                <c:pt idx="337">
                  <c:v>409.36</c:v>
                </c:pt>
                <c:pt idx="338">
                  <c:v>355.96</c:v>
                </c:pt>
                <c:pt idx="339">
                  <c:v>480.55</c:v>
                </c:pt>
                <c:pt idx="340">
                  <c:v>398.11</c:v>
                </c:pt>
                <c:pt idx="341">
                  <c:v>343.82</c:v>
                </c:pt>
                <c:pt idx="342">
                  <c:v>271.44</c:v>
                </c:pt>
                <c:pt idx="343">
                  <c:v>217.15</c:v>
                </c:pt>
                <c:pt idx="344">
                  <c:v>524.78</c:v>
                </c:pt>
                <c:pt idx="345">
                  <c:v>398.11</c:v>
                </c:pt>
                <c:pt idx="346">
                  <c:v>343.82</c:v>
                </c:pt>
                <c:pt idx="347">
                  <c:v>343.82</c:v>
                </c:pt>
                <c:pt idx="348">
                  <c:v>380.01</c:v>
                </c:pt>
                <c:pt idx="349">
                  <c:v>343.82</c:v>
                </c:pt>
                <c:pt idx="350">
                  <c:v>325.73</c:v>
                </c:pt>
                <c:pt idx="351">
                  <c:v>452.4</c:v>
                </c:pt>
                <c:pt idx="352">
                  <c:v>434.3</c:v>
                </c:pt>
                <c:pt idx="353">
                  <c:v>524.78</c:v>
                </c:pt>
                <c:pt idx="354">
                  <c:v>325.73</c:v>
                </c:pt>
                <c:pt idx="355">
                  <c:v>506.68</c:v>
                </c:pt>
                <c:pt idx="356">
                  <c:v>416.21</c:v>
                </c:pt>
                <c:pt idx="357">
                  <c:v>343.82</c:v>
                </c:pt>
                <c:pt idx="358">
                  <c:v>705.74</c:v>
                </c:pt>
                <c:pt idx="359">
                  <c:v>542.88</c:v>
                </c:pt>
              </c:numCache>
            </c:numRef>
          </c:yVal>
          <c:smooth val="0"/>
          <c:extLst>
            <c:ext xmlns:c16="http://schemas.microsoft.com/office/drawing/2014/chart" uri="{C3380CC4-5D6E-409C-BE32-E72D297353CC}">
              <c16:uniqueId val="{00000001-C6F8-5649-B730-ECE2735D6C1C}"/>
            </c:ext>
          </c:extLst>
        </c:ser>
        <c:dLbls>
          <c:showLegendKey val="0"/>
          <c:showVal val="0"/>
          <c:showCatName val="0"/>
          <c:showSerName val="0"/>
          <c:showPercent val="0"/>
          <c:showBubbleSize val="0"/>
        </c:dLbls>
        <c:axId val="437666608"/>
        <c:axId val="665349792"/>
      </c:scatterChart>
      <c:valAx>
        <c:axId val="437666608"/>
        <c:scaling>
          <c:orientation val="minMax"/>
          <c:max val="600"/>
          <c:min val="0"/>
        </c:scaling>
        <c:delete val="0"/>
        <c:axPos val="b"/>
        <c:majorGridlines>
          <c:spPr>
            <a:ln w="9525" cap="flat" cmpd="sng" algn="ctr">
              <a:noFill/>
              <a:round/>
            </a:ln>
            <a:effectLst/>
          </c:spPr>
        </c:majorGridlines>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665349792"/>
        <c:crosses val="autoZero"/>
        <c:crossBetween val="midCat"/>
        <c:majorUnit val="200"/>
      </c:valAx>
      <c:valAx>
        <c:axId val="665349792"/>
        <c:scaling>
          <c:orientation val="minMax"/>
          <c:max val="1050"/>
          <c:min val="0"/>
        </c:scaling>
        <c:delete val="0"/>
        <c:axPos val="l"/>
        <c:majorGridlines>
          <c:spPr>
            <a:ln w="9525" cap="flat" cmpd="sng" algn="ctr">
              <a:noFill/>
              <a:round/>
            </a:ln>
            <a:effectLst/>
          </c:spPr>
        </c:majorGridlines>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37666608"/>
        <c:crosses val="autoZero"/>
        <c:crossBetween val="midCat"/>
        <c:majorUnit val="200"/>
      </c:valAx>
      <c:spPr>
        <a:noFill/>
        <a:ln>
          <a:solidFill>
            <a:schemeClr val="tx1"/>
          </a:solidFill>
        </a:ln>
        <a:effectLst/>
      </c:spPr>
    </c:plotArea>
    <c:legend>
      <c:legendPos val="r"/>
      <c:layout>
        <c:manualLayout>
          <c:xMode val="edge"/>
          <c:yMode val="edge"/>
          <c:x val="0.85474564278831566"/>
          <c:y val="0.83382881131278663"/>
          <c:w val="9.5357068098653963E-2"/>
          <c:h val="7.0634779654259294E-2"/>
        </c:manualLayout>
      </c:layout>
      <c:overlay val="0"/>
      <c:spPr>
        <a:noFill/>
        <a:ln>
          <a:noFill/>
        </a:ln>
        <a:effectLst/>
      </c:spPr>
      <c:txPr>
        <a:bodyPr rot="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7770512972305819"/>
          <c:y val="5.4607436958302363E-2"/>
          <c:w val="0.76120940271771487"/>
          <c:h val="0.88127817419204002"/>
        </c:manualLayout>
      </c:layout>
      <c:scatterChart>
        <c:scatterStyle val="lineMarker"/>
        <c:varyColors val="0"/>
        <c:ser>
          <c:idx val="0"/>
          <c:order val="0"/>
          <c:tx>
            <c:v>NT</c:v>
          </c:tx>
          <c:spPr>
            <a:ln w="25400" cap="rnd">
              <a:noFill/>
              <a:round/>
            </a:ln>
            <a:effectLst/>
          </c:spPr>
          <c:marker>
            <c:symbol val="circle"/>
            <c:size val="4"/>
            <c:spPr>
              <a:noFill/>
              <a:ln w="12700">
                <a:solidFill>
                  <a:schemeClr val="accent2"/>
                </a:solidFill>
              </a:ln>
              <a:effectLst/>
            </c:spPr>
          </c:marker>
          <c:xVal>
            <c:numRef>
              <c:f>成熟期散布図!$H$4:$H$363</c:f>
              <c:numCache>
                <c:formatCode>General</c:formatCode>
                <c:ptCount val="360"/>
                <c:pt idx="0">
                  <c:v>100.56</c:v>
                </c:pt>
                <c:pt idx="1">
                  <c:v>89.39</c:v>
                </c:pt>
                <c:pt idx="2">
                  <c:v>100.56</c:v>
                </c:pt>
                <c:pt idx="3">
                  <c:v>134.08000000000001</c:v>
                </c:pt>
                <c:pt idx="4">
                  <c:v>67.040000000000006</c:v>
                </c:pt>
                <c:pt idx="5">
                  <c:v>89.39</c:v>
                </c:pt>
                <c:pt idx="6">
                  <c:v>134.08000000000001</c:v>
                </c:pt>
                <c:pt idx="7">
                  <c:v>89.39</c:v>
                </c:pt>
                <c:pt idx="8">
                  <c:v>134.08000000000001</c:v>
                </c:pt>
                <c:pt idx="9">
                  <c:v>122.91</c:v>
                </c:pt>
                <c:pt idx="10">
                  <c:v>89.39</c:v>
                </c:pt>
                <c:pt idx="11">
                  <c:v>89.39</c:v>
                </c:pt>
                <c:pt idx="12">
                  <c:v>89.39</c:v>
                </c:pt>
                <c:pt idx="13">
                  <c:v>134.08000000000001</c:v>
                </c:pt>
                <c:pt idx="14">
                  <c:v>89.39</c:v>
                </c:pt>
                <c:pt idx="15">
                  <c:v>100.56</c:v>
                </c:pt>
                <c:pt idx="16">
                  <c:v>100.56</c:v>
                </c:pt>
                <c:pt idx="17">
                  <c:v>134.08000000000001</c:v>
                </c:pt>
                <c:pt idx="18">
                  <c:v>89.39</c:v>
                </c:pt>
                <c:pt idx="19">
                  <c:v>134.08000000000001</c:v>
                </c:pt>
                <c:pt idx="20">
                  <c:v>116.27</c:v>
                </c:pt>
                <c:pt idx="21">
                  <c:v>104.64</c:v>
                </c:pt>
                <c:pt idx="22">
                  <c:v>139.52000000000001</c:v>
                </c:pt>
                <c:pt idx="23">
                  <c:v>186.03</c:v>
                </c:pt>
                <c:pt idx="24">
                  <c:v>127.89</c:v>
                </c:pt>
                <c:pt idx="25">
                  <c:v>104.64</c:v>
                </c:pt>
                <c:pt idx="26">
                  <c:v>104.64</c:v>
                </c:pt>
                <c:pt idx="27">
                  <c:v>116.27</c:v>
                </c:pt>
                <c:pt idx="28">
                  <c:v>197.65</c:v>
                </c:pt>
                <c:pt idx="29">
                  <c:v>104.64</c:v>
                </c:pt>
                <c:pt idx="30">
                  <c:v>127.89</c:v>
                </c:pt>
                <c:pt idx="31">
                  <c:v>116.27</c:v>
                </c:pt>
                <c:pt idx="32">
                  <c:v>104.64</c:v>
                </c:pt>
                <c:pt idx="33">
                  <c:v>139.52000000000001</c:v>
                </c:pt>
                <c:pt idx="34">
                  <c:v>127.89</c:v>
                </c:pt>
                <c:pt idx="35">
                  <c:v>116.27</c:v>
                </c:pt>
                <c:pt idx="36">
                  <c:v>151.15</c:v>
                </c:pt>
                <c:pt idx="37">
                  <c:v>81.39</c:v>
                </c:pt>
                <c:pt idx="38">
                  <c:v>93.01</c:v>
                </c:pt>
                <c:pt idx="39">
                  <c:v>93.01</c:v>
                </c:pt>
                <c:pt idx="40">
                  <c:v>125.23</c:v>
                </c:pt>
                <c:pt idx="41">
                  <c:v>113.85</c:v>
                </c:pt>
                <c:pt idx="42">
                  <c:v>148</c:v>
                </c:pt>
                <c:pt idx="43">
                  <c:v>79.69</c:v>
                </c:pt>
                <c:pt idx="44">
                  <c:v>91.08</c:v>
                </c:pt>
                <c:pt idx="45">
                  <c:v>102.46</c:v>
                </c:pt>
                <c:pt idx="46">
                  <c:v>79.69</c:v>
                </c:pt>
                <c:pt idx="47">
                  <c:v>148</c:v>
                </c:pt>
                <c:pt idx="48">
                  <c:v>102.46</c:v>
                </c:pt>
                <c:pt idx="49">
                  <c:v>113.85</c:v>
                </c:pt>
                <c:pt idx="50">
                  <c:v>45.54</c:v>
                </c:pt>
                <c:pt idx="51">
                  <c:v>113.85</c:v>
                </c:pt>
                <c:pt idx="52">
                  <c:v>56.92</c:v>
                </c:pt>
                <c:pt idx="53">
                  <c:v>136.61000000000001</c:v>
                </c:pt>
                <c:pt idx="54">
                  <c:v>125.23</c:v>
                </c:pt>
                <c:pt idx="55">
                  <c:v>102.46</c:v>
                </c:pt>
                <c:pt idx="56">
                  <c:v>102.46</c:v>
                </c:pt>
                <c:pt idx="57">
                  <c:v>136.61000000000001</c:v>
                </c:pt>
                <c:pt idx="58">
                  <c:v>91.08</c:v>
                </c:pt>
                <c:pt idx="59">
                  <c:v>102.46</c:v>
                </c:pt>
                <c:pt idx="60">
                  <c:v>167.7</c:v>
                </c:pt>
                <c:pt idx="61">
                  <c:v>152.44999999999999</c:v>
                </c:pt>
                <c:pt idx="62">
                  <c:v>106.72</c:v>
                </c:pt>
                <c:pt idx="63">
                  <c:v>152.44999999999999</c:v>
                </c:pt>
                <c:pt idx="64">
                  <c:v>152.44999999999999</c:v>
                </c:pt>
                <c:pt idx="65">
                  <c:v>152.44999999999999</c:v>
                </c:pt>
                <c:pt idx="66">
                  <c:v>213.43</c:v>
                </c:pt>
                <c:pt idx="67">
                  <c:v>213.43</c:v>
                </c:pt>
                <c:pt idx="68">
                  <c:v>137.21</c:v>
                </c:pt>
                <c:pt idx="69">
                  <c:v>198.19</c:v>
                </c:pt>
                <c:pt idx="70">
                  <c:v>152.44999999999999</c:v>
                </c:pt>
                <c:pt idx="71">
                  <c:v>137.21</c:v>
                </c:pt>
                <c:pt idx="72">
                  <c:v>198.19</c:v>
                </c:pt>
                <c:pt idx="73">
                  <c:v>198.19</c:v>
                </c:pt>
                <c:pt idx="74">
                  <c:v>137.21</c:v>
                </c:pt>
                <c:pt idx="75">
                  <c:v>121.96</c:v>
                </c:pt>
                <c:pt idx="76">
                  <c:v>152.44999999999999</c:v>
                </c:pt>
                <c:pt idx="77">
                  <c:v>137.21</c:v>
                </c:pt>
                <c:pt idx="78">
                  <c:v>152.44999999999999</c:v>
                </c:pt>
                <c:pt idx="79">
                  <c:v>137.21</c:v>
                </c:pt>
                <c:pt idx="80">
                  <c:v>163.63999999999999</c:v>
                </c:pt>
                <c:pt idx="81">
                  <c:v>122.73</c:v>
                </c:pt>
                <c:pt idx="82">
                  <c:v>150.01</c:v>
                </c:pt>
                <c:pt idx="83">
                  <c:v>95.46</c:v>
                </c:pt>
                <c:pt idx="84">
                  <c:v>122.73</c:v>
                </c:pt>
                <c:pt idx="85">
                  <c:v>109.1</c:v>
                </c:pt>
                <c:pt idx="86">
                  <c:v>163.63999999999999</c:v>
                </c:pt>
                <c:pt idx="87">
                  <c:v>109.1</c:v>
                </c:pt>
                <c:pt idx="88">
                  <c:v>163.63999999999999</c:v>
                </c:pt>
                <c:pt idx="89">
                  <c:v>109.1</c:v>
                </c:pt>
                <c:pt idx="90">
                  <c:v>122.73</c:v>
                </c:pt>
                <c:pt idx="91">
                  <c:v>204.56</c:v>
                </c:pt>
                <c:pt idx="92">
                  <c:v>163.63999999999999</c:v>
                </c:pt>
                <c:pt idx="93">
                  <c:v>190.92</c:v>
                </c:pt>
                <c:pt idx="94">
                  <c:v>150.01</c:v>
                </c:pt>
                <c:pt idx="95">
                  <c:v>109.1</c:v>
                </c:pt>
                <c:pt idx="96">
                  <c:v>136.37</c:v>
                </c:pt>
                <c:pt idx="97">
                  <c:v>163.63999999999999</c:v>
                </c:pt>
                <c:pt idx="98">
                  <c:v>54.55</c:v>
                </c:pt>
                <c:pt idx="99">
                  <c:v>95.46</c:v>
                </c:pt>
                <c:pt idx="100">
                  <c:v>216.4</c:v>
                </c:pt>
                <c:pt idx="101">
                  <c:v>81.150000000000006</c:v>
                </c:pt>
                <c:pt idx="102">
                  <c:v>135.25</c:v>
                </c:pt>
                <c:pt idx="103">
                  <c:v>81.150000000000006</c:v>
                </c:pt>
                <c:pt idx="104">
                  <c:v>81.150000000000006</c:v>
                </c:pt>
                <c:pt idx="105">
                  <c:v>94.67</c:v>
                </c:pt>
                <c:pt idx="106">
                  <c:v>121.72</c:v>
                </c:pt>
                <c:pt idx="107">
                  <c:v>67.62</c:v>
                </c:pt>
                <c:pt idx="108">
                  <c:v>175.82</c:v>
                </c:pt>
                <c:pt idx="109">
                  <c:v>202.87</c:v>
                </c:pt>
                <c:pt idx="110">
                  <c:v>81.150000000000006</c:v>
                </c:pt>
                <c:pt idx="111">
                  <c:v>108.2</c:v>
                </c:pt>
                <c:pt idx="112">
                  <c:v>108.2</c:v>
                </c:pt>
                <c:pt idx="113">
                  <c:v>94.67</c:v>
                </c:pt>
                <c:pt idx="114">
                  <c:v>121.72</c:v>
                </c:pt>
                <c:pt idx="115">
                  <c:v>94.67</c:v>
                </c:pt>
                <c:pt idx="116">
                  <c:v>135.25</c:v>
                </c:pt>
                <c:pt idx="117">
                  <c:v>162.30000000000001</c:v>
                </c:pt>
                <c:pt idx="118">
                  <c:v>135.25</c:v>
                </c:pt>
                <c:pt idx="119">
                  <c:v>175.82</c:v>
                </c:pt>
                <c:pt idx="120">
                  <c:v>145.77000000000001</c:v>
                </c:pt>
                <c:pt idx="121">
                  <c:v>172.28</c:v>
                </c:pt>
                <c:pt idx="122">
                  <c:v>106.02</c:v>
                </c:pt>
                <c:pt idx="123">
                  <c:v>132.52000000000001</c:v>
                </c:pt>
                <c:pt idx="124">
                  <c:v>119.27</c:v>
                </c:pt>
                <c:pt idx="125">
                  <c:v>119.27</c:v>
                </c:pt>
                <c:pt idx="126">
                  <c:v>79.510000000000005</c:v>
                </c:pt>
                <c:pt idx="127">
                  <c:v>79.510000000000005</c:v>
                </c:pt>
                <c:pt idx="128">
                  <c:v>159.02000000000001</c:v>
                </c:pt>
                <c:pt idx="129">
                  <c:v>145.77000000000001</c:v>
                </c:pt>
                <c:pt idx="130">
                  <c:v>172.28</c:v>
                </c:pt>
                <c:pt idx="131">
                  <c:v>238.54</c:v>
                </c:pt>
                <c:pt idx="132">
                  <c:v>132.52000000000001</c:v>
                </c:pt>
                <c:pt idx="133">
                  <c:v>225.29</c:v>
                </c:pt>
                <c:pt idx="134">
                  <c:v>145.77000000000001</c:v>
                </c:pt>
                <c:pt idx="135">
                  <c:v>172.28</c:v>
                </c:pt>
                <c:pt idx="136">
                  <c:v>159.02000000000001</c:v>
                </c:pt>
                <c:pt idx="137">
                  <c:v>119.27</c:v>
                </c:pt>
                <c:pt idx="138">
                  <c:v>106.02</c:v>
                </c:pt>
                <c:pt idx="139">
                  <c:v>119.27</c:v>
                </c:pt>
                <c:pt idx="140">
                  <c:v>132.78</c:v>
                </c:pt>
                <c:pt idx="141">
                  <c:v>79.67</c:v>
                </c:pt>
                <c:pt idx="142">
                  <c:v>79.67</c:v>
                </c:pt>
                <c:pt idx="143">
                  <c:v>132.78</c:v>
                </c:pt>
                <c:pt idx="144">
                  <c:v>199.16</c:v>
                </c:pt>
                <c:pt idx="145">
                  <c:v>239</c:v>
                </c:pt>
                <c:pt idx="146">
                  <c:v>212.44</c:v>
                </c:pt>
                <c:pt idx="147">
                  <c:v>106.22</c:v>
                </c:pt>
                <c:pt idx="148">
                  <c:v>106.22</c:v>
                </c:pt>
                <c:pt idx="149">
                  <c:v>119.5</c:v>
                </c:pt>
                <c:pt idx="150">
                  <c:v>119.5</c:v>
                </c:pt>
                <c:pt idx="151">
                  <c:v>106.22</c:v>
                </c:pt>
                <c:pt idx="152">
                  <c:v>132.78</c:v>
                </c:pt>
                <c:pt idx="153">
                  <c:v>92.94</c:v>
                </c:pt>
                <c:pt idx="154">
                  <c:v>92.94</c:v>
                </c:pt>
                <c:pt idx="155">
                  <c:v>119.5</c:v>
                </c:pt>
                <c:pt idx="156">
                  <c:v>172.61</c:v>
                </c:pt>
                <c:pt idx="157">
                  <c:v>172.61</c:v>
                </c:pt>
                <c:pt idx="158">
                  <c:v>159.33000000000001</c:v>
                </c:pt>
                <c:pt idx="159">
                  <c:v>146.05000000000001</c:v>
                </c:pt>
                <c:pt idx="160">
                  <c:v>121.88</c:v>
                </c:pt>
                <c:pt idx="161">
                  <c:v>135.41999999999999</c:v>
                </c:pt>
                <c:pt idx="162">
                  <c:v>135.41999999999999</c:v>
                </c:pt>
                <c:pt idx="163">
                  <c:v>148.96</c:v>
                </c:pt>
                <c:pt idx="164">
                  <c:v>121.88</c:v>
                </c:pt>
                <c:pt idx="165">
                  <c:v>162.5</c:v>
                </c:pt>
                <c:pt idx="166">
                  <c:v>121.88</c:v>
                </c:pt>
                <c:pt idx="167">
                  <c:v>81.25</c:v>
                </c:pt>
                <c:pt idx="168">
                  <c:v>81.25</c:v>
                </c:pt>
                <c:pt idx="169">
                  <c:v>94.79</c:v>
                </c:pt>
                <c:pt idx="170">
                  <c:v>94.79</c:v>
                </c:pt>
                <c:pt idx="171">
                  <c:v>108.34</c:v>
                </c:pt>
                <c:pt idx="172">
                  <c:v>135.41999999999999</c:v>
                </c:pt>
                <c:pt idx="173">
                  <c:v>148.96</c:v>
                </c:pt>
                <c:pt idx="174">
                  <c:v>121.88</c:v>
                </c:pt>
                <c:pt idx="175">
                  <c:v>121.88</c:v>
                </c:pt>
                <c:pt idx="176">
                  <c:v>135.41999999999999</c:v>
                </c:pt>
                <c:pt idx="177">
                  <c:v>189.59</c:v>
                </c:pt>
                <c:pt idx="178">
                  <c:v>135.41999999999999</c:v>
                </c:pt>
                <c:pt idx="179">
                  <c:v>135.41999999999999</c:v>
                </c:pt>
                <c:pt idx="180">
                  <c:v>164.37</c:v>
                </c:pt>
                <c:pt idx="181">
                  <c:v>136.97</c:v>
                </c:pt>
                <c:pt idx="182">
                  <c:v>95.88</c:v>
                </c:pt>
                <c:pt idx="183">
                  <c:v>150.66999999999999</c:v>
                </c:pt>
                <c:pt idx="184">
                  <c:v>82.18</c:v>
                </c:pt>
                <c:pt idx="185">
                  <c:v>178.07</c:v>
                </c:pt>
                <c:pt idx="186">
                  <c:v>123.28</c:v>
                </c:pt>
                <c:pt idx="187">
                  <c:v>178.07</c:v>
                </c:pt>
                <c:pt idx="188">
                  <c:v>136.97</c:v>
                </c:pt>
                <c:pt idx="189">
                  <c:v>95.88</c:v>
                </c:pt>
                <c:pt idx="190">
                  <c:v>82.18</c:v>
                </c:pt>
                <c:pt idx="191">
                  <c:v>109.58</c:v>
                </c:pt>
                <c:pt idx="192">
                  <c:v>136.97</c:v>
                </c:pt>
                <c:pt idx="193">
                  <c:v>164.37</c:v>
                </c:pt>
                <c:pt idx="194">
                  <c:v>164.37</c:v>
                </c:pt>
                <c:pt idx="195">
                  <c:v>191.76</c:v>
                </c:pt>
                <c:pt idx="196">
                  <c:v>219.16</c:v>
                </c:pt>
                <c:pt idx="197">
                  <c:v>82.18</c:v>
                </c:pt>
                <c:pt idx="198">
                  <c:v>136.97</c:v>
                </c:pt>
                <c:pt idx="199">
                  <c:v>150.66999999999999</c:v>
                </c:pt>
                <c:pt idx="200">
                  <c:v>109.42</c:v>
                </c:pt>
                <c:pt idx="201">
                  <c:v>123.1</c:v>
                </c:pt>
                <c:pt idx="202">
                  <c:v>109.42</c:v>
                </c:pt>
                <c:pt idx="203">
                  <c:v>136.78</c:v>
                </c:pt>
                <c:pt idx="204">
                  <c:v>136.78</c:v>
                </c:pt>
                <c:pt idx="205">
                  <c:v>123.1</c:v>
                </c:pt>
                <c:pt idx="206">
                  <c:v>68.39</c:v>
                </c:pt>
                <c:pt idx="207">
                  <c:v>150.46</c:v>
                </c:pt>
                <c:pt idx="208">
                  <c:v>164.13</c:v>
                </c:pt>
                <c:pt idx="209">
                  <c:v>205.17</c:v>
                </c:pt>
                <c:pt idx="210">
                  <c:v>109.42</c:v>
                </c:pt>
                <c:pt idx="211">
                  <c:v>164.13</c:v>
                </c:pt>
                <c:pt idx="212">
                  <c:v>259.88</c:v>
                </c:pt>
                <c:pt idx="213">
                  <c:v>273.56</c:v>
                </c:pt>
                <c:pt idx="214">
                  <c:v>164.13</c:v>
                </c:pt>
                <c:pt idx="215">
                  <c:v>205.17</c:v>
                </c:pt>
                <c:pt idx="216">
                  <c:v>205.17</c:v>
                </c:pt>
                <c:pt idx="217">
                  <c:v>123.1</c:v>
                </c:pt>
                <c:pt idx="218">
                  <c:v>123.1</c:v>
                </c:pt>
                <c:pt idx="219">
                  <c:v>109.42</c:v>
                </c:pt>
                <c:pt idx="220">
                  <c:v>107.06</c:v>
                </c:pt>
                <c:pt idx="221">
                  <c:v>120.44</c:v>
                </c:pt>
                <c:pt idx="222">
                  <c:v>93.68</c:v>
                </c:pt>
                <c:pt idx="223">
                  <c:v>120.44</c:v>
                </c:pt>
                <c:pt idx="224">
                  <c:v>160.59</c:v>
                </c:pt>
                <c:pt idx="225">
                  <c:v>173.98</c:v>
                </c:pt>
                <c:pt idx="226">
                  <c:v>133.83000000000001</c:v>
                </c:pt>
                <c:pt idx="227">
                  <c:v>200.74</c:v>
                </c:pt>
                <c:pt idx="228">
                  <c:v>120.44</c:v>
                </c:pt>
                <c:pt idx="229">
                  <c:v>147.21</c:v>
                </c:pt>
                <c:pt idx="230">
                  <c:v>133.83000000000001</c:v>
                </c:pt>
                <c:pt idx="231">
                  <c:v>93.68</c:v>
                </c:pt>
                <c:pt idx="232">
                  <c:v>93.68</c:v>
                </c:pt>
                <c:pt idx="233">
                  <c:v>120.44</c:v>
                </c:pt>
                <c:pt idx="234">
                  <c:v>147.21</c:v>
                </c:pt>
                <c:pt idx="235">
                  <c:v>160.59</c:v>
                </c:pt>
                <c:pt idx="236">
                  <c:v>160.59</c:v>
                </c:pt>
                <c:pt idx="237">
                  <c:v>214.12</c:v>
                </c:pt>
                <c:pt idx="238">
                  <c:v>107.06</c:v>
                </c:pt>
                <c:pt idx="239">
                  <c:v>120.44</c:v>
                </c:pt>
                <c:pt idx="240">
                  <c:v>162.94999999999999</c:v>
                </c:pt>
                <c:pt idx="241">
                  <c:v>135.80000000000001</c:v>
                </c:pt>
                <c:pt idx="242">
                  <c:v>135.80000000000001</c:v>
                </c:pt>
                <c:pt idx="243">
                  <c:v>122.22</c:v>
                </c:pt>
                <c:pt idx="244">
                  <c:v>190.11</c:v>
                </c:pt>
                <c:pt idx="245">
                  <c:v>176.53</c:v>
                </c:pt>
                <c:pt idx="246">
                  <c:v>135.80000000000001</c:v>
                </c:pt>
                <c:pt idx="247">
                  <c:v>135.80000000000001</c:v>
                </c:pt>
                <c:pt idx="248">
                  <c:v>135.80000000000001</c:v>
                </c:pt>
                <c:pt idx="249">
                  <c:v>162.94999999999999</c:v>
                </c:pt>
                <c:pt idx="250">
                  <c:v>81.48</c:v>
                </c:pt>
                <c:pt idx="251">
                  <c:v>108.64</c:v>
                </c:pt>
                <c:pt idx="252">
                  <c:v>135.80000000000001</c:v>
                </c:pt>
                <c:pt idx="253">
                  <c:v>67.900000000000006</c:v>
                </c:pt>
                <c:pt idx="254">
                  <c:v>176.53</c:v>
                </c:pt>
                <c:pt idx="255">
                  <c:v>95.06</c:v>
                </c:pt>
                <c:pt idx="256">
                  <c:v>203.69</c:v>
                </c:pt>
                <c:pt idx="257">
                  <c:v>217.27</c:v>
                </c:pt>
                <c:pt idx="258">
                  <c:v>176.53</c:v>
                </c:pt>
                <c:pt idx="259">
                  <c:v>190.11</c:v>
                </c:pt>
                <c:pt idx="260">
                  <c:v>117.46</c:v>
                </c:pt>
                <c:pt idx="261">
                  <c:v>132.13999999999999</c:v>
                </c:pt>
                <c:pt idx="262">
                  <c:v>146.82</c:v>
                </c:pt>
                <c:pt idx="263">
                  <c:v>117.46</c:v>
                </c:pt>
                <c:pt idx="264">
                  <c:v>117.46</c:v>
                </c:pt>
                <c:pt idx="265">
                  <c:v>44.05</c:v>
                </c:pt>
                <c:pt idx="266">
                  <c:v>102.77</c:v>
                </c:pt>
                <c:pt idx="267">
                  <c:v>161.5</c:v>
                </c:pt>
                <c:pt idx="268">
                  <c:v>146.82</c:v>
                </c:pt>
                <c:pt idx="269">
                  <c:v>161.5</c:v>
                </c:pt>
                <c:pt idx="270">
                  <c:v>102.77</c:v>
                </c:pt>
                <c:pt idx="271">
                  <c:v>132.13999999999999</c:v>
                </c:pt>
                <c:pt idx="272">
                  <c:v>102.77</c:v>
                </c:pt>
                <c:pt idx="273">
                  <c:v>117.46</c:v>
                </c:pt>
                <c:pt idx="274">
                  <c:v>161.5</c:v>
                </c:pt>
                <c:pt idx="275">
                  <c:v>176.19</c:v>
                </c:pt>
                <c:pt idx="276">
                  <c:v>176.19</c:v>
                </c:pt>
                <c:pt idx="277">
                  <c:v>117.46</c:v>
                </c:pt>
                <c:pt idx="278">
                  <c:v>102.77</c:v>
                </c:pt>
                <c:pt idx="279">
                  <c:v>190.87</c:v>
                </c:pt>
                <c:pt idx="280">
                  <c:v>189.66</c:v>
                </c:pt>
                <c:pt idx="281">
                  <c:v>116.72</c:v>
                </c:pt>
                <c:pt idx="282">
                  <c:v>145.88999999999999</c:v>
                </c:pt>
                <c:pt idx="283">
                  <c:v>145.88999999999999</c:v>
                </c:pt>
                <c:pt idx="284">
                  <c:v>160.47999999999999</c:v>
                </c:pt>
                <c:pt idx="285">
                  <c:v>131.30000000000001</c:v>
                </c:pt>
                <c:pt idx="286">
                  <c:v>116.72</c:v>
                </c:pt>
                <c:pt idx="287">
                  <c:v>72.95</c:v>
                </c:pt>
                <c:pt idx="288">
                  <c:v>160.47999999999999</c:v>
                </c:pt>
                <c:pt idx="289">
                  <c:v>189.66</c:v>
                </c:pt>
                <c:pt idx="290">
                  <c:v>116.72</c:v>
                </c:pt>
                <c:pt idx="291">
                  <c:v>102.13</c:v>
                </c:pt>
                <c:pt idx="292">
                  <c:v>175.07</c:v>
                </c:pt>
                <c:pt idx="293">
                  <c:v>131.30000000000001</c:v>
                </c:pt>
                <c:pt idx="294">
                  <c:v>131.30000000000001</c:v>
                </c:pt>
                <c:pt idx="295">
                  <c:v>87.54</c:v>
                </c:pt>
                <c:pt idx="296">
                  <c:v>175.07</c:v>
                </c:pt>
                <c:pt idx="297">
                  <c:v>145.88999999999999</c:v>
                </c:pt>
                <c:pt idx="298">
                  <c:v>160.47999999999999</c:v>
                </c:pt>
                <c:pt idx="299">
                  <c:v>175.07</c:v>
                </c:pt>
                <c:pt idx="300">
                  <c:v>131.733</c:v>
                </c:pt>
                <c:pt idx="301">
                  <c:v>115.26700000000001</c:v>
                </c:pt>
                <c:pt idx="302">
                  <c:v>181.13299999999998</c:v>
                </c:pt>
                <c:pt idx="303">
                  <c:v>148.19999999999999</c:v>
                </c:pt>
                <c:pt idx="304">
                  <c:v>131.733</c:v>
                </c:pt>
                <c:pt idx="305">
                  <c:v>131.733</c:v>
                </c:pt>
                <c:pt idx="306">
                  <c:v>148.19999999999999</c:v>
                </c:pt>
                <c:pt idx="307">
                  <c:v>197.6</c:v>
                </c:pt>
                <c:pt idx="308">
                  <c:v>148.19999999999999</c:v>
                </c:pt>
                <c:pt idx="309">
                  <c:v>181.13299999999998</c:v>
                </c:pt>
                <c:pt idx="310">
                  <c:v>131.733</c:v>
                </c:pt>
                <c:pt idx="311">
                  <c:v>65.86699999999999</c:v>
                </c:pt>
                <c:pt idx="312">
                  <c:v>197.6</c:v>
                </c:pt>
                <c:pt idx="313">
                  <c:v>115.26700000000001</c:v>
                </c:pt>
                <c:pt idx="314">
                  <c:v>197.6</c:v>
                </c:pt>
                <c:pt idx="315">
                  <c:v>197.6</c:v>
                </c:pt>
                <c:pt idx="316">
                  <c:v>131.733</c:v>
                </c:pt>
                <c:pt idx="317">
                  <c:v>82.332999999999998</c:v>
                </c:pt>
                <c:pt idx="318">
                  <c:v>131.733</c:v>
                </c:pt>
                <c:pt idx="319">
                  <c:v>98.8</c:v>
                </c:pt>
                <c:pt idx="320">
                  <c:v>252.96</c:v>
                </c:pt>
                <c:pt idx="321">
                  <c:v>142.29</c:v>
                </c:pt>
                <c:pt idx="322">
                  <c:v>158.1</c:v>
                </c:pt>
                <c:pt idx="323">
                  <c:v>110.67</c:v>
                </c:pt>
                <c:pt idx="324">
                  <c:v>158.1</c:v>
                </c:pt>
                <c:pt idx="325">
                  <c:v>126.48</c:v>
                </c:pt>
                <c:pt idx="326">
                  <c:v>126.48</c:v>
                </c:pt>
                <c:pt idx="327">
                  <c:v>126.48</c:v>
                </c:pt>
                <c:pt idx="328">
                  <c:v>142.29</c:v>
                </c:pt>
                <c:pt idx="329">
                  <c:v>142.29</c:v>
                </c:pt>
                <c:pt idx="330">
                  <c:v>110.67</c:v>
                </c:pt>
                <c:pt idx="331">
                  <c:v>126.48</c:v>
                </c:pt>
                <c:pt idx="332">
                  <c:v>126.48</c:v>
                </c:pt>
                <c:pt idx="333">
                  <c:v>94.86</c:v>
                </c:pt>
                <c:pt idx="334">
                  <c:v>94.86</c:v>
                </c:pt>
                <c:pt idx="335">
                  <c:v>142.29</c:v>
                </c:pt>
                <c:pt idx="336">
                  <c:v>110.67</c:v>
                </c:pt>
                <c:pt idx="337">
                  <c:v>94.86</c:v>
                </c:pt>
                <c:pt idx="338">
                  <c:v>79.05</c:v>
                </c:pt>
                <c:pt idx="339">
                  <c:v>126.48</c:v>
                </c:pt>
                <c:pt idx="340">
                  <c:v>243.55</c:v>
                </c:pt>
                <c:pt idx="341">
                  <c:v>243.55</c:v>
                </c:pt>
                <c:pt idx="342">
                  <c:v>229.23</c:v>
                </c:pt>
                <c:pt idx="343">
                  <c:v>214.9</c:v>
                </c:pt>
                <c:pt idx="344">
                  <c:v>243.55</c:v>
                </c:pt>
                <c:pt idx="345">
                  <c:v>200.57</c:v>
                </c:pt>
                <c:pt idx="346">
                  <c:v>128.94</c:v>
                </c:pt>
                <c:pt idx="347">
                  <c:v>143.27000000000001</c:v>
                </c:pt>
                <c:pt idx="348">
                  <c:v>257.88</c:v>
                </c:pt>
                <c:pt idx="349">
                  <c:v>214.9</c:v>
                </c:pt>
                <c:pt idx="350">
                  <c:v>315.19</c:v>
                </c:pt>
                <c:pt idx="351">
                  <c:v>300.86</c:v>
                </c:pt>
                <c:pt idx="352">
                  <c:v>143.27000000000001</c:v>
                </c:pt>
                <c:pt idx="353">
                  <c:v>214.9</c:v>
                </c:pt>
                <c:pt idx="354">
                  <c:v>186.25</c:v>
                </c:pt>
                <c:pt idx="355">
                  <c:v>229.23</c:v>
                </c:pt>
                <c:pt idx="356">
                  <c:v>200.57</c:v>
                </c:pt>
                <c:pt idx="357">
                  <c:v>257.88</c:v>
                </c:pt>
                <c:pt idx="358">
                  <c:v>186.25</c:v>
                </c:pt>
                <c:pt idx="359">
                  <c:v>157.59</c:v>
                </c:pt>
              </c:numCache>
            </c:numRef>
          </c:xVal>
          <c:yVal>
            <c:numRef>
              <c:f>成熟期散布図!$I$4:$I$363</c:f>
              <c:numCache>
                <c:formatCode>General</c:formatCode>
                <c:ptCount val="360"/>
                <c:pt idx="0">
                  <c:v>122.91</c:v>
                </c:pt>
                <c:pt idx="1">
                  <c:v>122.91</c:v>
                </c:pt>
                <c:pt idx="2">
                  <c:v>268.16000000000003</c:v>
                </c:pt>
                <c:pt idx="3">
                  <c:v>145.25</c:v>
                </c:pt>
                <c:pt idx="4">
                  <c:v>44.69</c:v>
                </c:pt>
                <c:pt idx="5">
                  <c:v>100.56</c:v>
                </c:pt>
                <c:pt idx="6">
                  <c:v>111.73</c:v>
                </c:pt>
                <c:pt idx="7">
                  <c:v>178.77</c:v>
                </c:pt>
                <c:pt idx="8">
                  <c:v>167.6</c:v>
                </c:pt>
                <c:pt idx="9">
                  <c:v>268.16000000000003</c:v>
                </c:pt>
                <c:pt idx="10">
                  <c:v>189.94</c:v>
                </c:pt>
                <c:pt idx="11">
                  <c:v>100.56</c:v>
                </c:pt>
                <c:pt idx="12">
                  <c:v>134.08000000000001</c:v>
                </c:pt>
                <c:pt idx="13">
                  <c:v>167.6</c:v>
                </c:pt>
                <c:pt idx="14">
                  <c:v>167.6</c:v>
                </c:pt>
                <c:pt idx="15">
                  <c:v>223.46</c:v>
                </c:pt>
                <c:pt idx="16">
                  <c:v>134.08000000000001</c:v>
                </c:pt>
                <c:pt idx="17">
                  <c:v>111.73</c:v>
                </c:pt>
                <c:pt idx="18">
                  <c:v>89.39</c:v>
                </c:pt>
                <c:pt idx="19">
                  <c:v>134.08000000000001</c:v>
                </c:pt>
                <c:pt idx="20">
                  <c:v>313.92</c:v>
                </c:pt>
                <c:pt idx="21">
                  <c:v>104.64</c:v>
                </c:pt>
                <c:pt idx="22">
                  <c:v>162.77000000000001</c:v>
                </c:pt>
                <c:pt idx="23">
                  <c:v>174.4</c:v>
                </c:pt>
                <c:pt idx="24">
                  <c:v>174.4</c:v>
                </c:pt>
                <c:pt idx="25">
                  <c:v>209.28</c:v>
                </c:pt>
                <c:pt idx="26">
                  <c:v>232.54</c:v>
                </c:pt>
                <c:pt idx="27">
                  <c:v>174.4</c:v>
                </c:pt>
                <c:pt idx="28">
                  <c:v>151.15</c:v>
                </c:pt>
                <c:pt idx="29">
                  <c:v>220.91</c:v>
                </c:pt>
                <c:pt idx="30">
                  <c:v>162.77000000000001</c:v>
                </c:pt>
                <c:pt idx="31">
                  <c:v>174.4</c:v>
                </c:pt>
                <c:pt idx="32">
                  <c:v>220.91</c:v>
                </c:pt>
                <c:pt idx="33">
                  <c:v>209.28</c:v>
                </c:pt>
                <c:pt idx="34">
                  <c:v>232.54</c:v>
                </c:pt>
                <c:pt idx="35">
                  <c:v>151.15</c:v>
                </c:pt>
                <c:pt idx="36">
                  <c:v>279.04000000000002</c:v>
                </c:pt>
                <c:pt idx="37">
                  <c:v>197.65</c:v>
                </c:pt>
                <c:pt idx="38">
                  <c:v>104.64</c:v>
                </c:pt>
                <c:pt idx="39">
                  <c:v>69.760000000000005</c:v>
                </c:pt>
                <c:pt idx="40">
                  <c:v>250.46</c:v>
                </c:pt>
                <c:pt idx="41">
                  <c:v>250.46</c:v>
                </c:pt>
                <c:pt idx="42">
                  <c:v>296</c:v>
                </c:pt>
                <c:pt idx="43">
                  <c:v>182.15</c:v>
                </c:pt>
                <c:pt idx="44">
                  <c:v>170.77</c:v>
                </c:pt>
                <c:pt idx="45">
                  <c:v>261.83999999999997</c:v>
                </c:pt>
                <c:pt idx="46">
                  <c:v>159.38</c:v>
                </c:pt>
                <c:pt idx="47">
                  <c:v>284.61</c:v>
                </c:pt>
                <c:pt idx="48">
                  <c:v>113.85</c:v>
                </c:pt>
                <c:pt idx="49">
                  <c:v>125.23</c:v>
                </c:pt>
                <c:pt idx="50">
                  <c:v>79.69</c:v>
                </c:pt>
                <c:pt idx="51">
                  <c:v>102.46</c:v>
                </c:pt>
                <c:pt idx="52">
                  <c:v>79.69</c:v>
                </c:pt>
                <c:pt idx="53">
                  <c:v>318.77</c:v>
                </c:pt>
                <c:pt idx="54">
                  <c:v>341.54</c:v>
                </c:pt>
                <c:pt idx="55">
                  <c:v>170.77</c:v>
                </c:pt>
                <c:pt idx="56">
                  <c:v>250.46</c:v>
                </c:pt>
                <c:pt idx="57">
                  <c:v>193.54</c:v>
                </c:pt>
                <c:pt idx="58">
                  <c:v>182.15</c:v>
                </c:pt>
                <c:pt idx="59">
                  <c:v>148</c:v>
                </c:pt>
                <c:pt idx="60">
                  <c:v>106.72</c:v>
                </c:pt>
                <c:pt idx="61">
                  <c:v>167.7</c:v>
                </c:pt>
                <c:pt idx="62">
                  <c:v>60.98</c:v>
                </c:pt>
                <c:pt idx="63">
                  <c:v>198.19</c:v>
                </c:pt>
                <c:pt idx="64">
                  <c:v>198.19</c:v>
                </c:pt>
                <c:pt idx="65">
                  <c:v>167.7</c:v>
                </c:pt>
                <c:pt idx="66">
                  <c:v>152.44999999999999</c:v>
                </c:pt>
                <c:pt idx="67">
                  <c:v>198.19</c:v>
                </c:pt>
                <c:pt idx="68">
                  <c:v>106.72</c:v>
                </c:pt>
                <c:pt idx="69">
                  <c:v>167.7</c:v>
                </c:pt>
                <c:pt idx="70">
                  <c:v>182.94</c:v>
                </c:pt>
                <c:pt idx="71">
                  <c:v>213.43</c:v>
                </c:pt>
                <c:pt idx="72">
                  <c:v>91.47</c:v>
                </c:pt>
                <c:pt idx="73">
                  <c:v>198.19</c:v>
                </c:pt>
                <c:pt idx="74">
                  <c:v>167.7</c:v>
                </c:pt>
                <c:pt idx="75">
                  <c:v>167.7</c:v>
                </c:pt>
                <c:pt idx="76">
                  <c:v>152.44999999999999</c:v>
                </c:pt>
                <c:pt idx="77">
                  <c:v>198.19</c:v>
                </c:pt>
                <c:pt idx="78">
                  <c:v>198.19</c:v>
                </c:pt>
                <c:pt idx="79">
                  <c:v>152.44999999999999</c:v>
                </c:pt>
                <c:pt idx="80">
                  <c:v>150.01</c:v>
                </c:pt>
                <c:pt idx="81">
                  <c:v>122.73</c:v>
                </c:pt>
                <c:pt idx="82">
                  <c:v>109.1</c:v>
                </c:pt>
                <c:pt idx="83">
                  <c:v>136.37</c:v>
                </c:pt>
                <c:pt idx="84">
                  <c:v>177.28</c:v>
                </c:pt>
                <c:pt idx="85">
                  <c:v>109.1</c:v>
                </c:pt>
                <c:pt idx="86">
                  <c:v>150.01</c:v>
                </c:pt>
                <c:pt idx="87">
                  <c:v>190.92</c:v>
                </c:pt>
                <c:pt idx="88">
                  <c:v>122.73</c:v>
                </c:pt>
                <c:pt idx="89">
                  <c:v>136.37</c:v>
                </c:pt>
                <c:pt idx="90">
                  <c:v>122.73</c:v>
                </c:pt>
                <c:pt idx="91">
                  <c:v>177.28</c:v>
                </c:pt>
                <c:pt idx="92">
                  <c:v>163.63999999999999</c:v>
                </c:pt>
                <c:pt idx="93">
                  <c:v>190.92</c:v>
                </c:pt>
                <c:pt idx="94">
                  <c:v>204.56</c:v>
                </c:pt>
                <c:pt idx="95">
                  <c:v>136.37</c:v>
                </c:pt>
                <c:pt idx="96">
                  <c:v>150.01</c:v>
                </c:pt>
                <c:pt idx="97">
                  <c:v>218.19</c:v>
                </c:pt>
                <c:pt idx="98">
                  <c:v>163.63999999999999</c:v>
                </c:pt>
                <c:pt idx="99">
                  <c:v>109.1</c:v>
                </c:pt>
                <c:pt idx="100">
                  <c:v>392.22</c:v>
                </c:pt>
                <c:pt idx="101">
                  <c:v>324.60000000000002</c:v>
                </c:pt>
                <c:pt idx="102">
                  <c:v>270.5</c:v>
                </c:pt>
                <c:pt idx="103">
                  <c:v>229.92</c:v>
                </c:pt>
                <c:pt idx="104">
                  <c:v>202.87</c:v>
                </c:pt>
                <c:pt idx="105">
                  <c:v>243.45</c:v>
                </c:pt>
                <c:pt idx="106">
                  <c:v>229.92</c:v>
                </c:pt>
                <c:pt idx="107">
                  <c:v>243.45</c:v>
                </c:pt>
                <c:pt idx="108">
                  <c:v>513.95000000000005</c:v>
                </c:pt>
                <c:pt idx="109">
                  <c:v>189.35</c:v>
                </c:pt>
                <c:pt idx="110">
                  <c:v>284.02</c:v>
                </c:pt>
                <c:pt idx="111">
                  <c:v>270.5</c:v>
                </c:pt>
                <c:pt idx="112">
                  <c:v>175.82</c:v>
                </c:pt>
                <c:pt idx="113">
                  <c:v>365.17</c:v>
                </c:pt>
                <c:pt idx="114">
                  <c:v>256.97000000000003</c:v>
                </c:pt>
                <c:pt idx="115">
                  <c:v>351.65</c:v>
                </c:pt>
                <c:pt idx="116">
                  <c:v>432.8</c:v>
                </c:pt>
                <c:pt idx="117">
                  <c:v>365.17</c:v>
                </c:pt>
                <c:pt idx="118">
                  <c:v>500.42</c:v>
                </c:pt>
                <c:pt idx="119">
                  <c:v>378.7</c:v>
                </c:pt>
                <c:pt idx="120">
                  <c:v>185.53</c:v>
                </c:pt>
                <c:pt idx="121">
                  <c:v>251.79</c:v>
                </c:pt>
                <c:pt idx="122">
                  <c:v>424.07</c:v>
                </c:pt>
                <c:pt idx="123">
                  <c:v>251.79</c:v>
                </c:pt>
                <c:pt idx="124">
                  <c:v>530.08000000000004</c:v>
                </c:pt>
                <c:pt idx="125">
                  <c:v>463.82</c:v>
                </c:pt>
                <c:pt idx="126">
                  <c:v>106.02</c:v>
                </c:pt>
                <c:pt idx="127">
                  <c:v>331.3</c:v>
                </c:pt>
                <c:pt idx="128">
                  <c:v>265.04000000000002</c:v>
                </c:pt>
                <c:pt idx="129">
                  <c:v>371.06</c:v>
                </c:pt>
                <c:pt idx="130">
                  <c:v>304.8</c:v>
                </c:pt>
                <c:pt idx="131">
                  <c:v>357.81</c:v>
                </c:pt>
                <c:pt idx="132">
                  <c:v>225.29</c:v>
                </c:pt>
                <c:pt idx="133">
                  <c:v>265.04000000000002</c:v>
                </c:pt>
                <c:pt idx="134">
                  <c:v>251.79</c:v>
                </c:pt>
                <c:pt idx="135">
                  <c:v>278.29000000000002</c:v>
                </c:pt>
                <c:pt idx="136">
                  <c:v>318.05</c:v>
                </c:pt>
                <c:pt idx="137">
                  <c:v>198.78</c:v>
                </c:pt>
                <c:pt idx="138">
                  <c:v>304.8</c:v>
                </c:pt>
                <c:pt idx="139">
                  <c:v>212.03</c:v>
                </c:pt>
                <c:pt idx="140">
                  <c:v>132.78</c:v>
                </c:pt>
                <c:pt idx="141">
                  <c:v>132.78</c:v>
                </c:pt>
                <c:pt idx="142">
                  <c:v>185.89</c:v>
                </c:pt>
                <c:pt idx="143">
                  <c:v>252.27</c:v>
                </c:pt>
                <c:pt idx="144">
                  <c:v>225.72</c:v>
                </c:pt>
                <c:pt idx="145">
                  <c:v>385.05</c:v>
                </c:pt>
                <c:pt idx="146">
                  <c:v>239</c:v>
                </c:pt>
                <c:pt idx="147">
                  <c:v>239</c:v>
                </c:pt>
                <c:pt idx="148">
                  <c:v>225.72</c:v>
                </c:pt>
                <c:pt idx="149">
                  <c:v>185.89</c:v>
                </c:pt>
                <c:pt idx="150">
                  <c:v>239</c:v>
                </c:pt>
                <c:pt idx="151">
                  <c:v>252.27</c:v>
                </c:pt>
                <c:pt idx="152">
                  <c:v>265.55</c:v>
                </c:pt>
                <c:pt idx="153">
                  <c:v>119.5</c:v>
                </c:pt>
                <c:pt idx="154">
                  <c:v>159.33000000000001</c:v>
                </c:pt>
                <c:pt idx="155">
                  <c:v>159.33000000000001</c:v>
                </c:pt>
                <c:pt idx="156">
                  <c:v>185.89</c:v>
                </c:pt>
                <c:pt idx="157">
                  <c:v>132.78</c:v>
                </c:pt>
                <c:pt idx="158">
                  <c:v>185.89</c:v>
                </c:pt>
                <c:pt idx="159">
                  <c:v>172.61</c:v>
                </c:pt>
                <c:pt idx="160">
                  <c:v>365.63</c:v>
                </c:pt>
                <c:pt idx="161">
                  <c:v>297.92</c:v>
                </c:pt>
                <c:pt idx="162">
                  <c:v>311.47000000000003</c:v>
                </c:pt>
                <c:pt idx="163">
                  <c:v>325.01</c:v>
                </c:pt>
                <c:pt idx="164">
                  <c:v>257.3</c:v>
                </c:pt>
                <c:pt idx="165">
                  <c:v>352.09</c:v>
                </c:pt>
                <c:pt idx="166">
                  <c:v>203.13</c:v>
                </c:pt>
                <c:pt idx="167">
                  <c:v>162.5</c:v>
                </c:pt>
                <c:pt idx="168">
                  <c:v>216.67</c:v>
                </c:pt>
                <c:pt idx="169">
                  <c:v>216.67</c:v>
                </c:pt>
                <c:pt idx="170">
                  <c:v>257.3</c:v>
                </c:pt>
                <c:pt idx="171">
                  <c:v>270.83999999999997</c:v>
                </c:pt>
                <c:pt idx="172">
                  <c:v>311.47000000000003</c:v>
                </c:pt>
                <c:pt idx="173">
                  <c:v>270.83999999999997</c:v>
                </c:pt>
                <c:pt idx="174">
                  <c:v>148.96</c:v>
                </c:pt>
                <c:pt idx="175">
                  <c:v>176.05</c:v>
                </c:pt>
                <c:pt idx="176">
                  <c:v>325.01</c:v>
                </c:pt>
                <c:pt idx="177">
                  <c:v>189.59</c:v>
                </c:pt>
                <c:pt idx="178">
                  <c:v>162.5</c:v>
                </c:pt>
                <c:pt idx="179">
                  <c:v>176.05</c:v>
                </c:pt>
                <c:pt idx="180">
                  <c:v>178.07</c:v>
                </c:pt>
                <c:pt idx="181">
                  <c:v>260.25</c:v>
                </c:pt>
                <c:pt idx="182">
                  <c:v>164.37</c:v>
                </c:pt>
                <c:pt idx="183">
                  <c:v>287.64999999999998</c:v>
                </c:pt>
                <c:pt idx="184">
                  <c:v>178.07</c:v>
                </c:pt>
                <c:pt idx="185">
                  <c:v>424.62</c:v>
                </c:pt>
                <c:pt idx="186">
                  <c:v>246.55</c:v>
                </c:pt>
                <c:pt idx="187">
                  <c:v>356.13</c:v>
                </c:pt>
                <c:pt idx="188">
                  <c:v>315.04000000000002</c:v>
                </c:pt>
                <c:pt idx="189">
                  <c:v>260.25</c:v>
                </c:pt>
                <c:pt idx="190">
                  <c:v>287.64999999999998</c:v>
                </c:pt>
                <c:pt idx="191">
                  <c:v>260.25</c:v>
                </c:pt>
                <c:pt idx="192">
                  <c:v>369.83</c:v>
                </c:pt>
                <c:pt idx="193">
                  <c:v>205.46</c:v>
                </c:pt>
                <c:pt idx="194">
                  <c:v>191.76</c:v>
                </c:pt>
                <c:pt idx="195">
                  <c:v>369.83</c:v>
                </c:pt>
                <c:pt idx="196">
                  <c:v>479.41</c:v>
                </c:pt>
                <c:pt idx="197">
                  <c:v>178.07</c:v>
                </c:pt>
                <c:pt idx="198">
                  <c:v>328.74</c:v>
                </c:pt>
                <c:pt idx="199">
                  <c:v>260.25</c:v>
                </c:pt>
                <c:pt idx="200">
                  <c:v>109.42</c:v>
                </c:pt>
                <c:pt idx="201">
                  <c:v>273.56</c:v>
                </c:pt>
                <c:pt idx="202">
                  <c:v>314.58999999999997</c:v>
                </c:pt>
                <c:pt idx="203">
                  <c:v>382.98</c:v>
                </c:pt>
                <c:pt idx="204">
                  <c:v>328.27</c:v>
                </c:pt>
                <c:pt idx="205">
                  <c:v>177.81</c:v>
                </c:pt>
                <c:pt idx="206">
                  <c:v>300.91000000000003</c:v>
                </c:pt>
                <c:pt idx="207">
                  <c:v>191.49</c:v>
                </c:pt>
                <c:pt idx="208">
                  <c:v>164.13</c:v>
                </c:pt>
                <c:pt idx="209">
                  <c:v>205.17</c:v>
                </c:pt>
                <c:pt idx="210">
                  <c:v>218.84</c:v>
                </c:pt>
                <c:pt idx="211">
                  <c:v>259.88</c:v>
                </c:pt>
                <c:pt idx="212">
                  <c:v>382.98</c:v>
                </c:pt>
                <c:pt idx="213">
                  <c:v>410.33</c:v>
                </c:pt>
                <c:pt idx="214">
                  <c:v>287.23</c:v>
                </c:pt>
                <c:pt idx="215">
                  <c:v>287.23</c:v>
                </c:pt>
                <c:pt idx="216">
                  <c:v>382.98</c:v>
                </c:pt>
                <c:pt idx="217">
                  <c:v>109.42</c:v>
                </c:pt>
                <c:pt idx="218">
                  <c:v>164.13</c:v>
                </c:pt>
                <c:pt idx="219">
                  <c:v>164.13</c:v>
                </c:pt>
                <c:pt idx="220">
                  <c:v>294.42</c:v>
                </c:pt>
                <c:pt idx="221">
                  <c:v>120.44</c:v>
                </c:pt>
                <c:pt idx="222">
                  <c:v>133.83000000000001</c:v>
                </c:pt>
                <c:pt idx="223">
                  <c:v>240.89</c:v>
                </c:pt>
                <c:pt idx="224">
                  <c:v>254.27</c:v>
                </c:pt>
                <c:pt idx="225">
                  <c:v>334.57</c:v>
                </c:pt>
                <c:pt idx="226">
                  <c:v>227.51</c:v>
                </c:pt>
                <c:pt idx="227">
                  <c:v>240.89</c:v>
                </c:pt>
                <c:pt idx="228">
                  <c:v>321.19</c:v>
                </c:pt>
                <c:pt idx="229">
                  <c:v>240.89</c:v>
                </c:pt>
                <c:pt idx="230">
                  <c:v>240.89</c:v>
                </c:pt>
                <c:pt idx="231">
                  <c:v>147.21</c:v>
                </c:pt>
                <c:pt idx="232">
                  <c:v>133.83000000000001</c:v>
                </c:pt>
                <c:pt idx="233">
                  <c:v>147.21</c:v>
                </c:pt>
                <c:pt idx="234">
                  <c:v>187.36</c:v>
                </c:pt>
                <c:pt idx="235">
                  <c:v>200.74</c:v>
                </c:pt>
                <c:pt idx="236">
                  <c:v>321.19</c:v>
                </c:pt>
                <c:pt idx="237">
                  <c:v>200.74</c:v>
                </c:pt>
                <c:pt idx="238">
                  <c:v>147.21</c:v>
                </c:pt>
                <c:pt idx="239">
                  <c:v>160.59</c:v>
                </c:pt>
                <c:pt idx="240">
                  <c:v>244.43</c:v>
                </c:pt>
                <c:pt idx="241">
                  <c:v>190.11</c:v>
                </c:pt>
                <c:pt idx="242">
                  <c:v>203.69</c:v>
                </c:pt>
                <c:pt idx="243">
                  <c:v>312.33</c:v>
                </c:pt>
                <c:pt idx="244">
                  <c:v>298.75</c:v>
                </c:pt>
                <c:pt idx="245">
                  <c:v>190.11</c:v>
                </c:pt>
                <c:pt idx="246">
                  <c:v>190.11</c:v>
                </c:pt>
                <c:pt idx="247">
                  <c:v>407.39</c:v>
                </c:pt>
                <c:pt idx="248">
                  <c:v>176.53</c:v>
                </c:pt>
                <c:pt idx="249">
                  <c:v>203.69</c:v>
                </c:pt>
                <c:pt idx="250">
                  <c:v>149.38</c:v>
                </c:pt>
                <c:pt idx="251">
                  <c:v>162.94999999999999</c:v>
                </c:pt>
                <c:pt idx="252">
                  <c:v>285.17</c:v>
                </c:pt>
                <c:pt idx="253">
                  <c:v>122.22</c:v>
                </c:pt>
                <c:pt idx="254">
                  <c:v>95.06</c:v>
                </c:pt>
                <c:pt idx="255">
                  <c:v>217.27</c:v>
                </c:pt>
                <c:pt idx="256">
                  <c:v>176.53</c:v>
                </c:pt>
                <c:pt idx="257">
                  <c:v>271.58999999999997</c:v>
                </c:pt>
                <c:pt idx="258">
                  <c:v>176.53</c:v>
                </c:pt>
                <c:pt idx="259">
                  <c:v>162.94999999999999</c:v>
                </c:pt>
                <c:pt idx="260">
                  <c:v>102.77</c:v>
                </c:pt>
                <c:pt idx="261">
                  <c:v>132.13999999999999</c:v>
                </c:pt>
                <c:pt idx="262">
                  <c:v>234.91</c:v>
                </c:pt>
                <c:pt idx="263">
                  <c:v>132.13999999999999</c:v>
                </c:pt>
                <c:pt idx="264">
                  <c:v>323.01</c:v>
                </c:pt>
                <c:pt idx="265">
                  <c:v>102.77</c:v>
                </c:pt>
                <c:pt idx="266">
                  <c:v>205.55</c:v>
                </c:pt>
                <c:pt idx="267">
                  <c:v>308.32</c:v>
                </c:pt>
                <c:pt idx="268">
                  <c:v>161.5</c:v>
                </c:pt>
                <c:pt idx="269">
                  <c:v>146.82</c:v>
                </c:pt>
                <c:pt idx="270">
                  <c:v>146.82</c:v>
                </c:pt>
                <c:pt idx="271">
                  <c:v>117.46</c:v>
                </c:pt>
                <c:pt idx="272">
                  <c:v>146.82</c:v>
                </c:pt>
                <c:pt idx="273">
                  <c:v>249.6</c:v>
                </c:pt>
                <c:pt idx="274">
                  <c:v>146.82</c:v>
                </c:pt>
                <c:pt idx="275">
                  <c:v>176.19</c:v>
                </c:pt>
                <c:pt idx="276">
                  <c:v>293.64</c:v>
                </c:pt>
                <c:pt idx="277">
                  <c:v>293.64</c:v>
                </c:pt>
                <c:pt idx="278">
                  <c:v>176.19</c:v>
                </c:pt>
                <c:pt idx="279">
                  <c:v>293.64</c:v>
                </c:pt>
                <c:pt idx="280">
                  <c:v>233.43</c:v>
                </c:pt>
                <c:pt idx="281">
                  <c:v>131.30000000000001</c:v>
                </c:pt>
                <c:pt idx="282">
                  <c:v>189.66</c:v>
                </c:pt>
                <c:pt idx="283">
                  <c:v>160.47999999999999</c:v>
                </c:pt>
                <c:pt idx="284">
                  <c:v>160.47999999999999</c:v>
                </c:pt>
                <c:pt idx="285">
                  <c:v>131.30000000000001</c:v>
                </c:pt>
                <c:pt idx="286">
                  <c:v>160.47999999999999</c:v>
                </c:pt>
                <c:pt idx="287">
                  <c:v>145.88999999999999</c:v>
                </c:pt>
                <c:pt idx="288">
                  <c:v>160.47999999999999</c:v>
                </c:pt>
                <c:pt idx="289">
                  <c:v>218.84</c:v>
                </c:pt>
                <c:pt idx="290">
                  <c:v>175.07</c:v>
                </c:pt>
                <c:pt idx="291">
                  <c:v>160.47999999999999</c:v>
                </c:pt>
                <c:pt idx="292">
                  <c:v>248.02</c:v>
                </c:pt>
                <c:pt idx="293">
                  <c:v>233.43</c:v>
                </c:pt>
                <c:pt idx="294">
                  <c:v>204.25</c:v>
                </c:pt>
                <c:pt idx="295">
                  <c:v>218.84</c:v>
                </c:pt>
                <c:pt idx="296">
                  <c:v>248.02</c:v>
                </c:pt>
                <c:pt idx="297">
                  <c:v>218.84</c:v>
                </c:pt>
                <c:pt idx="298">
                  <c:v>335.56</c:v>
                </c:pt>
                <c:pt idx="299">
                  <c:v>204.25</c:v>
                </c:pt>
                <c:pt idx="300">
                  <c:v>164.667</c:v>
                </c:pt>
                <c:pt idx="301">
                  <c:v>247</c:v>
                </c:pt>
                <c:pt idx="302">
                  <c:v>296.39999999999998</c:v>
                </c:pt>
                <c:pt idx="303">
                  <c:v>296.39999999999998</c:v>
                </c:pt>
                <c:pt idx="304">
                  <c:v>247</c:v>
                </c:pt>
                <c:pt idx="305">
                  <c:v>279.93299999999999</c:v>
                </c:pt>
                <c:pt idx="306">
                  <c:v>197.6</c:v>
                </c:pt>
                <c:pt idx="307">
                  <c:v>345.8</c:v>
                </c:pt>
                <c:pt idx="308">
                  <c:v>362.267</c:v>
                </c:pt>
                <c:pt idx="309">
                  <c:v>362.267</c:v>
                </c:pt>
                <c:pt idx="310">
                  <c:v>296.39999999999998</c:v>
                </c:pt>
                <c:pt idx="311">
                  <c:v>197.6</c:v>
                </c:pt>
                <c:pt idx="312">
                  <c:v>312.86700000000002</c:v>
                </c:pt>
                <c:pt idx="313">
                  <c:v>197.6</c:v>
                </c:pt>
                <c:pt idx="314">
                  <c:v>181.13299999999998</c:v>
                </c:pt>
                <c:pt idx="315">
                  <c:v>131.733</c:v>
                </c:pt>
                <c:pt idx="316">
                  <c:v>263.46699999999998</c:v>
                </c:pt>
                <c:pt idx="317">
                  <c:v>131.733</c:v>
                </c:pt>
                <c:pt idx="318">
                  <c:v>247</c:v>
                </c:pt>
                <c:pt idx="319">
                  <c:v>230.53299999999999</c:v>
                </c:pt>
                <c:pt idx="320">
                  <c:v>379.43</c:v>
                </c:pt>
                <c:pt idx="321">
                  <c:v>205.53</c:v>
                </c:pt>
                <c:pt idx="322">
                  <c:v>173.91</c:v>
                </c:pt>
                <c:pt idx="323">
                  <c:v>221.34</c:v>
                </c:pt>
                <c:pt idx="324">
                  <c:v>284.57</c:v>
                </c:pt>
                <c:pt idx="325">
                  <c:v>268.77</c:v>
                </c:pt>
                <c:pt idx="326">
                  <c:v>252.96</c:v>
                </c:pt>
                <c:pt idx="327">
                  <c:v>284.57</c:v>
                </c:pt>
                <c:pt idx="328">
                  <c:v>126.48</c:v>
                </c:pt>
                <c:pt idx="329">
                  <c:v>284.57</c:v>
                </c:pt>
                <c:pt idx="330">
                  <c:v>110.67</c:v>
                </c:pt>
                <c:pt idx="331">
                  <c:v>142.29</c:v>
                </c:pt>
                <c:pt idx="332">
                  <c:v>126.48</c:v>
                </c:pt>
                <c:pt idx="333">
                  <c:v>205.53</c:v>
                </c:pt>
                <c:pt idx="334">
                  <c:v>158.1</c:v>
                </c:pt>
                <c:pt idx="335">
                  <c:v>316.19</c:v>
                </c:pt>
                <c:pt idx="336">
                  <c:v>284.57</c:v>
                </c:pt>
                <c:pt idx="337">
                  <c:v>268.77</c:v>
                </c:pt>
                <c:pt idx="338">
                  <c:v>300.38</c:v>
                </c:pt>
                <c:pt idx="339">
                  <c:v>426.86</c:v>
                </c:pt>
                <c:pt idx="340">
                  <c:v>171.92</c:v>
                </c:pt>
                <c:pt idx="341">
                  <c:v>100.29</c:v>
                </c:pt>
                <c:pt idx="342">
                  <c:v>186.25</c:v>
                </c:pt>
                <c:pt idx="343">
                  <c:v>100.29</c:v>
                </c:pt>
                <c:pt idx="344">
                  <c:v>143.27000000000001</c:v>
                </c:pt>
                <c:pt idx="345">
                  <c:v>157.59</c:v>
                </c:pt>
                <c:pt idx="346">
                  <c:v>85.96</c:v>
                </c:pt>
                <c:pt idx="347">
                  <c:v>85.96</c:v>
                </c:pt>
                <c:pt idx="348">
                  <c:v>114.61</c:v>
                </c:pt>
                <c:pt idx="349">
                  <c:v>143.27000000000001</c:v>
                </c:pt>
                <c:pt idx="350">
                  <c:v>143.27000000000001</c:v>
                </c:pt>
                <c:pt idx="351">
                  <c:v>143.27000000000001</c:v>
                </c:pt>
                <c:pt idx="352">
                  <c:v>100.29</c:v>
                </c:pt>
                <c:pt idx="353">
                  <c:v>114.61</c:v>
                </c:pt>
                <c:pt idx="354">
                  <c:v>114.61</c:v>
                </c:pt>
                <c:pt idx="355">
                  <c:v>100.29</c:v>
                </c:pt>
                <c:pt idx="356">
                  <c:v>143.27000000000001</c:v>
                </c:pt>
                <c:pt idx="357">
                  <c:v>114.61</c:v>
                </c:pt>
                <c:pt idx="358">
                  <c:v>85.96</c:v>
                </c:pt>
                <c:pt idx="359">
                  <c:v>100.29</c:v>
                </c:pt>
              </c:numCache>
            </c:numRef>
          </c:yVal>
          <c:smooth val="0"/>
          <c:extLst>
            <c:ext xmlns:c16="http://schemas.microsoft.com/office/drawing/2014/chart" uri="{C3380CC4-5D6E-409C-BE32-E72D297353CC}">
              <c16:uniqueId val="{00000000-F625-0848-9566-121DA65EB886}"/>
            </c:ext>
          </c:extLst>
        </c:ser>
        <c:ser>
          <c:idx val="1"/>
          <c:order val="1"/>
          <c:tx>
            <c:v>GA</c:v>
          </c:tx>
          <c:spPr>
            <a:ln w="25400" cap="rnd">
              <a:noFill/>
              <a:round/>
            </a:ln>
            <a:effectLst/>
          </c:spPr>
          <c:marker>
            <c:symbol val="triangle"/>
            <c:size val="4"/>
            <c:spPr>
              <a:noFill/>
              <a:ln w="12700">
                <a:solidFill>
                  <a:schemeClr val="tx1"/>
                </a:solidFill>
              </a:ln>
              <a:effectLst/>
            </c:spPr>
          </c:marker>
          <c:xVal>
            <c:numRef>
              <c:f>成熟期散布図!$J$4:$J$363</c:f>
              <c:numCache>
                <c:formatCode>General</c:formatCode>
                <c:ptCount val="360"/>
                <c:pt idx="0">
                  <c:v>141.19954000000001</c:v>
                </c:pt>
                <c:pt idx="1">
                  <c:v>123.54960000000001</c:v>
                </c:pt>
                <c:pt idx="2">
                  <c:v>194.14937</c:v>
                </c:pt>
                <c:pt idx="3">
                  <c:v>141.19954000000001</c:v>
                </c:pt>
                <c:pt idx="4">
                  <c:v>194.14937</c:v>
                </c:pt>
                <c:pt idx="5">
                  <c:v>123.54960000000001</c:v>
                </c:pt>
                <c:pt idx="6">
                  <c:v>123.54960000000001</c:v>
                </c:pt>
                <c:pt idx="7">
                  <c:v>211.79930999999999</c:v>
                </c:pt>
                <c:pt idx="8">
                  <c:v>211.79930999999999</c:v>
                </c:pt>
                <c:pt idx="9">
                  <c:v>123.54960000000001</c:v>
                </c:pt>
                <c:pt idx="10">
                  <c:v>141.19954000000001</c:v>
                </c:pt>
                <c:pt idx="11">
                  <c:v>158.84949</c:v>
                </c:pt>
                <c:pt idx="12">
                  <c:v>123.54960000000001</c:v>
                </c:pt>
                <c:pt idx="13">
                  <c:v>105.89966</c:v>
                </c:pt>
                <c:pt idx="14">
                  <c:v>105.89966</c:v>
                </c:pt>
                <c:pt idx="15">
                  <c:v>141.19954000000001</c:v>
                </c:pt>
                <c:pt idx="16">
                  <c:v>158.84949</c:v>
                </c:pt>
                <c:pt idx="17">
                  <c:v>158.84949</c:v>
                </c:pt>
                <c:pt idx="18">
                  <c:v>194.14937</c:v>
                </c:pt>
                <c:pt idx="19">
                  <c:v>141.19954000000001</c:v>
                </c:pt>
                <c:pt idx="20">
                  <c:v>110</c:v>
                </c:pt>
                <c:pt idx="21">
                  <c:v>110</c:v>
                </c:pt>
                <c:pt idx="22">
                  <c:v>130</c:v>
                </c:pt>
                <c:pt idx="23">
                  <c:v>130</c:v>
                </c:pt>
                <c:pt idx="24">
                  <c:v>130</c:v>
                </c:pt>
                <c:pt idx="25">
                  <c:v>110</c:v>
                </c:pt>
                <c:pt idx="26">
                  <c:v>160</c:v>
                </c:pt>
                <c:pt idx="27">
                  <c:v>130</c:v>
                </c:pt>
                <c:pt idx="28">
                  <c:v>110</c:v>
                </c:pt>
                <c:pt idx="29">
                  <c:v>140</c:v>
                </c:pt>
                <c:pt idx="30">
                  <c:v>130</c:v>
                </c:pt>
                <c:pt idx="31">
                  <c:v>90</c:v>
                </c:pt>
                <c:pt idx="32">
                  <c:v>90</c:v>
                </c:pt>
                <c:pt idx="33">
                  <c:v>90</c:v>
                </c:pt>
                <c:pt idx="34">
                  <c:v>130</c:v>
                </c:pt>
                <c:pt idx="35">
                  <c:v>90</c:v>
                </c:pt>
                <c:pt idx="36">
                  <c:v>130</c:v>
                </c:pt>
                <c:pt idx="37">
                  <c:v>90</c:v>
                </c:pt>
                <c:pt idx="38">
                  <c:v>140</c:v>
                </c:pt>
                <c:pt idx="39">
                  <c:v>110</c:v>
                </c:pt>
                <c:pt idx="40">
                  <c:v>182</c:v>
                </c:pt>
                <c:pt idx="41">
                  <c:v>164</c:v>
                </c:pt>
                <c:pt idx="42">
                  <c:v>273</c:v>
                </c:pt>
                <c:pt idx="43">
                  <c:v>164</c:v>
                </c:pt>
                <c:pt idx="44">
                  <c:v>145</c:v>
                </c:pt>
                <c:pt idx="45">
                  <c:v>91</c:v>
                </c:pt>
                <c:pt idx="46">
                  <c:v>200</c:v>
                </c:pt>
                <c:pt idx="47">
                  <c:v>109.00000000000001</c:v>
                </c:pt>
                <c:pt idx="48">
                  <c:v>127</c:v>
                </c:pt>
                <c:pt idx="49">
                  <c:v>182</c:v>
                </c:pt>
                <c:pt idx="50">
                  <c:v>164</c:v>
                </c:pt>
                <c:pt idx="51">
                  <c:v>182</c:v>
                </c:pt>
                <c:pt idx="52">
                  <c:v>164</c:v>
                </c:pt>
                <c:pt idx="53">
                  <c:v>145</c:v>
                </c:pt>
                <c:pt idx="54">
                  <c:v>164</c:v>
                </c:pt>
                <c:pt idx="55">
                  <c:v>164</c:v>
                </c:pt>
                <c:pt idx="56">
                  <c:v>182</c:v>
                </c:pt>
                <c:pt idx="57">
                  <c:v>182</c:v>
                </c:pt>
                <c:pt idx="58">
                  <c:v>182</c:v>
                </c:pt>
                <c:pt idx="59">
                  <c:v>182</c:v>
                </c:pt>
                <c:pt idx="60">
                  <c:v>160</c:v>
                </c:pt>
                <c:pt idx="61">
                  <c:v>150</c:v>
                </c:pt>
                <c:pt idx="62">
                  <c:v>150</c:v>
                </c:pt>
                <c:pt idx="63">
                  <c:v>100</c:v>
                </c:pt>
                <c:pt idx="64">
                  <c:v>210</c:v>
                </c:pt>
                <c:pt idx="65">
                  <c:v>100</c:v>
                </c:pt>
                <c:pt idx="66">
                  <c:v>180</c:v>
                </c:pt>
                <c:pt idx="67">
                  <c:v>200</c:v>
                </c:pt>
                <c:pt idx="68">
                  <c:v>130</c:v>
                </c:pt>
                <c:pt idx="69">
                  <c:v>160</c:v>
                </c:pt>
                <c:pt idx="70">
                  <c:v>160</c:v>
                </c:pt>
                <c:pt idx="71">
                  <c:v>110</c:v>
                </c:pt>
                <c:pt idx="72">
                  <c:v>180</c:v>
                </c:pt>
                <c:pt idx="73">
                  <c:v>110</c:v>
                </c:pt>
                <c:pt idx="74">
                  <c:v>180</c:v>
                </c:pt>
                <c:pt idx="75">
                  <c:v>200</c:v>
                </c:pt>
                <c:pt idx="76">
                  <c:v>150</c:v>
                </c:pt>
                <c:pt idx="77">
                  <c:v>260</c:v>
                </c:pt>
                <c:pt idx="78">
                  <c:v>110</c:v>
                </c:pt>
                <c:pt idx="79">
                  <c:v>110</c:v>
                </c:pt>
                <c:pt idx="80">
                  <c:v>120</c:v>
                </c:pt>
                <c:pt idx="81">
                  <c:v>160</c:v>
                </c:pt>
                <c:pt idx="82">
                  <c:v>90</c:v>
                </c:pt>
                <c:pt idx="83">
                  <c:v>100</c:v>
                </c:pt>
                <c:pt idx="84">
                  <c:v>150</c:v>
                </c:pt>
                <c:pt idx="85">
                  <c:v>180</c:v>
                </c:pt>
                <c:pt idx="86">
                  <c:v>90</c:v>
                </c:pt>
                <c:pt idx="87">
                  <c:v>100</c:v>
                </c:pt>
                <c:pt idx="88">
                  <c:v>120</c:v>
                </c:pt>
                <c:pt idx="89">
                  <c:v>130</c:v>
                </c:pt>
                <c:pt idx="90">
                  <c:v>150</c:v>
                </c:pt>
                <c:pt idx="91">
                  <c:v>180</c:v>
                </c:pt>
                <c:pt idx="92">
                  <c:v>130</c:v>
                </c:pt>
                <c:pt idx="93">
                  <c:v>130</c:v>
                </c:pt>
                <c:pt idx="94">
                  <c:v>70</c:v>
                </c:pt>
                <c:pt idx="95">
                  <c:v>150</c:v>
                </c:pt>
                <c:pt idx="96">
                  <c:v>160</c:v>
                </c:pt>
                <c:pt idx="97">
                  <c:v>120</c:v>
                </c:pt>
                <c:pt idx="98">
                  <c:v>150</c:v>
                </c:pt>
                <c:pt idx="99">
                  <c:v>180</c:v>
                </c:pt>
                <c:pt idx="100">
                  <c:v>125.1</c:v>
                </c:pt>
                <c:pt idx="101">
                  <c:v>178.72</c:v>
                </c:pt>
                <c:pt idx="102">
                  <c:v>125.1</c:v>
                </c:pt>
                <c:pt idx="103">
                  <c:v>232.33</c:v>
                </c:pt>
                <c:pt idx="104">
                  <c:v>142.97</c:v>
                </c:pt>
                <c:pt idx="105">
                  <c:v>178.72</c:v>
                </c:pt>
                <c:pt idx="106">
                  <c:v>142.97</c:v>
                </c:pt>
                <c:pt idx="107">
                  <c:v>160.84</c:v>
                </c:pt>
                <c:pt idx="108">
                  <c:v>142.97</c:v>
                </c:pt>
                <c:pt idx="109">
                  <c:v>107.23</c:v>
                </c:pt>
                <c:pt idx="110">
                  <c:v>125.1</c:v>
                </c:pt>
                <c:pt idx="111">
                  <c:v>232.33</c:v>
                </c:pt>
                <c:pt idx="112">
                  <c:v>107.23</c:v>
                </c:pt>
                <c:pt idx="113">
                  <c:v>89.36</c:v>
                </c:pt>
                <c:pt idx="114">
                  <c:v>214.46</c:v>
                </c:pt>
                <c:pt idx="115">
                  <c:v>71.489999999999995</c:v>
                </c:pt>
                <c:pt idx="116">
                  <c:v>89.36</c:v>
                </c:pt>
                <c:pt idx="117">
                  <c:v>160.84</c:v>
                </c:pt>
                <c:pt idx="118">
                  <c:v>160.84</c:v>
                </c:pt>
                <c:pt idx="119">
                  <c:v>160.84</c:v>
                </c:pt>
                <c:pt idx="120">
                  <c:v>270.45999999999998</c:v>
                </c:pt>
                <c:pt idx="121">
                  <c:v>216.37</c:v>
                </c:pt>
                <c:pt idx="122">
                  <c:v>144.24</c:v>
                </c:pt>
                <c:pt idx="123">
                  <c:v>72.12</c:v>
                </c:pt>
                <c:pt idx="124">
                  <c:v>162.27000000000001</c:v>
                </c:pt>
                <c:pt idx="125">
                  <c:v>90.15</c:v>
                </c:pt>
                <c:pt idx="126">
                  <c:v>126.21</c:v>
                </c:pt>
                <c:pt idx="127">
                  <c:v>126.21</c:v>
                </c:pt>
                <c:pt idx="128">
                  <c:v>108.18</c:v>
                </c:pt>
                <c:pt idx="129">
                  <c:v>108.18</c:v>
                </c:pt>
                <c:pt idx="130">
                  <c:v>108.18</c:v>
                </c:pt>
                <c:pt idx="131">
                  <c:v>108.18</c:v>
                </c:pt>
                <c:pt idx="132">
                  <c:v>162.27000000000001</c:v>
                </c:pt>
                <c:pt idx="133">
                  <c:v>144.24</c:v>
                </c:pt>
                <c:pt idx="134">
                  <c:v>126.21</c:v>
                </c:pt>
                <c:pt idx="135">
                  <c:v>108.18</c:v>
                </c:pt>
                <c:pt idx="136">
                  <c:v>126.21</c:v>
                </c:pt>
                <c:pt idx="137">
                  <c:v>108.18</c:v>
                </c:pt>
                <c:pt idx="138">
                  <c:v>144.24</c:v>
                </c:pt>
                <c:pt idx="139">
                  <c:v>162.27000000000001</c:v>
                </c:pt>
                <c:pt idx="140">
                  <c:v>163.30942000000002</c:v>
                </c:pt>
                <c:pt idx="141">
                  <c:v>145.16392999999999</c:v>
                </c:pt>
                <c:pt idx="142">
                  <c:v>90.72744999999999</c:v>
                </c:pt>
                <c:pt idx="143">
                  <c:v>127.01844</c:v>
                </c:pt>
                <c:pt idx="144">
                  <c:v>181.45491000000001</c:v>
                </c:pt>
                <c:pt idx="145">
                  <c:v>145.16392999999999</c:v>
                </c:pt>
                <c:pt idx="146">
                  <c:v>108.87295</c:v>
                </c:pt>
                <c:pt idx="147">
                  <c:v>181.45491000000001</c:v>
                </c:pt>
                <c:pt idx="148">
                  <c:v>145.16392999999999</c:v>
                </c:pt>
                <c:pt idx="149">
                  <c:v>163.30942000000002</c:v>
                </c:pt>
                <c:pt idx="150">
                  <c:v>108.87295</c:v>
                </c:pt>
                <c:pt idx="151">
                  <c:v>90.72744999999999</c:v>
                </c:pt>
                <c:pt idx="152">
                  <c:v>90.72744999999999</c:v>
                </c:pt>
                <c:pt idx="153">
                  <c:v>127.01844</c:v>
                </c:pt>
                <c:pt idx="154">
                  <c:v>163.30942000000002</c:v>
                </c:pt>
                <c:pt idx="155">
                  <c:v>127.01844</c:v>
                </c:pt>
                <c:pt idx="156">
                  <c:v>127.01844</c:v>
                </c:pt>
                <c:pt idx="157">
                  <c:v>108.87295</c:v>
                </c:pt>
                <c:pt idx="158">
                  <c:v>90.72744999999999</c:v>
                </c:pt>
                <c:pt idx="159">
                  <c:v>127.01844</c:v>
                </c:pt>
                <c:pt idx="160">
                  <c:v>128.01</c:v>
                </c:pt>
                <c:pt idx="161">
                  <c:v>128.01</c:v>
                </c:pt>
                <c:pt idx="162">
                  <c:v>146.30000000000001</c:v>
                </c:pt>
                <c:pt idx="163">
                  <c:v>164.59</c:v>
                </c:pt>
                <c:pt idx="164">
                  <c:v>164.59</c:v>
                </c:pt>
                <c:pt idx="165">
                  <c:v>146.30000000000001</c:v>
                </c:pt>
                <c:pt idx="166">
                  <c:v>164.59</c:v>
                </c:pt>
                <c:pt idx="167">
                  <c:v>128.01</c:v>
                </c:pt>
                <c:pt idx="168">
                  <c:v>164.59</c:v>
                </c:pt>
                <c:pt idx="169">
                  <c:v>128.01</c:v>
                </c:pt>
                <c:pt idx="170">
                  <c:v>128.01</c:v>
                </c:pt>
                <c:pt idx="171">
                  <c:v>146.30000000000001</c:v>
                </c:pt>
                <c:pt idx="172">
                  <c:v>146.30000000000001</c:v>
                </c:pt>
                <c:pt idx="173">
                  <c:v>91.44</c:v>
                </c:pt>
                <c:pt idx="174">
                  <c:v>109.73</c:v>
                </c:pt>
                <c:pt idx="175">
                  <c:v>73.150000000000006</c:v>
                </c:pt>
                <c:pt idx="176">
                  <c:v>36.58</c:v>
                </c:pt>
                <c:pt idx="177">
                  <c:v>54.86</c:v>
                </c:pt>
                <c:pt idx="178">
                  <c:v>109.73</c:v>
                </c:pt>
                <c:pt idx="179">
                  <c:v>73.150000000000006</c:v>
                </c:pt>
                <c:pt idx="180">
                  <c:v>109.35</c:v>
                </c:pt>
                <c:pt idx="181">
                  <c:v>164.02</c:v>
                </c:pt>
                <c:pt idx="182">
                  <c:v>91.12</c:v>
                </c:pt>
                <c:pt idx="183">
                  <c:v>109.35</c:v>
                </c:pt>
                <c:pt idx="184">
                  <c:v>36.450000000000003</c:v>
                </c:pt>
                <c:pt idx="185">
                  <c:v>127.57</c:v>
                </c:pt>
                <c:pt idx="186">
                  <c:v>145.80000000000001</c:v>
                </c:pt>
                <c:pt idx="187">
                  <c:v>127.57</c:v>
                </c:pt>
                <c:pt idx="188">
                  <c:v>127.57</c:v>
                </c:pt>
                <c:pt idx="189">
                  <c:v>127.57</c:v>
                </c:pt>
                <c:pt idx="190">
                  <c:v>145.80000000000001</c:v>
                </c:pt>
                <c:pt idx="191">
                  <c:v>182.25</c:v>
                </c:pt>
                <c:pt idx="192">
                  <c:v>145.80000000000001</c:v>
                </c:pt>
                <c:pt idx="193">
                  <c:v>91.12</c:v>
                </c:pt>
                <c:pt idx="194">
                  <c:v>91.12</c:v>
                </c:pt>
                <c:pt idx="195">
                  <c:v>145.80000000000001</c:v>
                </c:pt>
                <c:pt idx="196">
                  <c:v>145.80000000000001</c:v>
                </c:pt>
                <c:pt idx="197">
                  <c:v>127.57</c:v>
                </c:pt>
                <c:pt idx="198">
                  <c:v>127.57</c:v>
                </c:pt>
                <c:pt idx="199">
                  <c:v>127.57</c:v>
                </c:pt>
                <c:pt idx="200">
                  <c:v>91.045000000000002</c:v>
                </c:pt>
                <c:pt idx="201">
                  <c:v>72.835999999999999</c:v>
                </c:pt>
                <c:pt idx="202">
                  <c:v>145.673</c:v>
                </c:pt>
                <c:pt idx="203">
                  <c:v>91.045000000000002</c:v>
                </c:pt>
                <c:pt idx="204">
                  <c:v>163.88200000000001</c:v>
                </c:pt>
                <c:pt idx="205">
                  <c:v>109.255</c:v>
                </c:pt>
                <c:pt idx="206">
                  <c:v>109.255</c:v>
                </c:pt>
                <c:pt idx="207">
                  <c:v>163.88200000000001</c:v>
                </c:pt>
                <c:pt idx="208">
                  <c:v>145.673</c:v>
                </c:pt>
                <c:pt idx="209">
                  <c:v>109.255</c:v>
                </c:pt>
                <c:pt idx="210">
                  <c:v>163.88200000000001</c:v>
                </c:pt>
                <c:pt idx="211">
                  <c:v>127.46400000000001</c:v>
                </c:pt>
                <c:pt idx="212">
                  <c:v>127.46400000000001</c:v>
                </c:pt>
                <c:pt idx="213">
                  <c:v>109.255</c:v>
                </c:pt>
                <c:pt idx="214">
                  <c:v>145.673</c:v>
                </c:pt>
                <c:pt idx="215">
                  <c:v>91.045000000000002</c:v>
                </c:pt>
                <c:pt idx="216">
                  <c:v>145.673</c:v>
                </c:pt>
                <c:pt idx="217">
                  <c:v>127.46400000000001</c:v>
                </c:pt>
                <c:pt idx="218">
                  <c:v>91.045000000000002</c:v>
                </c:pt>
                <c:pt idx="219">
                  <c:v>163.88200000000001</c:v>
                </c:pt>
                <c:pt idx="220">
                  <c:v>179.78</c:v>
                </c:pt>
                <c:pt idx="221">
                  <c:v>179.78</c:v>
                </c:pt>
                <c:pt idx="222">
                  <c:v>125.84</c:v>
                </c:pt>
                <c:pt idx="223">
                  <c:v>107.87</c:v>
                </c:pt>
                <c:pt idx="224">
                  <c:v>215.73</c:v>
                </c:pt>
                <c:pt idx="225">
                  <c:v>161.80000000000001</c:v>
                </c:pt>
                <c:pt idx="226">
                  <c:v>233.71</c:v>
                </c:pt>
                <c:pt idx="227">
                  <c:v>107.87</c:v>
                </c:pt>
                <c:pt idx="228">
                  <c:v>125.84</c:v>
                </c:pt>
                <c:pt idx="229">
                  <c:v>161.80000000000001</c:v>
                </c:pt>
                <c:pt idx="230">
                  <c:v>179.78</c:v>
                </c:pt>
                <c:pt idx="231">
                  <c:v>179.78</c:v>
                </c:pt>
                <c:pt idx="232">
                  <c:v>143.82</c:v>
                </c:pt>
                <c:pt idx="233">
                  <c:v>161.80000000000001</c:v>
                </c:pt>
                <c:pt idx="234">
                  <c:v>161.80000000000001</c:v>
                </c:pt>
                <c:pt idx="235">
                  <c:v>179.78</c:v>
                </c:pt>
                <c:pt idx="236">
                  <c:v>125.84</c:v>
                </c:pt>
                <c:pt idx="237">
                  <c:v>125.84</c:v>
                </c:pt>
                <c:pt idx="238">
                  <c:v>107.87</c:v>
                </c:pt>
                <c:pt idx="239">
                  <c:v>125.84</c:v>
                </c:pt>
                <c:pt idx="240">
                  <c:v>170</c:v>
                </c:pt>
                <c:pt idx="241">
                  <c:v>110</c:v>
                </c:pt>
                <c:pt idx="242">
                  <c:v>170</c:v>
                </c:pt>
                <c:pt idx="243">
                  <c:v>110</c:v>
                </c:pt>
                <c:pt idx="244">
                  <c:v>140</c:v>
                </c:pt>
                <c:pt idx="245">
                  <c:v>140</c:v>
                </c:pt>
                <c:pt idx="246">
                  <c:v>110</c:v>
                </c:pt>
                <c:pt idx="247">
                  <c:v>110</c:v>
                </c:pt>
                <c:pt idx="248">
                  <c:v>80</c:v>
                </c:pt>
                <c:pt idx="249">
                  <c:v>140</c:v>
                </c:pt>
                <c:pt idx="250">
                  <c:v>150</c:v>
                </c:pt>
                <c:pt idx="251">
                  <c:v>140</c:v>
                </c:pt>
                <c:pt idx="252">
                  <c:v>140</c:v>
                </c:pt>
                <c:pt idx="253">
                  <c:v>120</c:v>
                </c:pt>
                <c:pt idx="254">
                  <c:v>120</c:v>
                </c:pt>
                <c:pt idx="255">
                  <c:v>90</c:v>
                </c:pt>
                <c:pt idx="256">
                  <c:v>110</c:v>
                </c:pt>
                <c:pt idx="257">
                  <c:v>90</c:v>
                </c:pt>
                <c:pt idx="258">
                  <c:v>120</c:v>
                </c:pt>
                <c:pt idx="259">
                  <c:v>140</c:v>
                </c:pt>
                <c:pt idx="260">
                  <c:v>160</c:v>
                </c:pt>
                <c:pt idx="261">
                  <c:v>60</c:v>
                </c:pt>
                <c:pt idx="262">
                  <c:v>140</c:v>
                </c:pt>
                <c:pt idx="263">
                  <c:v>90</c:v>
                </c:pt>
                <c:pt idx="264">
                  <c:v>80</c:v>
                </c:pt>
                <c:pt idx="265">
                  <c:v>80</c:v>
                </c:pt>
                <c:pt idx="266">
                  <c:v>160</c:v>
                </c:pt>
                <c:pt idx="267">
                  <c:v>140</c:v>
                </c:pt>
                <c:pt idx="268">
                  <c:v>130</c:v>
                </c:pt>
                <c:pt idx="269">
                  <c:v>90</c:v>
                </c:pt>
                <c:pt idx="270">
                  <c:v>50</c:v>
                </c:pt>
                <c:pt idx="271">
                  <c:v>130</c:v>
                </c:pt>
                <c:pt idx="272">
                  <c:v>110</c:v>
                </c:pt>
                <c:pt idx="273">
                  <c:v>140</c:v>
                </c:pt>
                <c:pt idx="274">
                  <c:v>160</c:v>
                </c:pt>
                <c:pt idx="275">
                  <c:v>130</c:v>
                </c:pt>
                <c:pt idx="276">
                  <c:v>110</c:v>
                </c:pt>
                <c:pt idx="277">
                  <c:v>160</c:v>
                </c:pt>
                <c:pt idx="278">
                  <c:v>110</c:v>
                </c:pt>
                <c:pt idx="279">
                  <c:v>160</c:v>
                </c:pt>
                <c:pt idx="280">
                  <c:v>83</c:v>
                </c:pt>
                <c:pt idx="281">
                  <c:v>110.00000000000001</c:v>
                </c:pt>
                <c:pt idx="282">
                  <c:v>110.00000000000001</c:v>
                </c:pt>
                <c:pt idx="283">
                  <c:v>97</c:v>
                </c:pt>
                <c:pt idx="284">
                  <c:v>193</c:v>
                </c:pt>
                <c:pt idx="285">
                  <c:v>69</c:v>
                </c:pt>
                <c:pt idx="286">
                  <c:v>124</c:v>
                </c:pt>
                <c:pt idx="287">
                  <c:v>124</c:v>
                </c:pt>
                <c:pt idx="288">
                  <c:v>165</c:v>
                </c:pt>
                <c:pt idx="289">
                  <c:v>97</c:v>
                </c:pt>
                <c:pt idx="290">
                  <c:v>110.00000000000001</c:v>
                </c:pt>
                <c:pt idx="291">
                  <c:v>152</c:v>
                </c:pt>
                <c:pt idx="292">
                  <c:v>110.00000000000001</c:v>
                </c:pt>
                <c:pt idx="293">
                  <c:v>97</c:v>
                </c:pt>
                <c:pt idx="294">
                  <c:v>165</c:v>
                </c:pt>
                <c:pt idx="295">
                  <c:v>138</c:v>
                </c:pt>
                <c:pt idx="296">
                  <c:v>152</c:v>
                </c:pt>
                <c:pt idx="297">
                  <c:v>138</c:v>
                </c:pt>
                <c:pt idx="298">
                  <c:v>165</c:v>
                </c:pt>
                <c:pt idx="299">
                  <c:v>165</c:v>
                </c:pt>
                <c:pt idx="300">
                  <c:v>199.82</c:v>
                </c:pt>
                <c:pt idx="301">
                  <c:v>181.65</c:v>
                </c:pt>
                <c:pt idx="302">
                  <c:v>163.49</c:v>
                </c:pt>
                <c:pt idx="303">
                  <c:v>181.65</c:v>
                </c:pt>
                <c:pt idx="304">
                  <c:v>90.83</c:v>
                </c:pt>
                <c:pt idx="305">
                  <c:v>108.99</c:v>
                </c:pt>
                <c:pt idx="306">
                  <c:v>163.49</c:v>
                </c:pt>
                <c:pt idx="307">
                  <c:v>127.16</c:v>
                </c:pt>
                <c:pt idx="308">
                  <c:v>72.66</c:v>
                </c:pt>
                <c:pt idx="309">
                  <c:v>54.5</c:v>
                </c:pt>
                <c:pt idx="310">
                  <c:v>145.32</c:v>
                </c:pt>
                <c:pt idx="311">
                  <c:v>145.32</c:v>
                </c:pt>
                <c:pt idx="312">
                  <c:v>163.49</c:v>
                </c:pt>
                <c:pt idx="313">
                  <c:v>199.82</c:v>
                </c:pt>
                <c:pt idx="314">
                  <c:v>145.32</c:v>
                </c:pt>
                <c:pt idx="315">
                  <c:v>54.5</c:v>
                </c:pt>
                <c:pt idx="316">
                  <c:v>163.49</c:v>
                </c:pt>
                <c:pt idx="317">
                  <c:v>181.65</c:v>
                </c:pt>
                <c:pt idx="318">
                  <c:v>163.49</c:v>
                </c:pt>
                <c:pt idx="319">
                  <c:v>127.16</c:v>
                </c:pt>
                <c:pt idx="320">
                  <c:v>198.99</c:v>
                </c:pt>
                <c:pt idx="321">
                  <c:v>176.19</c:v>
                </c:pt>
                <c:pt idx="322">
                  <c:v>177.98</c:v>
                </c:pt>
                <c:pt idx="323">
                  <c:v>178.87</c:v>
                </c:pt>
                <c:pt idx="324">
                  <c:v>175.29</c:v>
                </c:pt>
                <c:pt idx="325">
                  <c:v>214.32</c:v>
                </c:pt>
                <c:pt idx="326">
                  <c:v>223.01</c:v>
                </c:pt>
                <c:pt idx="327">
                  <c:v>129.57</c:v>
                </c:pt>
                <c:pt idx="328">
                  <c:v>112.57</c:v>
                </c:pt>
                <c:pt idx="329">
                  <c:v>128.34</c:v>
                </c:pt>
                <c:pt idx="330">
                  <c:v>112.57</c:v>
                </c:pt>
                <c:pt idx="331">
                  <c:v>103.78</c:v>
                </c:pt>
                <c:pt idx="332">
                  <c:v>73.38</c:v>
                </c:pt>
                <c:pt idx="333">
                  <c:v>119.39</c:v>
                </c:pt>
                <c:pt idx="334">
                  <c:v>139.01</c:v>
                </c:pt>
                <c:pt idx="335">
                  <c:v>177.98</c:v>
                </c:pt>
                <c:pt idx="336">
                  <c:v>215.06</c:v>
                </c:pt>
                <c:pt idx="337">
                  <c:v>189.2</c:v>
                </c:pt>
                <c:pt idx="338">
                  <c:v>183.24</c:v>
                </c:pt>
                <c:pt idx="339">
                  <c:v>100.68</c:v>
                </c:pt>
                <c:pt idx="340">
                  <c:v>180.96</c:v>
                </c:pt>
                <c:pt idx="341">
                  <c:v>144.77000000000001</c:v>
                </c:pt>
                <c:pt idx="342">
                  <c:v>108.58</c:v>
                </c:pt>
                <c:pt idx="343">
                  <c:v>126.67</c:v>
                </c:pt>
                <c:pt idx="344">
                  <c:v>126.67</c:v>
                </c:pt>
                <c:pt idx="345">
                  <c:v>162.86000000000001</c:v>
                </c:pt>
                <c:pt idx="346">
                  <c:v>144.77000000000001</c:v>
                </c:pt>
                <c:pt idx="347">
                  <c:v>144.77000000000001</c:v>
                </c:pt>
                <c:pt idx="348">
                  <c:v>199.05</c:v>
                </c:pt>
                <c:pt idx="349">
                  <c:v>126.67</c:v>
                </c:pt>
                <c:pt idx="350">
                  <c:v>144.77000000000001</c:v>
                </c:pt>
                <c:pt idx="351">
                  <c:v>108.58</c:v>
                </c:pt>
                <c:pt idx="352">
                  <c:v>126.67</c:v>
                </c:pt>
                <c:pt idx="353">
                  <c:v>144.77000000000001</c:v>
                </c:pt>
                <c:pt idx="354">
                  <c:v>126.67</c:v>
                </c:pt>
                <c:pt idx="355">
                  <c:v>253.34</c:v>
                </c:pt>
                <c:pt idx="356">
                  <c:v>217.15</c:v>
                </c:pt>
                <c:pt idx="357">
                  <c:v>180.96</c:v>
                </c:pt>
                <c:pt idx="358">
                  <c:v>144.77000000000001</c:v>
                </c:pt>
                <c:pt idx="359">
                  <c:v>90.48</c:v>
                </c:pt>
              </c:numCache>
            </c:numRef>
          </c:xVal>
          <c:yVal>
            <c:numRef>
              <c:f>成熟期散布図!$K$4:$K$363</c:f>
              <c:numCache>
                <c:formatCode>General</c:formatCode>
                <c:ptCount val="360"/>
                <c:pt idx="0">
                  <c:v>229.44926000000001</c:v>
                </c:pt>
                <c:pt idx="1">
                  <c:v>264.74914000000001</c:v>
                </c:pt>
                <c:pt idx="2">
                  <c:v>264.74914000000001</c:v>
                </c:pt>
                <c:pt idx="3">
                  <c:v>247.09920000000002</c:v>
                </c:pt>
                <c:pt idx="4">
                  <c:v>247.09920000000002</c:v>
                </c:pt>
                <c:pt idx="5">
                  <c:v>211.79930999999999</c:v>
                </c:pt>
                <c:pt idx="6">
                  <c:v>141.19954000000001</c:v>
                </c:pt>
                <c:pt idx="7">
                  <c:v>317.69896999999997</c:v>
                </c:pt>
                <c:pt idx="8">
                  <c:v>264.74914000000001</c:v>
                </c:pt>
                <c:pt idx="9">
                  <c:v>247.09920000000002</c:v>
                </c:pt>
                <c:pt idx="10">
                  <c:v>282.39908000000003</c:v>
                </c:pt>
                <c:pt idx="11">
                  <c:v>300.04903000000002</c:v>
                </c:pt>
                <c:pt idx="12">
                  <c:v>300.04903000000002</c:v>
                </c:pt>
                <c:pt idx="13">
                  <c:v>211.79930999999999</c:v>
                </c:pt>
                <c:pt idx="14">
                  <c:v>158.84949</c:v>
                </c:pt>
                <c:pt idx="15">
                  <c:v>317.69896999999997</c:v>
                </c:pt>
                <c:pt idx="16">
                  <c:v>264.74914000000001</c:v>
                </c:pt>
                <c:pt idx="17">
                  <c:v>370.64879999999999</c:v>
                </c:pt>
                <c:pt idx="18">
                  <c:v>317.69896999999997</c:v>
                </c:pt>
                <c:pt idx="19">
                  <c:v>194.14937</c:v>
                </c:pt>
                <c:pt idx="20">
                  <c:v>330</c:v>
                </c:pt>
                <c:pt idx="21">
                  <c:v>290</c:v>
                </c:pt>
                <c:pt idx="22">
                  <c:v>200</c:v>
                </c:pt>
                <c:pt idx="23">
                  <c:v>290</c:v>
                </c:pt>
                <c:pt idx="24">
                  <c:v>430</c:v>
                </c:pt>
                <c:pt idx="25">
                  <c:v>600</c:v>
                </c:pt>
                <c:pt idx="26">
                  <c:v>540</c:v>
                </c:pt>
                <c:pt idx="27">
                  <c:v>630</c:v>
                </c:pt>
                <c:pt idx="28">
                  <c:v>220</c:v>
                </c:pt>
                <c:pt idx="29">
                  <c:v>270</c:v>
                </c:pt>
                <c:pt idx="30">
                  <c:v>490</c:v>
                </c:pt>
                <c:pt idx="31">
                  <c:v>250</c:v>
                </c:pt>
                <c:pt idx="32">
                  <c:v>240</c:v>
                </c:pt>
                <c:pt idx="33">
                  <c:v>420</c:v>
                </c:pt>
                <c:pt idx="34">
                  <c:v>690</c:v>
                </c:pt>
                <c:pt idx="35">
                  <c:v>340</c:v>
                </c:pt>
                <c:pt idx="36">
                  <c:v>540</c:v>
                </c:pt>
                <c:pt idx="37">
                  <c:v>290</c:v>
                </c:pt>
                <c:pt idx="38">
                  <c:v>330</c:v>
                </c:pt>
                <c:pt idx="39">
                  <c:v>310</c:v>
                </c:pt>
                <c:pt idx="40">
                  <c:v>236</c:v>
                </c:pt>
                <c:pt idx="41">
                  <c:v>236</c:v>
                </c:pt>
                <c:pt idx="42">
                  <c:v>309</c:v>
                </c:pt>
                <c:pt idx="43">
                  <c:v>273</c:v>
                </c:pt>
                <c:pt idx="44">
                  <c:v>236</c:v>
                </c:pt>
                <c:pt idx="45">
                  <c:v>218.00000000000003</c:v>
                </c:pt>
                <c:pt idx="46">
                  <c:v>254</c:v>
                </c:pt>
                <c:pt idx="47">
                  <c:v>218.00000000000003</c:v>
                </c:pt>
                <c:pt idx="48">
                  <c:v>363</c:v>
                </c:pt>
                <c:pt idx="49">
                  <c:v>327</c:v>
                </c:pt>
                <c:pt idx="50">
                  <c:v>254</c:v>
                </c:pt>
                <c:pt idx="51">
                  <c:v>254</c:v>
                </c:pt>
                <c:pt idx="52">
                  <c:v>309</c:v>
                </c:pt>
                <c:pt idx="53">
                  <c:v>164</c:v>
                </c:pt>
                <c:pt idx="54">
                  <c:v>236</c:v>
                </c:pt>
                <c:pt idx="55">
                  <c:v>254</c:v>
                </c:pt>
                <c:pt idx="56">
                  <c:v>254</c:v>
                </c:pt>
                <c:pt idx="57">
                  <c:v>218.00000000000003</c:v>
                </c:pt>
                <c:pt idx="58">
                  <c:v>236</c:v>
                </c:pt>
                <c:pt idx="59">
                  <c:v>309</c:v>
                </c:pt>
                <c:pt idx="60">
                  <c:v>240</c:v>
                </c:pt>
                <c:pt idx="61">
                  <c:v>180</c:v>
                </c:pt>
                <c:pt idx="62">
                  <c:v>460</c:v>
                </c:pt>
                <c:pt idx="63">
                  <c:v>230</c:v>
                </c:pt>
                <c:pt idx="64">
                  <c:v>210</c:v>
                </c:pt>
                <c:pt idx="65">
                  <c:v>180</c:v>
                </c:pt>
                <c:pt idx="66">
                  <c:v>410</c:v>
                </c:pt>
                <c:pt idx="67">
                  <c:v>410</c:v>
                </c:pt>
                <c:pt idx="68">
                  <c:v>410</c:v>
                </c:pt>
                <c:pt idx="69">
                  <c:v>230</c:v>
                </c:pt>
                <c:pt idx="70">
                  <c:v>310</c:v>
                </c:pt>
                <c:pt idx="71">
                  <c:v>260</c:v>
                </c:pt>
                <c:pt idx="72">
                  <c:v>160</c:v>
                </c:pt>
                <c:pt idx="73">
                  <c:v>240</c:v>
                </c:pt>
                <c:pt idx="74">
                  <c:v>460</c:v>
                </c:pt>
                <c:pt idx="75">
                  <c:v>440</c:v>
                </c:pt>
                <c:pt idx="76">
                  <c:v>260</c:v>
                </c:pt>
                <c:pt idx="77">
                  <c:v>490</c:v>
                </c:pt>
                <c:pt idx="78">
                  <c:v>160</c:v>
                </c:pt>
                <c:pt idx="79">
                  <c:v>150</c:v>
                </c:pt>
                <c:pt idx="80">
                  <c:v>250</c:v>
                </c:pt>
                <c:pt idx="81">
                  <c:v>370</c:v>
                </c:pt>
                <c:pt idx="82">
                  <c:v>280</c:v>
                </c:pt>
                <c:pt idx="83">
                  <c:v>220</c:v>
                </c:pt>
                <c:pt idx="84">
                  <c:v>270</c:v>
                </c:pt>
                <c:pt idx="85">
                  <c:v>360</c:v>
                </c:pt>
                <c:pt idx="86">
                  <c:v>190</c:v>
                </c:pt>
                <c:pt idx="87">
                  <c:v>70</c:v>
                </c:pt>
                <c:pt idx="88">
                  <c:v>270</c:v>
                </c:pt>
                <c:pt idx="89">
                  <c:v>250</c:v>
                </c:pt>
                <c:pt idx="90">
                  <c:v>250</c:v>
                </c:pt>
                <c:pt idx="91">
                  <c:v>220</c:v>
                </c:pt>
                <c:pt idx="92">
                  <c:v>370</c:v>
                </c:pt>
                <c:pt idx="93">
                  <c:v>220</c:v>
                </c:pt>
                <c:pt idx="94">
                  <c:v>150</c:v>
                </c:pt>
                <c:pt idx="95">
                  <c:v>150</c:v>
                </c:pt>
                <c:pt idx="96">
                  <c:v>400</c:v>
                </c:pt>
                <c:pt idx="97">
                  <c:v>210</c:v>
                </c:pt>
                <c:pt idx="98">
                  <c:v>430</c:v>
                </c:pt>
                <c:pt idx="99">
                  <c:v>390</c:v>
                </c:pt>
                <c:pt idx="100">
                  <c:v>339.56</c:v>
                </c:pt>
                <c:pt idx="101">
                  <c:v>357.43</c:v>
                </c:pt>
                <c:pt idx="102">
                  <c:v>321.69</c:v>
                </c:pt>
                <c:pt idx="103">
                  <c:v>357.43</c:v>
                </c:pt>
                <c:pt idx="104">
                  <c:v>393.17</c:v>
                </c:pt>
                <c:pt idx="105">
                  <c:v>428.92</c:v>
                </c:pt>
                <c:pt idx="106">
                  <c:v>232.33</c:v>
                </c:pt>
                <c:pt idx="107">
                  <c:v>285.94</c:v>
                </c:pt>
                <c:pt idx="108">
                  <c:v>303.82</c:v>
                </c:pt>
                <c:pt idx="109">
                  <c:v>178.72</c:v>
                </c:pt>
                <c:pt idx="110">
                  <c:v>250.2</c:v>
                </c:pt>
                <c:pt idx="111">
                  <c:v>178.72</c:v>
                </c:pt>
                <c:pt idx="112">
                  <c:v>107.23</c:v>
                </c:pt>
                <c:pt idx="113">
                  <c:v>250.2</c:v>
                </c:pt>
                <c:pt idx="114">
                  <c:v>536.15</c:v>
                </c:pt>
                <c:pt idx="115">
                  <c:v>214.46</c:v>
                </c:pt>
                <c:pt idx="116">
                  <c:v>285.94</c:v>
                </c:pt>
                <c:pt idx="117">
                  <c:v>196.59</c:v>
                </c:pt>
                <c:pt idx="118">
                  <c:v>232.33</c:v>
                </c:pt>
                <c:pt idx="119">
                  <c:v>214.46</c:v>
                </c:pt>
                <c:pt idx="120">
                  <c:v>234.4</c:v>
                </c:pt>
                <c:pt idx="121">
                  <c:v>252.43</c:v>
                </c:pt>
                <c:pt idx="122">
                  <c:v>216.37</c:v>
                </c:pt>
                <c:pt idx="123">
                  <c:v>360.61</c:v>
                </c:pt>
                <c:pt idx="124">
                  <c:v>252.43</c:v>
                </c:pt>
                <c:pt idx="125">
                  <c:v>252.43</c:v>
                </c:pt>
                <c:pt idx="126">
                  <c:v>180.3</c:v>
                </c:pt>
                <c:pt idx="127">
                  <c:v>306.52</c:v>
                </c:pt>
                <c:pt idx="128">
                  <c:v>216.37</c:v>
                </c:pt>
                <c:pt idx="129">
                  <c:v>234.4</c:v>
                </c:pt>
                <c:pt idx="130">
                  <c:v>144.24</c:v>
                </c:pt>
                <c:pt idx="131">
                  <c:v>288.49</c:v>
                </c:pt>
                <c:pt idx="132">
                  <c:v>234.4</c:v>
                </c:pt>
                <c:pt idx="133">
                  <c:v>288.49</c:v>
                </c:pt>
                <c:pt idx="134">
                  <c:v>306.52</c:v>
                </c:pt>
                <c:pt idx="135">
                  <c:v>306.52</c:v>
                </c:pt>
                <c:pt idx="136">
                  <c:v>288.49</c:v>
                </c:pt>
                <c:pt idx="137">
                  <c:v>252.43</c:v>
                </c:pt>
                <c:pt idx="138">
                  <c:v>234.4</c:v>
                </c:pt>
                <c:pt idx="139">
                  <c:v>378.64</c:v>
                </c:pt>
                <c:pt idx="140">
                  <c:v>399.20080000000002</c:v>
                </c:pt>
                <c:pt idx="141">
                  <c:v>217.74589</c:v>
                </c:pt>
                <c:pt idx="142">
                  <c:v>145.16392999999999</c:v>
                </c:pt>
                <c:pt idx="143">
                  <c:v>127.01844</c:v>
                </c:pt>
                <c:pt idx="144">
                  <c:v>362.90982000000002</c:v>
                </c:pt>
                <c:pt idx="145">
                  <c:v>290.32784999999996</c:v>
                </c:pt>
                <c:pt idx="146">
                  <c:v>163.30942000000002</c:v>
                </c:pt>
                <c:pt idx="147">
                  <c:v>235.89138</c:v>
                </c:pt>
                <c:pt idx="148">
                  <c:v>399.20080000000002</c:v>
                </c:pt>
                <c:pt idx="149">
                  <c:v>344.76433000000003</c:v>
                </c:pt>
                <c:pt idx="150">
                  <c:v>290.32784999999996</c:v>
                </c:pt>
                <c:pt idx="151">
                  <c:v>163.30942000000002</c:v>
                </c:pt>
                <c:pt idx="152">
                  <c:v>235.89138</c:v>
                </c:pt>
                <c:pt idx="153">
                  <c:v>272.18235999999996</c:v>
                </c:pt>
                <c:pt idx="154">
                  <c:v>290.32784999999996</c:v>
                </c:pt>
                <c:pt idx="155">
                  <c:v>290.32784999999996</c:v>
                </c:pt>
                <c:pt idx="156">
                  <c:v>272.18235999999996</c:v>
                </c:pt>
                <c:pt idx="157">
                  <c:v>308.47334000000001</c:v>
                </c:pt>
                <c:pt idx="158">
                  <c:v>127.01844</c:v>
                </c:pt>
                <c:pt idx="159">
                  <c:v>181.45491000000001</c:v>
                </c:pt>
                <c:pt idx="160">
                  <c:v>493.76</c:v>
                </c:pt>
                <c:pt idx="161">
                  <c:v>347.46</c:v>
                </c:pt>
                <c:pt idx="162">
                  <c:v>310.89</c:v>
                </c:pt>
                <c:pt idx="163">
                  <c:v>310.89</c:v>
                </c:pt>
                <c:pt idx="164">
                  <c:v>475.48</c:v>
                </c:pt>
                <c:pt idx="165">
                  <c:v>384.04</c:v>
                </c:pt>
                <c:pt idx="166">
                  <c:v>640.07000000000005</c:v>
                </c:pt>
                <c:pt idx="167">
                  <c:v>566.91999999999996</c:v>
                </c:pt>
                <c:pt idx="168">
                  <c:v>384.04</c:v>
                </c:pt>
                <c:pt idx="169">
                  <c:v>329.18</c:v>
                </c:pt>
                <c:pt idx="170">
                  <c:v>365.75</c:v>
                </c:pt>
                <c:pt idx="171">
                  <c:v>329.18</c:v>
                </c:pt>
                <c:pt idx="172">
                  <c:v>365.75</c:v>
                </c:pt>
                <c:pt idx="173">
                  <c:v>237.74</c:v>
                </c:pt>
                <c:pt idx="174">
                  <c:v>219.45</c:v>
                </c:pt>
                <c:pt idx="175">
                  <c:v>146.30000000000001</c:v>
                </c:pt>
                <c:pt idx="176">
                  <c:v>164.59</c:v>
                </c:pt>
                <c:pt idx="177">
                  <c:v>146.30000000000001</c:v>
                </c:pt>
                <c:pt idx="178">
                  <c:v>219.45</c:v>
                </c:pt>
                <c:pt idx="179">
                  <c:v>182.88</c:v>
                </c:pt>
                <c:pt idx="180">
                  <c:v>164.02</c:v>
                </c:pt>
                <c:pt idx="181">
                  <c:v>127.57</c:v>
                </c:pt>
                <c:pt idx="182">
                  <c:v>182.25</c:v>
                </c:pt>
                <c:pt idx="183">
                  <c:v>218.7</c:v>
                </c:pt>
                <c:pt idx="184">
                  <c:v>109.35</c:v>
                </c:pt>
                <c:pt idx="185">
                  <c:v>164.02</c:v>
                </c:pt>
                <c:pt idx="186">
                  <c:v>164.02</c:v>
                </c:pt>
                <c:pt idx="187">
                  <c:v>218.7</c:v>
                </c:pt>
                <c:pt idx="188">
                  <c:v>346.27</c:v>
                </c:pt>
                <c:pt idx="189">
                  <c:v>419.17</c:v>
                </c:pt>
                <c:pt idx="190">
                  <c:v>309.82</c:v>
                </c:pt>
                <c:pt idx="191">
                  <c:v>346.27</c:v>
                </c:pt>
                <c:pt idx="192">
                  <c:v>309.82</c:v>
                </c:pt>
                <c:pt idx="193">
                  <c:v>273.37</c:v>
                </c:pt>
                <c:pt idx="194">
                  <c:v>328.05</c:v>
                </c:pt>
                <c:pt idx="195">
                  <c:v>382.72</c:v>
                </c:pt>
                <c:pt idx="196">
                  <c:v>273.37</c:v>
                </c:pt>
                <c:pt idx="197">
                  <c:v>328.05</c:v>
                </c:pt>
                <c:pt idx="198">
                  <c:v>364.5</c:v>
                </c:pt>
                <c:pt idx="199">
                  <c:v>346.27</c:v>
                </c:pt>
                <c:pt idx="200">
                  <c:v>546.27299999999991</c:v>
                </c:pt>
                <c:pt idx="201">
                  <c:v>291.34499999999997</c:v>
                </c:pt>
                <c:pt idx="202">
                  <c:v>418.80900000000003</c:v>
                </c:pt>
                <c:pt idx="203">
                  <c:v>382.39099999999996</c:v>
                </c:pt>
                <c:pt idx="204">
                  <c:v>400.6</c:v>
                </c:pt>
                <c:pt idx="205">
                  <c:v>254.92699999999999</c:v>
                </c:pt>
                <c:pt idx="206">
                  <c:v>491.64499999999998</c:v>
                </c:pt>
                <c:pt idx="207">
                  <c:v>291.34499999999997</c:v>
                </c:pt>
                <c:pt idx="208">
                  <c:v>528.06400000000008</c:v>
                </c:pt>
                <c:pt idx="209">
                  <c:v>382.39099999999996</c:v>
                </c:pt>
                <c:pt idx="210">
                  <c:v>437.01800000000003</c:v>
                </c:pt>
                <c:pt idx="211">
                  <c:v>236.71799999999999</c:v>
                </c:pt>
                <c:pt idx="212">
                  <c:v>455.22700000000003</c:v>
                </c:pt>
                <c:pt idx="213">
                  <c:v>437.01800000000003</c:v>
                </c:pt>
                <c:pt idx="214">
                  <c:v>254.92699999999999</c:v>
                </c:pt>
                <c:pt idx="215">
                  <c:v>273.13600000000002</c:v>
                </c:pt>
                <c:pt idx="216">
                  <c:v>382.39099999999996</c:v>
                </c:pt>
                <c:pt idx="217">
                  <c:v>491.64499999999998</c:v>
                </c:pt>
                <c:pt idx="218">
                  <c:v>145.673</c:v>
                </c:pt>
                <c:pt idx="219">
                  <c:v>327.76400000000001</c:v>
                </c:pt>
                <c:pt idx="220">
                  <c:v>215.73</c:v>
                </c:pt>
                <c:pt idx="221">
                  <c:v>287.64</c:v>
                </c:pt>
                <c:pt idx="222">
                  <c:v>305.62</c:v>
                </c:pt>
                <c:pt idx="223">
                  <c:v>215.73</c:v>
                </c:pt>
                <c:pt idx="224">
                  <c:v>233.71</c:v>
                </c:pt>
                <c:pt idx="225">
                  <c:v>287.64</c:v>
                </c:pt>
                <c:pt idx="226">
                  <c:v>395.51</c:v>
                </c:pt>
                <c:pt idx="227">
                  <c:v>287.64</c:v>
                </c:pt>
                <c:pt idx="228">
                  <c:v>341.58</c:v>
                </c:pt>
                <c:pt idx="229">
                  <c:v>269.67</c:v>
                </c:pt>
                <c:pt idx="230">
                  <c:v>341.58</c:v>
                </c:pt>
                <c:pt idx="231">
                  <c:v>233.71</c:v>
                </c:pt>
                <c:pt idx="232">
                  <c:v>341.58</c:v>
                </c:pt>
                <c:pt idx="233">
                  <c:v>251.69</c:v>
                </c:pt>
                <c:pt idx="234">
                  <c:v>449.44</c:v>
                </c:pt>
                <c:pt idx="235">
                  <c:v>341.58</c:v>
                </c:pt>
                <c:pt idx="236">
                  <c:v>269.67</c:v>
                </c:pt>
                <c:pt idx="237">
                  <c:v>359.56</c:v>
                </c:pt>
                <c:pt idx="238">
                  <c:v>341.58</c:v>
                </c:pt>
                <c:pt idx="239">
                  <c:v>377.53</c:v>
                </c:pt>
                <c:pt idx="240">
                  <c:v>120</c:v>
                </c:pt>
                <c:pt idx="241">
                  <c:v>150</c:v>
                </c:pt>
                <c:pt idx="242">
                  <c:v>260</c:v>
                </c:pt>
                <c:pt idx="243">
                  <c:v>200</c:v>
                </c:pt>
                <c:pt idx="244">
                  <c:v>200</c:v>
                </c:pt>
                <c:pt idx="245">
                  <c:v>90</c:v>
                </c:pt>
                <c:pt idx="246">
                  <c:v>150</c:v>
                </c:pt>
                <c:pt idx="247">
                  <c:v>90</c:v>
                </c:pt>
                <c:pt idx="248">
                  <c:v>200</c:v>
                </c:pt>
                <c:pt idx="249">
                  <c:v>120</c:v>
                </c:pt>
                <c:pt idx="250">
                  <c:v>180</c:v>
                </c:pt>
                <c:pt idx="251">
                  <c:v>210</c:v>
                </c:pt>
                <c:pt idx="252">
                  <c:v>150</c:v>
                </c:pt>
                <c:pt idx="253">
                  <c:v>260</c:v>
                </c:pt>
                <c:pt idx="254">
                  <c:v>140</c:v>
                </c:pt>
                <c:pt idx="255">
                  <c:v>140</c:v>
                </c:pt>
                <c:pt idx="256">
                  <c:v>210</c:v>
                </c:pt>
                <c:pt idx="257">
                  <c:v>150</c:v>
                </c:pt>
                <c:pt idx="258">
                  <c:v>230</c:v>
                </c:pt>
                <c:pt idx="259">
                  <c:v>110</c:v>
                </c:pt>
                <c:pt idx="260">
                  <c:v>160</c:v>
                </c:pt>
                <c:pt idx="261">
                  <c:v>170</c:v>
                </c:pt>
                <c:pt idx="262">
                  <c:v>190</c:v>
                </c:pt>
                <c:pt idx="263">
                  <c:v>210</c:v>
                </c:pt>
                <c:pt idx="264">
                  <c:v>250</c:v>
                </c:pt>
                <c:pt idx="265">
                  <c:v>240</c:v>
                </c:pt>
                <c:pt idx="266">
                  <c:v>330</c:v>
                </c:pt>
                <c:pt idx="267">
                  <c:v>280</c:v>
                </c:pt>
                <c:pt idx="268">
                  <c:v>240</c:v>
                </c:pt>
                <c:pt idx="269">
                  <c:v>220</c:v>
                </c:pt>
                <c:pt idx="270">
                  <c:v>90</c:v>
                </c:pt>
                <c:pt idx="271">
                  <c:v>240</c:v>
                </c:pt>
                <c:pt idx="272">
                  <c:v>250</c:v>
                </c:pt>
                <c:pt idx="273">
                  <c:v>270</c:v>
                </c:pt>
                <c:pt idx="274">
                  <c:v>140</c:v>
                </c:pt>
                <c:pt idx="275">
                  <c:v>130</c:v>
                </c:pt>
                <c:pt idx="276">
                  <c:v>220</c:v>
                </c:pt>
                <c:pt idx="277">
                  <c:v>210</c:v>
                </c:pt>
                <c:pt idx="278">
                  <c:v>270</c:v>
                </c:pt>
                <c:pt idx="279">
                  <c:v>360</c:v>
                </c:pt>
                <c:pt idx="280">
                  <c:v>262</c:v>
                </c:pt>
                <c:pt idx="281">
                  <c:v>206.99999999999997</c:v>
                </c:pt>
                <c:pt idx="282">
                  <c:v>413.99999999999994</c:v>
                </c:pt>
                <c:pt idx="283">
                  <c:v>483</c:v>
                </c:pt>
                <c:pt idx="284">
                  <c:v>413.99999999999994</c:v>
                </c:pt>
                <c:pt idx="285">
                  <c:v>124</c:v>
                </c:pt>
                <c:pt idx="286">
                  <c:v>455</c:v>
                </c:pt>
                <c:pt idx="287">
                  <c:v>358</c:v>
                </c:pt>
                <c:pt idx="288">
                  <c:v>290</c:v>
                </c:pt>
                <c:pt idx="289">
                  <c:v>400</c:v>
                </c:pt>
                <c:pt idx="290">
                  <c:v>262</c:v>
                </c:pt>
                <c:pt idx="291">
                  <c:v>290</c:v>
                </c:pt>
                <c:pt idx="292">
                  <c:v>234</c:v>
                </c:pt>
                <c:pt idx="293">
                  <c:v>331</c:v>
                </c:pt>
                <c:pt idx="294">
                  <c:v>372</c:v>
                </c:pt>
                <c:pt idx="295">
                  <c:v>248</c:v>
                </c:pt>
                <c:pt idx="296">
                  <c:v>538</c:v>
                </c:pt>
                <c:pt idx="297">
                  <c:v>331</c:v>
                </c:pt>
                <c:pt idx="298">
                  <c:v>165</c:v>
                </c:pt>
                <c:pt idx="299">
                  <c:v>276</c:v>
                </c:pt>
                <c:pt idx="300">
                  <c:v>399.64</c:v>
                </c:pt>
                <c:pt idx="301">
                  <c:v>381.47</c:v>
                </c:pt>
                <c:pt idx="302">
                  <c:v>272.48</c:v>
                </c:pt>
                <c:pt idx="303">
                  <c:v>435.97</c:v>
                </c:pt>
                <c:pt idx="304">
                  <c:v>181.65</c:v>
                </c:pt>
                <c:pt idx="305">
                  <c:v>308.81</c:v>
                </c:pt>
                <c:pt idx="306">
                  <c:v>290.64999999999998</c:v>
                </c:pt>
                <c:pt idx="307">
                  <c:v>363.31</c:v>
                </c:pt>
                <c:pt idx="308">
                  <c:v>236.15</c:v>
                </c:pt>
                <c:pt idx="309">
                  <c:v>236.15</c:v>
                </c:pt>
                <c:pt idx="310">
                  <c:v>563.13</c:v>
                </c:pt>
                <c:pt idx="311">
                  <c:v>217.98</c:v>
                </c:pt>
                <c:pt idx="312">
                  <c:v>490.46</c:v>
                </c:pt>
                <c:pt idx="313">
                  <c:v>326.98</c:v>
                </c:pt>
                <c:pt idx="314">
                  <c:v>127.16</c:v>
                </c:pt>
                <c:pt idx="315">
                  <c:v>72.66</c:v>
                </c:pt>
                <c:pt idx="316">
                  <c:v>127.16</c:v>
                </c:pt>
                <c:pt idx="317">
                  <c:v>290.64999999999998</c:v>
                </c:pt>
                <c:pt idx="318">
                  <c:v>308.81</c:v>
                </c:pt>
                <c:pt idx="319">
                  <c:v>163.49</c:v>
                </c:pt>
                <c:pt idx="320">
                  <c:v>406.25</c:v>
                </c:pt>
                <c:pt idx="321">
                  <c:v>327.22000000000003</c:v>
                </c:pt>
                <c:pt idx="322">
                  <c:v>492.28</c:v>
                </c:pt>
                <c:pt idx="323">
                  <c:v>267.57</c:v>
                </c:pt>
                <c:pt idx="324">
                  <c:v>371.64</c:v>
                </c:pt>
                <c:pt idx="325">
                  <c:v>366.92</c:v>
                </c:pt>
                <c:pt idx="326">
                  <c:v>383.39</c:v>
                </c:pt>
                <c:pt idx="327">
                  <c:v>310.83</c:v>
                </c:pt>
                <c:pt idx="328">
                  <c:v>259.14999999999998</c:v>
                </c:pt>
                <c:pt idx="329">
                  <c:v>358.18</c:v>
                </c:pt>
                <c:pt idx="330">
                  <c:v>342.36</c:v>
                </c:pt>
                <c:pt idx="331">
                  <c:v>374.19</c:v>
                </c:pt>
                <c:pt idx="332">
                  <c:v>181.51</c:v>
                </c:pt>
                <c:pt idx="333">
                  <c:v>327.22000000000003</c:v>
                </c:pt>
                <c:pt idx="334">
                  <c:v>530.97</c:v>
                </c:pt>
                <c:pt idx="335">
                  <c:v>378.4</c:v>
                </c:pt>
                <c:pt idx="336">
                  <c:v>390.75</c:v>
                </c:pt>
                <c:pt idx="337">
                  <c:v>314.88</c:v>
                </c:pt>
                <c:pt idx="338">
                  <c:v>264.58999999999997</c:v>
                </c:pt>
                <c:pt idx="339">
                  <c:v>153.11000000000001</c:v>
                </c:pt>
                <c:pt idx="340">
                  <c:v>380.01</c:v>
                </c:pt>
                <c:pt idx="341">
                  <c:v>289.52999999999997</c:v>
                </c:pt>
                <c:pt idx="342">
                  <c:v>162.86000000000001</c:v>
                </c:pt>
                <c:pt idx="343">
                  <c:v>289.52999999999997</c:v>
                </c:pt>
                <c:pt idx="344">
                  <c:v>289.52999999999997</c:v>
                </c:pt>
                <c:pt idx="345">
                  <c:v>416.21</c:v>
                </c:pt>
                <c:pt idx="346">
                  <c:v>343.82</c:v>
                </c:pt>
                <c:pt idx="347">
                  <c:v>235.25</c:v>
                </c:pt>
                <c:pt idx="348">
                  <c:v>416.21</c:v>
                </c:pt>
                <c:pt idx="349">
                  <c:v>180.96</c:v>
                </c:pt>
                <c:pt idx="350">
                  <c:v>235.25</c:v>
                </c:pt>
                <c:pt idx="351">
                  <c:v>253.34</c:v>
                </c:pt>
                <c:pt idx="352">
                  <c:v>470.49</c:v>
                </c:pt>
                <c:pt idx="353">
                  <c:v>380.01</c:v>
                </c:pt>
                <c:pt idx="354">
                  <c:v>434.3</c:v>
                </c:pt>
                <c:pt idx="355">
                  <c:v>506.68</c:v>
                </c:pt>
                <c:pt idx="356">
                  <c:v>343.82</c:v>
                </c:pt>
                <c:pt idx="357">
                  <c:v>325.73</c:v>
                </c:pt>
                <c:pt idx="358">
                  <c:v>343.82</c:v>
                </c:pt>
                <c:pt idx="359">
                  <c:v>144.77000000000001</c:v>
                </c:pt>
              </c:numCache>
            </c:numRef>
          </c:yVal>
          <c:smooth val="0"/>
          <c:extLst>
            <c:ext xmlns:c16="http://schemas.microsoft.com/office/drawing/2014/chart" uri="{C3380CC4-5D6E-409C-BE32-E72D297353CC}">
              <c16:uniqueId val="{00000001-F625-0848-9566-121DA65EB886}"/>
            </c:ext>
          </c:extLst>
        </c:ser>
        <c:dLbls>
          <c:showLegendKey val="0"/>
          <c:showVal val="0"/>
          <c:showCatName val="0"/>
          <c:showSerName val="0"/>
          <c:showPercent val="0"/>
          <c:showBubbleSize val="0"/>
        </c:dLbls>
        <c:axId val="437666608"/>
        <c:axId val="665349792"/>
      </c:scatterChart>
      <c:valAx>
        <c:axId val="437666608"/>
        <c:scaling>
          <c:orientation val="minMax"/>
          <c:max val="400"/>
          <c:min val="0"/>
        </c:scaling>
        <c:delete val="0"/>
        <c:axPos val="b"/>
        <c:majorGridlines>
          <c:spPr>
            <a:ln w="9525" cap="flat" cmpd="sng" algn="ctr">
              <a:noFill/>
              <a:round/>
            </a:ln>
            <a:effectLst/>
          </c:spPr>
        </c:majorGridlines>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665349792"/>
        <c:crosses val="autoZero"/>
        <c:crossBetween val="midCat"/>
        <c:majorUnit val="100"/>
      </c:valAx>
      <c:valAx>
        <c:axId val="665349792"/>
        <c:scaling>
          <c:orientation val="minMax"/>
        </c:scaling>
        <c:delete val="0"/>
        <c:axPos val="l"/>
        <c:majorGridlines>
          <c:spPr>
            <a:ln w="9525" cap="flat" cmpd="sng" algn="ctr">
              <a:noFill/>
              <a:round/>
            </a:ln>
            <a:effectLst/>
          </c:spPr>
        </c:majorGridlines>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37666608"/>
        <c:crosses val="autoZero"/>
        <c:crossBetween val="midCat"/>
      </c:valAx>
      <c:spPr>
        <a:noFill/>
        <a:ln w="9525">
          <a:solidFill>
            <a:schemeClr val="tx1"/>
          </a:solidFill>
        </a:ln>
        <a:effectLst/>
      </c:spPr>
    </c:plotArea>
    <c:legend>
      <c:legendPos val="r"/>
      <c:layout>
        <c:manualLayout>
          <c:xMode val="edge"/>
          <c:yMode val="edge"/>
          <c:x val="0.8460842878328042"/>
          <c:y val="0.84141780485932693"/>
          <c:w val="8.6132805679041149E-2"/>
          <c:h val="7.6656521168091435E-2"/>
        </c:manualLayout>
      </c:layout>
      <c:overlay val="0"/>
      <c:spPr>
        <a:noFill/>
        <a:ln>
          <a:noFill/>
        </a:ln>
        <a:effectLst/>
      </c:spPr>
      <c:txPr>
        <a:bodyPr rot="0" spcFirstLastPara="1" vertOverflow="ellipsis" vert="horz" wrap="square" anchor="ctr" anchorCtr="1"/>
        <a:lstStyle/>
        <a:p>
          <a:pPr>
            <a:defRPr lang="ja-JP"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08E9918-E50D-D84C-B063-AE845F86B443}" type="datetimeFigureOut">
              <a:rPr kumimoji="1" lang="ja-JP" altLang="en-US" smtClean="0"/>
              <a:t>2026/1/17</a:t>
            </a:fld>
            <a:endParaRPr kumimoji="1" lang="ja-JP" altLang="en-US"/>
          </a:p>
        </p:txBody>
      </p:sp>
      <p:sp>
        <p:nvSpPr>
          <p:cNvPr id="4" name="スライド イメージ プレースホルダー 3"/>
          <p:cNvSpPr>
            <a:spLocks noGrp="1" noRot="1" noChangeAspect="1"/>
          </p:cNvSpPr>
          <p:nvPr>
            <p:ph type="sldImg" idx="2"/>
          </p:nvPr>
        </p:nvSpPr>
        <p:spPr>
          <a:xfrm>
            <a:off x="2338388" y="1143000"/>
            <a:ext cx="218122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9A264D5-EF0B-3142-A2F8-95449E7BA1DD}" type="slidenum">
              <a:rPr kumimoji="1" lang="ja-JP" altLang="en-US" smtClean="0"/>
              <a:t>‹#›</a:t>
            </a:fld>
            <a:endParaRPr kumimoji="1" lang="ja-JP" altLang="en-US"/>
          </a:p>
        </p:txBody>
      </p:sp>
    </p:spTree>
    <p:extLst>
      <p:ext uri="{BB962C8B-B14F-4D97-AF65-F5344CB8AC3E}">
        <p14:creationId xmlns:p14="http://schemas.microsoft.com/office/powerpoint/2010/main" val="1672372812"/>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BD2EB18E-D866-3740-9DB8-8CA13D5F7039}" type="slidenum">
              <a:rPr kumimoji="1" lang="ja-JP" altLang="en-US" smtClean="0"/>
              <a:t>4</a:t>
            </a:fld>
            <a:endParaRPr kumimoji="1" lang="ja-JP" altLang="en-US"/>
          </a:p>
        </p:txBody>
      </p:sp>
    </p:spTree>
    <p:extLst>
      <p:ext uri="{BB962C8B-B14F-4D97-AF65-F5344CB8AC3E}">
        <p14:creationId xmlns:p14="http://schemas.microsoft.com/office/powerpoint/2010/main" val="35317609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ja-JP" altLang="en-US"/>
              <a:t>マスター タイトルの書式設定</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96D72A68-3EFA-664B-ACC0-967A94CA54A5}" type="datetimeFigureOut">
              <a:rPr kumimoji="1" lang="ja-JP" altLang="en-US" smtClean="0"/>
              <a:t>2026/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D3E7D7-A3C6-BB4B-95A4-52E56D2676C5}" type="slidenum">
              <a:rPr kumimoji="1" lang="ja-JP" altLang="en-US" smtClean="0"/>
              <a:t>‹#›</a:t>
            </a:fld>
            <a:endParaRPr kumimoji="1" lang="ja-JP" altLang="en-US"/>
          </a:p>
        </p:txBody>
      </p:sp>
    </p:spTree>
    <p:extLst>
      <p:ext uri="{BB962C8B-B14F-4D97-AF65-F5344CB8AC3E}">
        <p14:creationId xmlns:p14="http://schemas.microsoft.com/office/powerpoint/2010/main" val="24535860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6D72A68-3EFA-664B-ACC0-967A94CA54A5}" type="datetimeFigureOut">
              <a:rPr kumimoji="1" lang="ja-JP" altLang="en-US" smtClean="0"/>
              <a:t>2026/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D3E7D7-A3C6-BB4B-95A4-52E56D2676C5}" type="slidenum">
              <a:rPr kumimoji="1" lang="ja-JP" altLang="en-US" smtClean="0"/>
              <a:t>‹#›</a:t>
            </a:fld>
            <a:endParaRPr kumimoji="1" lang="ja-JP" altLang="en-US"/>
          </a:p>
        </p:txBody>
      </p:sp>
    </p:spTree>
    <p:extLst>
      <p:ext uri="{BB962C8B-B14F-4D97-AF65-F5344CB8AC3E}">
        <p14:creationId xmlns:p14="http://schemas.microsoft.com/office/powerpoint/2010/main" val="41112920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6D72A68-3EFA-664B-ACC0-967A94CA54A5}" type="datetimeFigureOut">
              <a:rPr kumimoji="1" lang="ja-JP" altLang="en-US" smtClean="0"/>
              <a:t>2026/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D3E7D7-A3C6-BB4B-95A4-52E56D2676C5}" type="slidenum">
              <a:rPr kumimoji="1" lang="ja-JP" altLang="en-US" smtClean="0"/>
              <a:t>‹#›</a:t>
            </a:fld>
            <a:endParaRPr kumimoji="1" lang="ja-JP" altLang="en-US"/>
          </a:p>
        </p:txBody>
      </p:sp>
    </p:spTree>
    <p:extLst>
      <p:ext uri="{BB962C8B-B14F-4D97-AF65-F5344CB8AC3E}">
        <p14:creationId xmlns:p14="http://schemas.microsoft.com/office/powerpoint/2010/main" val="9861745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6D72A68-3EFA-664B-ACC0-967A94CA54A5}" type="datetimeFigureOut">
              <a:rPr kumimoji="1" lang="ja-JP" altLang="en-US" smtClean="0"/>
              <a:t>2026/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D3E7D7-A3C6-BB4B-95A4-52E56D2676C5}" type="slidenum">
              <a:rPr kumimoji="1" lang="ja-JP" altLang="en-US" smtClean="0"/>
              <a:t>‹#›</a:t>
            </a:fld>
            <a:endParaRPr kumimoji="1" lang="ja-JP" altLang="en-US"/>
          </a:p>
        </p:txBody>
      </p:sp>
    </p:spTree>
    <p:extLst>
      <p:ext uri="{BB962C8B-B14F-4D97-AF65-F5344CB8AC3E}">
        <p14:creationId xmlns:p14="http://schemas.microsoft.com/office/powerpoint/2010/main" val="22856297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tint val="82000"/>
                  </a:schemeClr>
                </a:solidFill>
              </a:defRPr>
            </a:lvl1pPr>
            <a:lvl2pPr marL="377967" indent="0">
              <a:buNone/>
              <a:defRPr sz="1653">
                <a:solidFill>
                  <a:schemeClr val="tx1">
                    <a:tint val="82000"/>
                  </a:schemeClr>
                </a:solidFill>
              </a:defRPr>
            </a:lvl2pPr>
            <a:lvl3pPr marL="755934" indent="0">
              <a:buNone/>
              <a:defRPr sz="1488">
                <a:solidFill>
                  <a:schemeClr val="tx1">
                    <a:tint val="82000"/>
                  </a:schemeClr>
                </a:solidFill>
              </a:defRPr>
            </a:lvl3pPr>
            <a:lvl4pPr marL="1133902" indent="0">
              <a:buNone/>
              <a:defRPr sz="1323">
                <a:solidFill>
                  <a:schemeClr val="tx1">
                    <a:tint val="82000"/>
                  </a:schemeClr>
                </a:solidFill>
              </a:defRPr>
            </a:lvl4pPr>
            <a:lvl5pPr marL="1511869" indent="0">
              <a:buNone/>
              <a:defRPr sz="1323">
                <a:solidFill>
                  <a:schemeClr val="tx1">
                    <a:tint val="82000"/>
                  </a:schemeClr>
                </a:solidFill>
              </a:defRPr>
            </a:lvl5pPr>
            <a:lvl6pPr marL="1889836" indent="0">
              <a:buNone/>
              <a:defRPr sz="1323">
                <a:solidFill>
                  <a:schemeClr val="tx1">
                    <a:tint val="82000"/>
                  </a:schemeClr>
                </a:solidFill>
              </a:defRPr>
            </a:lvl6pPr>
            <a:lvl7pPr marL="2267803" indent="0">
              <a:buNone/>
              <a:defRPr sz="1323">
                <a:solidFill>
                  <a:schemeClr val="tx1">
                    <a:tint val="82000"/>
                  </a:schemeClr>
                </a:solidFill>
              </a:defRPr>
            </a:lvl7pPr>
            <a:lvl8pPr marL="2645771" indent="0">
              <a:buNone/>
              <a:defRPr sz="1323">
                <a:solidFill>
                  <a:schemeClr val="tx1">
                    <a:tint val="82000"/>
                  </a:schemeClr>
                </a:solidFill>
              </a:defRPr>
            </a:lvl8pPr>
            <a:lvl9pPr marL="3023738" indent="0">
              <a:buNone/>
              <a:defRPr sz="1323">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96D72A68-3EFA-664B-ACC0-967A94CA54A5}" type="datetimeFigureOut">
              <a:rPr kumimoji="1" lang="ja-JP" altLang="en-US" smtClean="0"/>
              <a:t>2026/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D3E7D7-A3C6-BB4B-95A4-52E56D2676C5}" type="slidenum">
              <a:rPr kumimoji="1" lang="ja-JP" altLang="en-US" smtClean="0"/>
              <a:t>‹#›</a:t>
            </a:fld>
            <a:endParaRPr kumimoji="1" lang="ja-JP" altLang="en-US"/>
          </a:p>
        </p:txBody>
      </p:sp>
    </p:spTree>
    <p:extLst>
      <p:ext uri="{BB962C8B-B14F-4D97-AF65-F5344CB8AC3E}">
        <p14:creationId xmlns:p14="http://schemas.microsoft.com/office/powerpoint/2010/main" val="25641359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96D72A68-3EFA-664B-ACC0-967A94CA54A5}" type="datetimeFigureOut">
              <a:rPr kumimoji="1" lang="ja-JP" altLang="en-US" smtClean="0"/>
              <a:t>2026/1/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5D3E7D7-A3C6-BB4B-95A4-52E56D2676C5}" type="slidenum">
              <a:rPr kumimoji="1" lang="ja-JP" altLang="en-US" smtClean="0"/>
              <a:t>‹#›</a:t>
            </a:fld>
            <a:endParaRPr kumimoji="1" lang="ja-JP" altLang="en-US"/>
          </a:p>
        </p:txBody>
      </p:sp>
    </p:spTree>
    <p:extLst>
      <p:ext uri="{BB962C8B-B14F-4D97-AF65-F5344CB8AC3E}">
        <p14:creationId xmlns:p14="http://schemas.microsoft.com/office/powerpoint/2010/main" val="19125558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ja-JP" altLang="en-US"/>
              <a:t>マスター テキストの書式設定</a:t>
            </a:r>
          </a:p>
        </p:txBody>
      </p:sp>
      <p:sp>
        <p:nvSpPr>
          <p:cNvPr id="4" name="Content Placeholder 3"/>
          <p:cNvSpPr>
            <a:spLocks noGrp="1"/>
          </p:cNvSpPr>
          <p:nvPr>
            <p:ph sz="half" idx="2"/>
          </p:nvPr>
        </p:nvSpPr>
        <p:spPr>
          <a:xfrm>
            <a:off x="520713" y="3905482"/>
            <a:ext cx="3198096" cy="5744375"/>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ja-JP" altLang="en-US"/>
              <a:t>マスター テキストの書式設定</a:t>
            </a:r>
          </a:p>
        </p:txBody>
      </p:sp>
      <p:sp>
        <p:nvSpPr>
          <p:cNvPr id="6" name="Content Placeholder 5"/>
          <p:cNvSpPr>
            <a:spLocks noGrp="1"/>
          </p:cNvSpPr>
          <p:nvPr>
            <p:ph sz="quarter" idx="4"/>
          </p:nvPr>
        </p:nvSpPr>
        <p:spPr>
          <a:xfrm>
            <a:off x="3827086" y="3905482"/>
            <a:ext cx="3213847" cy="5744375"/>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96D72A68-3EFA-664B-ACC0-967A94CA54A5}" type="datetimeFigureOut">
              <a:rPr kumimoji="1" lang="ja-JP" altLang="en-US" smtClean="0"/>
              <a:t>2026/1/1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05D3E7D7-A3C6-BB4B-95A4-52E56D2676C5}" type="slidenum">
              <a:rPr kumimoji="1" lang="ja-JP" altLang="en-US" smtClean="0"/>
              <a:t>‹#›</a:t>
            </a:fld>
            <a:endParaRPr kumimoji="1" lang="ja-JP" altLang="en-US"/>
          </a:p>
        </p:txBody>
      </p:sp>
    </p:spTree>
    <p:extLst>
      <p:ext uri="{BB962C8B-B14F-4D97-AF65-F5344CB8AC3E}">
        <p14:creationId xmlns:p14="http://schemas.microsoft.com/office/powerpoint/2010/main" val="40438030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96D72A68-3EFA-664B-ACC0-967A94CA54A5}" type="datetimeFigureOut">
              <a:rPr kumimoji="1" lang="ja-JP" altLang="en-US" smtClean="0"/>
              <a:t>2026/1/1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05D3E7D7-A3C6-BB4B-95A4-52E56D2676C5}" type="slidenum">
              <a:rPr kumimoji="1" lang="ja-JP" altLang="en-US" smtClean="0"/>
              <a:t>‹#›</a:t>
            </a:fld>
            <a:endParaRPr kumimoji="1" lang="ja-JP" altLang="en-US"/>
          </a:p>
        </p:txBody>
      </p:sp>
    </p:spTree>
    <p:extLst>
      <p:ext uri="{BB962C8B-B14F-4D97-AF65-F5344CB8AC3E}">
        <p14:creationId xmlns:p14="http://schemas.microsoft.com/office/powerpoint/2010/main" val="532949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6D72A68-3EFA-664B-ACC0-967A94CA54A5}" type="datetimeFigureOut">
              <a:rPr kumimoji="1" lang="ja-JP" altLang="en-US" smtClean="0"/>
              <a:t>2026/1/1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05D3E7D7-A3C6-BB4B-95A4-52E56D2676C5}" type="slidenum">
              <a:rPr kumimoji="1" lang="ja-JP" altLang="en-US" smtClean="0"/>
              <a:t>‹#›</a:t>
            </a:fld>
            <a:endParaRPr kumimoji="1" lang="ja-JP" altLang="en-US"/>
          </a:p>
        </p:txBody>
      </p:sp>
    </p:spTree>
    <p:extLst>
      <p:ext uri="{BB962C8B-B14F-4D97-AF65-F5344CB8AC3E}">
        <p14:creationId xmlns:p14="http://schemas.microsoft.com/office/powerpoint/2010/main" val="25230361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ja-JP" altLang="en-US"/>
              <a:t>マスター タイトルの書式設定</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6D72A68-3EFA-664B-ACC0-967A94CA54A5}" type="datetimeFigureOut">
              <a:rPr kumimoji="1" lang="ja-JP" altLang="en-US" smtClean="0"/>
              <a:t>2026/1/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5D3E7D7-A3C6-BB4B-95A4-52E56D2676C5}" type="slidenum">
              <a:rPr kumimoji="1" lang="ja-JP" altLang="en-US" smtClean="0"/>
              <a:t>‹#›</a:t>
            </a:fld>
            <a:endParaRPr kumimoji="1" lang="ja-JP" altLang="en-US"/>
          </a:p>
        </p:txBody>
      </p:sp>
    </p:spTree>
    <p:extLst>
      <p:ext uri="{BB962C8B-B14F-4D97-AF65-F5344CB8AC3E}">
        <p14:creationId xmlns:p14="http://schemas.microsoft.com/office/powerpoint/2010/main" val="37002441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6D72A68-3EFA-664B-ACC0-967A94CA54A5}" type="datetimeFigureOut">
              <a:rPr kumimoji="1" lang="ja-JP" altLang="en-US" smtClean="0"/>
              <a:t>2026/1/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5D3E7D7-A3C6-BB4B-95A4-52E56D2676C5}" type="slidenum">
              <a:rPr kumimoji="1" lang="ja-JP" altLang="en-US" smtClean="0"/>
              <a:t>‹#›</a:t>
            </a:fld>
            <a:endParaRPr kumimoji="1" lang="ja-JP" altLang="en-US"/>
          </a:p>
        </p:txBody>
      </p:sp>
    </p:spTree>
    <p:extLst>
      <p:ext uri="{BB962C8B-B14F-4D97-AF65-F5344CB8AC3E}">
        <p14:creationId xmlns:p14="http://schemas.microsoft.com/office/powerpoint/2010/main" val="12761579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82000"/>
                  </a:schemeClr>
                </a:solidFill>
              </a:defRPr>
            </a:lvl1pPr>
          </a:lstStyle>
          <a:p>
            <a:fld id="{96D72A68-3EFA-664B-ACC0-967A94CA54A5}" type="datetimeFigureOut">
              <a:rPr kumimoji="1" lang="ja-JP" altLang="en-US" smtClean="0"/>
              <a:t>2026/1/17</a:t>
            </a:fld>
            <a:endParaRPr kumimoji="1" lang="ja-JP" altLang="en-US"/>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82000"/>
                  </a:schemeClr>
                </a:solidFill>
              </a:defRPr>
            </a:lvl1pPr>
          </a:lstStyle>
          <a:p>
            <a:fld id="{05D3E7D7-A3C6-BB4B-95A4-52E56D2676C5}" type="slidenum">
              <a:rPr kumimoji="1" lang="ja-JP" altLang="en-US" smtClean="0"/>
              <a:t>‹#›</a:t>
            </a:fld>
            <a:endParaRPr kumimoji="1" lang="ja-JP" altLang="en-US"/>
          </a:p>
        </p:txBody>
      </p:sp>
    </p:spTree>
    <p:extLst>
      <p:ext uri="{BB962C8B-B14F-4D97-AF65-F5344CB8AC3E}">
        <p14:creationId xmlns:p14="http://schemas.microsoft.com/office/powerpoint/2010/main" val="1389411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55934" rtl="0" eaLnBrk="1" latinLnBrk="0" hangingPunct="1">
        <a:lnSpc>
          <a:spcPct val="90000"/>
        </a:lnSpc>
        <a:spcBef>
          <a:spcPct val="0"/>
        </a:spcBef>
        <a:buNone/>
        <a:defRPr kumimoji="1"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kumimoji="1"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kumimoji="1"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kumimoji="1"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kumimoji="1"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kumimoji="1"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kumimoji="1"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kumimoji="1"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kumimoji="1"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kumimoji="1" sz="1488" kern="1200">
          <a:solidFill>
            <a:schemeClr val="tx1"/>
          </a:solidFill>
          <a:latin typeface="+mn-lt"/>
          <a:ea typeface="+mn-ea"/>
          <a:cs typeface="+mn-cs"/>
        </a:defRPr>
      </a:lvl9pPr>
    </p:bodyStyle>
    <p:otherStyle>
      <a:defPPr>
        <a:defRPr lang="en-US"/>
      </a:defPPr>
      <a:lvl1pPr marL="0" algn="l" defTabSz="755934" rtl="0" eaLnBrk="1" latinLnBrk="0" hangingPunct="1">
        <a:defRPr kumimoji="1" sz="1488" kern="1200">
          <a:solidFill>
            <a:schemeClr val="tx1"/>
          </a:solidFill>
          <a:latin typeface="+mn-lt"/>
          <a:ea typeface="+mn-ea"/>
          <a:cs typeface="+mn-cs"/>
        </a:defRPr>
      </a:lvl1pPr>
      <a:lvl2pPr marL="377967" algn="l" defTabSz="755934" rtl="0" eaLnBrk="1" latinLnBrk="0" hangingPunct="1">
        <a:defRPr kumimoji="1" sz="1488" kern="1200">
          <a:solidFill>
            <a:schemeClr val="tx1"/>
          </a:solidFill>
          <a:latin typeface="+mn-lt"/>
          <a:ea typeface="+mn-ea"/>
          <a:cs typeface="+mn-cs"/>
        </a:defRPr>
      </a:lvl2pPr>
      <a:lvl3pPr marL="755934" algn="l" defTabSz="755934" rtl="0" eaLnBrk="1" latinLnBrk="0" hangingPunct="1">
        <a:defRPr kumimoji="1" sz="1488" kern="1200">
          <a:solidFill>
            <a:schemeClr val="tx1"/>
          </a:solidFill>
          <a:latin typeface="+mn-lt"/>
          <a:ea typeface="+mn-ea"/>
          <a:cs typeface="+mn-cs"/>
        </a:defRPr>
      </a:lvl3pPr>
      <a:lvl4pPr marL="1133902" algn="l" defTabSz="755934" rtl="0" eaLnBrk="1" latinLnBrk="0" hangingPunct="1">
        <a:defRPr kumimoji="1" sz="1488" kern="1200">
          <a:solidFill>
            <a:schemeClr val="tx1"/>
          </a:solidFill>
          <a:latin typeface="+mn-lt"/>
          <a:ea typeface="+mn-ea"/>
          <a:cs typeface="+mn-cs"/>
        </a:defRPr>
      </a:lvl4pPr>
      <a:lvl5pPr marL="1511869" algn="l" defTabSz="755934" rtl="0" eaLnBrk="1" latinLnBrk="0" hangingPunct="1">
        <a:defRPr kumimoji="1" sz="1488" kern="1200">
          <a:solidFill>
            <a:schemeClr val="tx1"/>
          </a:solidFill>
          <a:latin typeface="+mn-lt"/>
          <a:ea typeface="+mn-ea"/>
          <a:cs typeface="+mn-cs"/>
        </a:defRPr>
      </a:lvl5pPr>
      <a:lvl6pPr marL="1889836" algn="l" defTabSz="755934" rtl="0" eaLnBrk="1" latinLnBrk="0" hangingPunct="1">
        <a:defRPr kumimoji="1" sz="1488" kern="1200">
          <a:solidFill>
            <a:schemeClr val="tx1"/>
          </a:solidFill>
          <a:latin typeface="+mn-lt"/>
          <a:ea typeface="+mn-ea"/>
          <a:cs typeface="+mn-cs"/>
        </a:defRPr>
      </a:lvl6pPr>
      <a:lvl7pPr marL="2267803" algn="l" defTabSz="755934" rtl="0" eaLnBrk="1" latinLnBrk="0" hangingPunct="1">
        <a:defRPr kumimoji="1" sz="1488" kern="1200">
          <a:solidFill>
            <a:schemeClr val="tx1"/>
          </a:solidFill>
          <a:latin typeface="+mn-lt"/>
          <a:ea typeface="+mn-ea"/>
          <a:cs typeface="+mn-cs"/>
        </a:defRPr>
      </a:lvl7pPr>
      <a:lvl8pPr marL="2645771" algn="l" defTabSz="755934" rtl="0" eaLnBrk="1" latinLnBrk="0" hangingPunct="1">
        <a:defRPr kumimoji="1" sz="1488" kern="1200">
          <a:solidFill>
            <a:schemeClr val="tx1"/>
          </a:solidFill>
          <a:latin typeface="+mn-lt"/>
          <a:ea typeface="+mn-ea"/>
          <a:cs typeface="+mn-cs"/>
        </a:defRPr>
      </a:lvl8pPr>
      <a:lvl9pPr marL="3023738" algn="l" defTabSz="755934" rtl="0" eaLnBrk="1" latinLnBrk="0" hangingPunct="1">
        <a:defRPr kumimoji="1"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a:extLst>
              <a:ext uri="{FF2B5EF4-FFF2-40B4-BE49-F238E27FC236}">
                <a16:creationId xmlns:a16="http://schemas.microsoft.com/office/drawing/2014/main" id="{92CCAF8C-7157-E700-44BF-9C93CC617D2B}"/>
              </a:ext>
            </a:extLst>
          </p:cNvPr>
          <p:cNvGraphicFramePr>
            <a:graphicFrameLocks/>
          </p:cNvGraphicFramePr>
          <p:nvPr/>
        </p:nvGraphicFramePr>
        <p:xfrm>
          <a:off x="1455464" y="768790"/>
          <a:ext cx="5549051" cy="8030023"/>
        </p:xfrm>
        <a:graphic>
          <a:graphicData uri="http://schemas.openxmlformats.org/drawingml/2006/chart">
            <c:chart xmlns:c="http://schemas.openxmlformats.org/drawingml/2006/chart" xmlns:r="http://schemas.openxmlformats.org/officeDocument/2006/relationships" r:id="rId2"/>
          </a:graphicData>
        </a:graphic>
      </p:graphicFrame>
      <p:sp>
        <p:nvSpPr>
          <p:cNvPr id="6" name="テキスト ボックス 5">
            <a:extLst>
              <a:ext uri="{FF2B5EF4-FFF2-40B4-BE49-F238E27FC236}">
                <a16:creationId xmlns:a16="http://schemas.microsoft.com/office/drawing/2014/main" id="{79411FF4-76DF-F377-0E7A-5920530FC90F}"/>
              </a:ext>
            </a:extLst>
          </p:cNvPr>
          <p:cNvSpPr txBox="1"/>
          <p:nvPr/>
        </p:nvSpPr>
        <p:spPr>
          <a:xfrm rot="16200000">
            <a:off x="-391897" y="4178253"/>
            <a:ext cx="2885100" cy="291618"/>
          </a:xfrm>
          <a:prstGeom prst="rect">
            <a:avLst/>
          </a:prstGeom>
          <a:noFill/>
        </p:spPr>
        <p:txBody>
          <a:bodyPr wrap="square" rtlCol="0">
            <a:spAutoFit/>
          </a:bodyPr>
          <a:lstStyle/>
          <a:p>
            <a:pPr algn="ctr"/>
            <a:r>
              <a:rPr kumimoji="1" lang="en-US" altLang="ja-JP" sz="1295" dirty="0">
                <a:latin typeface="Times New Roman" panose="02020603050405020304" pitchFamily="18" charset="0"/>
                <a:cs typeface="Times New Roman" panose="02020603050405020304" pitchFamily="18" charset="0"/>
              </a:rPr>
              <a:t>Vertical diameter of cell (</a:t>
            </a:r>
            <a:r>
              <a:rPr kumimoji="1" lang="en-US" altLang="ja-JP" sz="1295" dirty="0" err="1">
                <a:latin typeface="Times New Roman" panose="02020603050405020304" pitchFamily="18" charset="0"/>
                <a:cs typeface="Times New Roman" panose="02020603050405020304" pitchFamily="18" charset="0"/>
              </a:rPr>
              <a:t>μm</a:t>
            </a:r>
            <a:r>
              <a:rPr kumimoji="1" lang="en-US" altLang="ja-JP" sz="1295" dirty="0">
                <a:latin typeface="Times New Roman" panose="02020603050405020304" pitchFamily="18" charset="0"/>
                <a:cs typeface="Times New Roman" panose="02020603050405020304" pitchFamily="18" charset="0"/>
              </a:rPr>
              <a:t>)</a:t>
            </a:r>
            <a:endParaRPr kumimoji="1" lang="ja-JP" altLang="en-US" sz="1295">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2622D031-6A05-6784-C851-3C35C830FCEF}"/>
              </a:ext>
            </a:extLst>
          </p:cNvPr>
          <p:cNvSpPr txBox="1"/>
          <p:nvPr/>
        </p:nvSpPr>
        <p:spPr>
          <a:xfrm>
            <a:off x="2893447" y="8499840"/>
            <a:ext cx="2885100" cy="291618"/>
          </a:xfrm>
          <a:prstGeom prst="rect">
            <a:avLst/>
          </a:prstGeom>
          <a:noFill/>
        </p:spPr>
        <p:txBody>
          <a:bodyPr wrap="square" rtlCol="0">
            <a:spAutoFit/>
          </a:bodyPr>
          <a:lstStyle/>
          <a:p>
            <a:pPr algn="ctr"/>
            <a:r>
              <a:rPr kumimoji="1" lang="en-US" altLang="ja-JP" sz="1295" dirty="0">
                <a:latin typeface="Times New Roman" panose="02020603050405020304" pitchFamily="18" charset="0"/>
                <a:cs typeface="Times New Roman" panose="02020603050405020304" pitchFamily="18" charset="0"/>
              </a:rPr>
              <a:t>Lateral diameter of cell (</a:t>
            </a:r>
            <a:r>
              <a:rPr kumimoji="1" lang="en-US" altLang="ja-JP" sz="1295" dirty="0" err="1">
                <a:latin typeface="Times New Roman" panose="02020603050405020304" pitchFamily="18" charset="0"/>
                <a:cs typeface="Times New Roman" panose="02020603050405020304" pitchFamily="18" charset="0"/>
              </a:rPr>
              <a:t>μm</a:t>
            </a:r>
            <a:r>
              <a:rPr kumimoji="1" lang="en-US" altLang="ja-JP" sz="1295" dirty="0">
                <a:latin typeface="Times New Roman" panose="02020603050405020304" pitchFamily="18" charset="0"/>
                <a:cs typeface="Times New Roman" panose="02020603050405020304" pitchFamily="18" charset="0"/>
              </a:rPr>
              <a:t>)</a:t>
            </a:r>
            <a:endParaRPr kumimoji="1" lang="ja-JP" altLang="en-US" sz="1295">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2B5ECBF5-2AEB-7A03-38F3-9ABEEAF24A0D}"/>
              </a:ext>
            </a:extLst>
          </p:cNvPr>
          <p:cNvSpPr txBox="1"/>
          <p:nvPr/>
        </p:nvSpPr>
        <p:spPr>
          <a:xfrm>
            <a:off x="1977023" y="1065517"/>
            <a:ext cx="1776658" cy="291618"/>
          </a:xfrm>
          <a:prstGeom prst="rect">
            <a:avLst/>
          </a:prstGeom>
          <a:noFill/>
        </p:spPr>
        <p:txBody>
          <a:bodyPr wrap="square" rtlCol="0">
            <a:spAutoFit/>
          </a:bodyPr>
          <a:lstStyle/>
          <a:p>
            <a:r>
              <a:rPr kumimoji="1" lang="en-US" altLang="ja-JP" sz="1295" dirty="0">
                <a:latin typeface="Times New Roman" panose="02020603050405020304" pitchFamily="18" charset="0"/>
                <a:cs typeface="Times New Roman" panose="02020603050405020304" pitchFamily="18" charset="0"/>
              </a:rPr>
              <a:t>inner wall at DAFB39</a:t>
            </a:r>
            <a:endParaRPr kumimoji="1" lang="ja-JP" altLang="en-US" sz="1295">
              <a:latin typeface="Times New Roman" panose="02020603050405020304" pitchFamily="18" charset="0"/>
              <a:cs typeface="Times New Roman" panose="02020603050405020304" pitchFamily="18" charset="0"/>
            </a:endParaRPr>
          </a:p>
        </p:txBody>
      </p:sp>
      <p:sp>
        <p:nvSpPr>
          <p:cNvPr id="9" name="テキスト ボックス 20">
            <a:extLst>
              <a:ext uri="{FF2B5EF4-FFF2-40B4-BE49-F238E27FC236}">
                <a16:creationId xmlns:a16="http://schemas.microsoft.com/office/drawing/2014/main" id="{8AF03077-FC3A-3CF1-70B0-AC60D103E1F9}"/>
              </a:ext>
            </a:extLst>
          </p:cNvPr>
          <p:cNvSpPr txBox="1"/>
          <p:nvPr/>
        </p:nvSpPr>
        <p:spPr>
          <a:xfrm>
            <a:off x="869464" y="619303"/>
            <a:ext cx="577821" cy="291618"/>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1295" spc="108" dirty="0">
                <a:latin typeface="Times New Roman" panose="02020603050405020304" pitchFamily="18" charset="0"/>
                <a:ea typeface="Hiragino Kaku Gothic Pro W3" panose="020B0300000000000000" pitchFamily="34" charset="-128"/>
                <a:cs typeface="Times New Roman" panose="02020603050405020304" pitchFamily="18" charset="0"/>
              </a:rPr>
              <a:t>(a)</a:t>
            </a:r>
          </a:p>
        </p:txBody>
      </p:sp>
      <p:sp>
        <p:nvSpPr>
          <p:cNvPr id="2" name="テキスト ボックス 1">
            <a:extLst>
              <a:ext uri="{FF2B5EF4-FFF2-40B4-BE49-F238E27FC236}">
                <a16:creationId xmlns:a16="http://schemas.microsoft.com/office/drawing/2014/main" id="{BD16DF3A-247E-C89F-78BE-4B509BF67B9B}"/>
              </a:ext>
            </a:extLst>
          </p:cNvPr>
          <p:cNvSpPr txBox="1"/>
          <p:nvPr/>
        </p:nvSpPr>
        <p:spPr>
          <a:xfrm>
            <a:off x="5457630" y="222640"/>
            <a:ext cx="1966625" cy="291618"/>
          </a:xfrm>
          <a:prstGeom prst="rect">
            <a:avLst/>
          </a:prstGeom>
          <a:noFill/>
        </p:spPr>
        <p:txBody>
          <a:bodyPr wrap="square" rtlCol="0">
            <a:spAutoFit/>
          </a:bodyPr>
          <a:lstStyle/>
          <a:p>
            <a:r>
              <a:rPr kumimoji="1" lang="en-US" altLang="ja-JP" sz="1295" dirty="0">
                <a:latin typeface="Times New Roman" panose="02020603050405020304" pitchFamily="18" charset="0"/>
                <a:cs typeface="Times New Roman" panose="02020603050405020304" pitchFamily="18" charset="0"/>
              </a:rPr>
              <a:t>Ishikawa et al., Figure S1</a:t>
            </a:r>
            <a:endParaRPr kumimoji="1" lang="ja-JP" altLang="en-US" sz="1295">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275562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グラフ 1">
            <a:extLst>
              <a:ext uri="{FF2B5EF4-FFF2-40B4-BE49-F238E27FC236}">
                <a16:creationId xmlns:a16="http://schemas.microsoft.com/office/drawing/2014/main" id="{C7B4650D-0110-9FF5-8674-DD07B25BDD4A}"/>
              </a:ext>
            </a:extLst>
          </p:cNvPr>
          <p:cNvGraphicFramePr>
            <a:graphicFrameLocks/>
          </p:cNvGraphicFramePr>
          <p:nvPr/>
        </p:nvGraphicFramePr>
        <p:xfrm>
          <a:off x="1079099" y="746871"/>
          <a:ext cx="5821438" cy="7983840"/>
        </p:xfrm>
        <a:graphic>
          <a:graphicData uri="http://schemas.openxmlformats.org/drawingml/2006/chart">
            <c:chart xmlns:c="http://schemas.openxmlformats.org/drawingml/2006/chart" xmlns:r="http://schemas.openxmlformats.org/officeDocument/2006/relationships" r:id="rId2"/>
          </a:graphicData>
        </a:graphic>
      </p:graphicFrame>
      <p:sp>
        <p:nvSpPr>
          <p:cNvPr id="4" name="テキスト ボックス 3">
            <a:extLst>
              <a:ext uri="{FF2B5EF4-FFF2-40B4-BE49-F238E27FC236}">
                <a16:creationId xmlns:a16="http://schemas.microsoft.com/office/drawing/2014/main" id="{D535AFEB-EE97-5F70-0555-6838373831D2}"/>
              </a:ext>
            </a:extLst>
          </p:cNvPr>
          <p:cNvSpPr txBox="1"/>
          <p:nvPr/>
        </p:nvSpPr>
        <p:spPr>
          <a:xfrm rot="16200000">
            <a:off x="-391897" y="4178253"/>
            <a:ext cx="2885100" cy="291618"/>
          </a:xfrm>
          <a:prstGeom prst="rect">
            <a:avLst/>
          </a:prstGeom>
          <a:noFill/>
        </p:spPr>
        <p:txBody>
          <a:bodyPr wrap="square" rtlCol="0">
            <a:spAutoFit/>
          </a:bodyPr>
          <a:lstStyle/>
          <a:p>
            <a:pPr algn="ctr"/>
            <a:r>
              <a:rPr kumimoji="1" lang="en-US" altLang="ja-JP" sz="1295" dirty="0">
                <a:latin typeface="Times New Roman" panose="02020603050405020304" pitchFamily="18" charset="0"/>
                <a:cs typeface="Times New Roman" panose="02020603050405020304" pitchFamily="18" charset="0"/>
              </a:rPr>
              <a:t>Vertical diameter of cell (</a:t>
            </a:r>
            <a:r>
              <a:rPr kumimoji="1" lang="en-US" altLang="ja-JP" sz="1295" dirty="0" err="1">
                <a:latin typeface="Times New Roman" panose="02020603050405020304" pitchFamily="18" charset="0"/>
                <a:cs typeface="Times New Roman" panose="02020603050405020304" pitchFamily="18" charset="0"/>
              </a:rPr>
              <a:t>μm</a:t>
            </a:r>
            <a:r>
              <a:rPr kumimoji="1" lang="en-US" altLang="ja-JP" sz="1295" dirty="0">
                <a:latin typeface="Times New Roman" panose="02020603050405020304" pitchFamily="18" charset="0"/>
                <a:cs typeface="Times New Roman" panose="02020603050405020304" pitchFamily="18" charset="0"/>
              </a:rPr>
              <a:t>)</a:t>
            </a:r>
            <a:endParaRPr kumimoji="1" lang="ja-JP" altLang="en-US" sz="1295">
              <a:latin typeface="Times New Roman" panose="02020603050405020304" pitchFamily="18" charset="0"/>
              <a:cs typeface="Times New Roman" panose="02020603050405020304" pitchFamily="18" charset="0"/>
            </a:endParaRPr>
          </a:p>
        </p:txBody>
      </p:sp>
      <p:sp>
        <p:nvSpPr>
          <p:cNvPr id="5" name="テキスト ボックス 4">
            <a:extLst>
              <a:ext uri="{FF2B5EF4-FFF2-40B4-BE49-F238E27FC236}">
                <a16:creationId xmlns:a16="http://schemas.microsoft.com/office/drawing/2014/main" id="{E33ED287-18B8-3B3B-4B45-50FCC3E47EA1}"/>
              </a:ext>
            </a:extLst>
          </p:cNvPr>
          <p:cNvSpPr txBox="1"/>
          <p:nvPr/>
        </p:nvSpPr>
        <p:spPr>
          <a:xfrm>
            <a:off x="2893447" y="8499840"/>
            <a:ext cx="2885100" cy="291618"/>
          </a:xfrm>
          <a:prstGeom prst="rect">
            <a:avLst/>
          </a:prstGeom>
          <a:noFill/>
        </p:spPr>
        <p:txBody>
          <a:bodyPr wrap="square" rtlCol="0">
            <a:spAutoFit/>
          </a:bodyPr>
          <a:lstStyle/>
          <a:p>
            <a:pPr algn="ctr"/>
            <a:r>
              <a:rPr kumimoji="1" lang="en-US" altLang="ja-JP" sz="1295" dirty="0">
                <a:latin typeface="Times New Roman" panose="02020603050405020304" pitchFamily="18" charset="0"/>
                <a:cs typeface="Times New Roman" panose="02020603050405020304" pitchFamily="18" charset="0"/>
              </a:rPr>
              <a:t>Lateral diameter of cell (</a:t>
            </a:r>
            <a:r>
              <a:rPr kumimoji="1" lang="en-US" altLang="ja-JP" sz="1295" dirty="0" err="1">
                <a:latin typeface="Times New Roman" panose="02020603050405020304" pitchFamily="18" charset="0"/>
                <a:cs typeface="Times New Roman" panose="02020603050405020304" pitchFamily="18" charset="0"/>
              </a:rPr>
              <a:t>μm</a:t>
            </a:r>
            <a:r>
              <a:rPr kumimoji="1" lang="en-US" altLang="ja-JP" sz="1295" dirty="0">
                <a:latin typeface="Times New Roman" panose="02020603050405020304" pitchFamily="18" charset="0"/>
                <a:cs typeface="Times New Roman" panose="02020603050405020304" pitchFamily="18" charset="0"/>
              </a:rPr>
              <a:t>)</a:t>
            </a:r>
            <a:endParaRPr kumimoji="1" lang="ja-JP" altLang="en-US" sz="1295">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C94512DC-2AF7-EEC8-47A6-F8C6DA15FB8E}"/>
              </a:ext>
            </a:extLst>
          </p:cNvPr>
          <p:cNvSpPr txBox="1"/>
          <p:nvPr/>
        </p:nvSpPr>
        <p:spPr>
          <a:xfrm>
            <a:off x="1876215" y="1592585"/>
            <a:ext cx="1776658" cy="291618"/>
          </a:xfrm>
          <a:prstGeom prst="rect">
            <a:avLst/>
          </a:prstGeom>
          <a:noFill/>
        </p:spPr>
        <p:txBody>
          <a:bodyPr wrap="square" rtlCol="0">
            <a:spAutoFit/>
          </a:bodyPr>
          <a:lstStyle/>
          <a:p>
            <a:r>
              <a:rPr kumimoji="1" lang="en-US" altLang="ja-JP" sz="1295" dirty="0">
                <a:latin typeface="Times New Roman" panose="02020603050405020304" pitchFamily="18" charset="0"/>
                <a:cs typeface="Times New Roman" panose="02020603050405020304" pitchFamily="18" charset="0"/>
              </a:rPr>
              <a:t>outer wall at DAFB39</a:t>
            </a:r>
            <a:endParaRPr kumimoji="1" lang="ja-JP" altLang="en-US" sz="1295">
              <a:latin typeface="Times New Roman" panose="02020603050405020304" pitchFamily="18" charset="0"/>
              <a:cs typeface="Times New Roman" panose="02020603050405020304" pitchFamily="18" charset="0"/>
            </a:endParaRPr>
          </a:p>
        </p:txBody>
      </p:sp>
      <p:sp>
        <p:nvSpPr>
          <p:cNvPr id="7" name="テキスト ボックス 20">
            <a:extLst>
              <a:ext uri="{FF2B5EF4-FFF2-40B4-BE49-F238E27FC236}">
                <a16:creationId xmlns:a16="http://schemas.microsoft.com/office/drawing/2014/main" id="{C10F9AB4-9271-E3D8-DE22-64F953AF675D}"/>
              </a:ext>
            </a:extLst>
          </p:cNvPr>
          <p:cNvSpPr txBox="1"/>
          <p:nvPr/>
        </p:nvSpPr>
        <p:spPr>
          <a:xfrm>
            <a:off x="869464" y="619303"/>
            <a:ext cx="577821" cy="291618"/>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1295" spc="108" dirty="0">
                <a:latin typeface="Times New Roman" panose="02020603050405020304" pitchFamily="18" charset="0"/>
                <a:ea typeface="Hiragino Kaku Gothic Pro W3" panose="020B0300000000000000" pitchFamily="34" charset="-128"/>
                <a:cs typeface="Times New Roman" panose="02020603050405020304" pitchFamily="18" charset="0"/>
              </a:rPr>
              <a:t>(b)</a:t>
            </a:r>
          </a:p>
        </p:txBody>
      </p:sp>
      <p:sp>
        <p:nvSpPr>
          <p:cNvPr id="8" name="テキスト ボックス 7">
            <a:extLst>
              <a:ext uri="{FF2B5EF4-FFF2-40B4-BE49-F238E27FC236}">
                <a16:creationId xmlns:a16="http://schemas.microsoft.com/office/drawing/2014/main" id="{0F8B8AA1-CF76-59DF-109C-EF63A8410969}"/>
              </a:ext>
            </a:extLst>
          </p:cNvPr>
          <p:cNvSpPr txBox="1"/>
          <p:nvPr/>
        </p:nvSpPr>
        <p:spPr>
          <a:xfrm>
            <a:off x="5457630" y="222640"/>
            <a:ext cx="1966625" cy="291618"/>
          </a:xfrm>
          <a:prstGeom prst="rect">
            <a:avLst/>
          </a:prstGeom>
          <a:noFill/>
        </p:spPr>
        <p:txBody>
          <a:bodyPr wrap="square" rtlCol="0">
            <a:spAutoFit/>
          </a:bodyPr>
          <a:lstStyle/>
          <a:p>
            <a:r>
              <a:rPr kumimoji="1" lang="en-US" altLang="ja-JP" sz="1295" dirty="0">
                <a:latin typeface="Times New Roman" panose="02020603050405020304" pitchFamily="18" charset="0"/>
                <a:cs typeface="Times New Roman" panose="02020603050405020304" pitchFamily="18" charset="0"/>
              </a:rPr>
              <a:t>Ishikawa et al., Figure S1</a:t>
            </a:r>
            <a:endParaRPr kumimoji="1" lang="ja-JP" altLang="en-US" sz="1295">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69921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グラフ 1">
            <a:extLst>
              <a:ext uri="{FF2B5EF4-FFF2-40B4-BE49-F238E27FC236}">
                <a16:creationId xmlns:a16="http://schemas.microsoft.com/office/drawing/2014/main" id="{BD3A164C-9EC5-1819-D3C4-A36964EA410C}"/>
              </a:ext>
            </a:extLst>
          </p:cNvPr>
          <p:cNvGraphicFramePr>
            <a:graphicFrameLocks/>
          </p:cNvGraphicFramePr>
          <p:nvPr/>
        </p:nvGraphicFramePr>
        <p:xfrm>
          <a:off x="1332500" y="800219"/>
          <a:ext cx="5615163" cy="8002187"/>
        </p:xfrm>
        <a:graphic>
          <a:graphicData uri="http://schemas.openxmlformats.org/drawingml/2006/chart">
            <c:chart xmlns:c="http://schemas.openxmlformats.org/drawingml/2006/chart" xmlns:r="http://schemas.openxmlformats.org/officeDocument/2006/relationships" r:id="rId2"/>
          </a:graphicData>
        </a:graphic>
      </p:graphicFrame>
      <p:sp>
        <p:nvSpPr>
          <p:cNvPr id="4" name="テキスト ボックス 3">
            <a:extLst>
              <a:ext uri="{FF2B5EF4-FFF2-40B4-BE49-F238E27FC236}">
                <a16:creationId xmlns:a16="http://schemas.microsoft.com/office/drawing/2014/main" id="{F93A0300-8DC0-5EE8-991B-3315B33104D5}"/>
              </a:ext>
            </a:extLst>
          </p:cNvPr>
          <p:cNvSpPr txBox="1"/>
          <p:nvPr/>
        </p:nvSpPr>
        <p:spPr>
          <a:xfrm rot="16200000">
            <a:off x="-391897" y="4178253"/>
            <a:ext cx="2885100" cy="291618"/>
          </a:xfrm>
          <a:prstGeom prst="rect">
            <a:avLst/>
          </a:prstGeom>
          <a:noFill/>
        </p:spPr>
        <p:txBody>
          <a:bodyPr wrap="square" rtlCol="0">
            <a:spAutoFit/>
          </a:bodyPr>
          <a:lstStyle/>
          <a:p>
            <a:pPr algn="ctr"/>
            <a:r>
              <a:rPr kumimoji="1" lang="en-US" altLang="ja-JP" sz="1295" dirty="0">
                <a:latin typeface="Times New Roman" panose="02020603050405020304" pitchFamily="18" charset="0"/>
                <a:cs typeface="Times New Roman" panose="02020603050405020304" pitchFamily="18" charset="0"/>
              </a:rPr>
              <a:t>Vertical diameter of cell (</a:t>
            </a:r>
            <a:r>
              <a:rPr kumimoji="1" lang="en-US" altLang="ja-JP" sz="1295" dirty="0" err="1">
                <a:latin typeface="Times New Roman" panose="02020603050405020304" pitchFamily="18" charset="0"/>
                <a:cs typeface="Times New Roman" panose="02020603050405020304" pitchFamily="18" charset="0"/>
              </a:rPr>
              <a:t>μm</a:t>
            </a:r>
            <a:r>
              <a:rPr kumimoji="1" lang="en-US" altLang="ja-JP" sz="1295" dirty="0">
                <a:latin typeface="Times New Roman" panose="02020603050405020304" pitchFamily="18" charset="0"/>
                <a:cs typeface="Times New Roman" panose="02020603050405020304" pitchFamily="18" charset="0"/>
              </a:rPr>
              <a:t>)</a:t>
            </a:r>
            <a:endParaRPr kumimoji="1" lang="ja-JP" altLang="en-US" sz="1295">
              <a:latin typeface="Times New Roman" panose="02020603050405020304" pitchFamily="18" charset="0"/>
              <a:cs typeface="Times New Roman" panose="02020603050405020304" pitchFamily="18" charset="0"/>
            </a:endParaRPr>
          </a:p>
        </p:txBody>
      </p:sp>
      <p:sp>
        <p:nvSpPr>
          <p:cNvPr id="5" name="テキスト ボックス 4">
            <a:extLst>
              <a:ext uri="{FF2B5EF4-FFF2-40B4-BE49-F238E27FC236}">
                <a16:creationId xmlns:a16="http://schemas.microsoft.com/office/drawing/2014/main" id="{32FECED2-F445-1EC9-E7C2-DB1962C6347A}"/>
              </a:ext>
            </a:extLst>
          </p:cNvPr>
          <p:cNvSpPr txBox="1"/>
          <p:nvPr/>
        </p:nvSpPr>
        <p:spPr>
          <a:xfrm>
            <a:off x="2893447" y="8499840"/>
            <a:ext cx="2885100" cy="291618"/>
          </a:xfrm>
          <a:prstGeom prst="rect">
            <a:avLst/>
          </a:prstGeom>
          <a:noFill/>
        </p:spPr>
        <p:txBody>
          <a:bodyPr wrap="square" rtlCol="0">
            <a:spAutoFit/>
          </a:bodyPr>
          <a:lstStyle/>
          <a:p>
            <a:pPr algn="ctr"/>
            <a:r>
              <a:rPr kumimoji="1" lang="en-US" altLang="ja-JP" sz="1295" dirty="0">
                <a:latin typeface="Times New Roman" panose="02020603050405020304" pitchFamily="18" charset="0"/>
                <a:cs typeface="Times New Roman" panose="02020603050405020304" pitchFamily="18" charset="0"/>
              </a:rPr>
              <a:t>Lateral diameter of cell (</a:t>
            </a:r>
            <a:r>
              <a:rPr kumimoji="1" lang="en-US" altLang="ja-JP" sz="1295" dirty="0" err="1">
                <a:latin typeface="Times New Roman" panose="02020603050405020304" pitchFamily="18" charset="0"/>
                <a:cs typeface="Times New Roman" panose="02020603050405020304" pitchFamily="18" charset="0"/>
              </a:rPr>
              <a:t>μm</a:t>
            </a:r>
            <a:r>
              <a:rPr kumimoji="1" lang="en-US" altLang="ja-JP" sz="1295" dirty="0">
                <a:latin typeface="Times New Roman" panose="02020603050405020304" pitchFamily="18" charset="0"/>
                <a:cs typeface="Times New Roman" panose="02020603050405020304" pitchFamily="18" charset="0"/>
              </a:rPr>
              <a:t>)</a:t>
            </a:r>
            <a:endParaRPr kumimoji="1" lang="ja-JP" altLang="en-US" sz="1295">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9F909E05-4DE0-127A-760D-C338CDB3E21D}"/>
              </a:ext>
            </a:extLst>
          </p:cNvPr>
          <p:cNvSpPr txBox="1"/>
          <p:nvPr/>
        </p:nvSpPr>
        <p:spPr>
          <a:xfrm>
            <a:off x="1876215" y="1070895"/>
            <a:ext cx="1776658" cy="291618"/>
          </a:xfrm>
          <a:prstGeom prst="rect">
            <a:avLst/>
          </a:prstGeom>
          <a:noFill/>
        </p:spPr>
        <p:txBody>
          <a:bodyPr wrap="square" rtlCol="0">
            <a:spAutoFit/>
          </a:bodyPr>
          <a:lstStyle/>
          <a:p>
            <a:r>
              <a:rPr kumimoji="1" lang="en-US" altLang="ja-JP" sz="1295" dirty="0">
                <a:latin typeface="Times New Roman" panose="02020603050405020304" pitchFamily="18" charset="0"/>
                <a:cs typeface="Times New Roman" panose="02020603050405020304" pitchFamily="18" charset="0"/>
              </a:rPr>
              <a:t>inner wall at DAFB105</a:t>
            </a:r>
            <a:endParaRPr kumimoji="1" lang="ja-JP" altLang="en-US" sz="1295">
              <a:latin typeface="Times New Roman" panose="02020603050405020304" pitchFamily="18" charset="0"/>
              <a:cs typeface="Times New Roman" panose="02020603050405020304" pitchFamily="18" charset="0"/>
            </a:endParaRPr>
          </a:p>
        </p:txBody>
      </p:sp>
      <p:sp>
        <p:nvSpPr>
          <p:cNvPr id="7" name="テキスト ボックス 20">
            <a:extLst>
              <a:ext uri="{FF2B5EF4-FFF2-40B4-BE49-F238E27FC236}">
                <a16:creationId xmlns:a16="http://schemas.microsoft.com/office/drawing/2014/main" id="{693B35D8-A9D5-43F7-A5CB-26F6018B7C65}"/>
              </a:ext>
            </a:extLst>
          </p:cNvPr>
          <p:cNvSpPr txBox="1"/>
          <p:nvPr/>
        </p:nvSpPr>
        <p:spPr>
          <a:xfrm>
            <a:off x="869464" y="619303"/>
            <a:ext cx="577821" cy="291618"/>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1295" spc="108" dirty="0">
                <a:latin typeface="Times New Roman" panose="02020603050405020304" pitchFamily="18" charset="0"/>
                <a:ea typeface="Hiragino Kaku Gothic Pro W3" panose="020B0300000000000000" pitchFamily="34" charset="-128"/>
                <a:cs typeface="Times New Roman" panose="02020603050405020304" pitchFamily="18" charset="0"/>
              </a:rPr>
              <a:t>(c)</a:t>
            </a:r>
          </a:p>
        </p:txBody>
      </p:sp>
      <p:sp>
        <p:nvSpPr>
          <p:cNvPr id="8" name="テキスト ボックス 7">
            <a:extLst>
              <a:ext uri="{FF2B5EF4-FFF2-40B4-BE49-F238E27FC236}">
                <a16:creationId xmlns:a16="http://schemas.microsoft.com/office/drawing/2014/main" id="{B6EBA25C-3FEC-CA94-B407-71D32863B3C2}"/>
              </a:ext>
            </a:extLst>
          </p:cNvPr>
          <p:cNvSpPr txBox="1"/>
          <p:nvPr/>
        </p:nvSpPr>
        <p:spPr>
          <a:xfrm>
            <a:off x="5457630" y="222640"/>
            <a:ext cx="1966625" cy="291618"/>
          </a:xfrm>
          <a:prstGeom prst="rect">
            <a:avLst/>
          </a:prstGeom>
          <a:noFill/>
        </p:spPr>
        <p:txBody>
          <a:bodyPr wrap="square" rtlCol="0">
            <a:spAutoFit/>
          </a:bodyPr>
          <a:lstStyle/>
          <a:p>
            <a:r>
              <a:rPr kumimoji="1" lang="en-US" altLang="ja-JP" sz="1295" dirty="0">
                <a:latin typeface="Times New Roman" panose="02020603050405020304" pitchFamily="18" charset="0"/>
                <a:cs typeface="Times New Roman" panose="02020603050405020304" pitchFamily="18" charset="0"/>
              </a:rPr>
              <a:t>Ishikawa et al., Figure S1</a:t>
            </a:r>
            <a:endParaRPr kumimoji="1" lang="ja-JP" altLang="en-US" sz="1295">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09284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グラフ 2">
            <a:extLst>
              <a:ext uri="{FF2B5EF4-FFF2-40B4-BE49-F238E27FC236}">
                <a16:creationId xmlns:a16="http://schemas.microsoft.com/office/drawing/2014/main" id="{40BAA7F9-0025-394A-933F-A0CC6DB51E68}"/>
              </a:ext>
            </a:extLst>
          </p:cNvPr>
          <p:cNvGraphicFramePr>
            <a:graphicFrameLocks/>
          </p:cNvGraphicFramePr>
          <p:nvPr/>
        </p:nvGraphicFramePr>
        <p:xfrm>
          <a:off x="748778" y="626839"/>
          <a:ext cx="6335654" cy="8028861"/>
        </p:xfrm>
        <a:graphic>
          <a:graphicData uri="http://schemas.openxmlformats.org/drawingml/2006/chart">
            <c:chart xmlns:c="http://schemas.openxmlformats.org/drawingml/2006/chart" xmlns:r="http://schemas.openxmlformats.org/officeDocument/2006/relationships" r:id="rId3"/>
          </a:graphicData>
        </a:graphic>
      </p:graphicFrame>
      <p:sp>
        <p:nvSpPr>
          <p:cNvPr id="4" name="テキスト ボックス 3">
            <a:extLst>
              <a:ext uri="{FF2B5EF4-FFF2-40B4-BE49-F238E27FC236}">
                <a16:creationId xmlns:a16="http://schemas.microsoft.com/office/drawing/2014/main" id="{8A563B98-4F00-A642-BB7D-839AEB698F06}"/>
              </a:ext>
            </a:extLst>
          </p:cNvPr>
          <p:cNvSpPr txBox="1"/>
          <p:nvPr/>
        </p:nvSpPr>
        <p:spPr>
          <a:xfrm>
            <a:off x="5457630" y="222640"/>
            <a:ext cx="1966625" cy="291618"/>
          </a:xfrm>
          <a:prstGeom prst="rect">
            <a:avLst/>
          </a:prstGeom>
          <a:noFill/>
        </p:spPr>
        <p:txBody>
          <a:bodyPr wrap="square" rtlCol="0">
            <a:spAutoFit/>
          </a:bodyPr>
          <a:lstStyle/>
          <a:p>
            <a:r>
              <a:rPr kumimoji="1" lang="en-US" altLang="ja-JP" sz="1295" dirty="0">
                <a:latin typeface="Times New Roman" panose="02020603050405020304" pitchFamily="18" charset="0"/>
                <a:cs typeface="Times New Roman" panose="02020603050405020304" pitchFamily="18" charset="0"/>
              </a:rPr>
              <a:t>Ishikawa et al., Figure S1</a:t>
            </a:r>
            <a:endParaRPr kumimoji="1" lang="ja-JP" altLang="en-US" sz="1295" dirty="0">
              <a:latin typeface="Times New Roman" panose="02020603050405020304" pitchFamily="18" charset="0"/>
              <a:cs typeface="Times New Roman" panose="02020603050405020304" pitchFamily="18" charset="0"/>
            </a:endParaRPr>
          </a:p>
        </p:txBody>
      </p:sp>
      <p:sp>
        <p:nvSpPr>
          <p:cNvPr id="5" name="テキスト ボックス 4">
            <a:extLst>
              <a:ext uri="{FF2B5EF4-FFF2-40B4-BE49-F238E27FC236}">
                <a16:creationId xmlns:a16="http://schemas.microsoft.com/office/drawing/2014/main" id="{E825B0ED-B6CA-461F-3007-52990157E184}"/>
              </a:ext>
            </a:extLst>
          </p:cNvPr>
          <p:cNvSpPr txBox="1"/>
          <p:nvPr/>
        </p:nvSpPr>
        <p:spPr>
          <a:xfrm rot="16200000">
            <a:off x="-391897" y="4178253"/>
            <a:ext cx="2885100" cy="291618"/>
          </a:xfrm>
          <a:prstGeom prst="rect">
            <a:avLst/>
          </a:prstGeom>
          <a:noFill/>
        </p:spPr>
        <p:txBody>
          <a:bodyPr wrap="square" rtlCol="0">
            <a:spAutoFit/>
          </a:bodyPr>
          <a:lstStyle/>
          <a:p>
            <a:pPr algn="ctr"/>
            <a:r>
              <a:rPr kumimoji="1" lang="en-US" altLang="ja-JP" sz="1295" dirty="0">
                <a:latin typeface="Times New Roman" panose="02020603050405020304" pitchFamily="18" charset="0"/>
                <a:cs typeface="Times New Roman" panose="02020603050405020304" pitchFamily="18" charset="0"/>
              </a:rPr>
              <a:t>Vertical diameter of cell (</a:t>
            </a:r>
            <a:r>
              <a:rPr kumimoji="1" lang="en-US" altLang="ja-JP" sz="1295" dirty="0" err="1">
                <a:latin typeface="Times New Roman" panose="02020603050405020304" pitchFamily="18" charset="0"/>
                <a:cs typeface="Times New Roman" panose="02020603050405020304" pitchFamily="18" charset="0"/>
              </a:rPr>
              <a:t>μm</a:t>
            </a:r>
            <a:r>
              <a:rPr kumimoji="1" lang="en-US" altLang="ja-JP" sz="1295" dirty="0">
                <a:latin typeface="Times New Roman" panose="02020603050405020304" pitchFamily="18" charset="0"/>
                <a:cs typeface="Times New Roman" panose="02020603050405020304" pitchFamily="18" charset="0"/>
              </a:rPr>
              <a:t>)</a:t>
            </a:r>
            <a:endParaRPr kumimoji="1" lang="ja-JP" altLang="en-US" sz="1295">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7C7DAF09-666C-C475-629A-95FF34EB8072}"/>
              </a:ext>
            </a:extLst>
          </p:cNvPr>
          <p:cNvSpPr txBox="1"/>
          <p:nvPr/>
        </p:nvSpPr>
        <p:spPr>
          <a:xfrm>
            <a:off x="2893447" y="8499840"/>
            <a:ext cx="2885100" cy="291618"/>
          </a:xfrm>
          <a:prstGeom prst="rect">
            <a:avLst/>
          </a:prstGeom>
          <a:noFill/>
        </p:spPr>
        <p:txBody>
          <a:bodyPr wrap="square" rtlCol="0">
            <a:spAutoFit/>
          </a:bodyPr>
          <a:lstStyle/>
          <a:p>
            <a:pPr algn="ctr"/>
            <a:r>
              <a:rPr kumimoji="1" lang="en-US" altLang="ja-JP" sz="1295" dirty="0">
                <a:latin typeface="Times New Roman" panose="02020603050405020304" pitchFamily="18" charset="0"/>
                <a:cs typeface="Times New Roman" panose="02020603050405020304" pitchFamily="18" charset="0"/>
              </a:rPr>
              <a:t>Lateral diameter of cell (</a:t>
            </a:r>
            <a:r>
              <a:rPr kumimoji="1" lang="en-US" altLang="ja-JP" sz="1295" dirty="0" err="1">
                <a:latin typeface="Times New Roman" panose="02020603050405020304" pitchFamily="18" charset="0"/>
                <a:cs typeface="Times New Roman" panose="02020603050405020304" pitchFamily="18" charset="0"/>
              </a:rPr>
              <a:t>μm</a:t>
            </a:r>
            <a:r>
              <a:rPr kumimoji="1" lang="en-US" altLang="ja-JP" sz="1295" dirty="0">
                <a:latin typeface="Times New Roman" panose="02020603050405020304" pitchFamily="18" charset="0"/>
                <a:cs typeface="Times New Roman" panose="02020603050405020304" pitchFamily="18" charset="0"/>
              </a:rPr>
              <a:t>)</a:t>
            </a:r>
            <a:endParaRPr kumimoji="1" lang="ja-JP" altLang="en-US" sz="1295">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701B592C-F06E-3A0C-259B-0E2C45EF8DD1}"/>
              </a:ext>
            </a:extLst>
          </p:cNvPr>
          <p:cNvSpPr txBox="1"/>
          <p:nvPr/>
        </p:nvSpPr>
        <p:spPr>
          <a:xfrm>
            <a:off x="1876215" y="1070895"/>
            <a:ext cx="1776658" cy="291618"/>
          </a:xfrm>
          <a:prstGeom prst="rect">
            <a:avLst/>
          </a:prstGeom>
          <a:noFill/>
        </p:spPr>
        <p:txBody>
          <a:bodyPr wrap="square" rtlCol="0">
            <a:spAutoFit/>
          </a:bodyPr>
          <a:lstStyle/>
          <a:p>
            <a:r>
              <a:rPr kumimoji="1" lang="en-US" altLang="ja-JP" sz="1295" dirty="0">
                <a:latin typeface="Times New Roman" panose="02020603050405020304" pitchFamily="18" charset="0"/>
                <a:cs typeface="Times New Roman" panose="02020603050405020304" pitchFamily="18" charset="0"/>
              </a:rPr>
              <a:t>outer wall at DAFB105</a:t>
            </a:r>
            <a:endParaRPr kumimoji="1" lang="ja-JP" altLang="en-US" sz="1295">
              <a:latin typeface="Times New Roman" panose="02020603050405020304" pitchFamily="18" charset="0"/>
              <a:cs typeface="Times New Roman" panose="02020603050405020304" pitchFamily="18" charset="0"/>
            </a:endParaRPr>
          </a:p>
        </p:txBody>
      </p:sp>
      <p:sp>
        <p:nvSpPr>
          <p:cNvPr id="8" name="テキスト ボックス 20">
            <a:extLst>
              <a:ext uri="{FF2B5EF4-FFF2-40B4-BE49-F238E27FC236}">
                <a16:creationId xmlns:a16="http://schemas.microsoft.com/office/drawing/2014/main" id="{F430B7AE-43B4-0CF4-A7C9-530D5E7460B1}"/>
              </a:ext>
            </a:extLst>
          </p:cNvPr>
          <p:cNvSpPr txBox="1"/>
          <p:nvPr/>
        </p:nvSpPr>
        <p:spPr>
          <a:xfrm>
            <a:off x="869464" y="619303"/>
            <a:ext cx="577821" cy="291618"/>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1295" spc="108" dirty="0">
                <a:latin typeface="Times New Roman" panose="02020603050405020304" pitchFamily="18" charset="0"/>
                <a:ea typeface="Hiragino Kaku Gothic Pro W3" panose="020B0300000000000000" pitchFamily="34" charset="-128"/>
                <a:cs typeface="Times New Roman" panose="02020603050405020304" pitchFamily="18" charset="0"/>
              </a:rPr>
              <a:t>(d)</a:t>
            </a:r>
          </a:p>
        </p:txBody>
      </p:sp>
    </p:spTree>
    <p:extLst>
      <p:ext uri="{BB962C8B-B14F-4D97-AF65-F5344CB8AC3E}">
        <p14:creationId xmlns:p14="http://schemas.microsoft.com/office/powerpoint/2010/main" val="40466244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24992F7-F21A-78A1-EAD3-16CC9E7F5DF7}"/>
            </a:ext>
          </a:extLst>
        </p:cNvPr>
        <p:cNvGrpSpPr/>
        <p:nvPr/>
      </p:nvGrpSpPr>
      <p:grpSpPr>
        <a:xfrm>
          <a:off x="0" y="0"/>
          <a:ext cx="0" cy="0"/>
          <a:chOff x="0" y="0"/>
          <a:chExt cx="0" cy="0"/>
        </a:xfrm>
      </p:grpSpPr>
      <p:sp>
        <p:nvSpPr>
          <p:cNvPr id="2" name="テキスト ボックス 21">
            <a:extLst>
              <a:ext uri="{FF2B5EF4-FFF2-40B4-BE49-F238E27FC236}">
                <a16:creationId xmlns:a16="http://schemas.microsoft.com/office/drawing/2014/main" id="{A04452A1-CBCD-F32F-9E27-FC390F7C5330}"/>
              </a:ext>
            </a:extLst>
          </p:cNvPr>
          <p:cNvSpPr txBox="1"/>
          <p:nvPr/>
        </p:nvSpPr>
        <p:spPr>
          <a:xfrm>
            <a:off x="1115047" y="4072240"/>
            <a:ext cx="5646737" cy="1200329"/>
          </a:xfrm>
          <a:prstGeom prst="rect">
            <a:avLst/>
          </a:prstGeom>
          <a:noFill/>
        </p:spPr>
        <p:txBody>
          <a:bodyPr wrap="square" rtlCol="0">
            <a:spAutoFit/>
          </a:bodyPr>
          <a:lstStyle/>
          <a:p>
            <a:r>
              <a:rPr lang="en-US" altLang="ja-JP" sz="1200" kern="100" dirty="0">
                <a:effectLst/>
                <a:latin typeface="Arial" panose="020B0604020202020204" pitchFamily="34" charset="0"/>
                <a:ea typeface="MS Mincho" panose="02020609040205080304" pitchFamily="49" charset="-128"/>
                <a:cs typeface="Arial" panose="020B0604020202020204" pitchFamily="34" charset="0"/>
              </a:rPr>
              <a:t>Figure S1. Cell size variability in the mesocarp. Scatter plots of cell size in the (a) inner and (b) outer regions at DAFB39 and the (c) inner and (d) outer regions at DAFB105. The longitudinal diameter was defined as the cell length along the radial axis on the equatorial section, and the transverse diameter as the cell length along the circumferential axis (n = 360–460 cells). </a:t>
            </a:r>
            <a:r>
              <a:rPr lang="en-US" altLang="ja-JP" sz="1200" dirty="0">
                <a:latin typeface="Arial" panose="020B0604020202020204" pitchFamily="34" charset="0"/>
                <a:cs typeface="Arial" panose="020B0604020202020204" pitchFamily="34" charset="0"/>
              </a:rPr>
              <a:t>GA, GA-treated berries; NT, non-treated berries. </a:t>
            </a:r>
            <a:endParaRPr lang="ja-JP" altLang="en-US" sz="1200" kern="100">
              <a:effectLst/>
              <a:latin typeface="Arial" panose="020B0604020202020204" pitchFamily="34" charset="0"/>
              <a:ea typeface="MS Mincho" panose="02020609040205080304" pitchFamily="49" charset="-128"/>
              <a:cs typeface="Arial" panose="020B0604020202020204" pitchFamily="34" charset="0"/>
            </a:endParaRPr>
          </a:p>
        </p:txBody>
      </p:sp>
      <p:sp>
        <p:nvSpPr>
          <p:cNvPr id="3" name="テキスト ボックス 2">
            <a:extLst>
              <a:ext uri="{FF2B5EF4-FFF2-40B4-BE49-F238E27FC236}">
                <a16:creationId xmlns:a16="http://schemas.microsoft.com/office/drawing/2014/main" id="{2B4CD572-E03E-1377-9E4B-6E925D5D87B0}"/>
              </a:ext>
            </a:extLst>
          </p:cNvPr>
          <p:cNvSpPr txBox="1"/>
          <p:nvPr/>
        </p:nvSpPr>
        <p:spPr>
          <a:xfrm>
            <a:off x="5457630" y="222640"/>
            <a:ext cx="1966625" cy="291618"/>
          </a:xfrm>
          <a:prstGeom prst="rect">
            <a:avLst/>
          </a:prstGeom>
          <a:noFill/>
        </p:spPr>
        <p:txBody>
          <a:bodyPr wrap="square" rtlCol="0">
            <a:spAutoFit/>
          </a:bodyPr>
          <a:lstStyle/>
          <a:p>
            <a:r>
              <a:rPr kumimoji="1" lang="en-US" altLang="ja-JP" sz="1295" dirty="0">
                <a:latin typeface="Times New Roman" panose="02020603050405020304" pitchFamily="18" charset="0"/>
                <a:cs typeface="Times New Roman" panose="02020603050405020304" pitchFamily="18" charset="0"/>
              </a:rPr>
              <a:t>Ishikawa et al., Figure S1</a:t>
            </a:r>
            <a:endParaRPr kumimoji="1" lang="ja-JP" altLang="en-US" sz="1295">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5123143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6754BD8D-C41A-A684-3180-BE3B198A950F}"/>
              </a:ext>
            </a:extLst>
          </p:cNvPr>
          <p:cNvPicPr>
            <a:picLocks noChangeAspect="1"/>
          </p:cNvPicPr>
          <p:nvPr/>
        </p:nvPicPr>
        <p:blipFill>
          <a:blip r:embed="rId2"/>
          <a:srcRect b="19062"/>
          <a:stretch>
            <a:fillRect/>
          </a:stretch>
        </p:blipFill>
        <p:spPr>
          <a:xfrm>
            <a:off x="2147887" y="3177030"/>
            <a:ext cx="3263900" cy="2168876"/>
          </a:xfrm>
          <a:prstGeom prst="rect">
            <a:avLst/>
          </a:prstGeom>
        </p:spPr>
      </p:pic>
      <p:sp>
        <p:nvSpPr>
          <p:cNvPr id="5" name="テキスト ボックス 4">
            <a:extLst>
              <a:ext uri="{FF2B5EF4-FFF2-40B4-BE49-F238E27FC236}">
                <a16:creationId xmlns:a16="http://schemas.microsoft.com/office/drawing/2014/main" id="{C516E553-3FB6-D5AE-E768-D97C0EA8175E}"/>
              </a:ext>
            </a:extLst>
          </p:cNvPr>
          <p:cNvSpPr txBox="1"/>
          <p:nvPr/>
        </p:nvSpPr>
        <p:spPr>
          <a:xfrm>
            <a:off x="899420" y="5962639"/>
            <a:ext cx="5760836" cy="646331"/>
          </a:xfrm>
          <a:prstGeom prst="rect">
            <a:avLst/>
          </a:prstGeom>
          <a:noFill/>
        </p:spPr>
        <p:txBody>
          <a:bodyPr wrap="square">
            <a:spAutoFit/>
          </a:bodyPr>
          <a:lstStyle/>
          <a:p>
            <a:r>
              <a:rPr lang="en" altLang="ja-JP" sz="1200" dirty="0">
                <a:latin typeface="Arial" panose="020B0604020202020204" pitchFamily="34" charset="0"/>
                <a:cs typeface="Arial" panose="020B0604020202020204" pitchFamily="34" charset="0"/>
              </a:rPr>
              <a:t>Figure S2. TPM values of </a:t>
            </a:r>
            <a:r>
              <a:rPr lang="en" altLang="ja-JP" sz="1200" i="1" u="none" strike="noStrike" dirty="0">
                <a:effectLst/>
                <a:latin typeface="Arial" panose="020B0604020202020204" pitchFamily="34" charset="0"/>
                <a:cs typeface="Arial" panose="020B0604020202020204" pitchFamily="34" charset="0"/>
              </a:rPr>
              <a:t>VSMuph2.0_chr102g0031</a:t>
            </a:r>
            <a:r>
              <a:rPr lang="en" altLang="ja-JP" sz="1200" u="none" strike="noStrike" dirty="0">
                <a:effectLst/>
                <a:latin typeface="Arial" panose="020B0604020202020204" pitchFamily="34" charset="0"/>
                <a:cs typeface="Arial" panose="020B0604020202020204" pitchFamily="34" charset="0"/>
              </a:rPr>
              <a:t>(ACC </a:t>
            </a:r>
            <a:r>
              <a:rPr lang="en" altLang="ja-JP" sz="1200" dirty="0">
                <a:latin typeface="Arial" panose="020B0604020202020204" pitchFamily="34" charset="0"/>
                <a:cs typeface="Arial" panose="020B0604020202020204" pitchFamily="34" charset="0"/>
              </a:rPr>
              <a:t>synthase 1). </a:t>
            </a:r>
            <a:r>
              <a:rPr lang="en-US" altLang="ja-JP" sz="1200" dirty="0">
                <a:latin typeface="Arial" panose="020B0604020202020204" pitchFamily="34" charset="0"/>
                <a:cs typeface="Arial" panose="020B0604020202020204" pitchFamily="34" charset="0"/>
              </a:rPr>
              <a:t>Values are means ± SE (n = 3). *, </a:t>
            </a:r>
            <a:r>
              <a:rPr lang="en-US" altLang="ja-JP" sz="1200" i="1" dirty="0" err="1">
                <a:latin typeface="Arial" panose="020B0604020202020204" pitchFamily="34" charset="0"/>
                <a:cs typeface="Arial" panose="020B0604020202020204" pitchFamily="34" charset="0"/>
              </a:rPr>
              <a:t>padj</a:t>
            </a:r>
            <a:r>
              <a:rPr lang="en-US" altLang="ja-JP" sz="1200" dirty="0">
                <a:latin typeface="Arial" panose="020B0604020202020204" pitchFamily="34" charset="0"/>
                <a:cs typeface="Arial" panose="020B0604020202020204" pitchFamily="34" charset="0"/>
              </a:rPr>
              <a:t> &lt; 0.05; ***, </a:t>
            </a:r>
            <a:r>
              <a:rPr lang="en-US" altLang="ja-JP" sz="1200" i="1" dirty="0" err="1">
                <a:latin typeface="Arial" panose="020B0604020202020204" pitchFamily="34" charset="0"/>
                <a:cs typeface="Arial" panose="020B0604020202020204" pitchFamily="34" charset="0"/>
              </a:rPr>
              <a:t>padj</a:t>
            </a:r>
            <a:r>
              <a:rPr lang="en-US" altLang="ja-JP" sz="1200" dirty="0">
                <a:latin typeface="Arial" panose="020B0604020202020204" pitchFamily="34" charset="0"/>
                <a:cs typeface="Arial" panose="020B0604020202020204" pitchFamily="34" charset="0"/>
              </a:rPr>
              <a:t> &lt; 0.001. GA, GA-treated berries; NT, non-treated berries. </a:t>
            </a:r>
          </a:p>
        </p:txBody>
      </p:sp>
      <p:sp>
        <p:nvSpPr>
          <p:cNvPr id="6" name="テキスト ボックス 5">
            <a:extLst>
              <a:ext uri="{FF2B5EF4-FFF2-40B4-BE49-F238E27FC236}">
                <a16:creationId xmlns:a16="http://schemas.microsoft.com/office/drawing/2014/main" id="{DCABADD5-81A0-81A4-10D8-1AD8F8891CE7}"/>
              </a:ext>
            </a:extLst>
          </p:cNvPr>
          <p:cNvSpPr txBox="1"/>
          <p:nvPr/>
        </p:nvSpPr>
        <p:spPr>
          <a:xfrm>
            <a:off x="5457630" y="222640"/>
            <a:ext cx="1966625" cy="291618"/>
          </a:xfrm>
          <a:prstGeom prst="rect">
            <a:avLst/>
          </a:prstGeom>
          <a:noFill/>
        </p:spPr>
        <p:txBody>
          <a:bodyPr wrap="square" rtlCol="0">
            <a:spAutoFit/>
          </a:bodyPr>
          <a:lstStyle/>
          <a:p>
            <a:r>
              <a:rPr kumimoji="1" lang="en-US" altLang="ja-JP" sz="1295" dirty="0">
                <a:latin typeface="Times New Roman" panose="02020603050405020304" pitchFamily="18" charset="0"/>
                <a:cs typeface="Times New Roman" panose="02020603050405020304" pitchFamily="18" charset="0"/>
              </a:rPr>
              <a:t>Ishikawa et al., Figure S2</a:t>
            </a:r>
            <a:endParaRPr kumimoji="1" lang="ja-JP" altLang="en-US" sz="1295">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32631172"/>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075</TotalTime>
  <Words>255</Words>
  <Application>Microsoft Office PowerPoint</Application>
  <PresentationFormat>Custom</PresentationFormat>
  <Paragraphs>25</Paragraphs>
  <Slides>6</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游ゴシック</vt:lpstr>
      <vt:lpstr>Aptos</vt:lpstr>
      <vt:lpstr>Aptos Display</vt:lpstr>
      <vt:lpstr>Arial</vt:lpstr>
      <vt:lpstr>Times New Roman</vt:lpstr>
      <vt:lpstr>Office テーマ</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icrosoft office user</dc:creator>
  <cp:lastModifiedBy>MDPI</cp:lastModifiedBy>
  <cp:revision>2</cp:revision>
  <cp:lastPrinted>2025-12-27T23:06:54Z</cp:lastPrinted>
  <dcterms:created xsi:type="dcterms:W3CDTF">2025-12-10T02:19:32Z</dcterms:created>
  <dcterms:modified xsi:type="dcterms:W3CDTF">2026-01-17T12:43:38Z</dcterms:modified>
</cp:coreProperties>
</file>